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10"/>
  </p:notesMasterIdLst>
  <p:sldIdLst>
    <p:sldId id="263" r:id="rId2"/>
    <p:sldId id="278" r:id="rId3"/>
    <p:sldId id="282" r:id="rId4"/>
    <p:sldId id="271" r:id="rId5"/>
    <p:sldId id="280" r:id="rId6"/>
    <p:sldId id="264" r:id="rId7"/>
    <p:sldId id="281" r:id="rId8"/>
    <p:sldId id="279" r:id="rId9"/>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8000"/>
    <a:srgbClr val="55A0FB"/>
    <a:srgbClr val="A00000"/>
    <a:srgbClr val="AACFFD"/>
    <a:srgbClr val="80808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C54814D0-1ED5-46F1-A9DB-A900A18121C8}" v="19" dt="2024-12-04T21:41:26.795"/>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421" autoAdjust="0"/>
    <p:restoredTop sz="96327"/>
  </p:normalViewPr>
  <p:slideViewPr>
    <p:cSldViewPr snapToGrid="0">
      <p:cViewPr varScale="1">
        <p:scale>
          <a:sx n="83" d="100"/>
          <a:sy n="83" d="100"/>
        </p:scale>
        <p:origin x="614" y="51"/>
      </p:cViewPr>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6" Type="http://schemas.microsoft.com/office/2015/10/relationships/revisionInfo" Target="revisionInfo.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5" Type="http://schemas.microsoft.com/office/2016/11/relationships/changesInfo" Target="changesInfos/changesInfo1.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artorius, Carol" userId="717f8656-0c6f-4128-8672-6a166f4ce149" providerId="ADAL" clId="{2F088F5A-5D4A-4C38-BFF7-EC151CC291D0}"/>
    <pc:docChg chg="undo custSel addSld delSld modSld">
      <pc:chgData name="Sartorius, Carol" userId="717f8656-0c6f-4128-8672-6a166f4ce149" providerId="ADAL" clId="{2F088F5A-5D4A-4C38-BFF7-EC151CC291D0}" dt="2024-10-06T17:14:08.511" v="2564" actId="20577"/>
      <pc:docMkLst>
        <pc:docMk/>
      </pc:docMkLst>
      <pc:sldChg chg="addSp delSp modSp mod">
        <pc:chgData name="Sartorius, Carol" userId="717f8656-0c6f-4128-8672-6a166f4ce149" providerId="ADAL" clId="{2F088F5A-5D4A-4C38-BFF7-EC151CC291D0}" dt="2024-09-30T03:19:46.076" v="2323" actId="20577"/>
        <pc:sldMkLst>
          <pc:docMk/>
          <pc:sldMk cId="2911261070" sldId="263"/>
        </pc:sldMkLst>
        <pc:spChg chg="mod">
          <ac:chgData name="Sartorius, Carol" userId="717f8656-0c6f-4128-8672-6a166f4ce149" providerId="ADAL" clId="{2F088F5A-5D4A-4C38-BFF7-EC151CC291D0}" dt="2024-09-30T03:14:21.155" v="2259" actId="164"/>
          <ac:spMkLst>
            <pc:docMk/>
            <pc:sldMk cId="2911261070" sldId="263"/>
            <ac:spMk id="2" creationId="{CA28AA02-CC32-918B-391C-959DFB6466E4}"/>
          </ac:spMkLst>
        </pc:spChg>
        <pc:spChg chg="mod">
          <ac:chgData name="Sartorius, Carol" userId="717f8656-0c6f-4128-8672-6a166f4ce149" providerId="ADAL" clId="{2F088F5A-5D4A-4C38-BFF7-EC151CC291D0}" dt="2024-09-30T03:14:21.155" v="2259" actId="164"/>
          <ac:spMkLst>
            <pc:docMk/>
            <pc:sldMk cId="2911261070" sldId="263"/>
            <ac:spMk id="6" creationId="{67D62AD1-0BBB-2FFA-5D47-64975E8800B5}"/>
          </ac:spMkLst>
        </pc:spChg>
        <pc:spChg chg="add mod">
          <ac:chgData name="Sartorius, Carol" userId="717f8656-0c6f-4128-8672-6a166f4ce149" providerId="ADAL" clId="{2F088F5A-5D4A-4C38-BFF7-EC151CC291D0}" dt="2024-09-30T03:19:46.076" v="2323" actId="20577"/>
          <ac:spMkLst>
            <pc:docMk/>
            <pc:sldMk cId="2911261070" sldId="263"/>
            <ac:spMk id="8" creationId="{D432024D-04A1-3E8C-770B-C35C3098A895}"/>
          </ac:spMkLst>
        </pc:spChg>
        <pc:spChg chg="add del mod">
          <ac:chgData name="Sartorius, Carol" userId="717f8656-0c6f-4128-8672-6a166f4ce149" providerId="ADAL" clId="{2F088F5A-5D4A-4C38-BFF7-EC151CC291D0}" dt="2024-09-22T20:56:20.365" v="359" actId="478"/>
          <ac:spMkLst>
            <pc:docMk/>
            <pc:sldMk cId="2911261070" sldId="263"/>
            <ac:spMk id="9" creationId="{0E551BD2-3809-9AA8-91C0-BF7B4D53006B}"/>
          </ac:spMkLst>
        </pc:spChg>
        <pc:spChg chg="add del mod">
          <ac:chgData name="Sartorius, Carol" userId="717f8656-0c6f-4128-8672-6a166f4ce149" providerId="ADAL" clId="{2F088F5A-5D4A-4C38-BFF7-EC151CC291D0}" dt="2024-09-22T20:56:20.365" v="359" actId="478"/>
          <ac:spMkLst>
            <pc:docMk/>
            <pc:sldMk cId="2911261070" sldId="263"/>
            <ac:spMk id="10" creationId="{E25A4F04-5621-B0B9-76FD-6935086C312B}"/>
          </ac:spMkLst>
        </pc:spChg>
        <pc:spChg chg="add del mod">
          <ac:chgData name="Sartorius, Carol" userId="717f8656-0c6f-4128-8672-6a166f4ce149" providerId="ADAL" clId="{2F088F5A-5D4A-4C38-BFF7-EC151CC291D0}" dt="2024-09-22T20:56:20.365" v="359" actId="478"/>
          <ac:spMkLst>
            <pc:docMk/>
            <pc:sldMk cId="2911261070" sldId="263"/>
            <ac:spMk id="11" creationId="{B618A5CB-50DE-FDD1-D51E-718136EC2CB8}"/>
          </ac:spMkLst>
        </pc:spChg>
        <pc:spChg chg="mod">
          <ac:chgData name="Sartorius, Carol" userId="717f8656-0c6f-4128-8672-6a166f4ce149" providerId="ADAL" clId="{2F088F5A-5D4A-4C38-BFF7-EC151CC291D0}" dt="2024-09-30T03:14:21.155" v="2259" actId="164"/>
          <ac:spMkLst>
            <pc:docMk/>
            <pc:sldMk cId="2911261070" sldId="263"/>
            <ac:spMk id="12" creationId="{9F0FB4A8-6D22-247D-6D31-634F6F7C2A07}"/>
          </ac:spMkLst>
        </pc:spChg>
        <pc:spChg chg="mod">
          <ac:chgData name="Sartorius, Carol" userId="717f8656-0c6f-4128-8672-6a166f4ce149" providerId="ADAL" clId="{2F088F5A-5D4A-4C38-BFF7-EC151CC291D0}" dt="2024-09-30T03:14:21.155" v="2259" actId="164"/>
          <ac:spMkLst>
            <pc:docMk/>
            <pc:sldMk cId="2911261070" sldId="263"/>
            <ac:spMk id="13" creationId="{53129058-EBC2-96FE-F2F4-0F15D230BF7C}"/>
          </ac:spMkLst>
        </pc:spChg>
        <pc:spChg chg="mod">
          <ac:chgData name="Sartorius, Carol" userId="717f8656-0c6f-4128-8672-6a166f4ce149" providerId="ADAL" clId="{2F088F5A-5D4A-4C38-BFF7-EC151CC291D0}" dt="2024-09-30T03:14:21.155" v="2259" actId="164"/>
          <ac:spMkLst>
            <pc:docMk/>
            <pc:sldMk cId="2911261070" sldId="263"/>
            <ac:spMk id="14" creationId="{B351F77C-5E5C-266E-FBE6-22B3AEA1182F}"/>
          </ac:spMkLst>
        </pc:spChg>
        <pc:spChg chg="mod">
          <ac:chgData name="Sartorius, Carol" userId="717f8656-0c6f-4128-8672-6a166f4ce149" providerId="ADAL" clId="{2F088F5A-5D4A-4C38-BFF7-EC151CC291D0}" dt="2024-09-30T03:14:21.155" v="2259" actId="164"/>
          <ac:spMkLst>
            <pc:docMk/>
            <pc:sldMk cId="2911261070" sldId="263"/>
            <ac:spMk id="15" creationId="{C73C3402-0654-F5A8-1C75-2EA8959B80C4}"/>
          </ac:spMkLst>
        </pc:spChg>
        <pc:spChg chg="mod">
          <ac:chgData name="Sartorius, Carol" userId="717f8656-0c6f-4128-8672-6a166f4ce149" providerId="ADAL" clId="{2F088F5A-5D4A-4C38-BFF7-EC151CC291D0}" dt="2024-09-30T03:14:21.155" v="2259" actId="164"/>
          <ac:spMkLst>
            <pc:docMk/>
            <pc:sldMk cId="2911261070" sldId="263"/>
            <ac:spMk id="16" creationId="{70AB1D79-E710-35CB-0747-785EFE77C781}"/>
          </ac:spMkLst>
        </pc:spChg>
        <pc:spChg chg="mod">
          <ac:chgData name="Sartorius, Carol" userId="717f8656-0c6f-4128-8672-6a166f4ce149" providerId="ADAL" clId="{2F088F5A-5D4A-4C38-BFF7-EC151CC291D0}" dt="2024-09-30T03:14:21.155" v="2259" actId="164"/>
          <ac:spMkLst>
            <pc:docMk/>
            <pc:sldMk cId="2911261070" sldId="263"/>
            <ac:spMk id="17" creationId="{D5477D78-2A07-5B05-36B4-DFC880B93D01}"/>
          </ac:spMkLst>
        </pc:spChg>
        <pc:spChg chg="mod">
          <ac:chgData name="Sartorius, Carol" userId="717f8656-0c6f-4128-8672-6a166f4ce149" providerId="ADAL" clId="{2F088F5A-5D4A-4C38-BFF7-EC151CC291D0}" dt="2024-09-30T03:14:21.155" v="2259" actId="164"/>
          <ac:spMkLst>
            <pc:docMk/>
            <pc:sldMk cId="2911261070" sldId="263"/>
            <ac:spMk id="20" creationId="{50D902C1-B7EB-FAA4-9797-6D64CA8F4505}"/>
          </ac:spMkLst>
        </pc:spChg>
        <pc:spChg chg="mod">
          <ac:chgData name="Sartorius, Carol" userId="717f8656-0c6f-4128-8672-6a166f4ce149" providerId="ADAL" clId="{2F088F5A-5D4A-4C38-BFF7-EC151CC291D0}" dt="2024-09-30T03:14:21.155" v="2259" actId="164"/>
          <ac:spMkLst>
            <pc:docMk/>
            <pc:sldMk cId="2911261070" sldId="263"/>
            <ac:spMk id="21" creationId="{9CB1DEEA-31BA-A255-37C2-8A2AE3461CA7}"/>
          </ac:spMkLst>
        </pc:spChg>
        <pc:spChg chg="mod">
          <ac:chgData name="Sartorius, Carol" userId="717f8656-0c6f-4128-8672-6a166f4ce149" providerId="ADAL" clId="{2F088F5A-5D4A-4C38-BFF7-EC151CC291D0}" dt="2024-09-30T03:14:21.155" v="2259" actId="164"/>
          <ac:spMkLst>
            <pc:docMk/>
            <pc:sldMk cId="2911261070" sldId="263"/>
            <ac:spMk id="22" creationId="{9C012548-8BCB-F239-AAF1-4B7EF7EBCA9C}"/>
          </ac:spMkLst>
        </pc:spChg>
        <pc:spChg chg="mod">
          <ac:chgData name="Sartorius, Carol" userId="717f8656-0c6f-4128-8672-6a166f4ce149" providerId="ADAL" clId="{2F088F5A-5D4A-4C38-BFF7-EC151CC291D0}" dt="2024-09-30T03:14:21.155" v="2259" actId="164"/>
          <ac:spMkLst>
            <pc:docMk/>
            <pc:sldMk cId="2911261070" sldId="263"/>
            <ac:spMk id="23" creationId="{C31C038C-B4F9-77BA-2C85-46DFF22A9B29}"/>
          </ac:spMkLst>
        </pc:spChg>
        <pc:spChg chg="add del mod">
          <ac:chgData name="Sartorius, Carol" userId="717f8656-0c6f-4128-8672-6a166f4ce149" providerId="ADAL" clId="{2F088F5A-5D4A-4C38-BFF7-EC151CC291D0}" dt="2024-09-22T20:56:20.365" v="359" actId="478"/>
          <ac:spMkLst>
            <pc:docMk/>
            <pc:sldMk cId="2911261070" sldId="263"/>
            <ac:spMk id="24" creationId="{7547C106-22F1-4D6C-3A91-FF6709768A13}"/>
          </ac:spMkLst>
        </pc:spChg>
        <pc:spChg chg="mod">
          <ac:chgData name="Sartorius, Carol" userId="717f8656-0c6f-4128-8672-6a166f4ce149" providerId="ADAL" clId="{2F088F5A-5D4A-4C38-BFF7-EC151CC291D0}" dt="2024-09-30T03:19:18.933" v="2321" actId="1035"/>
          <ac:spMkLst>
            <pc:docMk/>
            <pc:sldMk cId="2911261070" sldId="263"/>
            <ac:spMk id="126" creationId="{67BA4D94-20CE-B069-20DA-F18B18BFA9D1}"/>
          </ac:spMkLst>
        </pc:spChg>
        <pc:spChg chg="mod">
          <ac:chgData name="Sartorius, Carol" userId="717f8656-0c6f-4128-8672-6a166f4ce149" providerId="ADAL" clId="{2F088F5A-5D4A-4C38-BFF7-EC151CC291D0}" dt="2024-09-30T03:19:18.933" v="2321" actId="1035"/>
          <ac:spMkLst>
            <pc:docMk/>
            <pc:sldMk cId="2911261070" sldId="263"/>
            <ac:spMk id="127" creationId="{9F5E2020-C448-C76F-0132-A91D8B7C9881}"/>
          </ac:spMkLst>
        </pc:spChg>
        <pc:spChg chg="mod">
          <ac:chgData name="Sartorius, Carol" userId="717f8656-0c6f-4128-8672-6a166f4ce149" providerId="ADAL" clId="{2F088F5A-5D4A-4C38-BFF7-EC151CC291D0}" dt="2024-09-30T03:18:31.604" v="2309" actId="1035"/>
          <ac:spMkLst>
            <pc:docMk/>
            <pc:sldMk cId="2911261070" sldId="263"/>
            <ac:spMk id="128" creationId="{FA550F3E-4DA8-4D69-F7A2-603665FCB6C9}"/>
          </ac:spMkLst>
        </pc:spChg>
        <pc:spChg chg="del">
          <ac:chgData name="Sartorius, Carol" userId="717f8656-0c6f-4128-8672-6a166f4ce149" providerId="ADAL" clId="{2F088F5A-5D4A-4C38-BFF7-EC151CC291D0}" dt="2024-09-22T23:02:55.966" v="861" actId="478"/>
          <ac:spMkLst>
            <pc:docMk/>
            <pc:sldMk cId="2911261070" sldId="263"/>
            <ac:spMk id="129" creationId="{E98F743B-2C6A-390B-B79D-C24DC1B33558}"/>
          </ac:spMkLst>
        </pc:spChg>
        <pc:grpChg chg="add mod">
          <ac:chgData name="Sartorius, Carol" userId="717f8656-0c6f-4128-8672-6a166f4ce149" providerId="ADAL" clId="{2F088F5A-5D4A-4C38-BFF7-EC151CC291D0}" dt="2024-09-30T03:14:15.665" v="2258" actId="164"/>
          <ac:grpSpMkLst>
            <pc:docMk/>
            <pc:sldMk cId="2911261070" sldId="263"/>
            <ac:grpSpMk id="9" creationId="{2B79285B-65C8-39CA-04CF-D4494A7DCC13}"/>
          </ac:grpSpMkLst>
        </pc:grpChg>
        <pc:grpChg chg="add del mod">
          <ac:chgData name="Sartorius, Carol" userId="717f8656-0c6f-4128-8672-6a166f4ce149" providerId="ADAL" clId="{2F088F5A-5D4A-4C38-BFF7-EC151CC291D0}" dt="2024-09-30T03:17:19.254" v="2264" actId="478"/>
          <ac:grpSpMkLst>
            <pc:docMk/>
            <pc:sldMk cId="2911261070" sldId="263"/>
            <ac:grpSpMk id="10" creationId="{920572EA-96E4-B03D-4830-7567D72361C4}"/>
          </ac:grpSpMkLst>
        </pc:grpChg>
        <pc:picChg chg="mod">
          <ac:chgData name="Sartorius, Carol" userId="717f8656-0c6f-4128-8672-6a166f4ce149" providerId="ADAL" clId="{2F088F5A-5D4A-4C38-BFF7-EC151CC291D0}" dt="2024-09-30T03:18:59.734" v="2313" actId="555"/>
          <ac:picMkLst>
            <pc:docMk/>
            <pc:sldMk cId="2911261070" sldId="263"/>
            <ac:picMk id="3" creationId="{4621F3F1-9BB8-832F-88DE-E199E73511C8}"/>
          </ac:picMkLst>
        </pc:picChg>
        <pc:picChg chg="mod">
          <ac:chgData name="Sartorius, Carol" userId="717f8656-0c6f-4128-8672-6a166f4ce149" providerId="ADAL" clId="{2F088F5A-5D4A-4C38-BFF7-EC151CC291D0}" dt="2024-09-30T03:19:05.280" v="2316" actId="1035"/>
          <ac:picMkLst>
            <pc:docMk/>
            <pc:sldMk cId="2911261070" sldId="263"/>
            <ac:picMk id="4" creationId="{42F86EB2-AE1D-A4E3-683A-A8AAB09A9211}"/>
          </ac:picMkLst>
        </pc:picChg>
        <pc:picChg chg="mod">
          <ac:chgData name="Sartorius, Carol" userId="717f8656-0c6f-4128-8672-6a166f4ce149" providerId="ADAL" clId="{2F088F5A-5D4A-4C38-BFF7-EC151CC291D0}" dt="2024-09-30T03:14:21.155" v="2259" actId="164"/>
          <ac:picMkLst>
            <pc:docMk/>
            <pc:sldMk cId="2911261070" sldId="263"/>
            <ac:picMk id="5" creationId="{6DFB8503-282C-5753-B9E9-607EAB78F89C}"/>
          </ac:picMkLst>
        </pc:picChg>
        <pc:picChg chg="mod">
          <ac:chgData name="Sartorius, Carol" userId="717f8656-0c6f-4128-8672-6a166f4ce149" providerId="ADAL" clId="{2F088F5A-5D4A-4C38-BFF7-EC151CC291D0}" dt="2024-09-30T03:14:21.155" v="2259" actId="164"/>
          <ac:picMkLst>
            <pc:docMk/>
            <pc:sldMk cId="2911261070" sldId="263"/>
            <ac:picMk id="7" creationId="{FA165160-2B08-10B3-697A-0D16D1016AF1}"/>
          </ac:picMkLst>
        </pc:picChg>
        <pc:picChg chg="add mod">
          <ac:chgData name="Sartorius, Carol" userId="717f8656-0c6f-4128-8672-6a166f4ce149" providerId="ADAL" clId="{2F088F5A-5D4A-4C38-BFF7-EC151CC291D0}" dt="2024-09-30T03:18:31.604" v="2309" actId="1035"/>
          <ac:picMkLst>
            <pc:docMk/>
            <pc:sldMk cId="2911261070" sldId="263"/>
            <ac:picMk id="24" creationId="{0A6059B1-609B-CA38-63A3-07072717B9E7}"/>
          </ac:picMkLst>
        </pc:picChg>
        <pc:cxnChg chg="mod">
          <ac:chgData name="Sartorius, Carol" userId="717f8656-0c6f-4128-8672-6a166f4ce149" providerId="ADAL" clId="{2F088F5A-5D4A-4C38-BFF7-EC151CC291D0}" dt="2024-09-30T03:14:21.155" v="2259" actId="164"/>
          <ac:cxnSpMkLst>
            <pc:docMk/>
            <pc:sldMk cId="2911261070" sldId="263"/>
            <ac:cxnSpMk id="18" creationId="{FD53D0E7-1A07-4CE4-27E6-863552B74A8A}"/>
          </ac:cxnSpMkLst>
        </pc:cxnChg>
        <pc:cxnChg chg="mod">
          <ac:chgData name="Sartorius, Carol" userId="717f8656-0c6f-4128-8672-6a166f4ce149" providerId="ADAL" clId="{2F088F5A-5D4A-4C38-BFF7-EC151CC291D0}" dt="2024-09-30T03:14:21.155" v="2259" actId="164"/>
          <ac:cxnSpMkLst>
            <pc:docMk/>
            <pc:sldMk cId="2911261070" sldId="263"/>
            <ac:cxnSpMk id="19" creationId="{49E43987-3D68-05BB-D36B-13DAD684D0A3}"/>
          </ac:cxnSpMkLst>
        </pc:cxnChg>
      </pc:sldChg>
      <pc:sldChg chg="addSp delSp modSp mod">
        <pc:chgData name="Sartorius, Carol" userId="717f8656-0c6f-4128-8672-6a166f4ce149" providerId="ADAL" clId="{2F088F5A-5D4A-4C38-BFF7-EC151CC291D0}" dt="2024-09-30T03:10:50.615" v="2141" actId="552"/>
        <pc:sldMkLst>
          <pc:docMk/>
          <pc:sldMk cId="3004741895" sldId="264"/>
        </pc:sldMkLst>
        <pc:spChg chg="mod">
          <ac:chgData name="Sartorius, Carol" userId="717f8656-0c6f-4128-8672-6a166f4ce149" providerId="ADAL" clId="{2F088F5A-5D4A-4C38-BFF7-EC151CC291D0}" dt="2024-09-22T22:47:58.007" v="457" actId="164"/>
          <ac:spMkLst>
            <pc:docMk/>
            <pc:sldMk cId="3004741895" sldId="264"/>
            <ac:spMk id="7" creationId="{C3290AC1-2CAB-9AF6-8D1F-EF12B4EE04FC}"/>
          </ac:spMkLst>
        </pc:spChg>
        <pc:spChg chg="mod">
          <ac:chgData name="Sartorius, Carol" userId="717f8656-0c6f-4128-8672-6a166f4ce149" providerId="ADAL" clId="{2F088F5A-5D4A-4C38-BFF7-EC151CC291D0}" dt="2024-09-22T22:49:31.649" v="458" actId="164"/>
          <ac:spMkLst>
            <pc:docMk/>
            <pc:sldMk cId="3004741895" sldId="264"/>
            <ac:spMk id="8" creationId="{6959AB70-FF7D-0C45-CA7E-9D7DC046A438}"/>
          </ac:spMkLst>
        </pc:spChg>
        <pc:spChg chg="mod">
          <ac:chgData name="Sartorius, Carol" userId="717f8656-0c6f-4128-8672-6a166f4ce149" providerId="ADAL" clId="{2F088F5A-5D4A-4C38-BFF7-EC151CC291D0}" dt="2024-09-22T22:47:58.007" v="457" actId="164"/>
          <ac:spMkLst>
            <pc:docMk/>
            <pc:sldMk cId="3004741895" sldId="264"/>
            <ac:spMk id="9" creationId="{FFC4FBD3-99DE-98B4-5C5F-51D53E680971}"/>
          </ac:spMkLst>
        </pc:spChg>
        <pc:spChg chg="mod ord">
          <ac:chgData name="Sartorius, Carol" userId="717f8656-0c6f-4128-8672-6a166f4ce149" providerId="ADAL" clId="{2F088F5A-5D4A-4C38-BFF7-EC151CC291D0}" dt="2024-09-22T22:52:02.954" v="487" actId="164"/>
          <ac:spMkLst>
            <pc:docMk/>
            <pc:sldMk cId="3004741895" sldId="264"/>
            <ac:spMk id="10" creationId="{5E0DE7AA-8337-C2F1-435A-67F32261CF71}"/>
          </ac:spMkLst>
        </pc:spChg>
        <pc:spChg chg="mod">
          <ac:chgData name="Sartorius, Carol" userId="717f8656-0c6f-4128-8672-6a166f4ce149" providerId="ADAL" clId="{2F088F5A-5D4A-4C38-BFF7-EC151CC291D0}" dt="2024-09-22T22:47:58.007" v="457" actId="164"/>
          <ac:spMkLst>
            <pc:docMk/>
            <pc:sldMk cId="3004741895" sldId="264"/>
            <ac:spMk id="11" creationId="{F0D0B9FE-5E93-CE64-397F-D0317ED54EA4}"/>
          </ac:spMkLst>
        </pc:spChg>
        <pc:spChg chg="mod">
          <ac:chgData name="Sartorius, Carol" userId="717f8656-0c6f-4128-8672-6a166f4ce149" providerId="ADAL" clId="{2F088F5A-5D4A-4C38-BFF7-EC151CC291D0}" dt="2024-09-22T22:47:58.007" v="457" actId="164"/>
          <ac:spMkLst>
            <pc:docMk/>
            <pc:sldMk cId="3004741895" sldId="264"/>
            <ac:spMk id="12" creationId="{A4A78C9D-8505-EB62-5D74-98705FFEC561}"/>
          </ac:spMkLst>
        </pc:spChg>
        <pc:spChg chg="mod">
          <ac:chgData name="Sartorius, Carol" userId="717f8656-0c6f-4128-8672-6a166f4ce149" providerId="ADAL" clId="{2F088F5A-5D4A-4C38-BFF7-EC151CC291D0}" dt="2024-09-22T22:47:58.007" v="457" actId="164"/>
          <ac:spMkLst>
            <pc:docMk/>
            <pc:sldMk cId="3004741895" sldId="264"/>
            <ac:spMk id="13" creationId="{CCCC86D0-2EC2-883F-2E2C-93D5D7AEC960}"/>
          </ac:spMkLst>
        </pc:spChg>
        <pc:spChg chg="mod">
          <ac:chgData name="Sartorius, Carol" userId="717f8656-0c6f-4128-8672-6a166f4ce149" providerId="ADAL" clId="{2F088F5A-5D4A-4C38-BFF7-EC151CC291D0}" dt="2024-09-22T22:47:58.007" v="457" actId="164"/>
          <ac:spMkLst>
            <pc:docMk/>
            <pc:sldMk cId="3004741895" sldId="264"/>
            <ac:spMk id="14" creationId="{BD5530B7-BBB6-2FFD-8A6B-6F7C9F632B81}"/>
          </ac:spMkLst>
        </pc:spChg>
        <pc:spChg chg="mod">
          <ac:chgData name="Sartorius, Carol" userId="717f8656-0c6f-4128-8672-6a166f4ce149" providerId="ADAL" clId="{2F088F5A-5D4A-4C38-BFF7-EC151CC291D0}" dt="2024-09-22T22:47:58.007" v="457" actId="164"/>
          <ac:spMkLst>
            <pc:docMk/>
            <pc:sldMk cId="3004741895" sldId="264"/>
            <ac:spMk id="15" creationId="{5E82068B-3E87-2DB2-A55D-3554D77276A7}"/>
          </ac:spMkLst>
        </pc:spChg>
        <pc:spChg chg="mod">
          <ac:chgData name="Sartorius, Carol" userId="717f8656-0c6f-4128-8672-6a166f4ce149" providerId="ADAL" clId="{2F088F5A-5D4A-4C38-BFF7-EC151CC291D0}" dt="2024-09-22T22:47:58.007" v="457" actId="164"/>
          <ac:spMkLst>
            <pc:docMk/>
            <pc:sldMk cId="3004741895" sldId="264"/>
            <ac:spMk id="16" creationId="{60EA168E-6387-A1C1-A0C8-4B3602FE1670}"/>
          </ac:spMkLst>
        </pc:spChg>
        <pc:spChg chg="mod">
          <ac:chgData name="Sartorius, Carol" userId="717f8656-0c6f-4128-8672-6a166f4ce149" providerId="ADAL" clId="{2F088F5A-5D4A-4C38-BFF7-EC151CC291D0}" dt="2024-09-22T22:47:58.007" v="457" actId="164"/>
          <ac:spMkLst>
            <pc:docMk/>
            <pc:sldMk cId="3004741895" sldId="264"/>
            <ac:spMk id="17" creationId="{0DC77D11-9A82-FD8A-92D9-09AF98EBCFBC}"/>
          </ac:spMkLst>
        </pc:spChg>
        <pc:spChg chg="mod">
          <ac:chgData name="Sartorius, Carol" userId="717f8656-0c6f-4128-8672-6a166f4ce149" providerId="ADAL" clId="{2F088F5A-5D4A-4C38-BFF7-EC151CC291D0}" dt="2024-09-22T22:47:58.007" v="457" actId="164"/>
          <ac:spMkLst>
            <pc:docMk/>
            <pc:sldMk cId="3004741895" sldId="264"/>
            <ac:spMk id="18" creationId="{8E7638D4-D410-E696-7979-70D1D893B9F8}"/>
          </ac:spMkLst>
        </pc:spChg>
        <pc:spChg chg="mod">
          <ac:chgData name="Sartorius, Carol" userId="717f8656-0c6f-4128-8672-6a166f4ce149" providerId="ADAL" clId="{2F088F5A-5D4A-4C38-BFF7-EC151CC291D0}" dt="2024-09-22T22:47:58.007" v="457" actId="164"/>
          <ac:spMkLst>
            <pc:docMk/>
            <pc:sldMk cId="3004741895" sldId="264"/>
            <ac:spMk id="19" creationId="{9B6E9D94-5896-0EE2-BA06-D817275C827F}"/>
          </ac:spMkLst>
        </pc:spChg>
        <pc:spChg chg="mod">
          <ac:chgData name="Sartorius, Carol" userId="717f8656-0c6f-4128-8672-6a166f4ce149" providerId="ADAL" clId="{2F088F5A-5D4A-4C38-BFF7-EC151CC291D0}" dt="2024-09-22T22:49:31.649" v="458" actId="164"/>
          <ac:spMkLst>
            <pc:docMk/>
            <pc:sldMk cId="3004741895" sldId="264"/>
            <ac:spMk id="20" creationId="{4ECA8521-5D79-29A3-C57E-EE04BD334A9C}"/>
          </ac:spMkLst>
        </pc:spChg>
        <pc:spChg chg="mod ord">
          <ac:chgData name="Sartorius, Carol" userId="717f8656-0c6f-4128-8672-6a166f4ce149" providerId="ADAL" clId="{2F088F5A-5D4A-4C38-BFF7-EC151CC291D0}" dt="2024-09-22T22:52:07.289" v="488" actId="164"/>
          <ac:spMkLst>
            <pc:docMk/>
            <pc:sldMk cId="3004741895" sldId="264"/>
            <ac:spMk id="21" creationId="{3C82E732-205E-941D-2681-C602B8FBBE8B}"/>
          </ac:spMkLst>
        </pc:spChg>
        <pc:spChg chg="mod">
          <ac:chgData name="Sartorius, Carol" userId="717f8656-0c6f-4128-8672-6a166f4ce149" providerId="ADAL" clId="{2F088F5A-5D4A-4C38-BFF7-EC151CC291D0}" dt="2024-09-22T22:49:31.649" v="458" actId="164"/>
          <ac:spMkLst>
            <pc:docMk/>
            <pc:sldMk cId="3004741895" sldId="264"/>
            <ac:spMk id="22" creationId="{4D55BA06-91D3-60E2-B34D-67CF936C9B1C}"/>
          </ac:spMkLst>
        </pc:spChg>
        <pc:spChg chg="mod">
          <ac:chgData name="Sartorius, Carol" userId="717f8656-0c6f-4128-8672-6a166f4ce149" providerId="ADAL" clId="{2F088F5A-5D4A-4C38-BFF7-EC151CC291D0}" dt="2024-09-22T22:49:31.649" v="458" actId="164"/>
          <ac:spMkLst>
            <pc:docMk/>
            <pc:sldMk cId="3004741895" sldId="264"/>
            <ac:spMk id="23" creationId="{19729210-62E8-F24A-968C-9826CB9E5BE5}"/>
          </ac:spMkLst>
        </pc:spChg>
        <pc:spChg chg="mod">
          <ac:chgData name="Sartorius, Carol" userId="717f8656-0c6f-4128-8672-6a166f4ce149" providerId="ADAL" clId="{2F088F5A-5D4A-4C38-BFF7-EC151CC291D0}" dt="2024-09-22T22:49:31.649" v="458" actId="164"/>
          <ac:spMkLst>
            <pc:docMk/>
            <pc:sldMk cId="3004741895" sldId="264"/>
            <ac:spMk id="24" creationId="{EA430C4E-87E1-F8A8-63C1-4138D8B1DD3F}"/>
          </ac:spMkLst>
        </pc:spChg>
        <pc:spChg chg="mod">
          <ac:chgData name="Sartorius, Carol" userId="717f8656-0c6f-4128-8672-6a166f4ce149" providerId="ADAL" clId="{2F088F5A-5D4A-4C38-BFF7-EC151CC291D0}" dt="2024-09-22T22:49:31.649" v="458" actId="164"/>
          <ac:spMkLst>
            <pc:docMk/>
            <pc:sldMk cId="3004741895" sldId="264"/>
            <ac:spMk id="25" creationId="{5153D5EA-EE60-1005-A661-B419D8E74F82}"/>
          </ac:spMkLst>
        </pc:spChg>
        <pc:spChg chg="mod">
          <ac:chgData name="Sartorius, Carol" userId="717f8656-0c6f-4128-8672-6a166f4ce149" providerId="ADAL" clId="{2F088F5A-5D4A-4C38-BFF7-EC151CC291D0}" dt="2024-09-22T22:49:31.649" v="458" actId="164"/>
          <ac:spMkLst>
            <pc:docMk/>
            <pc:sldMk cId="3004741895" sldId="264"/>
            <ac:spMk id="26" creationId="{E731CF68-AB51-FD3E-21E8-F17C09F84766}"/>
          </ac:spMkLst>
        </pc:spChg>
        <pc:spChg chg="mod">
          <ac:chgData name="Sartorius, Carol" userId="717f8656-0c6f-4128-8672-6a166f4ce149" providerId="ADAL" clId="{2F088F5A-5D4A-4C38-BFF7-EC151CC291D0}" dt="2024-09-22T22:49:31.649" v="458" actId="164"/>
          <ac:spMkLst>
            <pc:docMk/>
            <pc:sldMk cId="3004741895" sldId="264"/>
            <ac:spMk id="27" creationId="{E0B466E4-82AF-5B3E-1824-4CE27D2256AC}"/>
          </ac:spMkLst>
        </pc:spChg>
        <pc:spChg chg="mod">
          <ac:chgData name="Sartorius, Carol" userId="717f8656-0c6f-4128-8672-6a166f4ce149" providerId="ADAL" clId="{2F088F5A-5D4A-4C38-BFF7-EC151CC291D0}" dt="2024-09-22T22:49:31.649" v="458" actId="164"/>
          <ac:spMkLst>
            <pc:docMk/>
            <pc:sldMk cId="3004741895" sldId="264"/>
            <ac:spMk id="28" creationId="{A97EEA04-5C5C-48AA-0669-9F268F036505}"/>
          </ac:spMkLst>
        </pc:spChg>
        <pc:spChg chg="mod">
          <ac:chgData name="Sartorius, Carol" userId="717f8656-0c6f-4128-8672-6a166f4ce149" providerId="ADAL" clId="{2F088F5A-5D4A-4C38-BFF7-EC151CC291D0}" dt="2024-09-22T22:49:31.649" v="458" actId="164"/>
          <ac:spMkLst>
            <pc:docMk/>
            <pc:sldMk cId="3004741895" sldId="264"/>
            <ac:spMk id="29" creationId="{9078C77D-C6A8-F12D-EB8C-53E6A3139D24}"/>
          </ac:spMkLst>
        </pc:spChg>
        <pc:spChg chg="mod">
          <ac:chgData name="Sartorius, Carol" userId="717f8656-0c6f-4128-8672-6a166f4ce149" providerId="ADAL" clId="{2F088F5A-5D4A-4C38-BFF7-EC151CC291D0}" dt="2024-09-22T22:49:31.649" v="458" actId="164"/>
          <ac:spMkLst>
            <pc:docMk/>
            <pc:sldMk cId="3004741895" sldId="264"/>
            <ac:spMk id="30" creationId="{BA5BB1B0-1931-2FBE-3554-D58D86DC6C18}"/>
          </ac:spMkLst>
        </pc:spChg>
        <pc:spChg chg="mod">
          <ac:chgData name="Sartorius, Carol" userId="717f8656-0c6f-4128-8672-6a166f4ce149" providerId="ADAL" clId="{2F088F5A-5D4A-4C38-BFF7-EC151CC291D0}" dt="2024-09-22T22:47:58.007" v="457" actId="164"/>
          <ac:spMkLst>
            <pc:docMk/>
            <pc:sldMk cId="3004741895" sldId="264"/>
            <ac:spMk id="32" creationId="{957F91A5-3EFA-B3E3-8D12-E7425B5BD4AB}"/>
          </ac:spMkLst>
        </pc:spChg>
        <pc:spChg chg="mod">
          <ac:chgData name="Sartorius, Carol" userId="717f8656-0c6f-4128-8672-6a166f4ce149" providerId="ADAL" clId="{2F088F5A-5D4A-4C38-BFF7-EC151CC291D0}" dt="2024-09-22T22:47:58.007" v="457" actId="164"/>
          <ac:spMkLst>
            <pc:docMk/>
            <pc:sldMk cId="3004741895" sldId="264"/>
            <ac:spMk id="33" creationId="{DD4BD6C1-6F7B-1D90-28B5-91A97BC6398A}"/>
          </ac:spMkLst>
        </pc:spChg>
        <pc:spChg chg="mod">
          <ac:chgData name="Sartorius, Carol" userId="717f8656-0c6f-4128-8672-6a166f4ce149" providerId="ADAL" clId="{2F088F5A-5D4A-4C38-BFF7-EC151CC291D0}" dt="2024-09-22T22:49:31.649" v="458" actId="164"/>
          <ac:spMkLst>
            <pc:docMk/>
            <pc:sldMk cId="3004741895" sldId="264"/>
            <ac:spMk id="35" creationId="{08DF3DEB-C514-9752-EA92-218D2AE6A5C3}"/>
          </ac:spMkLst>
        </pc:spChg>
        <pc:spChg chg="mod">
          <ac:chgData name="Sartorius, Carol" userId="717f8656-0c6f-4128-8672-6a166f4ce149" providerId="ADAL" clId="{2F088F5A-5D4A-4C38-BFF7-EC151CC291D0}" dt="2024-09-22T22:49:31.649" v="458" actId="164"/>
          <ac:spMkLst>
            <pc:docMk/>
            <pc:sldMk cId="3004741895" sldId="264"/>
            <ac:spMk id="36" creationId="{B95B00F6-B357-1F52-3B9E-3C2C0659F804}"/>
          </ac:spMkLst>
        </pc:spChg>
        <pc:spChg chg="add mod">
          <ac:chgData name="Sartorius, Carol" userId="717f8656-0c6f-4128-8672-6a166f4ce149" providerId="ADAL" clId="{2F088F5A-5D4A-4C38-BFF7-EC151CC291D0}" dt="2024-09-30T03:10:36.218" v="2137" actId="404"/>
          <ac:spMkLst>
            <pc:docMk/>
            <pc:sldMk cId="3004741895" sldId="264"/>
            <ac:spMk id="53" creationId="{917D5808-3EF0-F357-9D97-5D95633AF724}"/>
          </ac:spMkLst>
        </pc:spChg>
        <pc:spChg chg="mod">
          <ac:chgData name="Sartorius, Carol" userId="717f8656-0c6f-4128-8672-6a166f4ce149" providerId="ADAL" clId="{2F088F5A-5D4A-4C38-BFF7-EC151CC291D0}" dt="2024-09-22T22:46:52.995" v="414" actId="164"/>
          <ac:spMkLst>
            <pc:docMk/>
            <pc:sldMk cId="3004741895" sldId="264"/>
            <ac:spMk id="68" creationId="{53D6B75E-FE3D-5E4B-0987-E42AFFB0BAA9}"/>
          </ac:spMkLst>
        </pc:spChg>
        <pc:spChg chg="mod">
          <ac:chgData name="Sartorius, Carol" userId="717f8656-0c6f-4128-8672-6a166f4ce149" providerId="ADAL" clId="{2F088F5A-5D4A-4C38-BFF7-EC151CC291D0}" dt="2024-09-22T22:46:52.995" v="414" actId="164"/>
          <ac:spMkLst>
            <pc:docMk/>
            <pc:sldMk cId="3004741895" sldId="264"/>
            <ac:spMk id="69" creationId="{408464C1-A778-7B3C-D9B1-0771B3C69EB9}"/>
          </ac:spMkLst>
        </pc:spChg>
        <pc:spChg chg="mod">
          <ac:chgData name="Sartorius, Carol" userId="717f8656-0c6f-4128-8672-6a166f4ce149" providerId="ADAL" clId="{2F088F5A-5D4A-4C38-BFF7-EC151CC291D0}" dt="2024-09-22T22:46:52.995" v="414" actId="164"/>
          <ac:spMkLst>
            <pc:docMk/>
            <pc:sldMk cId="3004741895" sldId="264"/>
            <ac:spMk id="71" creationId="{CCFC4192-589E-CEE2-CDAF-82E42E6F3B99}"/>
          </ac:spMkLst>
        </pc:spChg>
        <pc:spChg chg="mod">
          <ac:chgData name="Sartorius, Carol" userId="717f8656-0c6f-4128-8672-6a166f4ce149" providerId="ADAL" clId="{2F088F5A-5D4A-4C38-BFF7-EC151CC291D0}" dt="2024-09-22T22:46:52.995" v="414" actId="164"/>
          <ac:spMkLst>
            <pc:docMk/>
            <pc:sldMk cId="3004741895" sldId="264"/>
            <ac:spMk id="72" creationId="{67CC8A78-7638-691D-1CD4-3A9BAB7DB335}"/>
          </ac:spMkLst>
        </pc:spChg>
        <pc:spChg chg="mod">
          <ac:chgData name="Sartorius, Carol" userId="717f8656-0c6f-4128-8672-6a166f4ce149" providerId="ADAL" clId="{2F088F5A-5D4A-4C38-BFF7-EC151CC291D0}" dt="2024-09-22T22:46:52.995" v="414" actId="164"/>
          <ac:spMkLst>
            <pc:docMk/>
            <pc:sldMk cId="3004741895" sldId="264"/>
            <ac:spMk id="73" creationId="{97E5746A-6A8E-8A14-F506-B2CD65F09F64}"/>
          </ac:spMkLst>
        </pc:spChg>
        <pc:spChg chg="mod">
          <ac:chgData name="Sartorius, Carol" userId="717f8656-0c6f-4128-8672-6a166f4ce149" providerId="ADAL" clId="{2F088F5A-5D4A-4C38-BFF7-EC151CC291D0}" dt="2024-09-22T22:46:52.995" v="414" actId="164"/>
          <ac:spMkLst>
            <pc:docMk/>
            <pc:sldMk cId="3004741895" sldId="264"/>
            <ac:spMk id="74" creationId="{50961BF8-56DB-2A99-FED5-411254C54A11}"/>
          </ac:spMkLst>
        </pc:spChg>
        <pc:spChg chg="mod">
          <ac:chgData name="Sartorius, Carol" userId="717f8656-0c6f-4128-8672-6a166f4ce149" providerId="ADAL" clId="{2F088F5A-5D4A-4C38-BFF7-EC151CC291D0}" dt="2024-09-22T22:46:52.995" v="414" actId="164"/>
          <ac:spMkLst>
            <pc:docMk/>
            <pc:sldMk cId="3004741895" sldId="264"/>
            <ac:spMk id="75" creationId="{9F4D6A45-7C89-ECA0-3722-15F55F169E6C}"/>
          </ac:spMkLst>
        </pc:spChg>
        <pc:spChg chg="mod">
          <ac:chgData name="Sartorius, Carol" userId="717f8656-0c6f-4128-8672-6a166f4ce149" providerId="ADAL" clId="{2F088F5A-5D4A-4C38-BFF7-EC151CC291D0}" dt="2024-09-22T22:49:54.461" v="459" actId="164"/>
          <ac:spMkLst>
            <pc:docMk/>
            <pc:sldMk cId="3004741895" sldId="264"/>
            <ac:spMk id="76" creationId="{DA83A3EA-D053-3F31-9864-7229FFE30D56}"/>
          </ac:spMkLst>
        </pc:spChg>
        <pc:spChg chg="mod">
          <ac:chgData name="Sartorius, Carol" userId="717f8656-0c6f-4128-8672-6a166f4ce149" providerId="ADAL" clId="{2F088F5A-5D4A-4C38-BFF7-EC151CC291D0}" dt="2024-09-22T22:46:52.995" v="414" actId="164"/>
          <ac:spMkLst>
            <pc:docMk/>
            <pc:sldMk cId="3004741895" sldId="264"/>
            <ac:spMk id="77" creationId="{138FD98E-45FA-3AED-839E-2693F7ED2F8E}"/>
          </ac:spMkLst>
        </pc:spChg>
        <pc:spChg chg="mod">
          <ac:chgData name="Sartorius, Carol" userId="717f8656-0c6f-4128-8672-6a166f4ce149" providerId="ADAL" clId="{2F088F5A-5D4A-4C38-BFF7-EC151CC291D0}" dt="2024-09-22T22:46:52.995" v="414" actId="164"/>
          <ac:spMkLst>
            <pc:docMk/>
            <pc:sldMk cId="3004741895" sldId="264"/>
            <ac:spMk id="78" creationId="{C5E38AE7-DE7B-DF1D-F25E-9F1CC19C4C35}"/>
          </ac:spMkLst>
        </pc:spChg>
        <pc:spChg chg="mod">
          <ac:chgData name="Sartorius, Carol" userId="717f8656-0c6f-4128-8672-6a166f4ce149" providerId="ADAL" clId="{2F088F5A-5D4A-4C38-BFF7-EC151CC291D0}" dt="2024-09-22T22:46:52.995" v="414" actId="164"/>
          <ac:spMkLst>
            <pc:docMk/>
            <pc:sldMk cId="3004741895" sldId="264"/>
            <ac:spMk id="79" creationId="{873056B1-9E5A-C229-7EB1-A230C64E8AB7}"/>
          </ac:spMkLst>
        </pc:spChg>
        <pc:spChg chg="mod">
          <ac:chgData name="Sartorius, Carol" userId="717f8656-0c6f-4128-8672-6a166f4ce149" providerId="ADAL" clId="{2F088F5A-5D4A-4C38-BFF7-EC151CC291D0}" dt="2024-09-22T22:46:52.995" v="414" actId="164"/>
          <ac:spMkLst>
            <pc:docMk/>
            <pc:sldMk cId="3004741895" sldId="264"/>
            <ac:spMk id="80" creationId="{5E0B69B2-5469-64DA-BB9C-4F566A454CCD}"/>
          </ac:spMkLst>
        </pc:spChg>
        <pc:spChg chg="mod">
          <ac:chgData name="Sartorius, Carol" userId="717f8656-0c6f-4128-8672-6a166f4ce149" providerId="ADAL" clId="{2F088F5A-5D4A-4C38-BFF7-EC151CC291D0}" dt="2024-09-22T22:46:52.995" v="414" actId="164"/>
          <ac:spMkLst>
            <pc:docMk/>
            <pc:sldMk cId="3004741895" sldId="264"/>
            <ac:spMk id="81" creationId="{9002CDE1-E33E-A969-0041-45738DAAE29B}"/>
          </ac:spMkLst>
        </pc:spChg>
        <pc:spChg chg="mod">
          <ac:chgData name="Sartorius, Carol" userId="717f8656-0c6f-4128-8672-6a166f4ce149" providerId="ADAL" clId="{2F088F5A-5D4A-4C38-BFF7-EC151CC291D0}" dt="2024-09-22T22:46:52.995" v="414" actId="164"/>
          <ac:spMkLst>
            <pc:docMk/>
            <pc:sldMk cId="3004741895" sldId="264"/>
            <ac:spMk id="82" creationId="{D00FC496-A1D5-3D3A-6BAC-15BF64BB061B}"/>
          </ac:spMkLst>
        </pc:spChg>
        <pc:spChg chg="mod">
          <ac:chgData name="Sartorius, Carol" userId="717f8656-0c6f-4128-8672-6a166f4ce149" providerId="ADAL" clId="{2F088F5A-5D4A-4C38-BFF7-EC151CC291D0}" dt="2024-09-22T22:46:52.995" v="414" actId="164"/>
          <ac:spMkLst>
            <pc:docMk/>
            <pc:sldMk cId="3004741895" sldId="264"/>
            <ac:spMk id="83" creationId="{6FBED441-268A-6C7E-BD6C-1743B673BDA2}"/>
          </ac:spMkLst>
        </pc:spChg>
        <pc:spChg chg="mod">
          <ac:chgData name="Sartorius, Carol" userId="717f8656-0c6f-4128-8672-6a166f4ce149" providerId="ADAL" clId="{2F088F5A-5D4A-4C38-BFF7-EC151CC291D0}" dt="2024-09-22T22:46:52.995" v="414" actId="164"/>
          <ac:spMkLst>
            <pc:docMk/>
            <pc:sldMk cId="3004741895" sldId="264"/>
            <ac:spMk id="84" creationId="{5143B970-10DD-1A35-4278-7F45955EC5C6}"/>
          </ac:spMkLst>
        </pc:spChg>
        <pc:spChg chg="mod">
          <ac:chgData name="Sartorius, Carol" userId="717f8656-0c6f-4128-8672-6a166f4ce149" providerId="ADAL" clId="{2F088F5A-5D4A-4C38-BFF7-EC151CC291D0}" dt="2024-09-22T22:46:52.995" v="414" actId="164"/>
          <ac:spMkLst>
            <pc:docMk/>
            <pc:sldMk cId="3004741895" sldId="264"/>
            <ac:spMk id="86" creationId="{91558488-26DF-4E3C-58C2-BB8CF128C72E}"/>
          </ac:spMkLst>
        </pc:spChg>
        <pc:spChg chg="mod">
          <ac:chgData name="Sartorius, Carol" userId="717f8656-0c6f-4128-8672-6a166f4ce149" providerId="ADAL" clId="{2F088F5A-5D4A-4C38-BFF7-EC151CC291D0}" dt="2024-09-22T22:46:52.995" v="414" actId="164"/>
          <ac:spMkLst>
            <pc:docMk/>
            <pc:sldMk cId="3004741895" sldId="264"/>
            <ac:spMk id="87" creationId="{243649CC-E37E-8678-7BAC-5389D6731FAC}"/>
          </ac:spMkLst>
        </pc:spChg>
        <pc:spChg chg="mod">
          <ac:chgData name="Sartorius, Carol" userId="717f8656-0c6f-4128-8672-6a166f4ce149" providerId="ADAL" clId="{2F088F5A-5D4A-4C38-BFF7-EC151CC291D0}" dt="2024-09-22T22:46:52.995" v="414" actId="164"/>
          <ac:spMkLst>
            <pc:docMk/>
            <pc:sldMk cId="3004741895" sldId="264"/>
            <ac:spMk id="88" creationId="{99F3D82F-F6EE-93A7-F44C-3FEE08EA0284}"/>
          </ac:spMkLst>
        </pc:spChg>
        <pc:spChg chg="mod">
          <ac:chgData name="Sartorius, Carol" userId="717f8656-0c6f-4128-8672-6a166f4ce149" providerId="ADAL" clId="{2F088F5A-5D4A-4C38-BFF7-EC151CC291D0}" dt="2024-09-22T22:46:52.995" v="414" actId="164"/>
          <ac:spMkLst>
            <pc:docMk/>
            <pc:sldMk cId="3004741895" sldId="264"/>
            <ac:spMk id="89" creationId="{760052A8-AD70-509B-CC58-F5A7684DD03C}"/>
          </ac:spMkLst>
        </pc:spChg>
        <pc:spChg chg="mod">
          <ac:chgData name="Sartorius, Carol" userId="717f8656-0c6f-4128-8672-6a166f4ce149" providerId="ADAL" clId="{2F088F5A-5D4A-4C38-BFF7-EC151CC291D0}" dt="2024-09-22T22:46:52.995" v="414" actId="164"/>
          <ac:spMkLst>
            <pc:docMk/>
            <pc:sldMk cId="3004741895" sldId="264"/>
            <ac:spMk id="90" creationId="{5FAFC11A-AE30-33A6-8CD3-E17CAD004000}"/>
          </ac:spMkLst>
        </pc:spChg>
        <pc:spChg chg="mod">
          <ac:chgData name="Sartorius, Carol" userId="717f8656-0c6f-4128-8672-6a166f4ce149" providerId="ADAL" clId="{2F088F5A-5D4A-4C38-BFF7-EC151CC291D0}" dt="2024-09-22T22:46:52.995" v="414" actId="164"/>
          <ac:spMkLst>
            <pc:docMk/>
            <pc:sldMk cId="3004741895" sldId="264"/>
            <ac:spMk id="91" creationId="{12FB701E-98FD-0AB2-2AF9-8977CE5DE2EA}"/>
          </ac:spMkLst>
        </pc:spChg>
        <pc:spChg chg="mod">
          <ac:chgData name="Sartorius, Carol" userId="717f8656-0c6f-4128-8672-6a166f4ce149" providerId="ADAL" clId="{2F088F5A-5D4A-4C38-BFF7-EC151CC291D0}" dt="2024-09-22T22:46:52.995" v="414" actId="164"/>
          <ac:spMkLst>
            <pc:docMk/>
            <pc:sldMk cId="3004741895" sldId="264"/>
            <ac:spMk id="92" creationId="{A2C3F980-7447-4D32-61AC-05BDAAA494C6}"/>
          </ac:spMkLst>
        </pc:spChg>
        <pc:spChg chg="mod">
          <ac:chgData name="Sartorius, Carol" userId="717f8656-0c6f-4128-8672-6a166f4ce149" providerId="ADAL" clId="{2F088F5A-5D4A-4C38-BFF7-EC151CC291D0}" dt="2024-09-22T22:46:52.995" v="414" actId="164"/>
          <ac:spMkLst>
            <pc:docMk/>
            <pc:sldMk cId="3004741895" sldId="264"/>
            <ac:spMk id="93" creationId="{20EF108E-FB1C-9AE8-E285-2239D729F152}"/>
          </ac:spMkLst>
        </pc:spChg>
        <pc:spChg chg="mod">
          <ac:chgData name="Sartorius, Carol" userId="717f8656-0c6f-4128-8672-6a166f4ce149" providerId="ADAL" clId="{2F088F5A-5D4A-4C38-BFF7-EC151CC291D0}" dt="2024-09-22T22:46:52.995" v="414" actId="164"/>
          <ac:spMkLst>
            <pc:docMk/>
            <pc:sldMk cId="3004741895" sldId="264"/>
            <ac:spMk id="94" creationId="{D977774C-7E7F-800A-E3D1-B5B30586FE42}"/>
          </ac:spMkLst>
        </pc:spChg>
        <pc:spChg chg="mod">
          <ac:chgData name="Sartorius, Carol" userId="717f8656-0c6f-4128-8672-6a166f4ce149" providerId="ADAL" clId="{2F088F5A-5D4A-4C38-BFF7-EC151CC291D0}" dt="2024-09-22T22:46:52.995" v="414" actId="164"/>
          <ac:spMkLst>
            <pc:docMk/>
            <pc:sldMk cId="3004741895" sldId="264"/>
            <ac:spMk id="95" creationId="{73529A55-82DE-573B-6CDB-04FC92122FEF}"/>
          </ac:spMkLst>
        </pc:spChg>
        <pc:spChg chg="mod">
          <ac:chgData name="Sartorius, Carol" userId="717f8656-0c6f-4128-8672-6a166f4ce149" providerId="ADAL" clId="{2F088F5A-5D4A-4C38-BFF7-EC151CC291D0}" dt="2024-09-22T22:46:52.995" v="414" actId="164"/>
          <ac:spMkLst>
            <pc:docMk/>
            <pc:sldMk cId="3004741895" sldId="264"/>
            <ac:spMk id="96" creationId="{8369E298-1B6B-8338-2696-78C4AE9413AC}"/>
          </ac:spMkLst>
        </pc:spChg>
        <pc:spChg chg="mod">
          <ac:chgData name="Sartorius, Carol" userId="717f8656-0c6f-4128-8672-6a166f4ce149" providerId="ADAL" clId="{2F088F5A-5D4A-4C38-BFF7-EC151CC291D0}" dt="2024-09-22T22:46:52.995" v="414" actId="164"/>
          <ac:spMkLst>
            <pc:docMk/>
            <pc:sldMk cId="3004741895" sldId="264"/>
            <ac:spMk id="99" creationId="{4166230F-92E9-414F-CD73-4174909E7BA8}"/>
          </ac:spMkLst>
        </pc:spChg>
        <pc:spChg chg="mod">
          <ac:chgData name="Sartorius, Carol" userId="717f8656-0c6f-4128-8672-6a166f4ce149" providerId="ADAL" clId="{2F088F5A-5D4A-4C38-BFF7-EC151CC291D0}" dt="2024-09-22T22:46:52.995" v="414" actId="164"/>
          <ac:spMkLst>
            <pc:docMk/>
            <pc:sldMk cId="3004741895" sldId="264"/>
            <ac:spMk id="100" creationId="{521757FA-7917-3CF2-740E-7767AB913C76}"/>
          </ac:spMkLst>
        </pc:spChg>
        <pc:spChg chg="mod">
          <ac:chgData name="Sartorius, Carol" userId="717f8656-0c6f-4128-8672-6a166f4ce149" providerId="ADAL" clId="{2F088F5A-5D4A-4C38-BFF7-EC151CC291D0}" dt="2024-09-30T03:10:50.615" v="2141" actId="552"/>
          <ac:spMkLst>
            <pc:docMk/>
            <pc:sldMk cId="3004741895" sldId="264"/>
            <ac:spMk id="102" creationId="{B60004C9-2797-2AB6-D9BE-481A07013CAA}"/>
          </ac:spMkLst>
        </pc:spChg>
        <pc:spChg chg="mod">
          <ac:chgData name="Sartorius, Carol" userId="717f8656-0c6f-4128-8672-6a166f4ce149" providerId="ADAL" clId="{2F088F5A-5D4A-4C38-BFF7-EC151CC291D0}" dt="2024-09-30T03:10:50.615" v="2141" actId="552"/>
          <ac:spMkLst>
            <pc:docMk/>
            <pc:sldMk cId="3004741895" sldId="264"/>
            <ac:spMk id="103" creationId="{4FDCB41D-7B05-F41E-DFCE-4F73845975E6}"/>
          </ac:spMkLst>
        </pc:spChg>
        <pc:spChg chg="del">
          <ac:chgData name="Sartorius, Carol" userId="717f8656-0c6f-4128-8672-6a166f4ce149" providerId="ADAL" clId="{2F088F5A-5D4A-4C38-BFF7-EC151CC291D0}" dt="2024-09-22T22:55:38.351" v="537" actId="478"/>
          <ac:spMkLst>
            <pc:docMk/>
            <pc:sldMk cId="3004741895" sldId="264"/>
            <ac:spMk id="104" creationId="{D1C28608-478D-CDB4-F727-A3BB23416297}"/>
          </ac:spMkLst>
        </pc:spChg>
        <pc:spChg chg="mod">
          <ac:chgData name="Sartorius, Carol" userId="717f8656-0c6f-4128-8672-6a166f4ce149" providerId="ADAL" clId="{2F088F5A-5D4A-4C38-BFF7-EC151CC291D0}" dt="2024-09-30T03:10:50.615" v="2141" actId="552"/>
          <ac:spMkLst>
            <pc:docMk/>
            <pc:sldMk cId="3004741895" sldId="264"/>
            <ac:spMk id="106" creationId="{79360BE7-6436-C25E-57B8-A41EB6D7D8B2}"/>
          </ac:spMkLst>
        </pc:spChg>
        <pc:grpChg chg="add mod">
          <ac:chgData name="Sartorius, Carol" userId="717f8656-0c6f-4128-8672-6a166f4ce149" providerId="ADAL" clId="{2F088F5A-5D4A-4C38-BFF7-EC151CC291D0}" dt="2024-09-22T22:49:54.461" v="459" actId="164"/>
          <ac:grpSpMkLst>
            <pc:docMk/>
            <pc:sldMk cId="3004741895" sldId="264"/>
            <ac:grpSpMk id="2" creationId="{313D7ECB-B645-EE37-38ED-7B8F0A58EDD0}"/>
          </ac:grpSpMkLst>
        </pc:grpChg>
        <pc:grpChg chg="add del mod">
          <ac:chgData name="Sartorius, Carol" userId="717f8656-0c6f-4128-8672-6a166f4ce149" providerId="ADAL" clId="{2F088F5A-5D4A-4C38-BFF7-EC151CC291D0}" dt="2024-09-22T22:52:02.954" v="487" actId="164"/>
          <ac:grpSpMkLst>
            <pc:docMk/>
            <pc:sldMk cId="3004741895" sldId="264"/>
            <ac:grpSpMk id="4" creationId="{9B6BC9EB-9986-596B-D835-A615830C290E}"/>
          </ac:grpSpMkLst>
        </pc:grpChg>
        <pc:grpChg chg="add del mod">
          <ac:chgData name="Sartorius, Carol" userId="717f8656-0c6f-4128-8672-6a166f4ce149" providerId="ADAL" clId="{2F088F5A-5D4A-4C38-BFF7-EC151CC291D0}" dt="2024-09-22T22:52:07.289" v="488" actId="164"/>
          <ac:grpSpMkLst>
            <pc:docMk/>
            <pc:sldMk cId="3004741895" sldId="264"/>
            <ac:grpSpMk id="6" creationId="{FE5259D8-D263-D017-5685-E344DF526AEF}"/>
          </ac:grpSpMkLst>
        </pc:grpChg>
        <pc:grpChg chg="add del mod">
          <ac:chgData name="Sartorius, Carol" userId="717f8656-0c6f-4128-8672-6a166f4ce149" providerId="ADAL" clId="{2F088F5A-5D4A-4C38-BFF7-EC151CC291D0}" dt="2024-09-22T22:53:06.338" v="497" actId="478"/>
          <ac:grpSpMkLst>
            <pc:docMk/>
            <pc:sldMk cId="3004741895" sldId="264"/>
            <ac:grpSpMk id="31" creationId="{859ACFF0-41C0-56B5-6DA8-B8FED3FEDD32}"/>
          </ac:grpSpMkLst>
        </pc:grpChg>
        <pc:grpChg chg="add del mod">
          <ac:chgData name="Sartorius, Carol" userId="717f8656-0c6f-4128-8672-6a166f4ce149" providerId="ADAL" clId="{2F088F5A-5D4A-4C38-BFF7-EC151CC291D0}" dt="2024-09-22T22:54:11.185" v="512" actId="478"/>
          <ac:grpSpMkLst>
            <pc:docMk/>
            <pc:sldMk cId="3004741895" sldId="264"/>
            <ac:grpSpMk id="42" creationId="{869C1F90-78A6-B3A5-60C4-6E5A4DF2DD01}"/>
          </ac:grpSpMkLst>
        </pc:grpChg>
        <pc:grpChg chg="add del mod">
          <ac:chgData name="Sartorius, Carol" userId="717f8656-0c6f-4128-8672-6a166f4ce149" providerId="ADAL" clId="{2F088F5A-5D4A-4C38-BFF7-EC151CC291D0}" dt="2024-09-22T22:54:13.314" v="513" actId="478"/>
          <ac:grpSpMkLst>
            <pc:docMk/>
            <pc:sldMk cId="3004741895" sldId="264"/>
            <ac:grpSpMk id="43" creationId="{972C2A94-0456-8677-3375-170F296E89E0}"/>
          </ac:grpSpMkLst>
        </pc:grpChg>
        <pc:picChg chg="mod">
          <ac:chgData name="Sartorius, Carol" userId="717f8656-0c6f-4128-8672-6a166f4ce149" providerId="ADAL" clId="{2F088F5A-5D4A-4C38-BFF7-EC151CC291D0}" dt="2024-09-22T22:49:31.649" v="458" actId="164"/>
          <ac:picMkLst>
            <pc:docMk/>
            <pc:sldMk cId="3004741895" sldId="264"/>
            <ac:picMk id="3" creationId="{387663DB-FC93-39FF-81A3-75B0A27C1E0C}"/>
          </ac:picMkLst>
        </pc:picChg>
        <pc:picChg chg="mod">
          <ac:chgData name="Sartorius, Carol" userId="717f8656-0c6f-4128-8672-6a166f4ce149" providerId="ADAL" clId="{2F088F5A-5D4A-4C38-BFF7-EC151CC291D0}" dt="2024-09-22T22:47:58.007" v="457" actId="164"/>
          <ac:picMkLst>
            <pc:docMk/>
            <pc:sldMk cId="3004741895" sldId="264"/>
            <ac:picMk id="5" creationId="{FBCCF87B-54B6-78B8-84E5-99FAD3641F55}"/>
          </ac:picMkLst>
        </pc:picChg>
        <pc:picChg chg="add mod">
          <ac:chgData name="Sartorius, Carol" userId="717f8656-0c6f-4128-8672-6a166f4ce149" providerId="ADAL" clId="{2F088F5A-5D4A-4C38-BFF7-EC151CC291D0}" dt="2024-09-22T22:51:37.612" v="484" actId="1076"/>
          <ac:picMkLst>
            <pc:docMk/>
            <pc:sldMk cId="3004741895" sldId="264"/>
            <ac:picMk id="37" creationId="{F487BD82-B54D-5643-FE95-88B5628C7A90}"/>
          </ac:picMkLst>
        </pc:picChg>
        <pc:picChg chg="add mod">
          <ac:chgData name="Sartorius, Carol" userId="717f8656-0c6f-4128-8672-6a166f4ce149" providerId="ADAL" clId="{2F088F5A-5D4A-4C38-BFF7-EC151CC291D0}" dt="2024-09-22T22:51:37.612" v="484" actId="1076"/>
          <ac:picMkLst>
            <pc:docMk/>
            <pc:sldMk cId="3004741895" sldId="264"/>
            <ac:picMk id="39" creationId="{C7B9B6A5-AC34-5070-CCCB-29AA5DE42786}"/>
          </ac:picMkLst>
        </pc:picChg>
        <pc:picChg chg="add mod">
          <ac:chgData name="Sartorius, Carol" userId="717f8656-0c6f-4128-8672-6a166f4ce149" providerId="ADAL" clId="{2F088F5A-5D4A-4C38-BFF7-EC151CC291D0}" dt="2024-09-22T22:51:37.612" v="484" actId="1076"/>
          <ac:picMkLst>
            <pc:docMk/>
            <pc:sldMk cId="3004741895" sldId="264"/>
            <ac:picMk id="41" creationId="{AE66F225-10DF-E94C-5165-6666699CDE56}"/>
          </ac:picMkLst>
        </pc:picChg>
        <pc:picChg chg="add mod modCrop">
          <ac:chgData name="Sartorius, Carol" userId="717f8656-0c6f-4128-8672-6a166f4ce149" providerId="ADAL" clId="{2F088F5A-5D4A-4C38-BFF7-EC151CC291D0}" dt="2024-09-22T22:56:55.351" v="651" actId="1035"/>
          <ac:picMkLst>
            <pc:docMk/>
            <pc:sldMk cId="3004741895" sldId="264"/>
            <ac:picMk id="45" creationId="{C0ADE59B-6333-FF1A-8C0D-CB754080610C}"/>
          </ac:picMkLst>
        </pc:picChg>
        <pc:picChg chg="add del mod">
          <ac:chgData name="Sartorius, Carol" userId="717f8656-0c6f-4128-8672-6a166f4ce149" providerId="ADAL" clId="{2F088F5A-5D4A-4C38-BFF7-EC151CC291D0}" dt="2024-09-22T22:53:25.258" v="502" actId="478"/>
          <ac:picMkLst>
            <pc:docMk/>
            <pc:sldMk cId="3004741895" sldId="264"/>
            <ac:picMk id="47" creationId="{0C6A269C-B8F6-C436-9493-55C147DF71DC}"/>
          </ac:picMkLst>
        </pc:picChg>
        <pc:picChg chg="add mod modCrop">
          <ac:chgData name="Sartorius, Carol" userId="717f8656-0c6f-4128-8672-6a166f4ce149" providerId="ADAL" clId="{2F088F5A-5D4A-4C38-BFF7-EC151CC291D0}" dt="2024-09-22T22:57:06.073" v="653" actId="732"/>
          <ac:picMkLst>
            <pc:docMk/>
            <pc:sldMk cId="3004741895" sldId="264"/>
            <ac:picMk id="49" creationId="{73840464-BEB4-6005-1B1E-BF7F7543ED3B}"/>
          </ac:picMkLst>
        </pc:picChg>
        <pc:picChg chg="add mod modCrop">
          <ac:chgData name="Sartorius, Carol" userId="717f8656-0c6f-4128-8672-6a166f4ce149" providerId="ADAL" clId="{2F088F5A-5D4A-4C38-BFF7-EC151CC291D0}" dt="2024-09-22T22:57:01.427" v="652" actId="732"/>
          <ac:picMkLst>
            <pc:docMk/>
            <pc:sldMk cId="3004741895" sldId="264"/>
            <ac:picMk id="51" creationId="{503FAFF3-FA14-250E-3890-83333D5BE890}"/>
          </ac:picMkLst>
        </pc:picChg>
        <pc:picChg chg="mod">
          <ac:chgData name="Sartorius, Carol" userId="717f8656-0c6f-4128-8672-6a166f4ce149" providerId="ADAL" clId="{2F088F5A-5D4A-4C38-BFF7-EC151CC291D0}" dt="2024-09-22T22:46:52.995" v="414" actId="164"/>
          <ac:picMkLst>
            <pc:docMk/>
            <pc:sldMk cId="3004741895" sldId="264"/>
            <ac:picMk id="66" creationId="{C6F181DC-8053-8078-1092-A2A974781653}"/>
          </ac:picMkLst>
        </pc:picChg>
        <pc:picChg chg="mod">
          <ac:chgData name="Sartorius, Carol" userId="717f8656-0c6f-4128-8672-6a166f4ce149" providerId="ADAL" clId="{2F088F5A-5D4A-4C38-BFF7-EC151CC291D0}" dt="2024-09-22T22:46:52.995" v="414" actId="164"/>
          <ac:picMkLst>
            <pc:docMk/>
            <pc:sldMk cId="3004741895" sldId="264"/>
            <ac:picMk id="67" creationId="{840B3CF0-15A4-982E-7230-D4FD3CA0E0EF}"/>
          </ac:picMkLst>
        </pc:picChg>
        <pc:picChg chg="mod">
          <ac:chgData name="Sartorius, Carol" userId="717f8656-0c6f-4128-8672-6a166f4ce149" providerId="ADAL" clId="{2F088F5A-5D4A-4C38-BFF7-EC151CC291D0}" dt="2024-09-22T22:46:52.995" v="414" actId="164"/>
          <ac:picMkLst>
            <pc:docMk/>
            <pc:sldMk cId="3004741895" sldId="264"/>
            <ac:picMk id="70" creationId="{58653D6B-2F50-31AE-1FEF-F0FFFB7A439E}"/>
          </ac:picMkLst>
        </pc:picChg>
        <pc:picChg chg="mod">
          <ac:chgData name="Sartorius, Carol" userId="717f8656-0c6f-4128-8672-6a166f4ce149" providerId="ADAL" clId="{2F088F5A-5D4A-4C38-BFF7-EC151CC291D0}" dt="2024-09-22T22:46:52.995" v="414" actId="164"/>
          <ac:picMkLst>
            <pc:docMk/>
            <pc:sldMk cId="3004741895" sldId="264"/>
            <ac:picMk id="98" creationId="{17B7A5CC-2BE8-9043-B6E9-230B66C46964}"/>
          </ac:picMkLst>
        </pc:picChg>
        <pc:picChg chg="mod">
          <ac:chgData name="Sartorius, Carol" userId="717f8656-0c6f-4128-8672-6a166f4ce149" providerId="ADAL" clId="{2F088F5A-5D4A-4C38-BFF7-EC151CC291D0}" dt="2024-09-22T22:56:19.785" v="617" actId="1076"/>
          <ac:picMkLst>
            <pc:docMk/>
            <pc:sldMk cId="3004741895" sldId="264"/>
            <ac:picMk id="105" creationId="{BE2268C8-0417-4B48-9191-7600AF933CE1}"/>
          </ac:picMkLst>
        </pc:picChg>
        <pc:cxnChg chg="add del mod">
          <ac:chgData name="Sartorius, Carol" userId="717f8656-0c6f-4128-8672-6a166f4ce149" providerId="ADAL" clId="{2F088F5A-5D4A-4C38-BFF7-EC151CC291D0}" dt="2024-09-23T00:53:46.400" v="1287" actId="21"/>
          <ac:cxnSpMkLst>
            <pc:docMk/>
            <pc:sldMk cId="3004741895" sldId="264"/>
            <ac:cxnSpMk id="54" creationId="{6EC4CAB8-6614-E3E0-477D-9FF799252BFB}"/>
          </ac:cxnSpMkLst>
        </pc:cxnChg>
      </pc:sldChg>
      <pc:sldChg chg="addSp delSp modSp mod">
        <pc:chgData name="Sartorius, Carol" userId="717f8656-0c6f-4128-8672-6a166f4ce149" providerId="ADAL" clId="{2F088F5A-5D4A-4C38-BFF7-EC151CC291D0}" dt="2024-09-23T00:52:51.347" v="1180" actId="21"/>
        <pc:sldMkLst>
          <pc:docMk/>
          <pc:sldMk cId="2970839480" sldId="271"/>
        </pc:sldMkLst>
        <pc:spChg chg="add mod">
          <ac:chgData name="Sartorius, Carol" userId="717f8656-0c6f-4128-8672-6a166f4ce149" providerId="ADAL" clId="{2F088F5A-5D4A-4C38-BFF7-EC151CC291D0}" dt="2024-09-23T00:52:00.284" v="1158" actId="313"/>
          <ac:spMkLst>
            <pc:docMk/>
            <pc:sldMk cId="2970839480" sldId="271"/>
            <ac:spMk id="2" creationId="{CA4BBAA9-3AE1-E375-30CE-E08F2A2A3BC8}"/>
          </ac:spMkLst>
        </pc:spChg>
        <pc:spChg chg="mod">
          <ac:chgData name="Sartorius, Carol" userId="717f8656-0c6f-4128-8672-6a166f4ce149" providerId="ADAL" clId="{2F088F5A-5D4A-4C38-BFF7-EC151CC291D0}" dt="2024-09-23T00:51:39.725" v="1154" actId="3064"/>
          <ac:spMkLst>
            <pc:docMk/>
            <pc:sldMk cId="2970839480" sldId="271"/>
            <ac:spMk id="7" creationId="{B36DEFA2-A3E6-02BF-FF86-379460FA3728}"/>
          </ac:spMkLst>
        </pc:spChg>
        <pc:spChg chg="mod">
          <ac:chgData name="Sartorius, Carol" userId="717f8656-0c6f-4128-8672-6a166f4ce149" providerId="ADAL" clId="{2F088F5A-5D4A-4C38-BFF7-EC151CC291D0}" dt="2024-09-23T00:51:44.936" v="1155" actId="108"/>
          <ac:spMkLst>
            <pc:docMk/>
            <pc:sldMk cId="2970839480" sldId="271"/>
            <ac:spMk id="8" creationId="{49D23A22-6F87-D3F3-D1A1-DFD63C2D90B1}"/>
          </ac:spMkLst>
        </pc:spChg>
        <pc:spChg chg="del">
          <ac:chgData name="Sartorius, Carol" userId="717f8656-0c6f-4128-8672-6a166f4ce149" providerId="ADAL" clId="{2F088F5A-5D4A-4C38-BFF7-EC151CC291D0}" dt="2024-09-22T23:07:38.138" v="985" actId="478"/>
          <ac:spMkLst>
            <pc:docMk/>
            <pc:sldMk cId="2970839480" sldId="271"/>
            <ac:spMk id="9" creationId="{ADEDF3AF-6950-98B3-E8A9-079103F36FB5}"/>
          </ac:spMkLst>
        </pc:spChg>
        <pc:picChg chg="mod">
          <ac:chgData name="Sartorius, Carol" userId="717f8656-0c6f-4128-8672-6a166f4ce149" providerId="ADAL" clId="{2F088F5A-5D4A-4C38-BFF7-EC151CC291D0}" dt="2024-09-23T00:51:24.747" v="1153" actId="1035"/>
          <ac:picMkLst>
            <pc:docMk/>
            <pc:sldMk cId="2970839480" sldId="271"/>
            <ac:picMk id="3" creationId="{8300758F-F5B2-57F7-E7A0-BFC87167E1BE}"/>
          </ac:picMkLst>
        </pc:picChg>
        <pc:picChg chg="mod">
          <ac:chgData name="Sartorius, Carol" userId="717f8656-0c6f-4128-8672-6a166f4ce149" providerId="ADAL" clId="{2F088F5A-5D4A-4C38-BFF7-EC151CC291D0}" dt="2024-09-23T00:51:24.747" v="1153" actId="1035"/>
          <ac:picMkLst>
            <pc:docMk/>
            <pc:sldMk cId="2970839480" sldId="271"/>
            <ac:picMk id="10" creationId="{E5231AF4-460D-30B4-93E4-0352EACA0506}"/>
          </ac:picMkLst>
        </pc:picChg>
        <pc:cxnChg chg="add del mod">
          <ac:chgData name="Sartorius, Carol" userId="717f8656-0c6f-4128-8672-6a166f4ce149" providerId="ADAL" clId="{2F088F5A-5D4A-4C38-BFF7-EC151CC291D0}" dt="2024-09-23T00:52:18.124" v="1159" actId="21"/>
          <ac:cxnSpMkLst>
            <pc:docMk/>
            <pc:sldMk cId="2970839480" sldId="271"/>
            <ac:cxnSpMk id="5" creationId="{6EC4CAB8-6614-E3E0-477D-9FF799252BFB}"/>
          </ac:cxnSpMkLst>
        </pc:cxnChg>
        <pc:cxnChg chg="add del mod">
          <ac:chgData name="Sartorius, Carol" userId="717f8656-0c6f-4128-8672-6a166f4ce149" providerId="ADAL" clId="{2F088F5A-5D4A-4C38-BFF7-EC151CC291D0}" dt="2024-09-23T00:52:51.347" v="1180" actId="21"/>
          <ac:cxnSpMkLst>
            <pc:docMk/>
            <pc:sldMk cId="2970839480" sldId="271"/>
            <ac:cxnSpMk id="28" creationId="{6EC4CAB8-6614-E3E0-477D-9FF799252BFB}"/>
          </ac:cxnSpMkLst>
        </pc:cxnChg>
      </pc:sldChg>
      <pc:sldChg chg="addSp delSp modSp mod">
        <pc:chgData name="Sartorius, Carol" userId="717f8656-0c6f-4128-8672-6a166f4ce149" providerId="ADAL" clId="{2F088F5A-5D4A-4C38-BFF7-EC151CC291D0}" dt="2024-10-04T03:07:03.760" v="2325" actId="20577"/>
        <pc:sldMkLst>
          <pc:docMk/>
          <pc:sldMk cId="144900757" sldId="278"/>
        </pc:sldMkLst>
        <pc:spChg chg="del">
          <ac:chgData name="Sartorius, Carol" userId="717f8656-0c6f-4128-8672-6a166f4ce149" providerId="ADAL" clId="{2F088F5A-5D4A-4C38-BFF7-EC151CC291D0}" dt="2024-09-22T23:03:27.917" v="867" actId="478"/>
          <ac:spMkLst>
            <pc:docMk/>
            <pc:sldMk cId="144900757" sldId="278"/>
            <ac:spMk id="2" creationId="{08307884-84C4-ED1C-6DEA-804D78124EEF}"/>
          </ac:spMkLst>
        </pc:spChg>
        <pc:spChg chg="mod">
          <ac:chgData name="Sartorius, Carol" userId="717f8656-0c6f-4128-8672-6a166f4ce149" providerId="ADAL" clId="{2F088F5A-5D4A-4C38-BFF7-EC151CC291D0}" dt="2024-09-22T23:04:02.629" v="869" actId="164"/>
          <ac:spMkLst>
            <pc:docMk/>
            <pc:sldMk cId="144900757" sldId="278"/>
            <ac:spMk id="3" creationId="{D9AAB49F-B530-6E5F-CA69-C47171236633}"/>
          </ac:spMkLst>
        </pc:spChg>
        <pc:spChg chg="mod">
          <ac:chgData name="Sartorius, Carol" userId="717f8656-0c6f-4128-8672-6a166f4ce149" providerId="ADAL" clId="{2F088F5A-5D4A-4C38-BFF7-EC151CC291D0}" dt="2024-09-22T23:06:08.062" v="933" actId="1036"/>
          <ac:spMkLst>
            <pc:docMk/>
            <pc:sldMk cId="144900757" sldId="278"/>
            <ac:spMk id="7" creationId="{224CA08F-BB98-330F-B08D-C2ACF5A18A1C}"/>
          </ac:spMkLst>
        </pc:spChg>
        <pc:spChg chg="mod">
          <ac:chgData name="Sartorius, Carol" userId="717f8656-0c6f-4128-8672-6a166f4ce149" providerId="ADAL" clId="{2F088F5A-5D4A-4C38-BFF7-EC151CC291D0}" dt="2024-09-22T23:06:16.157" v="959" actId="1035"/>
          <ac:spMkLst>
            <pc:docMk/>
            <pc:sldMk cId="144900757" sldId="278"/>
            <ac:spMk id="8" creationId="{74556A17-B5BC-F802-EC0A-F407F5A157C3}"/>
          </ac:spMkLst>
        </pc:spChg>
        <pc:spChg chg="mod">
          <ac:chgData name="Sartorius, Carol" userId="717f8656-0c6f-4128-8672-6a166f4ce149" providerId="ADAL" clId="{2F088F5A-5D4A-4C38-BFF7-EC151CC291D0}" dt="2024-09-22T23:03:55.367" v="868" actId="164"/>
          <ac:spMkLst>
            <pc:docMk/>
            <pc:sldMk cId="144900757" sldId="278"/>
            <ac:spMk id="9" creationId="{74D60753-789C-771B-4DFA-956D3D922785}"/>
          </ac:spMkLst>
        </pc:spChg>
        <pc:spChg chg="mod">
          <ac:chgData name="Sartorius, Carol" userId="717f8656-0c6f-4128-8672-6a166f4ce149" providerId="ADAL" clId="{2F088F5A-5D4A-4C38-BFF7-EC151CC291D0}" dt="2024-09-22T23:04:02.629" v="869" actId="164"/>
          <ac:spMkLst>
            <pc:docMk/>
            <pc:sldMk cId="144900757" sldId="278"/>
            <ac:spMk id="10" creationId="{5589DCA1-8C44-2426-A8D8-B3A0099B3712}"/>
          </ac:spMkLst>
        </pc:spChg>
        <pc:spChg chg="mod">
          <ac:chgData name="Sartorius, Carol" userId="717f8656-0c6f-4128-8672-6a166f4ce149" providerId="ADAL" clId="{2F088F5A-5D4A-4C38-BFF7-EC151CC291D0}" dt="2024-09-22T23:03:55.367" v="868" actId="164"/>
          <ac:spMkLst>
            <pc:docMk/>
            <pc:sldMk cId="144900757" sldId="278"/>
            <ac:spMk id="11" creationId="{7605E70F-8572-2D52-2B67-F8E9BC7BB1C9}"/>
          </ac:spMkLst>
        </pc:spChg>
        <pc:spChg chg="mod">
          <ac:chgData name="Sartorius, Carol" userId="717f8656-0c6f-4128-8672-6a166f4ce149" providerId="ADAL" clId="{2F088F5A-5D4A-4C38-BFF7-EC151CC291D0}" dt="2024-09-22T23:03:55.367" v="868" actId="164"/>
          <ac:spMkLst>
            <pc:docMk/>
            <pc:sldMk cId="144900757" sldId="278"/>
            <ac:spMk id="12" creationId="{2CDB9AF9-BDC6-44BF-CC63-622C9D6490AD}"/>
          </ac:spMkLst>
        </pc:spChg>
        <pc:spChg chg="mod">
          <ac:chgData name="Sartorius, Carol" userId="717f8656-0c6f-4128-8672-6a166f4ce149" providerId="ADAL" clId="{2F088F5A-5D4A-4C38-BFF7-EC151CC291D0}" dt="2024-09-22T23:03:55.367" v="868" actId="164"/>
          <ac:spMkLst>
            <pc:docMk/>
            <pc:sldMk cId="144900757" sldId="278"/>
            <ac:spMk id="13" creationId="{6B467A01-35B2-3C69-D677-ED90951285AE}"/>
          </ac:spMkLst>
        </pc:spChg>
        <pc:spChg chg="mod">
          <ac:chgData name="Sartorius, Carol" userId="717f8656-0c6f-4128-8672-6a166f4ce149" providerId="ADAL" clId="{2F088F5A-5D4A-4C38-BFF7-EC151CC291D0}" dt="2024-09-22T23:03:55.367" v="868" actId="164"/>
          <ac:spMkLst>
            <pc:docMk/>
            <pc:sldMk cId="144900757" sldId="278"/>
            <ac:spMk id="14" creationId="{0978BCA2-8605-F0D9-0C2D-53179EDCF894}"/>
          </ac:spMkLst>
        </pc:spChg>
        <pc:spChg chg="mod">
          <ac:chgData name="Sartorius, Carol" userId="717f8656-0c6f-4128-8672-6a166f4ce149" providerId="ADAL" clId="{2F088F5A-5D4A-4C38-BFF7-EC151CC291D0}" dt="2024-09-22T23:03:55.367" v="868" actId="164"/>
          <ac:spMkLst>
            <pc:docMk/>
            <pc:sldMk cId="144900757" sldId="278"/>
            <ac:spMk id="15" creationId="{B37F142E-C5E2-FC69-3426-97C7FC879F60}"/>
          </ac:spMkLst>
        </pc:spChg>
        <pc:spChg chg="mod">
          <ac:chgData name="Sartorius, Carol" userId="717f8656-0c6f-4128-8672-6a166f4ce149" providerId="ADAL" clId="{2F088F5A-5D4A-4C38-BFF7-EC151CC291D0}" dt="2024-09-22T23:04:02.629" v="869" actId="164"/>
          <ac:spMkLst>
            <pc:docMk/>
            <pc:sldMk cId="144900757" sldId="278"/>
            <ac:spMk id="16" creationId="{79C9334B-3F64-F484-F8CF-E99584029EFE}"/>
          </ac:spMkLst>
        </pc:spChg>
        <pc:spChg chg="mod">
          <ac:chgData name="Sartorius, Carol" userId="717f8656-0c6f-4128-8672-6a166f4ce149" providerId="ADAL" clId="{2F088F5A-5D4A-4C38-BFF7-EC151CC291D0}" dt="2024-09-22T23:04:02.629" v="869" actId="164"/>
          <ac:spMkLst>
            <pc:docMk/>
            <pc:sldMk cId="144900757" sldId="278"/>
            <ac:spMk id="17" creationId="{AA6A8F3D-38D4-4DAA-457A-CAAA48A360BA}"/>
          </ac:spMkLst>
        </pc:spChg>
        <pc:spChg chg="mod">
          <ac:chgData name="Sartorius, Carol" userId="717f8656-0c6f-4128-8672-6a166f4ce149" providerId="ADAL" clId="{2F088F5A-5D4A-4C38-BFF7-EC151CC291D0}" dt="2024-09-22T23:04:02.629" v="869" actId="164"/>
          <ac:spMkLst>
            <pc:docMk/>
            <pc:sldMk cId="144900757" sldId="278"/>
            <ac:spMk id="18" creationId="{24C9ED1D-17F7-98FE-1ED4-B36A145D7A08}"/>
          </ac:spMkLst>
        </pc:spChg>
        <pc:spChg chg="mod">
          <ac:chgData name="Sartorius, Carol" userId="717f8656-0c6f-4128-8672-6a166f4ce149" providerId="ADAL" clId="{2F088F5A-5D4A-4C38-BFF7-EC151CC291D0}" dt="2024-09-22T23:04:02.629" v="869" actId="164"/>
          <ac:spMkLst>
            <pc:docMk/>
            <pc:sldMk cId="144900757" sldId="278"/>
            <ac:spMk id="19" creationId="{B2C9CA2E-A6B9-0725-FC15-A2EAFEF9750E}"/>
          </ac:spMkLst>
        </pc:spChg>
        <pc:spChg chg="add mod">
          <ac:chgData name="Sartorius, Carol" userId="717f8656-0c6f-4128-8672-6a166f4ce149" providerId="ADAL" clId="{2F088F5A-5D4A-4C38-BFF7-EC151CC291D0}" dt="2024-10-04T03:07:03.760" v="2325" actId="20577"/>
          <ac:spMkLst>
            <pc:docMk/>
            <pc:sldMk cId="144900757" sldId="278"/>
            <ac:spMk id="27" creationId="{43BDFAA0-CBD9-C05F-4F54-AC80BA54F02E}"/>
          </ac:spMkLst>
        </pc:spChg>
        <pc:grpChg chg="add del mod">
          <ac:chgData name="Sartorius, Carol" userId="717f8656-0c6f-4128-8672-6a166f4ce149" providerId="ADAL" clId="{2F088F5A-5D4A-4C38-BFF7-EC151CC291D0}" dt="2024-09-22T23:04:54.195" v="875" actId="478"/>
          <ac:grpSpMkLst>
            <pc:docMk/>
            <pc:sldMk cId="144900757" sldId="278"/>
            <ac:grpSpMk id="21" creationId="{5E6A916E-D1C9-27CE-5FFA-456941C6AC7A}"/>
          </ac:grpSpMkLst>
        </pc:grpChg>
        <pc:grpChg chg="add del mod">
          <ac:chgData name="Sartorius, Carol" userId="717f8656-0c6f-4128-8672-6a166f4ce149" providerId="ADAL" clId="{2F088F5A-5D4A-4C38-BFF7-EC151CC291D0}" dt="2024-09-22T23:05:12.863" v="880" actId="478"/>
          <ac:grpSpMkLst>
            <pc:docMk/>
            <pc:sldMk cId="144900757" sldId="278"/>
            <ac:grpSpMk id="22" creationId="{613A1DE0-D0EA-3F40-912D-2864C6DF0B08}"/>
          </ac:grpSpMkLst>
        </pc:grpChg>
        <pc:picChg chg="mod">
          <ac:chgData name="Sartorius, Carol" userId="717f8656-0c6f-4128-8672-6a166f4ce149" providerId="ADAL" clId="{2F088F5A-5D4A-4C38-BFF7-EC151CC291D0}" dt="2024-09-22T23:03:55.367" v="868" actId="164"/>
          <ac:picMkLst>
            <pc:docMk/>
            <pc:sldMk cId="144900757" sldId="278"/>
            <ac:picMk id="4" creationId="{688A5D8B-2B0C-0C47-5D8D-B9FAC39350D0}"/>
          </ac:picMkLst>
        </pc:picChg>
        <pc:picChg chg="mod">
          <ac:chgData name="Sartorius, Carol" userId="717f8656-0c6f-4128-8672-6a166f4ce149" providerId="ADAL" clId="{2F088F5A-5D4A-4C38-BFF7-EC151CC291D0}" dt="2024-09-22T23:04:02.629" v="869" actId="164"/>
          <ac:picMkLst>
            <pc:docMk/>
            <pc:sldMk cId="144900757" sldId="278"/>
            <ac:picMk id="6" creationId="{AB611E82-03BF-EE1B-36BA-9460DAC35643}"/>
          </ac:picMkLst>
        </pc:picChg>
        <pc:picChg chg="add mod">
          <ac:chgData name="Sartorius, Carol" userId="717f8656-0c6f-4128-8672-6a166f4ce149" providerId="ADAL" clId="{2F088F5A-5D4A-4C38-BFF7-EC151CC291D0}" dt="2024-09-23T00:52:29.144" v="1173" actId="1036"/>
          <ac:picMkLst>
            <pc:docMk/>
            <pc:sldMk cId="144900757" sldId="278"/>
            <ac:picMk id="24" creationId="{890F7E42-068D-74D5-29E4-2529FBD402A7}"/>
          </ac:picMkLst>
        </pc:picChg>
        <pc:picChg chg="add mod">
          <ac:chgData name="Sartorius, Carol" userId="717f8656-0c6f-4128-8672-6a166f4ce149" providerId="ADAL" clId="{2F088F5A-5D4A-4C38-BFF7-EC151CC291D0}" dt="2024-09-23T00:52:36.004" v="1177" actId="1036"/>
          <ac:picMkLst>
            <pc:docMk/>
            <pc:sldMk cId="144900757" sldId="278"/>
            <ac:picMk id="26" creationId="{3F07C977-DE53-1564-C725-BE2744B21B29}"/>
          </ac:picMkLst>
        </pc:picChg>
        <pc:cxnChg chg="mod">
          <ac:chgData name="Sartorius, Carol" userId="717f8656-0c6f-4128-8672-6a166f4ce149" providerId="ADAL" clId="{2F088F5A-5D4A-4C38-BFF7-EC151CC291D0}" dt="2024-09-22T23:04:54.195" v="875" actId="478"/>
          <ac:cxnSpMkLst>
            <pc:docMk/>
            <pc:sldMk cId="144900757" sldId="278"/>
            <ac:cxnSpMk id="5" creationId="{FF943CE4-2E54-349E-25B5-C08BAD123C13}"/>
          </ac:cxnSpMkLst>
        </pc:cxnChg>
        <pc:cxnChg chg="mod">
          <ac:chgData name="Sartorius, Carol" userId="717f8656-0c6f-4128-8672-6a166f4ce149" providerId="ADAL" clId="{2F088F5A-5D4A-4C38-BFF7-EC151CC291D0}" dt="2024-09-22T23:04:02.629" v="869" actId="164"/>
          <ac:cxnSpMkLst>
            <pc:docMk/>
            <pc:sldMk cId="144900757" sldId="278"/>
            <ac:cxnSpMk id="20" creationId="{F3BC078E-A66A-1ACA-4382-8BC4E3701459}"/>
          </ac:cxnSpMkLst>
        </pc:cxnChg>
        <pc:cxnChg chg="add del mod">
          <ac:chgData name="Sartorius, Carol" userId="717f8656-0c6f-4128-8672-6a166f4ce149" providerId="ADAL" clId="{2F088F5A-5D4A-4C38-BFF7-EC151CC291D0}" dt="2024-09-23T00:52:44.685" v="1178" actId="21"/>
          <ac:cxnSpMkLst>
            <pc:docMk/>
            <pc:sldMk cId="144900757" sldId="278"/>
            <ac:cxnSpMk id="28" creationId="{6EC4CAB8-6614-E3E0-477D-9FF799252BFB}"/>
          </ac:cxnSpMkLst>
        </pc:cxnChg>
      </pc:sldChg>
      <pc:sldChg chg="addSp delSp modSp mod">
        <pc:chgData name="Sartorius, Carol" userId="717f8656-0c6f-4128-8672-6a166f4ce149" providerId="ADAL" clId="{2F088F5A-5D4A-4C38-BFF7-EC151CC291D0}" dt="2024-10-06T17:14:08.511" v="2564" actId="20577"/>
        <pc:sldMkLst>
          <pc:docMk/>
          <pc:sldMk cId="3618263079" sldId="279"/>
        </pc:sldMkLst>
        <pc:spChg chg="add mod">
          <ac:chgData name="Sartorius, Carol" userId="717f8656-0c6f-4128-8672-6a166f4ce149" providerId="ADAL" clId="{2F088F5A-5D4A-4C38-BFF7-EC151CC291D0}" dt="2024-10-06T17:14:08.511" v="2564" actId="20577"/>
          <ac:spMkLst>
            <pc:docMk/>
            <pc:sldMk cId="3618263079" sldId="279"/>
            <ac:spMk id="2" creationId="{A4F10A4B-69B6-7984-9ED6-55244E080E5A}"/>
          </ac:spMkLst>
        </pc:spChg>
        <pc:spChg chg="mod">
          <ac:chgData name="Sartorius, Carol" userId="717f8656-0c6f-4128-8672-6a166f4ce149" providerId="ADAL" clId="{2F088F5A-5D4A-4C38-BFF7-EC151CC291D0}" dt="2024-09-30T03:09:36.060" v="2120" actId="554"/>
          <ac:spMkLst>
            <pc:docMk/>
            <pc:sldMk cId="3618263079" sldId="279"/>
            <ac:spMk id="3" creationId="{05777F17-98B4-DDB1-9A86-D9C9DC972F6A}"/>
          </ac:spMkLst>
        </pc:spChg>
        <pc:spChg chg="del">
          <ac:chgData name="Sartorius, Carol" userId="717f8656-0c6f-4128-8672-6a166f4ce149" providerId="ADAL" clId="{2F088F5A-5D4A-4C38-BFF7-EC151CC291D0}" dt="2024-09-23T00:53:52.761" v="1289" actId="478"/>
          <ac:spMkLst>
            <pc:docMk/>
            <pc:sldMk cId="3618263079" sldId="279"/>
            <ac:spMk id="4" creationId="{F167DE8B-8572-DC5F-C495-EDBBDB022ADC}"/>
          </ac:spMkLst>
        </pc:spChg>
        <pc:spChg chg="mod">
          <ac:chgData name="Sartorius, Carol" userId="717f8656-0c6f-4128-8672-6a166f4ce149" providerId="ADAL" clId="{2F088F5A-5D4A-4C38-BFF7-EC151CC291D0}" dt="2024-09-30T03:09:36.060" v="2120" actId="554"/>
          <ac:spMkLst>
            <pc:docMk/>
            <pc:sldMk cId="3618263079" sldId="279"/>
            <ac:spMk id="5" creationId="{37085FFE-2F7C-CD47-DBFD-1EE557C77D72}"/>
          </ac:spMkLst>
        </pc:spChg>
        <pc:spChg chg="add mod">
          <ac:chgData name="Sartorius, Carol" userId="717f8656-0c6f-4128-8672-6a166f4ce149" providerId="ADAL" clId="{2F088F5A-5D4A-4C38-BFF7-EC151CC291D0}" dt="2024-09-30T03:09:42.649" v="2124" actId="403"/>
          <ac:spMkLst>
            <pc:docMk/>
            <pc:sldMk cId="3618263079" sldId="279"/>
            <ac:spMk id="6" creationId="{BC737953-3292-305D-1566-C007BA4E6436}"/>
          </ac:spMkLst>
        </pc:spChg>
        <pc:spChg chg="add mod">
          <ac:chgData name="Sartorius, Carol" userId="717f8656-0c6f-4128-8672-6a166f4ce149" providerId="ADAL" clId="{2F088F5A-5D4A-4C38-BFF7-EC151CC291D0}" dt="2024-09-30T03:08:49.226" v="2087"/>
          <ac:spMkLst>
            <pc:docMk/>
            <pc:sldMk cId="3618263079" sldId="279"/>
            <ac:spMk id="7" creationId="{B1CBB68F-4AD9-D7FB-9BD4-7951FAEA1F63}"/>
          </ac:spMkLst>
        </pc:spChg>
        <pc:picChg chg="mod">
          <ac:chgData name="Sartorius, Carol" userId="717f8656-0c6f-4128-8672-6a166f4ce149" providerId="ADAL" clId="{2F088F5A-5D4A-4C38-BFF7-EC151CC291D0}" dt="2024-09-23T00:54:04.296" v="1314" actId="1036"/>
          <ac:picMkLst>
            <pc:docMk/>
            <pc:sldMk cId="3618263079" sldId="279"/>
            <ac:picMk id="14" creationId="{E17F0037-2B10-91D2-0CF8-D79994FA154A}"/>
          </ac:picMkLst>
        </pc:picChg>
        <pc:picChg chg="mod">
          <ac:chgData name="Sartorius, Carol" userId="717f8656-0c6f-4128-8672-6a166f4ce149" providerId="ADAL" clId="{2F088F5A-5D4A-4C38-BFF7-EC151CC291D0}" dt="2024-09-23T00:54:04.296" v="1314" actId="1036"/>
          <ac:picMkLst>
            <pc:docMk/>
            <pc:sldMk cId="3618263079" sldId="279"/>
            <ac:picMk id="15" creationId="{08490850-10AD-50EA-40DC-FF43C37EAB97}"/>
          </ac:picMkLst>
        </pc:picChg>
        <pc:cxnChg chg="add del mod">
          <ac:chgData name="Sartorius, Carol" userId="717f8656-0c6f-4128-8672-6a166f4ce149" providerId="ADAL" clId="{2F088F5A-5D4A-4C38-BFF7-EC151CC291D0}" dt="2024-09-30T03:08:52.886" v="2088" actId="478"/>
          <ac:cxnSpMkLst>
            <pc:docMk/>
            <pc:sldMk cId="3618263079" sldId="279"/>
            <ac:cxnSpMk id="54" creationId="{6EC4CAB8-6614-E3E0-477D-9FF799252BFB}"/>
          </ac:cxnSpMkLst>
        </pc:cxnChg>
      </pc:sldChg>
      <pc:sldChg chg="addSp delSp modSp mod">
        <pc:chgData name="Sartorius, Carol" userId="717f8656-0c6f-4128-8672-6a166f4ce149" providerId="ADAL" clId="{2F088F5A-5D4A-4C38-BFF7-EC151CC291D0}" dt="2024-09-23T00:53:42.413" v="1285" actId="21"/>
        <pc:sldMkLst>
          <pc:docMk/>
          <pc:sldMk cId="1268847539" sldId="280"/>
        </pc:sldMkLst>
        <pc:spChg chg="del">
          <ac:chgData name="Sartorius, Carol" userId="717f8656-0c6f-4128-8672-6a166f4ce149" providerId="ADAL" clId="{2F088F5A-5D4A-4C38-BFF7-EC151CC291D0}" dt="2024-09-22T23:02:49.768" v="860" actId="478"/>
          <ac:spMkLst>
            <pc:docMk/>
            <pc:sldMk cId="1268847539" sldId="280"/>
            <ac:spMk id="2" creationId="{207E58E3-9346-147D-8314-2B976237725B}"/>
          </ac:spMkLst>
        </pc:spChg>
        <pc:spChg chg="add mod">
          <ac:chgData name="Sartorius, Carol" userId="717f8656-0c6f-4128-8672-6a166f4ce149" providerId="ADAL" clId="{2F088F5A-5D4A-4C38-BFF7-EC151CC291D0}" dt="2024-09-23T00:53:38.534" v="1284" actId="1035"/>
          <ac:spMkLst>
            <pc:docMk/>
            <pc:sldMk cId="1268847539" sldId="280"/>
            <ac:spMk id="3" creationId="{C57E9503-4BC3-967E-3D28-93FEBFD6004D}"/>
          </ac:spMkLst>
        </pc:spChg>
        <pc:spChg chg="mod">
          <ac:chgData name="Sartorius, Carol" userId="717f8656-0c6f-4128-8672-6a166f4ce149" providerId="ADAL" clId="{2F088F5A-5D4A-4C38-BFF7-EC151CC291D0}" dt="2024-09-23T00:53:33.725" v="1271" actId="1035"/>
          <ac:spMkLst>
            <pc:docMk/>
            <pc:sldMk cId="1268847539" sldId="280"/>
            <ac:spMk id="12" creationId="{54FBD016-4F1A-7041-CFF6-C79F4C19EF6A}"/>
          </ac:spMkLst>
        </pc:spChg>
        <pc:spChg chg="mod">
          <ac:chgData name="Sartorius, Carol" userId="717f8656-0c6f-4128-8672-6a166f4ce149" providerId="ADAL" clId="{2F088F5A-5D4A-4C38-BFF7-EC151CC291D0}" dt="2024-09-23T00:53:33.725" v="1271" actId="1035"/>
          <ac:spMkLst>
            <pc:docMk/>
            <pc:sldMk cId="1268847539" sldId="280"/>
            <ac:spMk id="13" creationId="{C9877368-A593-E105-A81F-C102903D8C97}"/>
          </ac:spMkLst>
        </pc:spChg>
        <pc:spChg chg="mod">
          <ac:chgData name="Sartorius, Carol" userId="717f8656-0c6f-4128-8672-6a166f4ce149" providerId="ADAL" clId="{2F088F5A-5D4A-4C38-BFF7-EC151CC291D0}" dt="2024-09-23T00:53:33.725" v="1271" actId="1035"/>
          <ac:spMkLst>
            <pc:docMk/>
            <pc:sldMk cId="1268847539" sldId="280"/>
            <ac:spMk id="14" creationId="{EAB61C68-95DB-C54D-3C6A-6F85BAB294B6}"/>
          </ac:spMkLst>
        </pc:spChg>
        <pc:spChg chg="mod">
          <ac:chgData name="Sartorius, Carol" userId="717f8656-0c6f-4128-8672-6a166f4ce149" providerId="ADAL" clId="{2F088F5A-5D4A-4C38-BFF7-EC151CC291D0}" dt="2024-09-23T00:53:33.725" v="1271" actId="1035"/>
          <ac:spMkLst>
            <pc:docMk/>
            <pc:sldMk cId="1268847539" sldId="280"/>
            <ac:spMk id="15" creationId="{43FE32CE-4338-FE41-4809-33BF867EA2CF}"/>
          </ac:spMkLst>
        </pc:spChg>
        <pc:spChg chg="mod">
          <ac:chgData name="Sartorius, Carol" userId="717f8656-0c6f-4128-8672-6a166f4ce149" providerId="ADAL" clId="{2F088F5A-5D4A-4C38-BFF7-EC151CC291D0}" dt="2024-09-23T00:53:33.725" v="1271" actId="1035"/>
          <ac:spMkLst>
            <pc:docMk/>
            <pc:sldMk cId="1268847539" sldId="280"/>
            <ac:spMk id="16" creationId="{7A1440FE-8759-4F60-7AD6-7B725A08F69D}"/>
          </ac:spMkLst>
        </pc:spChg>
        <pc:spChg chg="mod">
          <ac:chgData name="Sartorius, Carol" userId="717f8656-0c6f-4128-8672-6a166f4ce149" providerId="ADAL" clId="{2F088F5A-5D4A-4C38-BFF7-EC151CC291D0}" dt="2024-09-23T00:53:33.725" v="1271" actId="1035"/>
          <ac:spMkLst>
            <pc:docMk/>
            <pc:sldMk cId="1268847539" sldId="280"/>
            <ac:spMk id="17" creationId="{6F1D3D44-CCB1-87A2-1542-69891729A47A}"/>
          </ac:spMkLst>
        </pc:spChg>
        <pc:spChg chg="mod">
          <ac:chgData name="Sartorius, Carol" userId="717f8656-0c6f-4128-8672-6a166f4ce149" providerId="ADAL" clId="{2F088F5A-5D4A-4C38-BFF7-EC151CC291D0}" dt="2024-09-23T00:53:33.725" v="1271" actId="1035"/>
          <ac:spMkLst>
            <pc:docMk/>
            <pc:sldMk cId="1268847539" sldId="280"/>
            <ac:spMk id="18" creationId="{C517B2DC-4B53-73B8-C096-69DEB71F1CA5}"/>
          </ac:spMkLst>
        </pc:spChg>
        <pc:spChg chg="mod">
          <ac:chgData name="Sartorius, Carol" userId="717f8656-0c6f-4128-8672-6a166f4ce149" providerId="ADAL" clId="{2F088F5A-5D4A-4C38-BFF7-EC151CC291D0}" dt="2024-09-23T00:53:33.725" v="1271" actId="1035"/>
          <ac:spMkLst>
            <pc:docMk/>
            <pc:sldMk cId="1268847539" sldId="280"/>
            <ac:spMk id="19" creationId="{62F2CECE-2BB8-0483-4622-B6611ABA2ECD}"/>
          </ac:spMkLst>
        </pc:spChg>
        <pc:spChg chg="mod">
          <ac:chgData name="Sartorius, Carol" userId="717f8656-0c6f-4128-8672-6a166f4ce149" providerId="ADAL" clId="{2F088F5A-5D4A-4C38-BFF7-EC151CC291D0}" dt="2024-09-23T00:53:33.725" v="1271" actId="1035"/>
          <ac:spMkLst>
            <pc:docMk/>
            <pc:sldMk cId="1268847539" sldId="280"/>
            <ac:spMk id="20" creationId="{595FF878-81A5-DFF5-D988-65700A5F8A33}"/>
          </ac:spMkLst>
        </pc:spChg>
        <pc:spChg chg="mod">
          <ac:chgData name="Sartorius, Carol" userId="717f8656-0c6f-4128-8672-6a166f4ce149" providerId="ADAL" clId="{2F088F5A-5D4A-4C38-BFF7-EC151CC291D0}" dt="2024-09-23T00:53:04.514" v="1225" actId="1035"/>
          <ac:spMkLst>
            <pc:docMk/>
            <pc:sldMk cId="1268847539" sldId="280"/>
            <ac:spMk id="21" creationId="{66023367-BA8A-936A-3BE6-D086E738DD8C}"/>
          </ac:spMkLst>
        </pc:spChg>
        <pc:spChg chg="mod">
          <ac:chgData name="Sartorius, Carol" userId="717f8656-0c6f-4128-8672-6a166f4ce149" providerId="ADAL" clId="{2F088F5A-5D4A-4C38-BFF7-EC151CC291D0}" dt="2024-09-23T00:53:33.725" v="1271" actId="1035"/>
          <ac:spMkLst>
            <pc:docMk/>
            <pc:sldMk cId="1268847539" sldId="280"/>
            <ac:spMk id="22" creationId="{EA1297BE-002A-6BDF-E291-AC73984CC502}"/>
          </ac:spMkLst>
        </pc:spChg>
        <pc:spChg chg="mod">
          <ac:chgData name="Sartorius, Carol" userId="717f8656-0c6f-4128-8672-6a166f4ce149" providerId="ADAL" clId="{2F088F5A-5D4A-4C38-BFF7-EC151CC291D0}" dt="2024-09-23T00:53:04.514" v="1225" actId="1035"/>
          <ac:spMkLst>
            <pc:docMk/>
            <pc:sldMk cId="1268847539" sldId="280"/>
            <ac:spMk id="23" creationId="{2BCB7DAB-80B9-6043-8E4E-668A2D4704D0}"/>
          </ac:spMkLst>
        </pc:spChg>
        <pc:spChg chg="mod">
          <ac:chgData name="Sartorius, Carol" userId="717f8656-0c6f-4128-8672-6a166f4ce149" providerId="ADAL" clId="{2F088F5A-5D4A-4C38-BFF7-EC151CC291D0}" dt="2024-09-23T00:53:33.725" v="1271" actId="1035"/>
          <ac:spMkLst>
            <pc:docMk/>
            <pc:sldMk cId="1268847539" sldId="280"/>
            <ac:spMk id="24" creationId="{EB347F67-E92E-A4EA-E8C7-2092F03A0B8D}"/>
          </ac:spMkLst>
        </pc:spChg>
        <pc:spChg chg="mod">
          <ac:chgData name="Sartorius, Carol" userId="717f8656-0c6f-4128-8672-6a166f4ce149" providerId="ADAL" clId="{2F088F5A-5D4A-4C38-BFF7-EC151CC291D0}" dt="2024-09-23T00:53:33.725" v="1271" actId="1035"/>
          <ac:spMkLst>
            <pc:docMk/>
            <pc:sldMk cId="1268847539" sldId="280"/>
            <ac:spMk id="25" creationId="{D7CD10BF-E66F-DEB6-3405-650506E1E2B6}"/>
          </ac:spMkLst>
        </pc:spChg>
        <pc:spChg chg="mod">
          <ac:chgData name="Sartorius, Carol" userId="717f8656-0c6f-4128-8672-6a166f4ce149" providerId="ADAL" clId="{2F088F5A-5D4A-4C38-BFF7-EC151CC291D0}" dt="2024-09-23T00:53:33.725" v="1271" actId="1035"/>
          <ac:spMkLst>
            <pc:docMk/>
            <pc:sldMk cId="1268847539" sldId="280"/>
            <ac:spMk id="26" creationId="{2DF7CC4F-ACBF-DC94-7E7C-170990015C1E}"/>
          </ac:spMkLst>
        </pc:spChg>
        <pc:spChg chg="mod">
          <ac:chgData name="Sartorius, Carol" userId="717f8656-0c6f-4128-8672-6a166f4ce149" providerId="ADAL" clId="{2F088F5A-5D4A-4C38-BFF7-EC151CC291D0}" dt="2024-09-23T00:53:33.725" v="1271" actId="1035"/>
          <ac:spMkLst>
            <pc:docMk/>
            <pc:sldMk cId="1268847539" sldId="280"/>
            <ac:spMk id="27" creationId="{D1D215C7-2D49-90BF-BE60-D38DE33BFB56}"/>
          </ac:spMkLst>
        </pc:spChg>
        <pc:spChg chg="mod">
          <ac:chgData name="Sartorius, Carol" userId="717f8656-0c6f-4128-8672-6a166f4ce149" providerId="ADAL" clId="{2F088F5A-5D4A-4C38-BFF7-EC151CC291D0}" dt="2024-09-23T00:53:33.725" v="1271" actId="1035"/>
          <ac:spMkLst>
            <pc:docMk/>
            <pc:sldMk cId="1268847539" sldId="280"/>
            <ac:spMk id="28" creationId="{CF98A430-4442-A713-FDFE-D25B8B691769}"/>
          </ac:spMkLst>
        </pc:spChg>
        <pc:spChg chg="mod">
          <ac:chgData name="Sartorius, Carol" userId="717f8656-0c6f-4128-8672-6a166f4ce149" providerId="ADAL" clId="{2F088F5A-5D4A-4C38-BFF7-EC151CC291D0}" dt="2024-09-23T00:53:04.514" v="1225" actId="1035"/>
          <ac:spMkLst>
            <pc:docMk/>
            <pc:sldMk cId="1268847539" sldId="280"/>
            <ac:spMk id="29" creationId="{3FEE0510-F789-3930-BDB0-D09AF905EA5B}"/>
          </ac:spMkLst>
        </pc:spChg>
        <pc:spChg chg="mod">
          <ac:chgData name="Sartorius, Carol" userId="717f8656-0c6f-4128-8672-6a166f4ce149" providerId="ADAL" clId="{2F088F5A-5D4A-4C38-BFF7-EC151CC291D0}" dt="2024-09-23T00:53:04.514" v="1225" actId="1035"/>
          <ac:spMkLst>
            <pc:docMk/>
            <pc:sldMk cId="1268847539" sldId="280"/>
            <ac:spMk id="30" creationId="{49FCC462-B5C6-D398-88A4-47F086966C18}"/>
          </ac:spMkLst>
        </pc:spChg>
        <pc:spChg chg="mod">
          <ac:chgData name="Sartorius, Carol" userId="717f8656-0c6f-4128-8672-6a166f4ce149" providerId="ADAL" clId="{2F088F5A-5D4A-4C38-BFF7-EC151CC291D0}" dt="2024-09-23T00:53:04.514" v="1225" actId="1035"/>
          <ac:spMkLst>
            <pc:docMk/>
            <pc:sldMk cId="1268847539" sldId="280"/>
            <ac:spMk id="31" creationId="{104F429D-394D-646F-682D-20D351527872}"/>
          </ac:spMkLst>
        </pc:spChg>
        <pc:spChg chg="mod">
          <ac:chgData name="Sartorius, Carol" userId="717f8656-0c6f-4128-8672-6a166f4ce149" providerId="ADAL" clId="{2F088F5A-5D4A-4C38-BFF7-EC151CC291D0}" dt="2024-09-23T00:53:33.725" v="1271" actId="1035"/>
          <ac:spMkLst>
            <pc:docMk/>
            <pc:sldMk cId="1268847539" sldId="280"/>
            <ac:spMk id="32" creationId="{945AB2F6-267D-48E7-A653-AC9DCB726FB8}"/>
          </ac:spMkLst>
        </pc:spChg>
        <pc:spChg chg="mod">
          <ac:chgData name="Sartorius, Carol" userId="717f8656-0c6f-4128-8672-6a166f4ce149" providerId="ADAL" clId="{2F088F5A-5D4A-4C38-BFF7-EC151CC291D0}" dt="2024-09-23T00:53:04.514" v="1225" actId="1035"/>
          <ac:spMkLst>
            <pc:docMk/>
            <pc:sldMk cId="1268847539" sldId="280"/>
            <ac:spMk id="33" creationId="{3B4F9130-F109-E6E1-0198-A411C790EE1E}"/>
          </ac:spMkLst>
        </pc:spChg>
        <pc:spChg chg="mod">
          <ac:chgData name="Sartorius, Carol" userId="717f8656-0c6f-4128-8672-6a166f4ce149" providerId="ADAL" clId="{2F088F5A-5D4A-4C38-BFF7-EC151CC291D0}" dt="2024-09-23T00:53:04.514" v="1225" actId="1035"/>
          <ac:spMkLst>
            <pc:docMk/>
            <pc:sldMk cId="1268847539" sldId="280"/>
            <ac:spMk id="34" creationId="{639BA061-7997-F8FE-1841-5A8836442547}"/>
          </ac:spMkLst>
        </pc:spChg>
        <pc:spChg chg="mod">
          <ac:chgData name="Sartorius, Carol" userId="717f8656-0c6f-4128-8672-6a166f4ce149" providerId="ADAL" clId="{2F088F5A-5D4A-4C38-BFF7-EC151CC291D0}" dt="2024-09-23T00:53:33.725" v="1271" actId="1035"/>
          <ac:spMkLst>
            <pc:docMk/>
            <pc:sldMk cId="1268847539" sldId="280"/>
            <ac:spMk id="35" creationId="{8F75E693-B158-2CDA-D0C9-6ED2B2078FA2}"/>
          </ac:spMkLst>
        </pc:spChg>
        <pc:picChg chg="mod">
          <ac:chgData name="Sartorius, Carol" userId="717f8656-0c6f-4128-8672-6a166f4ce149" providerId="ADAL" clId="{2F088F5A-5D4A-4C38-BFF7-EC151CC291D0}" dt="2024-09-23T00:53:33.725" v="1271" actId="1035"/>
          <ac:picMkLst>
            <pc:docMk/>
            <pc:sldMk cId="1268847539" sldId="280"/>
            <ac:picMk id="4" creationId="{CAD615E4-C717-E420-5D66-84867A84C37D}"/>
          </ac:picMkLst>
        </pc:picChg>
        <pc:picChg chg="mod">
          <ac:chgData name="Sartorius, Carol" userId="717f8656-0c6f-4128-8672-6a166f4ce149" providerId="ADAL" clId="{2F088F5A-5D4A-4C38-BFF7-EC151CC291D0}" dt="2024-09-23T00:53:33.725" v="1271" actId="1035"/>
          <ac:picMkLst>
            <pc:docMk/>
            <pc:sldMk cId="1268847539" sldId="280"/>
            <ac:picMk id="6" creationId="{EBA1DBEA-7481-56AE-8B3F-1C09FC3B94CD}"/>
          </ac:picMkLst>
        </pc:picChg>
        <pc:picChg chg="mod">
          <ac:chgData name="Sartorius, Carol" userId="717f8656-0c6f-4128-8672-6a166f4ce149" providerId="ADAL" clId="{2F088F5A-5D4A-4C38-BFF7-EC151CC291D0}" dt="2024-09-23T00:53:33.725" v="1271" actId="1035"/>
          <ac:picMkLst>
            <pc:docMk/>
            <pc:sldMk cId="1268847539" sldId="280"/>
            <ac:picMk id="8" creationId="{D2D97F2E-EB12-8CBA-F80A-F1898C551FD9}"/>
          </ac:picMkLst>
        </pc:picChg>
        <pc:picChg chg="mod">
          <ac:chgData name="Sartorius, Carol" userId="717f8656-0c6f-4128-8672-6a166f4ce149" providerId="ADAL" clId="{2F088F5A-5D4A-4C38-BFF7-EC151CC291D0}" dt="2024-09-23T00:53:33.725" v="1271" actId="1035"/>
          <ac:picMkLst>
            <pc:docMk/>
            <pc:sldMk cId="1268847539" sldId="280"/>
            <ac:picMk id="10" creationId="{A571F61C-E753-4739-5E33-915C8456B399}"/>
          </ac:picMkLst>
        </pc:picChg>
        <pc:cxnChg chg="add del mod">
          <ac:chgData name="Sartorius, Carol" userId="717f8656-0c6f-4128-8672-6a166f4ce149" providerId="ADAL" clId="{2F088F5A-5D4A-4C38-BFF7-EC151CC291D0}" dt="2024-09-23T00:53:22.399" v="1257" actId="21"/>
          <ac:cxnSpMkLst>
            <pc:docMk/>
            <pc:sldMk cId="1268847539" sldId="280"/>
            <ac:cxnSpMk id="5" creationId="{6EC4CAB8-6614-E3E0-477D-9FF799252BFB}"/>
          </ac:cxnSpMkLst>
        </pc:cxnChg>
        <pc:cxnChg chg="add del mod">
          <ac:chgData name="Sartorius, Carol" userId="717f8656-0c6f-4128-8672-6a166f4ce149" providerId="ADAL" clId="{2F088F5A-5D4A-4C38-BFF7-EC151CC291D0}" dt="2024-09-23T00:53:42.413" v="1285" actId="21"/>
          <ac:cxnSpMkLst>
            <pc:docMk/>
            <pc:sldMk cId="1268847539" sldId="280"/>
            <ac:cxnSpMk id="7" creationId="{6EC4CAB8-6614-E3E0-477D-9FF799252BFB}"/>
          </ac:cxnSpMkLst>
        </pc:cxnChg>
      </pc:sldChg>
      <pc:sldChg chg="addSp delSp modSp new mod">
        <pc:chgData name="Sartorius, Carol" userId="717f8656-0c6f-4128-8672-6a166f4ce149" providerId="ADAL" clId="{2F088F5A-5D4A-4C38-BFF7-EC151CC291D0}" dt="2024-09-30T03:11:19.966" v="2143" actId="948"/>
        <pc:sldMkLst>
          <pc:docMk/>
          <pc:sldMk cId="1313199831" sldId="281"/>
        </pc:sldMkLst>
        <pc:spChg chg="add mod">
          <ac:chgData name="Sartorius, Carol" userId="717f8656-0c6f-4128-8672-6a166f4ce149" providerId="ADAL" clId="{2F088F5A-5D4A-4C38-BFF7-EC151CC291D0}" dt="2024-09-30T03:11:19.966" v="2143" actId="948"/>
          <ac:spMkLst>
            <pc:docMk/>
            <pc:sldMk cId="1313199831" sldId="281"/>
            <ac:spMk id="2" creationId="{2AF6D795-274B-3B14-0EFE-052AA60971BE}"/>
          </ac:spMkLst>
        </pc:spChg>
        <pc:spChg chg="del">
          <ac:chgData name="Sartorius, Carol" userId="717f8656-0c6f-4128-8672-6a166f4ce149" providerId="ADAL" clId="{2F088F5A-5D4A-4C38-BFF7-EC151CC291D0}" dt="2024-09-30T03:01:33.360" v="1699" actId="21"/>
          <ac:spMkLst>
            <pc:docMk/>
            <pc:sldMk cId="1313199831" sldId="281"/>
            <ac:spMk id="7" creationId="{B1CBB68F-4AD9-D7FB-9BD4-7951FAEA1F63}"/>
          </ac:spMkLst>
        </pc:spChg>
        <pc:spChg chg="mod">
          <ac:chgData name="Sartorius, Carol" userId="717f8656-0c6f-4128-8672-6a166f4ce149" providerId="ADAL" clId="{2F088F5A-5D4A-4C38-BFF7-EC151CC291D0}" dt="2024-09-30T01:10:50.222" v="1478" actId="1036"/>
          <ac:spMkLst>
            <pc:docMk/>
            <pc:sldMk cId="1313199831" sldId="281"/>
            <ac:spMk id="12" creationId="{B97A57B3-A4AD-780D-EC08-825E9604D11C}"/>
          </ac:spMkLst>
        </pc:spChg>
        <pc:spChg chg="mod">
          <ac:chgData name="Sartorius, Carol" userId="717f8656-0c6f-4128-8672-6a166f4ce149" providerId="ADAL" clId="{2F088F5A-5D4A-4C38-BFF7-EC151CC291D0}" dt="2024-09-30T01:11:06.662" v="1541" actId="1036"/>
          <ac:spMkLst>
            <pc:docMk/>
            <pc:sldMk cId="1313199831" sldId="281"/>
            <ac:spMk id="13" creationId="{6F6D5148-DA0D-BD0F-585E-135D677B09E3}"/>
          </ac:spMkLst>
        </pc:spChg>
        <pc:picChg chg="del">
          <ac:chgData name="Sartorius, Carol" userId="717f8656-0c6f-4128-8672-6a166f4ce149" providerId="ADAL" clId="{2F088F5A-5D4A-4C38-BFF7-EC151CC291D0}" dt="2024-09-29T23:55:41.036" v="1410" actId="478"/>
          <ac:picMkLst>
            <pc:docMk/>
            <pc:sldMk cId="1313199831" sldId="281"/>
            <ac:picMk id="4" creationId="{BC4ED977-5C80-B5FF-0113-F9FAA2E59629}"/>
          </ac:picMkLst>
        </pc:picChg>
        <pc:picChg chg="add mod modCrop">
          <ac:chgData name="Sartorius, Carol" userId="717f8656-0c6f-4128-8672-6a166f4ce149" providerId="ADAL" clId="{2F088F5A-5D4A-4C38-BFF7-EC151CC291D0}" dt="2024-09-30T01:11:16.002" v="1543" actId="1076"/>
          <ac:picMkLst>
            <pc:docMk/>
            <pc:sldMk cId="1313199831" sldId="281"/>
            <ac:picMk id="5" creationId="{FE81A481-3928-AB7A-566B-FAE95DAED8F7}"/>
          </ac:picMkLst>
        </pc:picChg>
        <pc:picChg chg="add mod modCrop">
          <ac:chgData name="Sartorius, Carol" userId="717f8656-0c6f-4128-8672-6a166f4ce149" providerId="ADAL" clId="{2F088F5A-5D4A-4C38-BFF7-EC151CC291D0}" dt="2024-09-30T01:11:00.297" v="1525" actId="1036"/>
          <ac:picMkLst>
            <pc:docMk/>
            <pc:sldMk cId="1313199831" sldId="281"/>
            <ac:picMk id="8" creationId="{768FB610-4707-D093-D6C7-25EACEA30945}"/>
          </ac:picMkLst>
        </pc:picChg>
        <pc:picChg chg="del">
          <ac:chgData name="Sartorius, Carol" userId="717f8656-0c6f-4128-8672-6a166f4ce149" providerId="ADAL" clId="{2F088F5A-5D4A-4C38-BFF7-EC151CC291D0}" dt="2024-09-30T01:08:27.092" v="1412" actId="478"/>
          <ac:picMkLst>
            <pc:docMk/>
            <pc:sldMk cId="1313199831" sldId="281"/>
            <ac:picMk id="11" creationId="{F83CAC02-1405-4F5E-28A8-A2B7FC14FE80}"/>
          </ac:picMkLst>
        </pc:picChg>
      </pc:sldChg>
      <pc:sldChg chg="addSp delSp modSp new del mod">
        <pc:chgData name="Sartorius, Carol" userId="717f8656-0c6f-4128-8672-6a166f4ce149" providerId="ADAL" clId="{2F088F5A-5D4A-4C38-BFF7-EC151CC291D0}" dt="2024-09-22T23:07:20.849" v="982" actId="2696"/>
        <pc:sldMkLst>
          <pc:docMk/>
          <pc:sldMk cId="1557258530" sldId="281"/>
        </pc:sldMkLst>
        <pc:spChg chg="add del mod">
          <ac:chgData name="Sartorius, Carol" userId="717f8656-0c6f-4128-8672-6a166f4ce149" providerId="ADAL" clId="{2F088F5A-5D4A-4C38-BFF7-EC151CC291D0}" dt="2024-09-22T23:05:41.290" v="894" actId="21"/>
          <ac:spMkLst>
            <pc:docMk/>
            <pc:sldMk cId="1557258530" sldId="281"/>
            <ac:spMk id="3" creationId="{43BDFAA0-CBD9-C05F-4F54-AC80BA54F02E}"/>
          </ac:spMkLst>
        </pc:spChg>
      </pc:sldChg>
      <pc:sldChg chg="addSp delSp modSp new mod">
        <pc:chgData name="Sartorius, Carol" userId="717f8656-0c6f-4128-8672-6a166f4ce149" providerId="ADAL" clId="{2F088F5A-5D4A-4C38-BFF7-EC151CC291D0}" dt="2024-10-04T03:01:23.263" v="2324" actId="20577"/>
        <pc:sldMkLst>
          <pc:docMk/>
          <pc:sldMk cId="3274515102" sldId="282"/>
        </pc:sldMkLst>
        <pc:spChg chg="add mod">
          <ac:chgData name="Sartorius, Carol" userId="717f8656-0c6f-4128-8672-6a166f4ce149" providerId="ADAL" clId="{2F088F5A-5D4A-4C38-BFF7-EC151CC291D0}" dt="2024-09-30T03:01:44.943" v="1701"/>
          <ac:spMkLst>
            <pc:docMk/>
            <pc:sldMk cId="3274515102" sldId="282"/>
            <ac:spMk id="6" creationId="{6D671AAA-A678-7C45-F2B8-254EC76AA53F}"/>
          </ac:spMkLst>
        </pc:spChg>
        <pc:spChg chg="add del mod">
          <ac:chgData name="Sartorius, Carol" userId="717f8656-0c6f-4128-8672-6a166f4ce149" providerId="ADAL" clId="{2F088F5A-5D4A-4C38-BFF7-EC151CC291D0}" dt="2024-09-30T03:08:43.490" v="2086" actId="21"/>
          <ac:spMkLst>
            <pc:docMk/>
            <pc:sldMk cId="3274515102" sldId="282"/>
            <ac:spMk id="7" creationId="{B1CBB68F-4AD9-D7FB-9BD4-7951FAEA1F63}"/>
          </ac:spMkLst>
        </pc:spChg>
        <pc:spChg chg="add mod">
          <ac:chgData name="Sartorius, Carol" userId="717f8656-0c6f-4128-8672-6a166f4ce149" providerId="ADAL" clId="{2F088F5A-5D4A-4C38-BFF7-EC151CC291D0}" dt="2024-09-30T03:01:54.030" v="1739" actId="1036"/>
          <ac:spMkLst>
            <pc:docMk/>
            <pc:sldMk cId="3274515102" sldId="282"/>
            <ac:spMk id="8" creationId="{F44609E8-820A-C17B-A227-9C63B450B2BE}"/>
          </ac:spMkLst>
        </pc:spChg>
        <pc:spChg chg="add mod">
          <ac:chgData name="Sartorius, Carol" userId="717f8656-0c6f-4128-8672-6a166f4ce149" providerId="ADAL" clId="{2F088F5A-5D4A-4C38-BFF7-EC151CC291D0}" dt="2024-10-04T03:01:23.263" v="2324" actId="20577"/>
          <ac:spMkLst>
            <pc:docMk/>
            <pc:sldMk cId="3274515102" sldId="282"/>
            <ac:spMk id="9" creationId="{9786C0DB-5669-D39D-4642-65D188F8D2E7}"/>
          </ac:spMkLst>
        </pc:spChg>
        <pc:picChg chg="add mod">
          <ac:chgData name="Sartorius, Carol" userId="717f8656-0c6f-4128-8672-6a166f4ce149" providerId="ADAL" clId="{2F088F5A-5D4A-4C38-BFF7-EC151CC291D0}" dt="2024-09-30T03:02:04.448" v="1742" actId="1076"/>
          <ac:picMkLst>
            <pc:docMk/>
            <pc:sldMk cId="3274515102" sldId="282"/>
            <ac:picMk id="3" creationId="{FF6C6677-D6E3-8DD0-62A6-73A851FCA709}"/>
          </ac:picMkLst>
        </pc:picChg>
        <pc:picChg chg="add mod">
          <ac:chgData name="Sartorius, Carol" userId="717f8656-0c6f-4128-8672-6a166f4ce149" providerId="ADAL" clId="{2F088F5A-5D4A-4C38-BFF7-EC151CC291D0}" dt="2024-09-30T03:01:26.768" v="1698" actId="1076"/>
          <ac:picMkLst>
            <pc:docMk/>
            <pc:sldMk cId="3274515102" sldId="282"/>
            <ac:picMk id="5" creationId="{74A01151-A188-59EF-A96E-0E846EEA21B5}"/>
          </ac:picMkLst>
        </pc:picChg>
      </pc:sldChg>
    </pc:docChg>
  </pc:docChgLst>
  <pc:docChgLst>
    <pc:chgData name="Sartorius, Carol" userId="717f8656-0c6f-4128-8672-6a166f4ce149" providerId="ADAL" clId="{7EF6F3C4-4684-4338-9CE2-2316932B4716}"/>
    <pc:docChg chg="undo custSel modSld sldOrd">
      <pc:chgData name="Sartorius, Carol" userId="717f8656-0c6f-4128-8672-6a166f4ce149" providerId="ADAL" clId="{7EF6F3C4-4684-4338-9CE2-2316932B4716}" dt="2024-12-02T02:22:03.401" v="901"/>
      <pc:docMkLst>
        <pc:docMk/>
      </pc:docMkLst>
      <pc:sldChg chg="addSp delSp modSp mod">
        <pc:chgData name="Sartorius, Carol" userId="717f8656-0c6f-4128-8672-6a166f4ce149" providerId="ADAL" clId="{7EF6F3C4-4684-4338-9CE2-2316932B4716}" dt="2024-11-27T19:57:52.713" v="632" actId="1076"/>
        <pc:sldMkLst>
          <pc:docMk/>
          <pc:sldMk cId="2911261070" sldId="263"/>
        </pc:sldMkLst>
        <pc:spChg chg="add mod">
          <ac:chgData name="Sartorius, Carol" userId="717f8656-0c6f-4128-8672-6a166f4ce149" providerId="ADAL" clId="{7EF6F3C4-4684-4338-9CE2-2316932B4716}" dt="2024-11-27T19:56:28.575" v="618" actId="164"/>
          <ac:spMkLst>
            <pc:docMk/>
            <pc:sldMk cId="2911261070" sldId="263"/>
            <ac:spMk id="9" creationId="{9F0FB4A8-6D22-247D-6D31-634F6F7C2A07}"/>
          </ac:spMkLst>
        </pc:spChg>
        <pc:spChg chg="add del mod">
          <ac:chgData name="Sartorius, Carol" userId="717f8656-0c6f-4128-8672-6a166f4ce149" providerId="ADAL" clId="{7EF6F3C4-4684-4338-9CE2-2316932B4716}" dt="2024-11-27T19:56:23.879" v="617" actId="478"/>
          <ac:spMkLst>
            <pc:docMk/>
            <pc:sldMk cId="2911261070" sldId="263"/>
            <ac:spMk id="10" creationId="{53129058-EBC2-96FE-F2F4-0F15D230BF7C}"/>
          </ac:spMkLst>
        </pc:spChg>
        <pc:spChg chg="add mod">
          <ac:chgData name="Sartorius, Carol" userId="717f8656-0c6f-4128-8672-6a166f4ce149" providerId="ADAL" clId="{7EF6F3C4-4684-4338-9CE2-2316932B4716}" dt="2024-11-27T19:56:28.575" v="618" actId="164"/>
          <ac:spMkLst>
            <pc:docMk/>
            <pc:sldMk cId="2911261070" sldId="263"/>
            <ac:spMk id="11" creationId="{B351F77C-5E5C-266E-FBE6-22B3AEA1182F}"/>
          </ac:spMkLst>
        </pc:spChg>
        <pc:spChg chg="add mod">
          <ac:chgData name="Sartorius, Carol" userId="717f8656-0c6f-4128-8672-6a166f4ce149" providerId="ADAL" clId="{7EF6F3C4-4684-4338-9CE2-2316932B4716}" dt="2024-11-27T19:56:28.575" v="618" actId="164"/>
          <ac:spMkLst>
            <pc:docMk/>
            <pc:sldMk cId="2911261070" sldId="263"/>
            <ac:spMk id="12" creationId="{C73C3402-0654-F5A8-1C75-2EA8959B80C4}"/>
          </ac:spMkLst>
        </pc:spChg>
        <pc:spChg chg="add mod">
          <ac:chgData name="Sartorius, Carol" userId="717f8656-0c6f-4128-8672-6a166f4ce149" providerId="ADAL" clId="{7EF6F3C4-4684-4338-9CE2-2316932B4716}" dt="2024-11-27T19:56:28.575" v="618" actId="164"/>
          <ac:spMkLst>
            <pc:docMk/>
            <pc:sldMk cId="2911261070" sldId="263"/>
            <ac:spMk id="13" creationId="{70AB1D79-E710-35CB-0747-785EFE77C781}"/>
          </ac:spMkLst>
        </pc:spChg>
        <pc:spChg chg="add mod">
          <ac:chgData name="Sartorius, Carol" userId="717f8656-0c6f-4128-8672-6a166f4ce149" providerId="ADAL" clId="{7EF6F3C4-4684-4338-9CE2-2316932B4716}" dt="2024-11-27T19:56:28.575" v="618" actId="164"/>
          <ac:spMkLst>
            <pc:docMk/>
            <pc:sldMk cId="2911261070" sldId="263"/>
            <ac:spMk id="14" creationId="{D5477D78-2A07-5B05-36B4-DFC880B93D01}"/>
          </ac:spMkLst>
        </pc:spChg>
        <pc:spChg chg="add mod">
          <ac:chgData name="Sartorius, Carol" userId="717f8656-0c6f-4128-8672-6a166f4ce149" providerId="ADAL" clId="{7EF6F3C4-4684-4338-9CE2-2316932B4716}" dt="2024-11-27T19:57:04.236" v="620" actId="20577"/>
          <ac:spMkLst>
            <pc:docMk/>
            <pc:sldMk cId="2911261070" sldId="263"/>
            <ac:spMk id="17" creationId="{50D902C1-B7EB-FAA4-9797-6D64CA8F4505}"/>
          </ac:spMkLst>
        </pc:spChg>
        <pc:spChg chg="add mod">
          <ac:chgData name="Sartorius, Carol" userId="717f8656-0c6f-4128-8672-6a166f4ce149" providerId="ADAL" clId="{7EF6F3C4-4684-4338-9CE2-2316932B4716}" dt="2024-11-27T19:56:28.575" v="618" actId="164"/>
          <ac:spMkLst>
            <pc:docMk/>
            <pc:sldMk cId="2911261070" sldId="263"/>
            <ac:spMk id="18" creationId="{9CB1DEEA-31BA-A255-37C2-8A2AE3461CA7}"/>
          </ac:spMkLst>
        </pc:spChg>
        <pc:spChg chg="add mod">
          <ac:chgData name="Sartorius, Carol" userId="717f8656-0c6f-4128-8672-6a166f4ce149" providerId="ADAL" clId="{7EF6F3C4-4684-4338-9CE2-2316932B4716}" dt="2024-11-27T19:56:28.575" v="618" actId="164"/>
          <ac:spMkLst>
            <pc:docMk/>
            <pc:sldMk cId="2911261070" sldId="263"/>
            <ac:spMk id="19" creationId="{CA28AA02-CC32-918B-391C-959DFB6466E4}"/>
          </ac:spMkLst>
        </pc:spChg>
        <pc:spChg chg="add mod">
          <ac:chgData name="Sartorius, Carol" userId="717f8656-0c6f-4128-8672-6a166f4ce149" providerId="ADAL" clId="{7EF6F3C4-4684-4338-9CE2-2316932B4716}" dt="2024-11-27T19:56:28.575" v="618" actId="164"/>
          <ac:spMkLst>
            <pc:docMk/>
            <pc:sldMk cId="2911261070" sldId="263"/>
            <ac:spMk id="20" creationId="{67D62AD1-0BBB-2FFA-5D47-64975E8800B5}"/>
          </ac:spMkLst>
        </pc:spChg>
        <pc:spChg chg="add mod">
          <ac:chgData name="Sartorius, Carol" userId="717f8656-0c6f-4128-8672-6a166f4ce149" providerId="ADAL" clId="{7EF6F3C4-4684-4338-9CE2-2316932B4716}" dt="2024-11-27T19:56:28.575" v="618" actId="164"/>
          <ac:spMkLst>
            <pc:docMk/>
            <pc:sldMk cId="2911261070" sldId="263"/>
            <ac:spMk id="21" creationId="{9C012548-8BCB-F239-AAF1-4B7EF7EBCA9C}"/>
          </ac:spMkLst>
        </pc:spChg>
        <pc:spChg chg="add mod">
          <ac:chgData name="Sartorius, Carol" userId="717f8656-0c6f-4128-8672-6a166f4ce149" providerId="ADAL" clId="{7EF6F3C4-4684-4338-9CE2-2316932B4716}" dt="2024-11-27T19:57:40.878" v="629" actId="6549"/>
          <ac:spMkLst>
            <pc:docMk/>
            <pc:sldMk cId="2911261070" sldId="263"/>
            <ac:spMk id="22" creationId="{C31C038C-B4F9-77BA-2C85-46DFF22A9B29}"/>
          </ac:spMkLst>
        </pc:spChg>
        <pc:spChg chg="ord">
          <ac:chgData name="Sartorius, Carol" userId="717f8656-0c6f-4128-8672-6a166f4ce149" providerId="ADAL" clId="{7EF6F3C4-4684-4338-9CE2-2316932B4716}" dt="2024-11-27T19:55:32.579" v="611" actId="166"/>
          <ac:spMkLst>
            <pc:docMk/>
            <pc:sldMk cId="2911261070" sldId="263"/>
            <ac:spMk id="126" creationId="{67BA4D94-20CE-B069-20DA-F18B18BFA9D1}"/>
          </ac:spMkLst>
        </pc:spChg>
        <pc:grpChg chg="add del mod">
          <ac:chgData name="Sartorius, Carol" userId="717f8656-0c6f-4128-8672-6a166f4ce149" providerId="ADAL" clId="{7EF6F3C4-4684-4338-9CE2-2316932B4716}" dt="2024-11-27T19:57:43.343" v="630" actId="478"/>
          <ac:grpSpMkLst>
            <pc:docMk/>
            <pc:sldMk cId="2911261070" sldId="263"/>
            <ac:grpSpMk id="26" creationId="{7ECCD1A3-FD7C-652B-A0CA-EA7A6565214F}"/>
          </ac:grpSpMkLst>
        </pc:grpChg>
        <pc:picChg chg="del mod">
          <ac:chgData name="Sartorius, Carol" userId="717f8656-0c6f-4128-8672-6a166f4ce149" providerId="ADAL" clId="{7EF6F3C4-4684-4338-9CE2-2316932B4716}" dt="2024-11-27T19:54:58.895" v="601" actId="478"/>
          <ac:picMkLst>
            <pc:docMk/>
            <pc:sldMk cId="2911261070" sldId="263"/>
            <ac:picMk id="3" creationId="{4621F3F1-9BB8-832F-88DE-E199E73511C8}"/>
          </ac:picMkLst>
        </pc:picChg>
        <pc:picChg chg="add mod">
          <ac:chgData name="Sartorius, Carol" userId="717f8656-0c6f-4128-8672-6a166f4ce149" providerId="ADAL" clId="{7EF6F3C4-4684-4338-9CE2-2316932B4716}" dt="2024-11-27T19:55:25.024" v="610" actId="1035"/>
          <ac:picMkLst>
            <pc:docMk/>
            <pc:sldMk cId="2911261070" sldId="263"/>
            <ac:picMk id="5" creationId="{AEF17CF0-3F4B-6517-054F-88385C274C9E}"/>
          </ac:picMkLst>
        </pc:picChg>
        <pc:picChg chg="add mod">
          <ac:chgData name="Sartorius, Carol" userId="717f8656-0c6f-4128-8672-6a166f4ce149" providerId="ADAL" clId="{7EF6F3C4-4684-4338-9CE2-2316932B4716}" dt="2024-11-27T19:56:28.575" v="618" actId="164"/>
          <ac:picMkLst>
            <pc:docMk/>
            <pc:sldMk cId="2911261070" sldId="263"/>
            <ac:picMk id="6" creationId="{6DFB8503-282C-5753-B9E9-607EAB78F89C}"/>
          </ac:picMkLst>
        </pc:picChg>
        <pc:picChg chg="add mod">
          <ac:chgData name="Sartorius, Carol" userId="717f8656-0c6f-4128-8672-6a166f4ce149" providerId="ADAL" clId="{7EF6F3C4-4684-4338-9CE2-2316932B4716}" dt="2024-11-27T19:56:28.575" v="618" actId="164"/>
          <ac:picMkLst>
            <pc:docMk/>
            <pc:sldMk cId="2911261070" sldId="263"/>
            <ac:picMk id="7" creationId="{FA165160-2B08-10B3-697A-0D16D1016AF1}"/>
          </ac:picMkLst>
        </pc:picChg>
        <pc:picChg chg="del">
          <ac:chgData name="Sartorius, Carol" userId="717f8656-0c6f-4128-8672-6a166f4ce149" providerId="ADAL" clId="{7EF6F3C4-4684-4338-9CE2-2316932B4716}" dt="2024-11-27T19:57:45.459" v="631" actId="478"/>
          <ac:picMkLst>
            <pc:docMk/>
            <pc:sldMk cId="2911261070" sldId="263"/>
            <ac:picMk id="24" creationId="{0A6059B1-609B-CA38-63A3-07072717B9E7}"/>
          </ac:picMkLst>
        </pc:picChg>
        <pc:picChg chg="add mod">
          <ac:chgData name="Sartorius, Carol" userId="717f8656-0c6f-4128-8672-6a166f4ce149" providerId="ADAL" clId="{7EF6F3C4-4684-4338-9CE2-2316932B4716}" dt="2024-11-27T19:57:52.713" v="632" actId="1076"/>
          <ac:picMkLst>
            <pc:docMk/>
            <pc:sldMk cId="2911261070" sldId="263"/>
            <ac:picMk id="28" creationId="{DAA4B437-66B5-3583-B5FC-4DFDA8470316}"/>
          </ac:picMkLst>
        </pc:picChg>
        <pc:cxnChg chg="add mod">
          <ac:chgData name="Sartorius, Carol" userId="717f8656-0c6f-4128-8672-6a166f4ce149" providerId="ADAL" clId="{7EF6F3C4-4684-4338-9CE2-2316932B4716}" dt="2024-11-27T19:56:28.575" v="618" actId="164"/>
          <ac:cxnSpMkLst>
            <pc:docMk/>
            <pc:sldMk cId="2911261070" sldId="263"/>
            <ac:cxnSpMk id="15" creationId="{FD53D0E7-1A07-4CE4-27E6-863552B74A8A}"/>
          </ac:cxnSpMkLst>
        </pc:cxnChg>
        <pc:cxnChg chg="add mod">
          <ac:chgData name="Sartorius, Carol" userId="717f8656-0c6f-4128-8672-6a166f4ce149" providerId="ADAL" clId="{7EF6F3C4-4684-4338-9CE2-2316932B4716}" dt="2024-11-27T19:56:28.575" v="618" actId="164"/>
          <ac:cxnSpMkLst>
            <pc:docMk/>
            <pc:sldMk cId="2911261070" sldId="263"/>
            <ac:cxnSpMk id="16" creationId="{49E43987-3D68-05BB-D36B-13DAD684D0A3}"/>
          </ac:cxnSpMkLst>
        </pc:cxnChg>
      </pc:sldChg>
      <pc:sldChg chg="addSp delSp modSp mod">
        <pc:chgData name="Sartorius, Carol" userId="717f8656-0c6f-4128-8672-6a166f4ce149" providerId="ADAL" clId="{7EF6F3C4-4684-4338-9CE2-2316932B4716}" dt="2024-11-27T19:29:35.365" v="582" actId="1076"/>
        <pc:sldMkLst>
          <pc:docMk/>
          <pc:sldMk cId="3004741895" sldId="264"/>
        </pc:sldMkLst>
        <pc:spChg chg="add mod topLvl">
          <ac:chgData name="Sartorius, Carol" userId="717f8656-0c6f-4128-8672-6a166f4ce149" providerId="ADAL" clId="{7EF6F3C4-4684-4338-9CE2-2316932B4716}" dt="2024-11-27T19:21:16.415" v="283" actId="165"/>
          <ac:spMkLst>
            <pc:docMk/>
            <pc:sldMk cId="3004741895" sldId="264"/>
            <ac:spMk id="4" creationId="{53D6B75E-FE3D-5E4B-0987-E42AFFB0BAA9}"/>
          </ac:spMkLst>
        </pc:spChg>
        <pc:spChg chg="add mod topLvl">
          <ac:chgData name="Sartorius, Carol" userId="717f8656-0c6f-4128-8672-6a166f4ce149" providerId="ADAL" clId="{7EF6F3C4-4684-4338-9CE2-2316932B4716}" dt="2024-11-27T19:21:16.415" v="283" actId="165"/>
          <ac:spMkLst>
            <pc:docMk/>
            <pc:sldMk cId="3004741895" sldId="264"/>
            <ac:spMk id="5" creationId="{408464C1-A778-7B3C-D9B1-0771B3C69EB9}"/>
          </ac:spMkLst>
        </pc:spChg>
        <pc:spChg chg="add mod topLvl">
          <ac:chgData name="Sartorius, Carol" userId="717f8656-0c6f-4128-8672-6a166f4ce149" providerId="ADAL" clId="{7EF6F3C4-4684-4338-9CE2-2316932B4716}" dt="2024-11-27T19:21:16.415" v="283" actId="165"/>
          <ac:spMkLst>
            <pc:docMk/>
            <pc:sldMk cId="3004741895" sldId="264"/>
            <ac:spMk id="7" creationId="{CCFC4192-589E-CEE2-CDAF-82E42E6F3B99}"/>
          </ac:spMkLst>
        </pc:spChg>
        <pc:spChg chg="add mod topLvl">
          <ac:chgData name="Sartorius, Carol" userId="717f8656-0c6f-4128-8672-6a166f4ce149" providerId="ADAL" clId="{7EF6F3C4-4684-4338-9CE2-2316932B4716}" dt="2024-11-27T19:21:16.415" v="283" actId="165"/>
          <ac:spMkLst>
            <pc:docMk/>
            <pc:sldMk cId="3004741895" sldId="264"/>
            <ac:spMk id="8" creationId="{67CC8A78-7638-691D-1CD4-3A9BAB7DB335}"/>
          </ac:spMkLst>
        </pc:spChg>
        <pc:spChg chg="add mod topLvl">
          <ac:chgData name="Sartorius, Carol" userId="717f8656-0c6f-4128-8672-6a166f4ce149" providerId="ADAL" clId="{7EF6F3C4-4684-4338-9CE2-2316932B4716}" dt="2024-11-27T19:21:16.415" v="283" actId="165"/>
          <ac:spMkLst>
            <pc:docMk/>
            <pc:sldMk cId="3004741895" sldId="264"/>
            <ac:spMk id="9" creationId="{97E5746A-6A8E-8A14-F506-B2CD65F09F64}"/>
          </ac:spMkLst>
        </pc:spChg>
        <pc:spChg chg="add mod topLvl">
          <ac:chgData name="Sartorius, Carol" userId="717f8656-0c6f-4128-8672-6a166f4ce149" providerId="ADAL" clId="{7EF6F3C4-4684-4338-9CE2-2316932B4716}" dt="2024-11-27T19:21:16.415" v="283" actId="165"/>
          <ac:spMkLst>
            <pc:docMk/>
            <pc:sldMk cId="3004741895" sldId="264"/>
            <ac:spMk id="10" creationId="{50961BF8-56DB-2A99-FED5-411254C54A11}"/>
          </ac:spMkLst>
        </pc:spChg>
        <pc:spChg chg="add mod topLvl">
          <ac:chgData name="Sartorius, Carol" userId="717f8656-0c6f-4128-8672-6a166f4ce149" providerId="ADAL" clId="{7EF6F3C4-4684-4338-9CE2-2316932B4716}" dt="2024-11-27T19:29:05.048" v="579" actId="1035"/>
          <ac:spMkLst>
            <pc:docMk/>
            <pc:sldMk cId="3004741895" sldId="264"/>
            <ac:spMk id="11" creationId="{9F4D6A45-7C89-ECA0-3722-15F55F169E6C}"/>
          </ac:spMkLst>
        </pc:spChg>
        <pc:spChg chg="add mod topLvl">
          <ac:chgData name="Sartorius, Carol" userId="717f8656-0c6f-4128-8672-6a166f4ce149" providerId="ADAL" clId="{7EF6F3C4-4684-4338-9CE2-2316932B4716}" dt="2024-11-27T19:29:05.048" v="579" actId="1035"/>
          <ac:spMkLst>
            <pc:docMk/>
            <pc:sldMk cId="3004741895" sldId="264"/>
            <ac:spMk id="12" creationId="{DA83A3EA-D053-3F31-9864-7229FFE30D56}"/>
          </ac:spMkLst>
        </pc:spChg>
        <pc:spChg chg="add mod topLvl">
          <ac:chgData name="Sartorius, Carol" userId="717f8656-0c6f-4128-8672-6a166f4ce149" providerId="ADAL" clId="{7EF6F3C4-4684-4338-9CE2-2316932B4716}" dt="2024-11-27T19:29:05.048" v="579" actId="1035"/>
          <ac:spMkLst>
            <pc:docMk/>
            <pc:sldMk cId="3004741895" sldId="264"/>
            <ac:spMk id="13" creationId="{138FD98E-45FA-3AED-839E-2693F7ED2F8E}"/>
          </ac:spMkLst>
        </pc:spChg>
        <pc:spChg chg="add mod topLvl">
          <ac:chgData name="Sartorius, Carol" userId="717f8656-0c6f-4128-8672-6a166f4ce149" providerId="ADAL" clId="{7EF6F3C4-4684-4338-9CE2-2316932B4716}" dt="2024-11-27T19:29:05.048" v="579" actId="1035"/>
          <ac:spMkLst>
            <pc:docMk/>
            <pc:sldMk cId="3004741895" sldId="264"/>
            <ac:spMk id="14" creationId="{C5E38AE7-DE7B-DF1D-F25E-9F1CC19C4C35}"/>
          </ac:spMkLst>
        </pc:spChg>
        <pc:spChg chg="add mod topLvl">
          <ac:chgData name="Sartorius, Carol" userId="717f8656-0c6f-4128-8672-6a166f4ce149" providerId="ADAL" clId="{7EF6F3C4-4684-4338-9CE2-2316932B4716}" dt="2024-11-27T19:29:05.048" v="579" actId="1035"/>
          <ac:spMkLst>
            <pc:docMk/>
            <pc:sldMk cId="3004741895" sldId="264"/>
            <ac:spMk id="15" creationId="{873056B1-9E5A-C229-7EB1-A230C64E8AB7}"/>
          </ac:spMkLst>
        </pc:spChg>
        <pc:spChg chg="add mod topLvl">
          <ac:chgData name="Sartorius, Carol" userId="717f8656-0c6f-4128-8672-6a166f4ce149" providerId="ADAL" clId="{7EF6F3C4-4684-4338-9CE2-2316932B4716}" dt="2024-11-27T19:29:05.048" v="579" actId="1035"/>
          <ac:spMkLst>
            <pc:docMk/>
            <pc:sldMk cId="3004741895" sldId="264"/>
            <ac:spMk id="16" creationId="{5E0B69B2-5469-64DA-BB9C-4F566A454CCD}"/>
          </ac:spMkLst>
        </pc:spChg>
        <pc:spChg chg="add mod topLvl">
          <ac:chgData name="Sartorius, Carol" userId="717f8656-0c6f-4128-8672-6a166f4ce149" providerId="ADAL" clId="{7EF6F3C4-4684-4338-9CE2-2316932B4716}" dt="2024-11-27T19:29:05.048" v="579" actId="1035"/>
          <ac:spMkLst>
            <pc:docMk/>
            <pc:sldMk cId="3004741895" sldId="264"/>
            <ac:spMk id="17" creationId="{9002CDE1-E33E-A969-0041-45738DAAE29B}"/>
          </ac:spMkLst>
        </pc:spChg>
        <pc:spChg chg="add del mod topLvl">
          <ac:chgData name="Sartorius, Carol" userId="717f8656-0c6f-4128-8672-6a166f4ce149" providerId="ADAL" clId="{7EF6F3C4-4684-4338-9CE2-2316932B4716}" dt="2024-11-27T19:21:38.009" v="286" actId="478"/>
          <ac:spMkLst>
            <pc:docMk/>
            <pc:sldMk cId="3004741895" sldId="264"/>
            <ac:spMk id="18" creationId="{D00FC496-A1D5-3D3A-6BAC-15BF64BB061B}"/>
          </ac:spMkLst>
        </pc:spChg>
        <pc:spChg chg="add mod topLvl">
          <ac:chgData name="Sartorius, Carol" userId="717f8656-0c6f-4128-8672-6a166f4ce149" providerId="ADAL" clId="{7EF6F3C4-4684-4338-9CE2-2316932B4716}" dt="2024-11-27T19:29:05.048" v="579" actId="1035"/>
          <ac:spMkLst>
            <pc:docMk/>
            <pc:sldMk cId="3004741895" sldId="264"/>
            <ac:spMk id="19" creationId="{6FBED441-268A-6C7E-BD6C-1743B673BDA2}"/>
          </ac:spMkLst>
        </pc:spChg>
        <pc:spChg chg="add mod topLvl">
          <ac:chgData name="Sartorius, Carol" userId="717f8656-0c6f-4128-8672-6a166f4ce149" providerId="ADAL" clId="{7EF6F3C4-4684-4338-9CE2-2316932B4716}" dt="2024-11-27T19:29:05.048" v="579" actId="1035"/>
          <ac:spMkLst>
            <pc:docMk/>
            <pc:sldMk cId="3004741895" sldId="264"/>
            <ac:spMk id="20" creationId="{5143B970-10DD-1A35-4278-7F45955EC5C6}"/>
          </ac:spMkLst>
        </pc:spChg>
        <pc:spChg chg="add mod topLvl">
          <ac:chgData name="Sartorius, Carol" userId="717f8656-0c6f-4128-8672-6a166f4ce149" providerId="ADAL" clId="{7EF6F3C4-4684-4338-9CE2-2316932B4716}" dt="2024-11-27T19:21:16.415" v="283" actId="165"/>
          <ac:spMkLst>
            <pc:docMk/>
            <pc:sldMk cId="3004741895" sldId="264"/>
            <ac:spMk id="21" creationId="{91558488-26DF-4E3C-58C2-BB8CF128C72E}"/>
          </ac:spMkLst>
        </pc:spChg>
        <pc:spChg chg="add mod topLvl">
          <ac:chgData name="Sartorius, Carol" userId="717f8656-0c6f-4128-8672-6a166f4ce149" providerId="ADAL" clId="{7EF6F3C4-4684-4338-9CE2-2316932B4716}" dt="2024-11-27T19:21:16.415" v="283" actId="165"/>
          <ac:spMkLst>
            <pc:docMk/>
            <pc:sldMk cId="3004741895" sldId="264"/>
            <ac:spMk id="22" creationId="{243649CC-E37E-8678-7BAC-5389D6731FAC}"/>
          </ac:spMkLst>
        </pc:spChg>
        <pc:spChg chg="add mod topLvl">
          <ac:chgData name="Sartorius, Carol" userId="717f8656-0c6f-4128-8672-6a166f4ce149" providerId="ADAL" clId="{7EF6F3C4-4684-4338-9CE2-2316932B4716}" dt="2024-11-27T19:21:16.415" v="283" actId="165"/>
          <ac:spMkLst>
            <pc:docMk/>
            <pc:sldMk cId="3004741895" sldId="264"/>
            <ac:spMk id="23" creationId="{99F3D82F-F6EE-93A7-F44C-3FEE08EA0284}"/>
          </ac:spMkLst>
        </pc:spChg>
        <pc:spChg chg="add mod topLvl">
          <ac:chgData name="Sartorius, Carol" userId="717f8656-0c6f-4128-8672-6a166f4ce149" providerId="ADAL" clId="{7EF6F3C4-4684-4338-9CE2-2316932B4716}" dt="2024-11-27T19:21:16.415" v="283" actId="165"/>
          <ac:spMkLst>
            <pc:docMk/>
            <pc:sldMk cId="3004741895" sldId="264"/>
            <ac:spMk id="24" creationId="{760052A8-AD70-509B-CC58-F5A7684DD03C}"/>
          </ac:spMkLst>
        </pc:spChg>
        <pc:spChg chg="add mod topLvl">
          <ac:chgData name="Sartorius, Carol" userId="717f8656-0c6f-4128-8672-6a166f4ce149" providerId="ADAL" clId="{7EF6F3C4-4684-4338-9CE2-2316932B4716}" dt="2024-11-27T19:21:16.415" v="283" actId="165"/>
          <ac:spMkLst>
            <pc:docMk/>
            <pc:sldMk cId="3004741895" sldId="264"/>
            <ac:spMk id="25" creationId="{5FAFC11A-AE30-33A6-8CD3-E17CAD004000}"/>
          </ac:spMkLst>
        </pc:spChg>
        <pc:spChg chg="add mod topLvl">
          <ac:chgData name="Sartorius, Carol" userId="717f8656-0c6f-4128-8672-6a166f4ce149" providerId="ADAL" clId="{7EF6F3C4-4684-4338-9CE2-2316932B4716}" dt="2024-11-27T19:21:16.415" v="283" actId="165"/>
          <ac:spMkLst>
            <pc:docMk/>
            <pc:sldMk cId="3004741895" sldId="264"/>
            <ac:spMk id="26" creationId="{12FB701E-98FD-0AB2-2AF9-8977CE5DE2EA}"/>
          </ac:spMkLst>
        </pc:spChg>
        <pc:spChg chg="add mod topLvl">
          <ac:chgData name="Sartorius, Carol" userId="717f8656-0c6f-4128-8672-6a166f4ce149" providerId="ADAL" clId="{7EF6F3C4-4684-4338-9CE2-2316932B4716}" dt="2024-11-27T19:21:16.415" v="283" actId="165"/>
          <ac:spMkLst>
            <pc:docMk/>
            <pc:sldMk cId="3004741895" sldId="264"/>
            <ac:spMk id="27" creationId="{A2C3F980-7447-4D32-61AC-05BDAAA494C6}"/>
          </ac:spMkLst>
        </pc:spChg>
        <pc:spChg chg="add mod topLvl">
          <ac:chgData name="Sartorius, Carol" userId="717f8656-0c6f-4128-8672-6a166f4ce149" providerId="ADAL" clId="{7EF6F3C4-4684-4338-9CE2-2316932B4716}" dt="2024-11-27T19:21:16.415" v="283" actId="165"/>
          <ac:spMkLst>
            <pc:docMk/>
            <pc:sldMk cId="3004741895" sldId="264"/>
            <ac:spMk id="28" creationId="{20EF108E-FB1C-9AE8-E285-2239D729F152}"/>
          </ac:spMkLst>
        </pc:spChg>
        <pc:spChg chg="add mod topLvl">
          <ac:chgData name="Sartorius, Carol" userId="717f8656-0c6f-4128-8672-6a166f4ce149" providerId="ADAL" clId="{7EF6F3C4-4684-4338-9CE2-2316932B4716}" dt="2024-11-27T19:21:16.415" v="283" actId="165"/>
          <ac:spMkLst>
            <pc:docMk/>
            <pc:sldMk cId="3004741895" sldId="264"/>
            <ac:spMk id="29" creationId="{D977774C-7E7F-800A-E3D1-B5B30586FE42}"/>
          </ac:spMkLst>
        </pc:spChg>
        <pc:spChg chg="add mod topLvl">
          <ac:chgData name="Sartorius, Carol" userId="717f8656-0c6f-4128-8672-6a166f4ce149" providerId="ADAL" clId="{7EF6F3C4-4684-4338-9CE2-2316932B4716}" dt="2024-11-27T19:21:16.415" v="283" actId="165"/>
          <ac:spMkLst>
            <pc:docMk/>
            <pc:sldMk cId="3004741895" sldId="264"/>
            <ac:spMk id="30" creationId="{73529A55-82DE-573B-6CDB-04FC92122FEF}"/>
          </ac:spMkLst>
        </pc:spChg>
        <pc:spChg chg="add mod topLvl">
          <ac:chgData name="Sartorius, Carol" userId="717f8656-0c6f-4128-8672-6a166f4ce149" providerId="ADAL" clId="{7EF6F3C4-4684-4338-9CE2-2316932B4716}" dt="2024-11-27T19:21:16.415" v="283" actId="165"/>
          <ac:spMkLst>
            <pc:docMk/>
            <pc:sldMk cId="3004741895" sldId="264"/>
            <ac:spMk id="31" creationId="{8369E298-1B6B-8338-2696-78C4AE9413AC}"/>
          </ac:spMkLst>
        </pc:spChg>
        <pc:spChg chg="add mod topLvl">
          <ac:chgData name="Sartorius, Carol" userId="717f8656-0c6f-4128-8672-6a166f4ce149" providerId="ADAL" clId="{7EF6F3C4-4684-4338-9CE2-2316932B4716}" dt="2024-11-27T19:21:16.415" v="283" actId="165"/>
          <ac:spMkLst>
            <pc:docMk/>
            <pc:sldMk cId="3004741895" sldId="264"/>
            <ac:spMk id="33" creationId="{4166230F-92E9-414F-CD73-4174909E7BA8}"/>
          </ac:spMkLst>
        </pc:spChg>
        <pc:spChg chg="add mod topLvl">
          <ac:chgData name="Sartorius, Carol" userId="717f8656-0c6f-4128-8672-6a166f4ce149" providerId="ADAL" clId="{7EF6F3C4-4684-4338-9CE2-2316932B4716}" dt="2024-11-27T19:21:16.415" v="283" actId="165"/>
          <ac:spMkLst>
            <pc:docMk/>
            <pc:sldMk cId="3004741895" sldId="264"/>
            <ac:spMk id="34" creationId="{521757FA-7917-3CF2-740E-7767AB913C76}"/>
          </ac:spMkLst>
        </pc:spChg>
        <pc:spChg chg="add del mod topLvl">
          <ac:chgData name="Sartorius, Carol" userId="717f8656-0c6f-4128-8672-6a166f4ce149" providerId="ADAL" clId="{7EF6F3C4-4684-4338-9CE2-2316932B4716}" dt="2024-11-27T19:20:49.229" v="277" actId="478"/>
          <ac:spMkLst>
            <pc:docMk/>
            <pc:sldMk cId="3004741895" sldId="264"/>
            <ac:spMk id="35" creationId="{4FDCB41D-7B05-F41E-DFCE-4F73845975E6}"/>
          </ac:spMkLst>
        </pc:spChg>
        <pc:spChg chg="add mod">
          <ac:chgData name="Sartorius, Carol" userId="717f8656-0c6f-4128-8672-6a166f4ce149" providerId="ADAL" clId="{7EF6F3C4-4684-4338-9CE2-2316932B4716}" dt="2024-11-27T19:22:54.715" v="294" actId="3064"/>
          <ac:spMkLst>
            <pc:docMk/>
            <pc:sldMk cId="3004741895" sldId="264"/>
            <ac:spMk id="40" creationId="{C3290AC1-2CAB-9AF6-8D1F-EF12B4EE04FC}"/>
          </ac:spMkLst>
        </pc:spChg>
        <pc:spChg chg="add mod">
          <ac:chgData name="Sartorius, Carol" userId="717f8656-0c6f-4128-8672-6a166f4ce149" providerId="ADAL" clId="{7EF6F3C4-4684-4338-9CE2-2316932B4716}" dt="2024-11-27T19:22:45.558" v="293" actId="555"/>
          <ac:spMkLst>
            <pc:docMk/>
            <pc:sldMk cId="3004741895" sldId="264"/>
            <ac:spMk id="41" creationId="{6959AB70-FF7D-0C45-CA7E-9D7DC046A438}"/>
          </ac:spMkLst>
        </pc:spChg>
        <pc:spChg chg="add mod">
          <ac:chgData name="Sartorius, Carol" userId="717f8656-0c6f-4128-8672-6a166f4ce149" providerId="ADAL" clId="{7EF6F3C4-4684-4338-9CE2-2316932B4716}" dt="2024-11-27T19:23:42.256" v="313" actId="1037"/>
          <ac:spMkLst>
            <pc:docMk/>
            <pc:sldMk cId="3004741895" sldId="264"/>
            <ac:spMk id="42" creationId="{FFC4FBD3-99DE-98B4-5C5F-51D53E680971}"/>
          </ac:spMkLst>
        </pc:spChg>
        <pc:spChg chg="add mod">
          <ac:chgData name="Sartorius, Carol" userId="717f8656-0c6f-4128-8672-6a166f4ce149" providerId="ADAL" clId="{7EF6F3C4-4684-4338-9CE2-2316932B4716}" dt="2024-11-27T19:25:14.138" v="415" actId="1038"/>
          <ac:spMkLst>
            <pc:docMk/>
            <pc:sldMk cId="3004741895" sldId="264"/>
            <ac:spMk id="43" creationId="{F0D0B9FE-5E93-CE64-397F-D0317ED54EA4}"/>
          </ac:spMkLst>
        </pc:spChg>
        <pc:spChg chg="add mod">
          <ac:chgData name="Sartorius, Carol" userId="717f8656-0c6f-4128-8672-6a166f4ce149" providerId="ADAL" clId="{7EF6F3C4-4684-4338-9CE2-2316932B4716}" dt="2024-11-27T19:25:07.057" v="401" actId="1038"/>
          <ac:spMkLst>
            <pc:docMk/>
            <pc:sldMk cId="3004741895" sldId="264"/>
            <ac:spMk id="44" creationId="{A4A78C9D-8505-EB62-5D74-98705FFEC561}"/>
          </ac:spMkLst>
        </pc:spChg>
        <pc:spChg chg="add mod">
          <ac:chgData name="Sartorius, Carol" userId="717f8656-0c6f-4128-8672-6a166f4ce149" providerId="ADAL" clId="{7EF6F3C4-4684-4338-9CE2-2316932B4716}" dt="2024-11-27T19:25:03.005" v="392" actId="1038"/>
          <ac:spMkLst>
            <pc:docMk/>
            <pc:sldMk cId="3004741895" sldId="264"/>
            <ac:spMk id="46" creationId="{CCCC86D0-2EC2-883F-2E2C-93D5D7AEC960}"/>
          </ac:spMkLst>
        </pc:spChg>
        <pc:spChg chg="add mod">
          <ac:chgData name="Sartorius, Carol" userId="717f8656-0c6f-4128-8672-6a166f4ce149" providerId="ADAL" clId="{7EF6F3C4-4684-4338-9CE2-2316932B4716}" dt="2024-11-27T19:23:31.195" v="302" actId="1037"/>
          <ac:spMkLst>
            <pc:docMk/>
            <pc:sldMk cId="3004741895" sldId="264"/>
            <ac:spMk id="47" creationId="{BD5530B7-BBB6-2FFD-8A6B-6F7C9F632B81}"/>
          </ac:spMkLst>
        </pc:spChg>
        <pc:spChg chg="add mod">
          <ac:chgData name="Sartorius, Carol" userId="717f8656-0c6f-4128-8672-6a166f4ce149" providerId="ADAL" clId="{7EF6F3C4-4684-4338-9CE2-2316932B4716}" dt="2024-11-27T19:23:20.137" v="296" actId="555"/>
          <ac:spMkLst>
            <pc:docMk/>
            <pc:sldMk cId="3004741895" sldId="264"/>
            <ac:spMk id="48" creationId="{5E82068B-3E87-2DB2-A55D-3554D77276A7}"/>
          </ac:spMkLst>
        </pc:spChg>
        <pc:spChg chg="add del mod">
          <ac:chgData name="Sartorius, Carol" userId="717f8656-0c6f-4128-8672-6a166f4ce149" providerId="ADAL" clId="{7EF6F3C4-4684-4338-9CE2-2316932B4716}" dt="2024-11-27T19:29:18.081" v="580" actId="478"/>
          <ac:spMkLst>
            <pc:docMk/>
            <pc:sldMk cId="3004741895" sldId="264"/>
            <ac:spMk id="50" creationId="{60EA168E-6387-A1C1-A0C8-4B3602FE1670}"/>
          </ac:spMkLst>
        </pc:spChg>
        <pc:spChg chg="add mod">
          <ac:chgData name="Sartorius, Carol" userId="717f8656-0c6f-4128-8672-6a166f4ce149" providerId="ADAL" clId="{7EF6F3C4-4684-4338-9CE2-2316932B4716}" dt="2024-11-27T19:23:20.137" v="296" actId="555"/>
          <ac:spMkLst>
            <pc:docMk/>
            <pc:sldMk cId="3004741895" sldId="264"/>
            <ac:spMk id="52" creationId="{0DC77D11-9A82-FD8A-92D9-09AF98EBCFBC}"/>
          </ac:spMkLst>
        </pc:spChg>
        <pc:spChg chg="add mod">
          <ac:chgData name="Sartorius, Carol" userId="717f8656-0c6f-4128-8672-6a166f4ce149" providerId="ADAL" clId="{7EF6F3C4-4684-4338-9CE2-2316932B4716}" dt="2024-11-27T19:22:21.326" v="291" actId="1076"/>
          <ac:spMkLst>
            <pc:docMk/>
            <pc:sldMk cId="3004741895" sldId="264"/>
            <ac:spMk id="54" creationId="{8E7638D4-D410-E696-7979-70D1D893B9F8}"/>
          </ac:spMkLst>
        </pc:spChg>
        <pc:spChg chg="add mod">
          <ac:chgData name="Sartorius, Carol" userId="717f8656-0c6f-4128-8672-6a166f4ce149" providerId="ADAL" clId="{7EF6F3C4-4684-4338-9CE2-2316932B4716}" dt="2024-11-27T19:26:50.023" v="447" actId="1037"/>
          <ac:spMkLst>
            <pc:docMk/>
            <pc:sldMk cId="3004741895" sldId="264"/>
            <ac:spMk id="55" creationId="{4ECA8521-5D79-29A3-C57E-EE04BD334A9C}"/>
          </ac:spMkLst>
        </pc:spChg>
        <pc:spChg chg="add mod">
          <ac:chgData name="Sartorius, Carol" userId="717f8656-0c6f-4128-8672-6a166f4ce149" providerId="ADAL" clId="{7EF6F3C4-4684-4338-9CE2-2316932B4716}" dt="2024-11-27T19:26:58.374" v="464" actId="1037"/>
          <ac:spMkLst>
            <pc:docMk/>
            <pc:sldMk cId="3004741895" sldId="264"/>
            <ac:spMk id="56" creationId="{4D55BA06-91D3-60E2-B34D-67CF936C9B1C}"/>
          </ac:spMkLst>
        </pc:spChg>
        <pc:spChg chg="add mod">
          <ac:chgData name="Sartorius, Carol" userId="717f8656-0c6f-4128-8672-6a166f4ce149" providerId="ADAL" clId="{7EF6F3C4-4684-4338-9CE2-2316932B4716}" dt="2024-11-27T19:27:05.940" v="471" actId="1037"/>
          <ac:spMkLst>
            <pc:docMk/>
            <pc:sldMk cId="3004741895" sldId="264"/>
            <ac:spMk id="57" creationId="{19729210-62E8-F24A-968C-9826CB9E5BE5}"/>
          </ac:spMkLst>
        </pc:spChg>
        <pc:spChg chg="add mod">
          <ac:chgData name="Sartorius, Carol" userId="717f8656-0c6f-4128-8672-6a166f4ce149" providerId="ADAL" clId="{7EF6F3C4-4684-4338-9CE2-2316932B4716}" dt="2024-11-27T19:27:10.841" v="480" actId="1037"/>
          <ac:spMkLst>
            <pc:docMk/>
            <pc:sldMk cId="3004741895" sldId="264"/>
            <ac:spMk id="58" creationId="{EA430C4E-87E1-F8A8-63C1-4138D8B1DD3F}"/>
          </ac:spMkLst>
        </pc:spChg>
        <pc:spChg chg="add mod">
          <ac:chgData name="Sartorius, Carol" userId="717f8656-0c6f-4128-8672-6a166f4ce149" providerId="ADAL" clId="{7EF6F3C4-4684-4338-9CE2-2316932B4716}" dt="2024-11-27T19:27:15.988" v="489" actId="1037"/>
          <ac:spMkLst>
            <pc:docMk/>
            <pc:sldMk cId="3004741895" sldId="264"/>
            <ac:spMk id="59" creationId="{5153D5EA-EE60-1005-A661-B419D8E74F82}"/>
          </ac:spMkLst>
        </pc:spChg>
        <pc:spChg chg="add mod">
          <ac:chgData name="Sartorius, Carol" userId="717f8656-0c6f-4128-8672-6a166f4ce149" providerId="ADAL" clId="{7EF6F3C4-4684-4338-9CE2-2316932B4716}" dt="2024-11-27T19:27:20.339" v="497" actId="1038"/>
          <ac:spMkLst>
            <pc:docMk/>
            <pc:sldMk cId="3004741895" sldId="264"/>
            <ac:spMk id="60" creationId="{E731CF68-AB51-FD3E-21E8-F17C09F84766}"/>
          </ac:spMkLst>
        </pc:spChg>
        <pc:spChg chg="add del mod">
          <ac:chgData name="Sartorius, Carol" userId="717f8656-0c6f-4128-8672-6a166f4ce149" providerId="ADAL" clId="{7EF6F3C4-4684-4338-9CE2-2316932B4716}" dt="2024-11-27T19:27:30.089" v="510" actId="478"/>
          <ac:spMkLst>
            <pc:docMk/>
            <pc:sldMk cId="3004741895" sldId="264"/>
            <ac:spMk id="61" creationId="{E0B466E4-82AF-5B3E-1824-4CE27D2256AC}"/>
          </ac:spMkLst>
        </pc:spChg>
        <pc:spChg chg="add mod">
          <ac:chgData name="Sartorius, Carol" userId="717f8656-0c6f-4128-8672-6a166f4ce149" providerId="ADAL" clId="{7EF6F3C4-4684-4338-9CE2-2316932B4716}" dt="2024-11-27T19:22:45.558" v="293" actId="555"/>
          <ac:spMkLst>
            <pc:docMk/>
            <pc:sldMk cId="3004741895" sldId="264"/>
            <ac:spMk id="62" creationId="{A97EEA04-5C5C-48AA-0669-9F268F036505}"/>
          </ac:spMkLst>
        </pc:spChg>
        <pc:spChg chg="add mod">
          <ac:chgData name="Sartorius, Carol" userId="717f8656-0c6f-4128-8672-6a166f4ce149" providerId="ADAL" clId="{7EF6F3C4-4684-4338-9CE2-2316932B4716}" dt="2024-11-27T19:27:35.471" v="515" actId="1038"/>
          <ac:spMkLst>
            <pc:docMk/>
            <pc:sldMk cId="3004741895" sldId="264"/>
            <ac:spMk id="63" creationId="{9078C77D-C6A8-F12D-EB8C-53E6A3139D24}"/>
          </ac:spMkLst>
        </pc:spChg>
        <pc:spChg chg="add del mod">
          <ac:chgData name="Sartorius, Carol" userId="717f8656-0c6f-4128-8672-6a166f4ce149" providerId="ADAL" clId="{7EF6F3C4-4684-4338-9CE2-2316932B4716}" dt="2024-11-27T19:26:25.469" v="422" actId="478"/>
          <ac:spMkLst>
            <pc:docMk/>
            <pc:sldMk cId="3004741895" sldId="264"/>
            <ac:spMk id="64" creationId="{BA5BB1B0-1931-2FBE-3554-D58D86DC6C18}"/>
          </ac:spMkLst>
        </pc:spChg>
        <pc:spChg chg="add mod">
          <ac:chgData name="Sartorius, Carol" userId="717f8656-0c6f-4128-8672-6a166f4ce149" providerId="ADAL" clId="{7EF6F3C4-4684-4338-9CE2-2316932B4716}" dt="2024-11-27T19:22:54.715" v="294" actId="3064"/>
          <ac:spMkLst>
            <pc:docMk/>
            <pc:sldMk cId="3004741895" sldId="264"/>
            <ac:spMk id="65" creationId="{957F91A5-3EFA-B3E3-8D12-E7425B5BD4AB}"/>
          </ac:spMkLst>
        </pc:spChg>
        <pc:spChg chg="add mod">
          <ac:chgData name="Sartorius, Carol" userId="717f8656-0c6f-4128-8672-6a166f4ce149" providerId="ADAL" clId="{7EF6F3C4-4684-4338-9CE2-2316932B4716}" dt="2024-11-27T19:22:54.715" v="294" actId="3064"/>
          <ac:spMkLst>
            <pc:docMk/>
            <pc:sldMk cId="3004741895" sldId="264"/>
            <ac:spMk id="66" creationId="{DD4BD6C1-6F7B-1D90-28B5-91A97BC6398A}"/>
          </ac:spMkLst>
        </pc:spChg>
        <pc:spChg chg="add mod">
          <ac:chgData name="Sartorius, Carol" userId="717f8656-0c6f-4128-8672-6a166f4ce149" providerId="ADAL" clId="{7EF6F3C4-4684-4338-9CE2-2316932B4716}" dt="2024-11-27T19:22:21.326" v="291" actId="1076"/>
          <ac:spMkLst>
            <pc:docMk/>
            <pc:sldMk cId="3004741895" sldId="264"/>
            <ac:spMk id="67" creationId="{08DF3DEB-C514-9752-EA92-218D2AE6A5C3}"/>
          </ac:spMkLst>
        </pc:spChg>
        <pc:spChg chg="add mod">
          <ac:chgData name="Sartorius, Carol" userId="717f8656-0c6f-4128-8672-6a166f4ce149" providerId="ADAL" clId="{7EF6F3C4-4684-4338-9CE2-2316932B4716}" dt="2024-11-27T19:22:21.326" v="291" actId="1076"/>
          <ac:spMkLst>
            <pc:docMk/>
            <pc:sldMk cId="3004741895" sldId="264"/>
            <ac:spMk id="68" creationId="{B95B00F6-B357-1F52-3B9E-3C2C0659F804}"/>
          </ac:spMkLst>
        </pc:spChg>
        <pc:spChg chg="add mod">
          <ac:chgData name="Sartorius, Carol" userId="717f8656-0c6f-4128-8672-6a166f4ce149" providerId="ADAL" clId="{7EF6F3C4-4684-4338-9CE2-2316932B4716}" dt="2024-11-27T19:24:31.464" v="379"/>
          <ac:spMkLst>
            <pc:docMk/>
            <pc:sldMk cId="3004741895" sldId="264"/>
            <ac:spMk id="71" creationId="{C3290AC1-2CAB-9AF6-8D1F-EF12B4EE04FC}"/>
          </ac:spMkLst>
        </pc:spChg>
        <pc:spChg chg="add mod">
          <ac:chgData name="Sartorius, Carol" userId="717f8656-0c6f-4128-8672-6a166f4ce149" providerId="ADAL" clId="{7EF6F3C4-4684-4338-9CE2-2316932B4716}" dt="2024-11-27T19:24:31.464" v="379"/>
          <ac:spMkLst>
            <pc:docMk/>
            <pc:sldMk cId="3004741895" sldId="264"/>
            <ac:spMk id="72" creationId="{6959AB70-FF7D-0C45-CA7E-9D7DC046A438}"/>
          </ac:spMkLst>
        </pc:spChg>
        <pc:spChg chg="add mod">
          <ac:chgData name="Sartorius, Carol" userId="717f8656-0c6f-4128-8672-6a166f4ce149" providerId="ADAL" clId="{7EF6F3C4-4684-4338-9CE2-2316932B4716}" dt="2024-11-27T19:24:31.464" v="379"/>
          <ac:spMkLst>
            <pc:docMk/>
            <pc:sldMk cId="3004741895" sldId="264"/>
            <ac:spMk id="73" creationId="{FFC4FBD3-99DE-98B4-5C5F-51D53E680971}"/>
          </ac:spMkLst>
        </pc:spChg>
        <pc:spChg chg="add mod">
          <ac:chgData name="Sartorius, Carol" userId="717f8656-0c6f-4128-8672-6a166f4ce149" providerId="ADAL" clId="{7EF6F3C4-4684-4338-9CE2-2316932B4716}" dt="2024-11-27T19:24:31.464" v="379"/>
          <ac:spMkLst>
            <pc:docMk/>
            <pc:sldMk cId="3004741895" sldId="264"/>
            <ac:spMk id="74" creationId="{F0D0B9FE-5E93-CE64-397F-D0317ED54EA4}"/>
          </ac:spMkLst>
        </pc:spChg>
        <pc:spChg chg="add mod">
          <ac:chgData name="Sartorius, Carol" userId="717f8656-0c6f-4128-8672-6a166f4ce149" providerId="ADAL" clId="{7EF6F3C4-4684-4338-9CE2-2316932B4716}" dt="2024-11-27T19:24:31.464" v="379"/>
          <ac:spMkLst>
            <pc:docMk/>
            <pc:sldMk cId="3004741895" sldId="264"/>
            <ac:spMk id="75" creationId="{A4A78C9D-8505-EB62-5D74-98705FFEC561}"/>
          </ac:spMkLst>
        </pc:spChg>
        <pc:spChg chg="add mod">
          <ac:chgData name="Sartorius, Carol" userId="717f8656-0c6f-4128-8672-6a166f4ce149" providerId="ADAL" clId="{7EF6F3C4-4684-4338-9CE2-2316932B4716}" dt="2024-11-27T19:24:31.464" v="379"/>
          <ac:spMkLst>
            <pc:docMk/>
            <pc:sldMk cId="3004741895" sldId="264"/>
            <ac:spMk id="76" creationId="{CCCC86D0-2EC2-883F-2E2C-93D5D7AEC960}"/>
          </ac:spMkLst>
        </pc:spChg>
        <pc:spChg chg="add mod">
          <ac:chgData name="Sartorius, Carol" userId="717f8656-0c6f-4128-8672-6a166f4ce149" providerId="ADAL" clId="{7EF6F3C4-4684-4338-9CE2-2316932B4716}" dt="2024-11-27T19:24:31.464" v="379"/>
          <ac:spMkLst>
            <pc:docMk/>
            <pc:sldMk cId="3004741895" sldId="264"/>
            <ac:spMk id="77" creationId="{BD5530B7-BBB6-2FFD-8A6B-6F7C9F632B81}"/>
          </ac:spMkLst>
        </pc:spChg>
        <pc:spChg chg="add mod">
          <ac:chgData name="Sartorius, Carol" userId="717f8656-0c6f-4128-8672-6a166f4ce149" providerId="ADAL" clId="{7EF6F3C4-4684-4338-9CE2-2316932B4716}" dt="2024-11-27T19:24:31.464" v="379"/>
          <ac:spMkLst>
            <pc:docMk/>
            <pc:sldMk cId="3004741895" sldId="264"/>
            <ac:spMk id="78" creationId="{5E82068B-3E87-2DB2-A55D-3554D77276A7}"/>
          </ac:spMkLst>
        </pc:spChg>
        <pc:spChg chg="add mod">
          <ac:chgData name="Sartorius, Carol" userId="717f8656-0c6f-4128-8672-6a166f4ce149" providerId="ADAL" clId="{7EF6F3C4-4684-4338-9CE2-2316932B4716}" dt="2024-11-27T19:24:31.464" v="379"/>
          <ac:spMkLst>
            <pc:docMk/>
            <pc:sldMk cId="3004741895" sldId="264"/>
            <ac:spMk id="79" creationId="{60EA168E-6387-A1C1-A0C8-4B3602FE1670}"/>
          </ac:spMkLst>
        </pc:spChg>
        <pc:spChg chg="add mod">
          <ac:chgData name="Sartorius, Carol" userId="717f8656-0c6f-4128-8672-6a166f4ce149" providerId="ADAL" clId="{7EF6F3C4-4684-4338-9CE2-2316932B4716}" dt="2024-11-27T19:24:31.464" v="379"/>
          <ac:spMkLst>
            <pc:docMk/>
            <pc:sldMk cId="3004741895" sldId="264"/>
            <ac:spMk id="80" creationId="{0DC77D11-9A82-FD8A-92D9-09AF98EBCFBC}"/>
          </ac:spMkLst>
        </pc:spChg>
        <pc:spChg chg="add mod">
          <ac:chgData name="Sartorius, Carol" userId="717f8656-0c6f-4128-8672-6a166f4ce149" providerId="ADAL" clId="{7EF6F3C4-4684-4338-9CE2-2316932B4716}" dt="2024-11-27T19:24:31.464" v="379"/>
          <ac:spMkLst>
            <pc:docMk/>
            <pc:sldMk cId="3004741895" sldId="264"/>
            <ac:spMk id="81" creationId="{8E7638D4-D410-E696-7979-70D1D893B9F8}"/>
          </ac:spMkLst>
        </pc:spChg>
        <pc:spChg chg="add mod">
          <ac:chgData name="Sartorius, Carol" userId="717f8656-0c6f-4128-8672-6a166f4ce149" providerId="ADAL" clId="{7EF6F3C4-4684-4338-9CE2-2316932B4716}" dt="2024-11-27T19:24:31.464" v="379"/>
          <ac:spMkLst>
            <pc:docMk/>
            <pc:sldMk cId="3004741895" sldId="264"/>
            <ac:spMk id="82" creationId="{4ECA8521-5D79-29A3-C57E-EE04BD334A9C}"/>
          </ac:spMkLst>
        </pc:spChg>
        <pc:spChg chg="add mod">
          <ac:chgData name="Sartorius, Carol" userId="717f8656-0c6f-4128-8672-6a166f4ce149" providerId="ADAL" clId="{7EF6F3C4-4684-4338-9CE2-2316932B4716}" dt="2024-11-27T19:24:31.464" v="379"/>
          <ac:spMkLst>
            <pc:docMk/>
            <pc:sldMk cId="3004741895" sldId="264"/>
            <ac:spMk id="83" creationId="{4D55BA06-91D3-60E2-B34D-67CF936C9B1C}"/>
          </ac:spMkLst>
        </pc:spChg>
        <pc:spChg chg="add mod">
          <ac:chgData name="Sartorius, Carol" userId="717f8656-0c6f-4128-8672-6a166f4ce149" providerId="ADAL" clId="{7EF6F3C4-4684-4338-9CE2-2316932B4716}" dt="2024-11-27T19:24:31.464" v="379"/>
          <ac:spMkLst>
            <pc:docMk/>
            <pc:sldMk cId="3004741895" sldId="264"/>
            <ac:spMk id="84" creationId="{19729210-62E8-F24A-968C-9826CB9E5BE5}"/>
          </ac:spMkLst>
        </pc:spChg>
        <pc:spChg chg="add mod">
          <ac:chgData name="Sartorius, Carol" userId="717f8656-0c6f-4128-8672-6a166f4ce149" providerId="ADAL" clId="{7EF6F3C4-4684-4338-9CE2-2316932B4716}" dt="2024-11-27T19:24:31.464" v="379"/>
          <ac:spMkLst>
            <pc:docMk/>
            <pc:sldMk cId="3004741895" sldId="264"/>
            <ac:spMk id="85" creationId="{EA430C4E-87E1-F8A8-63C1-4138D8B1DD3F}"/>
          </ac:spMkLst>
        </pc:spChg>
        <pc:spChg chg="add mod">
          <ac:chgData name="Sartorius, Carol" userId="717f8656-0c6f-4128-8672-6a166f4ce149" providerId="ADAL" clId="{7EF6F3C4-4684-4338-9CE2-2316932B4716}" dt="2024-11-27T19:24:31.464" v="379"/>
          <ac:spMkLst>
            <pc:docMk/>
            <pc:sldMk cId="3004741895" sldId="264"/>
            <ac:spMk id="86" creationId="{5153D5EA-EE60-1005-A661-B419D8E74F82}"/>
          </ac:spMkLst>
        </pc:spChg>
        <pc:spChg chg="add mod">
          <ac:chgData name="Sartorius, Carol" userId="717f8656-0c6f-4128-8672-6a166f4ce149" providerId="ADAL" clId="{7EF6F3C4-4684-4338-9CE2-2316932B4716}" dt="2024-11-27T19:24:31.464" v="379"/>
          <ac:spMkLst>
            <pc:docMk/>
            <pc:sldMk cId="3004741895" sldId="264"/>
            <ac:spMk id="87" creationId="{E731CF68-AB51-FD3E-21E8-F17C09F84766}"/>
          </ac:spMkLst>
        </pc:spChg>
        <pc:spChg chg="add mod">
          <ac:chgData name="Sartorius, Carol" userId="717f8656-0c6f-4128-8672-6a166f4ce149" providerId="ADAL" clId="{7EF6F3C4-4684-4338-9CE2-2316932B4716}" dt="2024-11-27T19:24:31.464" v="379"/>
          <ac:spMkLst>
            <pc:docMk/>
            <pc:sldMk cId="3004741895" sldId="264"/>
            <ac:spMk id="88" creationId="{E0B466E4-82AF-5B3E-1824-4CE27D2256AC}"/>
          </ac:spMkLst>
        </pc:spChg>
        <pc:spChg chg="add mod">
          <ac:chgData name="Sartorius, Carol" userId="717f8656-0c6f-4128-8672-6a166f4ce149" providerId="ADAL" clId="{7EF6F3C4-4684-4338-9CE2-2316932B4716}" dt="2024-11-27T19:24:31.464" v="379"/>
          <ac:spMkLst>
            <pc:docMk/>
            <pc:sldMk cId="3004741895" sldId="264"/>
            <ac:spMk id="89" creationId="{A97EEA04-5C5C-48AA-0669-9F268F036505}"/>
          </ac:spMkLst>
        </pc:spChg>
        <pc:spChg chg="add mod">
          <ac:chgData name="Sartorius, Carol" userId="717f8656-0c6f-4128-8672-6a166f4ce149" providerId="ADAL" clId="{7EF6F3C4-4684-4338-9CE2-2316932B4716}" dt="2024-11-27T19:24:31.464" v="379"/>
          <ac:spMkLst>
            <pc:docMk/>
            <pc:sldMk cId="3004741895" sldId="264"/>
            <ac:spMk id="90" creationId="{9078C77D-C6A8-F12D-EB8C-53E6A3139D24}"/>
          </ac:spMkLst>
        </pc:spChg>
        <pc:spChg chg="add mod">
          <ac:chgData name="Sartorius, Carol" userId="717f8656-0c6f-4128-8672-6a166f4ce149" providerId="ADAL" clId="{7EF6F3C4-4684-4338-9CE2-2316932B4716}" dt="2024-11-27T19:24:31.464" v="379"/>
          <ac:spMkLst>
            <pc:docMk/>
            <pc:sldMk cId="3004741895" sldId="264"/>
            <ac:spMk id="91" creationId="{BA5BB1B0-1931-2FBE-3554-D58D86DC6C18}"/>
          </ac:spMkLst>
        </pc:spChg>
        <pc:spChg chg="add mod">
          <ac:chgData name="Sartorius, Carol" userId="717f8656-0c6f-4128-8672-6a166f4ce149" providerId="ADAL" clId="{7EF6F3C4-4684-4338-9CE2-2316932B4716}" dt="2024-11-27T19:24:31.464" v="379"/>
          <ac:spMkLst>
            <pc:docMk/>
            <pc:sldMk cId="3004741895" sldId="264"/>
            <ac:spMk id="92" creationId="{957F91A5-3EFA-B3E3-8D12-E7425B5BD4AB}"/>
          </ac:spMkLst>
        </pc:spChg>
        <pc:spChg chg="add mod">
          <ac:chgData name="Sartorius, Carol" userId="717f8656-0c6f-4128-8672-6a166f4ce149" providerId="ADAL" clId="{7EF6F3C4-4684-4338-9CE2-2316932B4716}" dt="2024-11-27T19:24:31.464" v="379"/>
          <ac:spMkLst>
            <pc:docMk/>
            <pc:sldMk cId="3004741895" sldId="264"/>
            <ac:spMk id="93" creationId="{DD4BD6C1-6F7B-1D90-28B5-91A97BC6398A}"/>
          </ac:spMkLst>
        </pc:spChg>
        <pc:spChg chg="add mod">
          <ac:chgData name="Sartorius, Carol" userId="717f8656-0c6f-4128-8672-6a166f4ce149" providerId="ADAL" clId="{7EF6F3C4-4684-4338-9CE2-2316932B4716}" dt="2024-11-27T19:24:31.464" v="379"/>
          <ac:spMkLst>
            <pc:docMk/>
            <pc:sldMk cId="3004741895" sldId="264"/>
            <ac:spMk id="94" creationId="{08DF3DEB-C514-9752-EA92-218D2AE6A5C3}"/>
          </ac:spMkLst>
        </pc:spChg>
        <pc:spChg chg="add mod">
          <ac:chgData name="Sartorius, Carol" userId="717f8656-0c6f-4128-8672-6a166f4ce149" providerId="ADAL" clId="{7EF6F3C4-4684-4338-9CE2-2316932B4716}" dt="2024-11-27T19:24:31.464" v="379"/>
          <ac:spMkLst>
            <pc:docMk/>
            <pc:sldMk cId="3004741895" sldId="264"/>
            <ac:spMk id="95" creationId="{B95B00F6-B357-1F52-3B9E-3C2C0659F804}"/>
          </ac:spMkLst>
        </pc:spChg>
        <pc:spChg chg="add mod">
          <ac:chgData name="Sartorius, Carol" userId="717f8656-0c6f-4128-8672-6a166f4ce149" providerId="ADAL" clId="{7EF6F3C4-4684-4338-9CE2-2316932B4716}" dt="2024-11-27T19:25:27.120" v="417" actId="1076"/>
          <ac:spMkLst>
            <pc:docMk/>
            <pc:sldMk cId="3004741895" sldId="264"/>
            <ac:spMk id="96" creationId="{5E0DE7AA-8337-C2F1-435A-67F32261CF71}"/>
          </ac:spMkLst>
        </pc:spChg>
        <pc:spChg chg="add mod">
          <ac:chgData name="Sartorius, Carol" userId="717f8656-0c6f-4128-8672-6a166f4ce149" providerId="ADAL" clId="{7EF6F3C4-4684-4338-9CE2-2316932B4716}" dt="2024-11-27T19:26:54.211" v="455" actId="1037"/>
          <ac:spMkLst>
            <pc:docMk/>
            <pc:sldMk cId="3004741895" sldId="264"/>
            <ac:spMk id="97" creationId="{E109B43B-BB2D-95B8-CF61-B1CD1E543591}"/>
          </ac:spMkLst>
        </pc:spChg>
        <pc:spChg chg="mod">
          <ac:chgData name="Sartorius, Carol" userId="717f8656-0c6f-4128-8672-6a166f4ce149" providerId="ADAL" clId="{7EF6F3C4-4684-4338-9CE2-2316932B4716}" dt="2024-11-27T19:22:54.715" v="294" actId="3064"/>
          <ac:spMkLst>
            <pc:docMk/>
            <pc:sldMk cId="3004741895" sldId="264"/>
            <ac:spMk id="102" creationId="{B60004C9-2797-2AB6-D9BE-481A07013CAA}"/>
          </ac:spMkLst>
        </pc:spChg>
        <pc:spChg chg="mod">
          <ac:chgData name="Sartorius, Carol" userId="717f8656-0c6f-4128-8672-6a166f4ce149" providerId="ADAL" clId="{7EF6F3C4-4684-4338-9CE2-2316932B4716}" dt="2024-11-27T19:22:21.326" v="291" actId="1076"/>
          <ac:spMkLst>
            <pc:docMk/>
            <pc:sldMk cId="3004741895" sldId="264"/>
            <ac:spMk id="103" creationId="{4FDCB41D-7B05-F41E-DFCE-4F73845975E6}"/>
          </ac:spMkLst>
        </pc:spChg>
        <pc:spChg chg="mod">
          <ac:chgData name="Sartorius, Carol" userId="717f8656-0c6f-4128-8672-6a166f4ce149" providerId="ADAL" clId="{7EF6F3C4-4684-4338-9CE2-2316932B4716}" dt="2024-11-27T19:29:35.365" v="582" actId="1076"/>
          <ac:spMkLst>
            <pc:docMk/>
            <pc:sldMk cId="3004741895" sldId="264"/>
            <ac:spMk id="106" creationId="{79360BE7-6436-C25E-57B8-A41EB6D7D8B2}"/>
          </ac:spMkLst>
        </pc:spChg>
        <pc:grpChg chg="add del mod">
          <ac:chgData name="Sartorius, Carol" userId="717f8656-0c6f-4128-8672-6a166f4ce149" providerId="ADAL" clId="{7EF6F3C4-4684-4338-9CE2-2316932B4716}" dt="2024-11-27T19:20:44.373" v="275" actId="165"/>
          <ac:grpSpMkLst>
            <pc:docMk/>
            <pc:sldMk cId="3004741895" sldId="264"/>
            <ac:grpSpMk id="36" creationId="{E464C36D-4E51-97D9-7A0E-45A4E3ED0D78}"/>
          </ac:grpSpMkLst>
        </pc:grpChg>
        <pc:grpChg chg="add del mod">
          <ac:chgData name="Sartorius, Carol" userId="717f8656-0c6f-4128-8672-6a166f4ce149" providerId="ADAL" clId="{7EF6F3C4-4684-4338-9CE2-2316932B4716}" dt="2024-11-27T19:21:16.415" v="283" actId="165"/>
          <ac:grpSpMkLst>
            <pc:docMk/>
            <pc:sldMk cId="3004741895" sldId="264"/>
            <ac:grpSpMk id="37" creationId="{945F963D-66A1-4221-6416-BFA27E3B8C0D}"/>
          </ac:grpSpMkLst>
        </pc:grpChg>
        <pc:picChg chg="add mod topLvl">
          <ac:chgData name="Sartorius, Carol" userId="717f8656-0c6f-4128-8672-6a166f4ce149" providerId="ADAL" clId="{7EF6F3C4-4684-4338-9CE2-2316932B4716}" dt="2024-11-27T19:21:16.415" v="283" actId="165"/>
          <ac:picMkLst>
            <pc:docMk/>
            <pc:sldMk cId="3004741895" sldId="264"/>
            <ac:picMk id="2" creationId="{C6F181DC-8053-8078-1092-A2A974781653}"/>
          </ac:picMkLst>
        </pc:picChg>
        <pc:picChg chg="add mod topLvl">
          <ac:chgData name="Sartorius, Carol" userId="717f8656-0c6f-4128-8672-6a166f4ce149" providerId="ADAL" clId="{7EF6F3C4-4684-4338-9CE2-2316932B4716}" dt="2024-11-27T19:21:16.415" v="283" actId="165"/>
          <ac:picMkLst>
            <pc:docMk/>
            <pc:sldMk cId="3004741895" sldId="264"/>
            <ac:picMk id="3" creationId="{840B3CF0-15A4-982E-7230-D4FD3CA0E0EF}"/>
          </ac:picMkLst>
        </pc:picChg>
        <pc:picChg chg="add mod topLvl">
          <ac:chgData name="Sartorius, Carol" userId="717f8656-0c6f-4128-8672-6a166f4ce149" providerId="ADAL" clId="{7EF6F3C4-4684-4338-9CE2-2316932B4716}" dt="2024-11-27T19:21:16.415" v="283" actId="165"/>
          <ac:picMkLst>
            <pc:docMk/>
            <pc:sldMk cId="3004741895" sldId="264"/>
            <ac:picMk id="6" creationId="{58653D6B-2F50-31AE-1FEF-F0FFFB7A439E}"/>
          </ac:picMkLst>
        </pc:picChg>
        <pc:picChg chg="add mod topLvl">
          <ac:chgData name="Sartorius, Carol" userId="717f8656-0c6f-4128-8672-6a166f4ce149" providerId="ADAL" clId="{7EF6F3C4-4684-4338-9CE2-2316932B4716}" dt="2024-11-27T19:21:16.415" v="283" actId="165"/>
          <ac:picMkLst>
            <pc:docMk/>
            <pc:sldMk cId="3004741895" sldId="264"/>
            <ac:picMk id="32" creationId="{17B7A5CC-2BE8-9043-B6E9-230B66C46964}"/>
          </ac:picMkLst>
        </pc:picChg>
        <pc:picChg chg="add mod">
          <ac:chgData name="Sartorius, Carol" userId="717f8656-0c6f-4128-8672-6a166f4ce149" providerId="ADAL" clId="{7EF6F3C4-4684-4338-9CE2-2316932B4716}" dt="2024-11-27T19:22:21.326" v="291" actId="1076"/>
          <ac:picMkLst>
            <pc:docMk/>
            <pc:sldMk cId="3004741895" sldId="264"/>
            <ac:picMk id="38" creationId="{387663DB-FC93-39FF-81A3-75B0A27C1E0C}"/>
          </ac:picMkLst>
        </pc:picChg>
        <pc:picChg chg="add mod">
          <ac:chgData name="Sartorius, Carol" userId="717f8656-0c6f-4128-8672-6a166f4ce149" providerId="ADAL" clId="{7EF6F3C4-4684-4338-9CE2-2316932B4716}" dt="2024-11-27T19:22:21.326" v="291" actId="1076"/>
          <ac:picMkLst>
            <pc:docMk/>
            <pc:sldMk cId="3004741895" sldId="264"/>
            <ac:picMk id="39" creationId="{FBCCF87B-54B6-78B8-84E5-99FAD3641F55}"/>
          </ac:picMkLst>
        </pc:picChg>
        <pc:picChg chg="del mod">
          <ac:chgData name="Sartorius, Carol" userId="717f8656-0c6f-4128-8672-6a166f4ce149" providerId="ADAL" clId="{7EF6F3C4-4684-4338-9CE2-2316932B4716}" dt="2024-11-27T19:20:54.968" v="278" actId="478"/>
          <ac:picMkLst>
            <pc:docMk/>
            <pc:sldMk cId="3004741895" sldId="264"/>
            <ac:picMk id="45" creationId="{C0ADE59B-6333-FF1A-8C0D-CB754080610C}"/>
          </ac:picMkLst>
        </pc:picChg>
        <pc:picChg chg="del mod">
          <ac:chgData name="Sartorius, Carol" userId="717f8656-0c6f-4128-8672-6a166f4ce149" providerId="ADAL" clId="{7EF6F3C4-4684-4338-9CE2-2316932B4716}" dt="2024-11-27T19:22:14.240" v="290" actId="478"/>
          <ac:picMkLst>
            <pc:docMk/>
            <pc:sldMk cId="3004741895" sldId="264"/>
            <ac:picMk id="49" creationId="{73840464-BEB4-6005-1B1E-BF7F7543ED3B}"/>
          </ac:picMkLst>
        </pc:picChg>
        <pc:picChg chg="del">
          <ac:chgData name="Sartorius, Carol" userId="717f8656-0c6f-4128-8672-6a166f4ce149" providerId="ADAL" clId="{7EF6F3C4-4684-4338-9CE2-2316932B4716}" dt="2024-11-27T19:22:08.101" v="289" actId="478"/>
          <ac:picMkLst>
            <pc:docMk/>
            <pc:sldMk cId="3004741895" sldId="264"/>
            <ac:picMk id="51" creationId="{503FAFF3-FA14-250E-3890-83333D5BE890}"/>
          </ac:picMkLst>
        </pc:picChg>
        <pc:picChg chg="add mod">
          <ac:chgData name="Sartorius, Carol" userId="717f8656-0c6f-4128-8672-6a166f4ce149" providerId="ADAL" clId="{7EF6F3C4-4684-4338-9CE2-2316932B4716}" dt="2024-11-27T19:24:31.464" v="379"/>
          <ac:picMkLst>
            <pc:docMk/>
            <pc:sldMk cId="3004741895" sldId="264"/>
            <ac:picMk id="69" creationId="{387663DB-FC93-39FF-81A3-75B0A27C1E0C}"/>
          </ac:picMkLst>
        </pc:picChg>
        <pc:picChg chg="add mod">
          <ac:chgData name="Sartorius, Carol" userId="717f8656-0c6f-4128-8672-6a166f4ce149" providerId="ADAL" clId="{7EF6F3C4-4684-4338-9CE2-2316932B4716}" dt="2024-11-27T19:24:31.464" v="379"/>
          <ac:picMkLst>
            <pc:docMk/>
            <pc:sldMk cId="3004741895" sldId="264"/>
            <ac:picMk id="70" creationId="{FBCCF87B-54B6-78B8-84E5-99FAD3641F55}"/>
          </ac:picMkLst>
        </pc:picChg>
        <pc:picChg chg="mod">
          <ac:chgData name="Sartorius, Carol" userId="717f8656-0c6f-4128-8672-6a166f4ce149" providerId="ADAL" clId="{7EF6F3C4-4684-4338-9CE2-2316932B4716}" dt="2024-11-27T19:29:28.872" v="581" actId="1076"/>
          <ac:picMkLst>
            <pc:docMk/>
            <pc:sldMk cId="3004741895" sldId="264"/>
            <ac:picMk id="105" creationId="{BE2268C8-0417-4B48-9191-7600AF933CE1}"/>
          </ac:picMkLst>
        </pc:picChg>
      </pc:sldChg>
      <pc:sldChg chg="modSp mod">
        <pc:chgData name="Sartorius, Carol" userId="717f8656-0c6f-4128-8672-6a166f4ce149" providerId="ADAL" clId="{7EF6F3C4-4684-4338-9CE2-2316932B4716}" dt="2024-11-27T20:27:03.584" v="898" actId="123"/>
        <pc:sldMkLst>
          <pc:docMk/>
          <pc:sldMk cId="2970839480" sldId="271"/>
        </pc:sldMkLst>
        <pc:spChg chg="mod">
          <ac:chgData name="Sartorius, Carol" userId="717f8656-0c6f-4128-8672-6a166f4ce149" providerId="ADAL" clId="{7EF6F3C4-4684-4338-9CE2-2316932B4716}" dt="2024-11-27T20:27:03.584" v="898" actId="123"/>
          <ac:spMkLst>
            <pc:docMk/>
            <pc:sldMk cId="2970839480" sldId="271"/>
            <ac:spMk id="2" creationId="{CA4BBAA9-3AE1-E375-30CE-E08F2A2A3BC8}"/>
          </ac:spMkLst>
        </pc:spChg>
      </pc:sldChg>
      <pc:sldChg chg="addSp delSp modSp mod">
        <pc:chgData name="Sartorius, Carol" userId="717f8656-0c6f-4128-8672-6a166f4ce149" providerId="ADAL" clId="{7EF6F3C4-4684-4338-9CE2-2316932B4716}" dt="2024-11-27T20:26:53.849" v="897" actId="20577"/>
        <pc:sldMkLst>
          <pc:docMk/>
          <pc:sldMk cId="144900757" sldId="278"/>
        </pc:sldMkLst>
        <pc:spChg chg="add mod">
          <ac:chgData name="Sartorius, Carol" userId="717f8656-0c6f-4128-8672-6a166f4ce149" providerId="ADAL" clId="{7EF6F3C4-4684-4338-9CE2-2316932B4716}" dt="2024-11-27T19:59:04.097" v="636" actId="1076"/>
          <ac:spMkLst>
            <pc:docMk/>
            <pc:sldMk cId="144900757" sldId="278"/>
            <ac:spMk id="2" creationId="{BE0CF9B2-1D76-1DDD-DB66-9A2C6B818C55}"/>
          </ac:spMkLst>
        </pc:spChg>
        <pc:spChg chg="add mod">
          <ac:chgData name="Sartorius, Carol" userId="717f8656-0c6f-4128-8672-6a166f4ce149" providerId="ADAL" clId="{7EF6F3C4-4684-4338-9CE2-2316932B4716}" dt="2024-11-27T19:59:04.097" v="636" actId="1076"/>
          <ac:spMkLst>
            <pc:docMk/>
            <pc:sldMk cId="144900757" sldId="278"/>
            <ac:spMk id="5" creationId="{D7CBA0C7-CD08-E81B-9CA4-AC7141C57561}"/>
          </ac:spMkLst>
        </pc:spChg>
        <pc:spChg chg="add mod">
          <ac:chgData name="Sartorius, Carol" userId="717f8656-0c6f-4128-8672-6a166f4ce149" providerId="ADAL" clId="{7EF6F3C4-4684-4338-9CE2-2316932B4716}" dt="2024-11-27T19:59:04.097" v="636" actId="1076"/>
          <ac:spMkLst>
            <pc:docMk/>
            <pc:sldMk cId="144900757" sldId="278"/>
            <ac:spMk id="6" creationId="{68148886-CC0D-0FFD-59B9-8ADC6C21D470}"/>
          </ac:spMkLst>
        </pc:spChg>
        <pc:spChg chg="mod">
          <ac:chgData name="Sartorius, Carol" userId="717f8656-0c6f-4128-8672-6a166f4ce149" providerId="ADAL" clId="{7EF6F3C4-4684-4338-9CE2-2316932B4716}" dt="2024-11-27T20:25:33.855" v="860" actId="403"/>
          <ac:spMkLst>
            <pc:docMk/>
            <pc:sldMk cId="144900757" sldId="278"/>
            <ac:spMk id="7" creationId="{224CA08F-BB98-330F-B08D-C2ACF5A18A1C}"/>
          </ac:spMkLst>
        </pc:spChg>
        <pc:spChg chg="mod">
          <ac:chgData name="Sartorius, Carol" userId="717f8656-0c6f-4128-8672-6a166f4ce149" providerId="ADAL" clId="{7EF6F3C4-4684-4338-9CE2-2316932B4716}" dt="2024-11-27T20:25:40.983" v="869" actId="404"/>
          <ac:spMkLst>
            <pc:docMk/>
            <pc:sldMk cId="144900757" sldId="278"/>
            <ac:spMk id="8" creationId="{74556A17-B5BC-F802-EC0A-F407F5A157C3}"/>
          </ac:spMkLst>
        </pc:spChg>
        <pc:spChg chg="add mod">
          <ac:chgData name="Sartorius, Carol" userId="717f8656-0c6f-4128-8672-6a166f4ce149" providerId="ADAL" clId="{7EF6F3C4-4684-4338-9CE2-2316932B4716}" dt="2024-11-27T19:59:04.097" v="636" actId="1076"/>
          <ac:spMkLst>
            <pc:docMk/>
            <pc:sldMk cId="144900757" sldId="278"/>
            <ac:spMk id="9" creationId="{8E4D4CE9-7EB5-E1EF-623B-54623D4EDEF4}"/>
          </ac:spMkLst>
        </pc:spChg>
        <pc:spChg chg="add mod">
          <ac:chgData name="Sartorius, Carol" userId="717f8656-0c6f-4128-8672-6a166f4ce149" providerId="ADAL" clId="{7EF6F3C4-4684-4338-9CE2-2316932B4716}" dt="2024-11-27T19:59:04.097" v="636" actId="1076"/>
          <ac:spMkLst>
            <pc:docMk/>
            <pc:sldMk cId="144900757" sldId="278"/>
            <ac:spMk id="10" creationId="{EAA65F7D-F160-5D6A-CC8E-D965DB6DFB5A}"/>
          </ac:spMkLst>
        </pc:spChg>
        <pc:spChg chg="add mod">
          <ac:chgData name="Sartorius, Carol" userId="717f8656-0c6f-4128-8672-6a166f4ce149" providerId="ADAL" clId="{7EF6F3C4-4684-4338-9CE2-2316932B4716}" dt="2024-11-27T19:59:04.097" v="636" actId="1076"/>
          <ac:spMkLst>
            <pc:docMk/>
            <pc:sldMk cId="144900757" sldId="278"/>
            <ac:spMk id="11" creationId="{DB63A565-2FDF-3B3D-40DE-B1BFC9887DC0}"/>
          </ac:spMkLst>
        </pc:spChg>
        <pc:spChg chg="add mod">
          <ac:chgData name="Sartorius, Carol" userId="717f8656-0c6f-4128-8672-6a166f4ce149" providerId="ADAL" clId="{7EF6F3C4-4684-4338-9CE2-2316932B4716}" dt="2024-11-27T19:59:04.097" v="636" actId="1076"/>
          <ac:spMkLst>
            <pc:docMk/>
            <pc:sldMk cId="144900757" sldId="278"/>
            <ac:spMk id="12" creationId="{E4F6F0D9-E131-67F5-CD51-D841B262BEBB}"/>
          </ac:spMkLst>
        </pc:spChg>
        <pc:spChg chg="add mod">
          <ac:chgData name="Sartorius, Carol" userId="717f8656-0c6f-4128-8672-6a166f4ce149" providerId="ADAL" clId="{7EF6F3C4-4684-4338-9CE2-2316932B4716}" dt="2024-11-27T19:59:04.097" v="636" actId="1076"/>
          <ac:spMkLst>
            <pc:docMk/>
            <pc:sldMk cId="144900757" sldId="278"/>
            <ac:spMk id="13" creationId="{C97DC4F3-BD65-1401-8E66-E47ED4FDEED5}"/>
          </ac:spMkLst>
        </pc:spChg>
        <pc:spChg chg="add mod">
          <ac:chgData name="Sartorius, Carol" userId="717f8656-0c6f-4128-8672-6a166f4ce149" providerId="ADAL" clId="{7EF6F3C4-4684-4338-9CE2-2316932B4716}" dt="2024-11-27T19:59:04.097" v="636" actId="1076"/>
          <ac:spMkLst>
            <pc:docMk/>
            <pc:sldMk cId="144900757" sldId="278"/>
            <ac:spMk id="14" creationId="{0B699F41-3EAB-0F5C-4CFB-875555D7F67B}"/>
          </ac:spMkLst>
        </pc:spChg>
        <pc:spChg chg="add mod">
          <ac:chgData name="Sartorius, Carol" userId="717f8656-0c6f-4128-8672-6a166f4ce149" providerId="ADAL" clId="{7EF6F3C4-4684-4338-9CE2-2316932B4716}" dt="2024-11-27T19:59:04.097" v="636" actId="1076"/>
          <ac:spMkLst>
            <pc:docMk/>
            <pc:sldMk cId="144900757" sldId="278"/>
            <ac:spMk id="15" creationId="{7EA10036-7373-0FFE-EF2C-0DF1A9996EFD}"/>
          </ac:spMkLst>
        </pc:spChg>
        <pc:spChg chg="add mod">
          <ac:chgData name="Sartorius, Carol" userId="717f8656-0c6f-4128-8672-6a166f4ce149" providerId="ADAL" clId="{7EF6F3C4-4684-4338-9CE2-2316932B4716}" dt="2024-11-27T19:59:04.097" v="636" actId="1076"/>
          <ac:spMkLst>
            <pc:docMk/>
            <pc:sldMk cId="144900757" sldId="278"/>
            <ac:spMk id="16" creationId="{2119BA06-052B-DEC8-770E-F427875F4252}"/>
          </ac:spMkLst>
        </pc:spChg>
        <pc:spChg chg="add mod">
          <ac:chgData name="Sartorius, Carol" userId="717f8656-0c6f-4128-8672-6a166f4ce149" providerId="ADAL" clId="{7EF6F3C4-4684-4338-9CE2-2316932B4716}" dt="2024-11-27T19:59:04.097" v="636" actId="1076"/>
          <ac:spMkLst>
            <pc:docMk/>
            <pc:sldMk cId="144900757" sldId="278"/>
            <ac:spMk id="17" creationId="{F5513F56-73F7-B15D-1B5E-76C7B8638DF6}"/>
          </ac:spMkLst>
        </pc:spChg>
        <pc:spChg chg="add mod">
          <ac:chgData name="Sartorius, Carol" userId="717f8656-0c6f-4128-8672-6a166f4ce149" providerId="ADAL" clId="{7EF6F3C4-4684-4338-9CE2-2316932B4716}" dt="2024-11-27T19:59:04.097" v="636" actId="1076"/>
          <ac:spMkLst>
            <pc:docMk/>
            <pc:sldMk cId="144900757" sldId="278"/>
            <ac:spMk id="18" creationId="{8198AA4E-105F-AA5D-907D-9C5BFB0CA925}"/>
          </ac:spMkLst>
        </pc:spChg>
        <pc:spChg chg="add mod">
          <ac:chgData name="Sartorius, Carol" userId="717f8656-0c6f-4128-8672-6a166f4ce149" providerId="ADAL" clId="{7EF6F3C4-4684-4338-9CE2-2316932B4716}" dt="2024-11-27T19:59:04.097" v="636" actId="1076"/>
          <ac:spMkLst>
            <pc:docMk/>
            <pc:sldMk cId="144900757" sldId="278"/>
            <ac:spMk id="20" creationId="{85479004-0761-AE7E-A43A-A68CABEE3465}"/>
          </ac:spMkLst>
        </pc:spChg>
        <pc:spChg chg="add mod">
          <ac:chgData name="Sartorius, Carol" userId="717f8656-0c6f-4128-8672-6a166f4ce149" providerId="ADAL" clId="{7EF6F3C4-4684-4338-9CE2-2316932B4716}" dt="2024-11-27T19:59:04.097" v="636" actId="1076"/>
          <ac:spMkLst>
            <pc:docMk/>
            <pc:sldMk cId="144900757" sldId="278"/>
            <ac:spMk id="22" creationId="{8546AE21-1CC7-FCCE-852B-D7C5439E91BF}"/>
          </ac:spMkLst>
        </pc:spChg>
        <pc:spChg chg="add del mod">
          <ac:chgData name="Sartorius, Carol" userId="717f8656-0c6f-4128-8672-6a166f4ce149" providerId="ADAL" clId="{7EF6F3C4-4684-4338-9CE2-2316932B4716}" dt="2024-11-27T19:59:34.425" v="640" actId="478"/>
          <ac:spMkLst>
            <pc:docMk/>
            <pc:sldMk cId="144900757" sldId="278"/>
            <ac:spMk id="25" creationId="{D4FC7E1A-2A3D-42DA-9FAF-548F7C2592D8}"/>
          </ac:spMkLst>
        </pc:spChg>
        <pc:spChg chg="mod">
          <ac:chgData name="Sartorius, Carol" userId="717f8656-0c6f-4128-8672-6a166f4ce149" providerId="ADAL" clId="{7EF6F3C4-4684-4338-9CE2-2316932B4716}" dt="2024-11-27T20:26:53.849" v="897" actId="20577"/>
          <ac:spMkLst>
            <pc:docMk/>
            <pc:sldMk cId="144900757" sldId="278"/>
            <ac:spMk id="27" creationId="{43BDFAA0-CBD9-C05F-4F54-AC80BA54F02E}"/>
          </ac:spMkLst>
        </pc:spChg>
        <pc:spChg chg="add del mod">
          <ac:chgData name="Sartorius, Carol" userId="717f8656-0c6f-4128-8672-6a166f4ce149" providerId="ADAL" clId="{7EF6F3C4-4684-4338-9CE2-2316932B4716}" dt="2024-11-27T20:05:55.737" v="821" actId="478"/>
          <ac:spMkLst>
            <pc:docMk/>
            <pc:sldMk cId="144900757" sldId="278"/>
            <ac:spMk id="28" creationId="{CC5AD3B9-7B14-D62E-9F26-B55B164031DB}"/>
          </ac:spMkLst>
        </pc:spChg>
        <pc:spChg chg="add mod">
          <ac:chgData name="Sartorius, Carol" userId="717f8656-0c6f-4128-8672-6a166f4ce149" providerId="ADAL" clId="{7EF6F3C4-4684-4338-9CE2-2316932B4716}" dt="2024-11-27T20:04:11.815" v="809" actId="404"/>
          <ac:spMkLst>
            <pc:docMk/>
            <pc:sldMk cId="144900757" sldId="278"/>
            <ac:spMk id="29" creationId="{C6D9A907-6519-9CA2-3CC1-2B0943FBF736}"/>
          </ac:spMkLst>
        </pc:spChg>
        <pc:spChg chg="add del mod">
          <ac:chgData name="Sartorius, Carol" userId="717f8656-0c6f-4128-8672-6a166f4ce149" providerId="ADAL" clId="{7EF6F3C4-4684-4338-9CE2-2316932B4716}" dt="2024-11-27T20:03:32.167" v="742" actId="478"/>
          <ac:spMkLst>
            <pc:docMk/>
            <pc:sldMk cId="144900757" sldId="278"/>
            <ac:spMk id="30" creationId="{44445348-1FFE-08E8-08F9-BBE690CF2C97}"/>
          </ac:spMkLst>
        </pc:spChg>
        <pc:spChg chg="add mod">
          <ac:chgData name="Sartorius, Carol" userId="717f8656-0c6f-4128-8672-6a166f4ce149" providerId="ADAL" clId="{7EF6F3C4-4684-4338-9CE2-2316932B4716}" dt="2024-11-27T20:03:58.429" v="799" actId="1037"/>
          <ac:spMkLst>
            <pc:docMk/>
            <pc:sldMk cId="144900757" sldId="278"/>
            <ac:spMk id="31" creationId="{5AC5FBAA-2889-1143-69DF-760E136EBFA3}"/>
          </ac:spMkLst>
        </pc:spChg>
        <pc:spChg chg="add mod">
          <ac:chgData name="Sartorius, Carol" userId="717f8656-0c6f-4128-8672-6a166f4ce149" providerId="ADAL" clId="{7EF6F3C4-4684-4338-9CE2-2316932B4716}" dt="2024-11-27T20:04:05.118" v="807" actId="1037"/>
          <ac:spMkLst>
            <pc:docMk/>
            <pc:sldMk cId="144900757" sldId="278"/>
            <ac:spMk id="32" creationId="{068F4F95-5CB3-C765-0E24-A3E26826A417}"/>
          </ac:spMkLst>
        </pc:spChg>
        <pc:spChg chg="add del mod">
          <ac:chgData name="Sartorius, Carol" userId="717f8656-0c6f-4128-8672-6a166f4ce149" providerId="ADAL" clId="{7EF6F3C4-4684-4338-9CE2-2316932B4716}" dt="2024-11-27T20:06:01.045" v="823" actId="478"/>
          <ac:spMkLst>
            <pc:docMk/>
            <pc:sldMk cId="144900757" sldId="278"/>
            <ac:spMk id="34" creationId="{7CFE64AF-1C64-C801-4279-51B5A60A3520}"/>
          </ac:spMkLst>
        </pc:spChg>
        <pc:spChg chg="add del mod">
          <ac:chgData name="Sartorius, Carol" userId="717f8656-0c6f-4128-8672-6a166f4ce149" providerId="ADAL" clId="{7EF6F3C4-4684-4338-9CE2-2316932B4716}" dt="2024-11-27T20:24:20.475" v="833" actId="478"/>
          <ac:spMkLst>
            <pc:docMk/>
            <pc:sldMk cId="144900757" sldId="278"/>
            <ac:spMk id="39" creationId="{D71D682E-FDCF-9BEB-881E-CC73DD829E58}"/>
          </ac:spMkLst>
        </pc:spChg>
        <pc:spChg chg="add mod">
          <ac:chgData name="Sartorius, Carol" userId="717f8656-0c6f-4128-8672-6a166f4ce149" providerId="ADAL" clId="{7EF6F3C4-4684-4338-9CE2-2316932B4716}" dt="2024-11-27T20:25:23.614" v="854" actId="1076"/>
          <ac:spMkLst>
            <pc:docMk/>
            <pc:sldMk cId="144900757" sldId="278"/>
            <ac:spMk id="40" creationId="{1FF6726A-ACD2-1443-55BA-F678DF0D246E}"/>
          </ac:spMkLst>
        </pc:spChg>
        <pc:spChg chg="add mod">
          <ac:chgData name="Sartorius, Carol" userId="717f8656-0c6f-4128-8672-6a166f4ce149" providerId="ADAL" clId="{7EF6F3C4-4684-4338-9CE2-2316932B4716}" dt="2024-11-27T20:25:56.690" v="891" actId="1037"/>
          <ac:spMkLst>
            <pc:docMk/>
            <pc:sldMk cId="144900757" sldId="278"/>
            <ac:spMk id="41" creationId="{3B52A14A-F452-0C16-7D76-998D9AD304B2}"/>
          </ac:spMkLst>
        </pc:spChg>
        <pc:spChg chg="add mod">
          <ac:chgData name="Sartorius, Carol" userId="717f8656-0c6f-4128-8672-6a166f4ce149" providerId="ADAL" clId="{7EF6F3C4-4684-4338-9CE2-2316932B4716}" dt="2024-11-27T20:25:48.390" v="877" actId="1038"/>
          <ac:spMkLst>
            <pc:docMk/>
            <pc:sldMk cId="144900757" sldId="278"/>
            <ac:spMk id="42" creationId="{4C337CAF-A1F0-76F2-37E5-93673032E867}"/>
          </ac:spMkLst>
        </pc:spChg>
        <pc:spChg chg="add mod">
          <ac:chgData name="Sartorius, Carol" userId="717f8656-0c6f-4128-8672-6a166f4ce149" providerId="ADAL" clId="{7EF6F3C4-4684-4338-9CE2-2316932B4716}" dt="2024-11-27T20:25:53.297" v="889" actId="1037"/>
          <ac:spMkLst>
            <pc:docMk/>
            <pc:sldMk cId="144900757" sldId="278"/>
            <ac:spMk id="43" creationId="{8F9A184C-DAF5-4B24-1115-844F74C4C745}"/>
          </ac:spMkLst>
        </pc:spChg>
        <pc:spChg chg="add del mod">
          <ac:chgData name="Sartorius, Carol" userId="717f8656-0c6f-4128-8672-6a166f4ce149" providerId="ADAL" clId="{7EF6F3C4-4684-4338-9CE2-2316932B4716}" dt="2024-11-27T20:24:16.185" v="831" actId="478"/>
          <ac:spMkLst>
            <pc:docMk/>
            <pc:sldMk cId="144900757" sldId="278"/>
            <ac:spMk id="45" creationId="{1EE465E7-D2A1-54A1-D51B-779974E9F0B7}"/>
          </ac:spMkLst>
        </pc:spChg>
        <pc:grpChg chg="add mod">
          <ac:chgData name="Sartorius, Carol" userId="717f8656-0c6f-4128-8672-6a166f4ce149" providerId="ADAL" clId="{7EF6F3C4-4684-4338-9CE2-2316932B4716}" dt="2024-11-27T20:04:39.493" v="816" actId="164"/>
          <ac:grpSpMkLst>
            <pc:docMk/>
            <pc:sldMk cId="144900757" sldId="278"/>
            <ac:grpSpMk id="37" creationId="{0270D7FB-203F-590D-17C7-D2E948000B21}"/>
          </ac:grpSpMkLst>
        </pc:grpChg>
        <pc:picChg chg="add mod">
          <ac:chgData name="Sartorius, Carol" userId="717f8656-0c6f-4128-8672-6a166f4ce149" providerId="ADAL" clId="{7EF6F3C4-4684-4338-9CE2-2316932B4716}" dt="2024-11-27T19:59:04.097" v="636" actId="1076"/>
          <ac:picMkLst>
            <pc:docMk/>
            <pc:sldMk cId="144900757" sldId="278"/>
            <ac:picMk id="3" creationId="{C383A59F-BB63-A24C-03C4-FD95FB468D03}"/>
          </ac:picMkLst>
        </pc:picChg>
        <pc:picChg chg="add mod">
          <ac:chgData name="Sartorius, Carol" userId="717f8656-0c6f-4128-8672-6a166f4ce149" providerId="ADAL" clId="{7EF6F3C4-4684-4338-9CE2-2316932B4716}" dt="2024-11-27T19:59:04.097" v="636" actId="1076"/>
          <ac:picMkLst>
            <pc:docMk/>
            <pc:sldMk cId="144900757" sldId="278"/>
            <ac:picMk id="4" creationId="{386AB2EC-CA7B-26E6-BC2D-AD95B1BA0D59}"/>
          </ac:picMkLst>
        </pc:picChg>
        <pc:picChg chg="add del mod">
          <ac:chgData name="Sartorius, Carol" userId="717f8656-0c6f-4128-8672-6a166f4ce149" providerId="ADAL" clId="{7EF6F3C4-4684-4338-9CE2-2316932B4716}" dt="2024-11-27T20:02:23.769" v="650" actId="478"/>
          <ac:picMkLst>
            <pc:docMk/>
            <pc:sldMk cId="144900757" sldId="278"/>
            <ac:picMk id="23" creationId="{A4673966-675C-8965-F006-A43127DA4AC2}"/>
          </ac:picMkLst>
        </pc:picChg>
        <pc:picChg chg="del mod">
          <ac:chgData name="Sartorius, Carol" userId="717f8656-0c6f-4128-8672-6a166f4ce149" providerId="ADAL" clId="{7EF6F3C4-4684-4338-9CE2-2316932B4716}" dt="2024-11-27T20:26:08.135" v="892" actId="478"/>
          <ac:picMkLst>
            <pc:docMk/>
            <pc:sldMk cId="144900757" sldId="278"/>
            <ac:picMk id="24" creationId="{890F7E42-068D-74D5-29E4-2529FBD402A7}"/>
          </ac:picMkLst>
        </pc:picChg>
        <pc:picChg chg="del">
          <ac:chgData name="Sartorius, Carol" userId="717f8656-0c6f-4128-8672-6a166f4ce149" providerId="ADAL" clId="{7EF6F3C4-4684-4338-9CE2-2316932B4716}" dt="2024-11-27T19:58:56.615" v="633" actId="478"/>
          <ac:picMkLst>
            <pc:docMk/>
            <pc:sldMk cId="144900757" sldId="278"/>
            <ac:picMk id="26" creationId="{3F07C977-DE53-1564-C725-BE2744B21B29}"/>
          </ac:picMkLst>
        </pc:picChg>
        <pc:picChg chg="add mod modCrop">
          <ac:chgData name="Sartorius, Carol" userId="717f8656-0c6f-4128-8672-6a166f4ce149" providerId="ADAL" clId="{7EF6F3C4-4684-4338-9CE2-2316932B4716}" dt="2024-11-27T20:04:39.493" v="816" actId="164"/>
          <ac:picMkLst>
            <pc:docMk/>
            <pc:sldMk cId="144900757" sldId="278"/>
            <ac:picMk id="35" creationId="{2D5173A5-61EA-32B7-E5EE-FF050A55C02C}"/>
          </ac:picMkLst>
        </pc:picChg>
        <pc:picChg chg="add mod modCrop">
          <ac:chgData name="Sartorius, Carol" userId="717f8656-0c6f-4128-8672-6a166f4ce149" providerId="ADAL" clId="{7EF6F3C4-4684-4338-9CE2-2316932B4716}" dt="2024-11-27T20:04:39.493" v="816" actId="164"/>
          <ac:picMkLst>
            <pc:docMk/>
            <pc:sldMk cId="144900757" sldId="278"/>
            <ac:picMk id="36" creationId="{5304953F-A5A3-2B1D-D4DB-B88091A6AFAD}"/>
          </ac:picMkLst>
        </pc:picChg>
        <pc:picChg chg="add mod">
          <ac:chgData name="Sartorius, Carol" userId="717f8656-0c6f-4128-8672-6a166f4ce149" providerId="ADAL" clId="{7EF6F3C4-4684-4338-9CE2-2316932B4716}" dt="2024-11-27T20:25:10.079" v="851" actId="1038"/>
          <ac:picMkLst>
            <pc:docMk/>
            <pc:sldMk cId="144900757" sldId="278"/>
            <ac:picMk id="38" creationId="{44D79603-99F8-2467-99FB-1F923A2EDB85}"/>
          </ac:picMkLst>
        </pc:picChg>
        <pc:cxnChg chg="add mod">
          <ac:chgData name="Sartorius, Carol" userId="717f8656-0c6f-4128-8672-6a166f4ce149" providerId="ADAL" clId="{7EF6F3C4-4684-4338-9CE2-2316932B4716}" dt="2024-11-27T19:59:04.097" v="636" actId="1076"/>
          <ac:cxnSpMkLst>
            <pc:docMk/>
            <pc:sldMk cId="144900757" sldId="278"/>
            <ac:cxnSpMk id="19" creationId="{329A67AB-C372-53D3-75D0-E174F87FFC62}"/>
          </ac:cxnSpMkLst>
        </pc:cxnChg>
        <pc:cxnChg chg="add mod">
          <ac:chgData name="Sartorius, Carol" userId="717f8656-0c6f-4128-8672-6a166f4ce149" providerId="ADAL" clId="{7EF6F3C4-4684-4338-9CE2-2316932B4716}" dt="2024-11-27T19:59:04.097" v="636" actId="1076"/>
          <ac:cxnSpMkLst>
            <pc:docMk/>
            <pc:sldMk cId="144900757" sldId="278"/>
            <ac:cxnSpMk id="21" creationId="{534F91AD-934B-C0AD-1AB4-7347A6EF36AE}"/>
          </ac:cxnSpMkLst>
        </pc:cxnChg>
        <pc:cxnChg chg="add del mod">
          <ac:chgData name="Sartorius, Carol" userId="717f8656-0c6f-4128-8672-6a166f4ce149" providerId="ADAL" clId="{7EF6F3C4-4684-4338-9CE2-2316932B4716}" dt="2024-11-27T20:05:58.040" v="822" actId="478"/>
          <ac:cxnSpMkLst>
            <pc:docMk/>
            <pc:sldMk cId="144900757" sldId="278"/>
            <ac:cxnSpMk id="33" creationId="{EE0B3EE2-52B9-7194-5775-4CD1BFBC534F}"/>
          </ac:cxnSpMkLst>
        </pc:cxnChg>
        <pc:cxnChg chg="add del mod">
          <ac:chgData name="Sartorius, Carol" userId="717f8656-0c6f-4128-8672-6a166f4ce149" providerId="ADAL" clId="{7EF6F3C4-4684-4338-9CE2-2316932B4716}" dt="2024-11-27T20:24:18.458" v="832" actId="478"/>
          <ac:cxnSpMkLst>
            <pc:docMk/>
            <pc:sldMk cId="144900757" sldId="278"/>
            <ac:cxnSpMk id="44" creationId="{A94B6C83-61EB-0DA6-E718-22718CCDDA3D}"/>
          </ac:cxnSpMkLst>
        </pc:cxnChg>
      </pc:sldChg>
      <pc:sldChg chg="addSp delSp modSp mod">
        <pc:chgData name="Sartorius, Carol" userId="717f8656-0c6f-4128-8672-6a166f4ce149" providerId="ADAL" clId="{7EF6F3C4-4684-4338-9CE2-2316932B4716}" dt="2024-11-27T19:35:17.077" v="595" actId="1035"/>
        <pc:sldMkLst>
          <pc:docMk/>
          <pc:sldMk cId="3618263079" sldId="279"/>
        </pc:sldMkLst>
        <pc:picChg chg="add mod">
          <ac:chgData name="Sartorius, Carol" userId="717f8656-0c6f-4128-8672-6a166f4ce149" providerId="ADAL" clId="{7EF6F3C4-4684-4338-9CE2-2316932B4716}" dt="2024-11-27T19:35:11.780" v="590" actId="555"/>
          <ac:picMkLst>
            <pc:docMk/>
            <pc:sldMk cId="3618263079" sldId="279"/>
            <ac:picMk id="7" creationId="{BF6F79AB-E8AF-C39A-6239-FD32D542B1AD}"/>
          </ac:picMkLst>
        </pc:picChg>
        <pc:picChg chg="mod">
          <ac:chgData name="Sartorius, Carol" userId="717f8656-0c6f-4128-8672-6a166f4ce149" providerId="ADAL" clId="{7EF6F3C4-4684-4338-9CE2-2316932B4716}" dt="2024-11-27T19:35:17.077" v="595" actId="1035"/>
          <ac:picMkLst>
            <pc:docMk/>
            <pc:sldMk cId="3618263079" sldId="279"/>
            <ac:picMk id="14" creationId="{E17F0037-2B10-91D2-0CF8-D79994FA154A}"/>
          </ac:picMkLst>
        </pc:picChg>
        <pc:picChg chg="del mod">
          <ac:chgData name="Sartorius, Carol" userId="717f8656-0c6f-4128-8672-6a166f4ce149" providerId="ADAL" clId="{7EF6F3C4-4684-4338-9CE2-2316932B4716}" dt="2024-11-27T19:34:55.542" v="588" actId="478"/>
          <ac:picMkLst>
            <pc:docMk/>
            <pc:sldMk cId="3618263079" sldId="279"/>
            <ac:picMk id="15" creationId="{08490850-10AD-50EA-40DC-FF43C37EAB97}"/>
          </ac:picMkLst>
        </pc:picChg>
      </pc:sldChg>
      <pc:sldChg chg="addSp delSp modSp mod">
        <pc:chgData name="Sartorius, Carol" userId="717f8656-0c6f-4128-8672-6a166f4ce149" providerId="ADAL" clId="{7EF6F3C4-4684-4338-9CE2-2316932B4716}" dt="2024-11-27T20:27:12.631" v="899" actId="123"/>
        <pc:sldMkLst>
          <pc:docMk/>
          <pc:sldMk cId="1268847539" sldId="280"/>
        </pc:sldMkLst>
        <pc:spChg chg="add mod">
          <ac:chgData name="Sartorius, Carol" userId="717f8656-0c6f-4128-8672-6a166f4ce149" providerId="ADAL" clId="{7EF6F3C4-4684-4338-9CE2-2316932B4716}" dt="2024-11-27T16:54:46.322" v="160" actId="1036"/>
          <ac:spMkLst>
            <pc:docMk/>
            <pc:sldMk cId="1268847539" sldId="280"/>
            <ac:spMk id="2" creationId="{6E90A044-560E-5E3B-A01D-399941935A54}"/>
          </ac:spMkLst>
        </pc:spChg>
        <pc:spChg chg="mod">
          <ac:chgData name="Sartorius, Carol" userId="717f8656-0c6f-4128-8672-6a166f4ce149" providerId="ADAL" clId="{7EF6F3C4-4684-4338-9CE2-2316932B4716}" dt="2024-11-27T20:27:12.631" v="899" actId="123"/>
          <ac:spMkLst>
            <pc:docMk/>
            <pc:sldMk cId="1268847539" sldId="280"/>
            <ac:spMk id="3" creationId="{C57E9503-4BC3-967E-3D28-93FEBFD6004D}"/>
          </ac:spMkLst>
        </pc:spChg>
        <pc:spChg chg="add mod">
          <ac:chgData name="Sartorius, Carol" userId="717f8656-0c6f-4128-8672-6a166f4ce149" providerId="ADAL" clId="{7EF6F3C4-4684-4338-9CE2-2316932B4716}" dt="2024-11-27T16:54:46.322" v="160" actId="1036"/>
          <ac:spMkLst>
            <pc:docMk/>
            <pc:sldMk cId="1268847539" sldId="280"/>
            <ac:spMk id="5" creationId="{0B17ACC6-604A-9FE7-9AAE-CBC3BEA13684}"/>
          </ac:spMkLst>
        </pc:spChg>
        <pc:spChg chg="mod">
          <ac:chgData name="Sartorius, Carol" userId="717f8656-0c6f-4128-8672-6a166f4ce149" providerId="ADAL" clId="{7EF6F3C4-4684-4338-9CE2-2316932B4716}" dt="2024-11-27T16:56:18.523" v="201" actId="113"/>
          <ac:spMkLst>
            <pc:docMk/>
            <pc:sldMk cId="1268847539" sldId="280"/>
            <ac:spMk id="12" creationId="{54FBD016-4F1A-7041-CFF6-C79F4C19EF6A}"/>
          </ac:spMkLst>
        </pc:spChg>
        <pc:spChg chg="mod">
          <ac:chgData name="Sartorius, Carol" userId="717f8656-0c6f-4128-8672-6a166f4ce149" providerId="ADAL" clId="{7EF6F3C4-4684-4338-9CE2-2316932B4716}" dt="2024-11-27T16:56:22.619" v="202" actId="113"/>
          <ac:spMkLst>
            <pc:docMk/>
            <pc:sldMk cId="1268847539" sldId="280"/>
            <ac:spMk id="13" creationId="{C9877368-A593-E105-A81F-C102903D8C97}"/>
          </ac:spMkLst>
        </pc:spChg>
        <pc:spChg chg="mod">
          <ac:chgData name="Sartorius, Carol" userId="717f8656-0c6f-4128-8672-6a166f4ce149" providerId="ADAL" clId="{7EF6F3C4-4684-4338-9CE2-2316932B4716}" dt="2024-11-27T16:57:32.581" v="268" actId="113"/>
          <ac:spMkLst>
            <pc:docMk/>
            <pc:sldMk cId="1268847539" sldId="280"/>
            <ac:spMk id="14" creationId="{EAB61C68-95DB-C54D-3C6A-6F85BAB294B6}"/>
          </ac:spMkLst>
        </pc:spChg>
        <pc:spChg chg="mod">
          <ac:chgData name="Sartorius, Carol" userId="717f8656-0c6f-4128-8672-6a166f4ce149" providerId="ADAL" clId="{7EF6F3C4-4684-4338-9CE2-2316932B4716}" dt="2024-11-27T16:57:37.977" v="269" actId="113"/>
          <ac:spMkLst>
            <pc:docMk/>
            <pc:sldMk cId="1268847539" sldId="280"/>
            <ac:spMk id="15" creationId="{43FE32CE-4338-FE41-4809-33BF867EA2CF}"/>
          </ac:spMkLst>
        </pc:spChg>
        <pc:spChg chg="mod">
          <ac:chgData name="Sartorius, Carol" userId="717f8656-0c6f-4128-8672-6a166f4ce149" providerId="ADAL" clId="{7EF6F3C4-4684-4338-9CE2-2316932B4716}" dt="2024-11-27T16:49:23.686" v="62" actId="20577"/>
          <ac:spMkLst>
            <pc:docMk/>
            <pc:sldMk cId="1268847539" sldId="280"/>
            <ac:spMk id="16" creationId="{7A1440FE-8759-4F60-7AD6-7B725A08F69D}"/>
          </ac:spMkLst>
        </pc:spChg>
        <pc:spChg chg="mod">
          <ac:chgData name="Sartorius, Carol" userId="717f8656-0c6f-4128-8672-6a166f4ce149" providerId="ADAL" clId="{7EF6F3C4-4684-4338-9CE2-2316932B4716}" dt="2024-11-27T16:49:33.517" v="66" actId="20577"/>
          <ac:spMkLst>
            <pc:docMk/>
            <pc:sldMk cId="1268847539" sldId="280"/>
            <ac:spMk id="17" creationId="{6F1D3D44-CCB1-87A2-1542-69891729A47A}"/>
          </ac:spMkLst>
        </pc:spChg>
        <pc:spChg chg="mod">
          <ac:chgData name="Sartorius, Carol" userId="717f8656-0c6f-4128-8672-6a166f4ce149" providerId="ADAL" clId="{7EF6F3C4-4684-4338-9CE2-2316932B4716}" dt="2024-11-27T16:49:27.416" v="64" actId="20577"/>
          <ac:spMkLst>
            <pc:docMk/>
            <pc:sldMk cId="1268847539" sldId="280"/>
            <ac:spMk id="18" creationId="{C517B2DC-4B53-73B8-C096-69DEB71F1CA5}"/>
          </ac:spMkLst>
        </pc:spChg>
        <pc:spChg chg="mod">
          <ac:chgData name="Sartorius, Carol" userId="717f8656-0c6f-4128-8672-6a166f4ce149" providerId="ADAL" clId="{7EF6F3C4-4684-4338-9CE2-2316932B4716}" dt="2024-11-27T16:49:36.625" v="68" actId="20577"/>
          <ac:spMkLst>
            <pc:docMk/>
            <pc:sldMk cId="1268847539" sldId="280"/>
            <ac:spMk id="19" creationId="{62F2CECE-2BB8-0483-4622-B6611ABA2ECD}"/>
          </ac:spMkLst>
        </pc:spChg>
        <pc:spChg chg="mod">
          <ac:chgData name="Sartorius, Carol" userId="717f8656-0c6f-4128-8672-6a166f4ce149" providerId="ADAL" clId="{7EF6F3C4-4684-4338-9CE2-2316932B4716}" dt="2024-11-27T16:54:58.669" v="161" actId="1076"/>
          <ac:spMkLst>
            <pc:docMk/>
            <pc:sldMk cId="1268847539" sldId="280"/>
            <ac:spMk id="20" creationId="{595FF878-81A5-DFF5-D988-65700A5F8A33}"/>
          </ac:spMkLst>
        </pc:spChg>
        <pc:spChg chg="mod">
          <ac:chgData name="Sartorius, Carol" userId="717f8656-0c6f-4128-8672-6a166f4ce149" providerId="ADAL" clId="{7EF6F3C4-4684-4338-9CE2-2316932B4716}" dt="2024-11-27T16:54:46.322" v="160" actId="1036"/>
          <ac:spMkLst>
            <pc:docMk/>
            <pc:sldMk cId="1268847539" sldId="280"/>
            <ac:spMk id="21" creationId="{66023367-BA8A-936A-3BE6-D086E738DD8C}"/>
          </ac:spMkLst>
        </pc:spChg>
        <pc:spChg chg="mod">
          <ac:chgData name="Sartorius, Carol" userId="717f8656-0c6f-4128-8672-6a166f4ce149" providerId="ADAL" clId="{7EF6F3C4-4684-4338-9CE2-2316932B4716}" dt="2024-11-27T16:54:46.322" v="160" actId="1036"/>
          <ac:spMkLst>
            <pc:docMk/>
            <pc:sldMk cId="1268847539" sldId="280"/>
            <ac:spMk id="22" creationId="{EA1297BE-002A-6BDF-E291-AC73984CC502}"/>
          </ac:spMkLst>
        </pc:spChg>
        <pc:spChg chg="mod">
          <ac:chgData name="Sartorius, Carol" userId="717f8656-0c6f-4128-8672-6a166f4ce149" providerId="ADAL" clId="{7EF6F3C4-4684-4338-9CE2-2316932B4716}" dt="2024-11-27T16:54:46.322" v="160" actId="1036"/>
          <ac:spMkLst>
            <pc:docMk/>
            <pc:sldMk cId="1268847539" sldId="280"/>
            <ac:spMk id="23" creationId="{2BCB7DAB-80B9-6043-8E4E-668A2D4704D0}"/>
          </ac:spMkLst>
        </pc:spChg>
        <pc:spChg chg="mod">
          <ac:chgData name="Sartorius, Carol" userId="717f8656-0c6f-4128-8672-6a166f4ce149" providerId="ADAL" clId="{7EF6F3C4-4684-4338-9CE2-2316932B4716}" dt="2024-11-27T16:55:08.225" v="162" actId="1076"/>
          <ac:spMkLst>
            <pc:docMk/>
            <pc:sldMk cId="1268847539" sldId="280"/>
            <ac:spMk id="24" creationId="{EB347F67-E92E-A4EA-E8C7-2092F03A0B8D}"/>
          </ac:spMkLst>
        </pc:spChg>
        <pc:spChg chg="del mod">
          <ac:chgData name="Sartorius, Carol" userId="717f8656-0c6f-4128-8672-6a166f4ce149" providerId="ADAL" clId="{7EF6F3C4-4684-4338-9CE2-2316932B4716}" dt="2024-11-27T16:54:02.449" v="139" actId="478"/>
          <ac:spMkLst>
            <pc:docMk/>
            <pc:sldMk cId="1268847539" sldId="280"/>
            <ac:spMk id="25" creationId="{D7CD10BF-E66F-DEB6-3405-650506E1E2B6}"/>
          </ac:spMkLst>
        </pc:spChg>
        <pc:spChg chg="mod">
          <ac:chgData name="Sartorius, Carol" userId="717f8656-0c6f-4128-8672-6a166f4ce149" providerId="ADAL" clId="{7EF6F3C4-4684-4338-9CE2-2316932B4716}" dt="2024-11-27T16:54:46.322" v="160" actId="1036"/>
          <ac:spMkLst>
            <pc:docMk/>
            <pc:sldMk cId="1268847539" sldId="280"/>
            <ac:spMk id="26" creationId="{2DF7CC4F-ACBF-DC94-7E7C-170990015C1E}"/>
          </ac:spMkLst>
        </pc:spChg>
        <pc:spChg chg="mod">
          <ac:chgData name="Sartorius, Carol" userId="717f8656-0c6f-4128-8672-6a166f4ce149" providerId="ADAL" clId="{7EF6F3C4-4684-4338-9CE2-2316932B4716}" dt="2024-11-27T16:54:46.322" v="160" actId="1036"/>
          <ac:spMkLst>
            <pc:docMk/>
            <pc:sldMk cId="1268847539" sldId="280"/>
            <ac:spMk id="27" creationId="{D1D215C7-2D49-90BF-BE60-D38DE33BFB56}"/>
          </ac:spMkLst>
        </pc:spChg>
        <pc:spChg chg="del">
          <ac:chgData name="Sartorius, Carol" userId="717f8656-0c6f-4128-8672-6a166f4ce149" providerId="ADAL" clId="{7EF6F3C4-4684-4338-9CE2-2316932B4716}" dt="2024-11-27T16:56:12.317" v="200" actId="478"/>
          <ac:spMkLst>
            <pc:docMk/>
            <pc:sldMk cId="1268847539" sldId="280"/>
            <ac:spMk id="28" creationId="{CF98A430-4442-A713-FDFE-D25B8B691769}"/>
          </ac:spMkLst>
        </pc:spChg>
        <pc:spChg chg="del">
          <ac:chgData name="Sartorius, Carol" userId="717f8656-0c6f-4128-8672-6a166f4ce149" providerId="ADAL" clId="{7EF6F3C4-4684-4338-9CE2-2316932B4716}" dt="2024-11-27T16:55:57.018" v="194" actId="478"/>
          <ac:spMkLst>
            <pc:docMk/>
            <pc:sldMk cId="1268847539" sldId="280"/>
            <ac:spMk id="29" creationId="{3FEE0510-F789-3930-BDB0-D09AF905EA5B}"/>
          </ac:spMkLst>
        </pc:spChg>
        <pc:spChg chg="del">
          <ac:chgData name="Sartorius, Carol" userId="717f8656-0c6f-4128-8672-6a166f4ce149" providerId="ADAL" clId="{7EF6F3C4-4684-4338-9CE2-2316932B4716}" dt="2024-11-27T16:55:57.018" v="194" actId="478"/>
          <ac:spMkLst>
            <pc:docMk/>
            <pc:sldMk cId="1268847539" sldId="280"/>
            <ac:spMk id="30" creationId="{49FCC462-B5C6-D398-88A4-47F086966C18}"/>
          </ac:spMkLst>
        </pc:spChg>
        <pc:spChg chg="del">
          <ac:chgData name="Sartorius, Carol" userId="717f8656-0c6f-4128-8672-6a166f4ce149" providerId="ADAL" clId="{7EF6F3C4-4684-4338-9CE2-2316932B4716}" dt="2024-11-27T16:55:57.018" v="194" actId="478"/>
          <ac:spMkLst>
            <pc:docMk/>
            <pc:sldMk cId="1268847539" sldId="280"/>
            <ac:spMk id="31" creationId="{104F429D-394D-646F-682D-20D351527872}"/>
          </ac:spMkLst>
        </pc:spChg>
        <pc:spChg chg="del">
          <ac:chgData name="Sartorius, Carol" userId="717f8656-0c6f-4128-8672-6a166f4ce149" providerId="ADAL" clId="{7EF6F3C4-4684-4338-9CE2-2316932B4716}" dt="2024-11-27T16:55:57.018" v="194" actId="478"/>
          <ac:spMkLst>
            <pc:docMk/>
            <pc:sldMk cId="1268847539" sldId="280"/>
            <ac:spMk id="32" creationId="{945AB2F6-267D-48E7-A653-AC9DCB726FB8}"/>
          </ac:spMkLst>
        </pc:spChg>
        <pc:spChg chg="del mod">
          <ac:chgData name="Sartorius, Carol" userId="717f8656-0c6f-4128-8672-6a166f4ce149" providerId="ADAL" clId="{7EF6F3C4-4684-4338-9CE2-2316932B4716}" dt="2024-11-27T16:56:06.179" v="198" actId="478"/>
          <ac:spMkLst>
            <pc:docMk/>
            <pc:sldMk cId="1268847539" sldId="280"/>
            <ac:spMk id="33" creationId="{3B4F9130-F109-E6E1-0198-A411C790EE1E}"/>
          </ac:spMkLst>
        </pc:spChg>
        <pc:spChg chg="del">
          <ac:chgData name="Sartorius, Carol" userId="717f8656-0c6f-4128-8672-6a166f4ce149" providerId="ADAL" clId="{7EF6F3C4-4684-4338-9CE2-2316932B4716}" dt="2024-11-27T16:56:08.760" v="199" actId="478"/>
          <ac:spMkLst>
            <pc:docMk/>
            <pc:sldMk cId="1268847539" sldId="280"/>
            <ac:spMk id="34" creationId="{639BA061-7997-F8FE-1841-5A8836442547}"/>
          </ac:spMkLst>
        </pc:spChg>
        <pc:spChg chg="del mod">
          <ac:chgData name="Sartorius, Carol" userId="717f8656-0c6f-4128-8672-6a166f4ce149" providerId="ADAL" clId="{7EF6F3C4-4684-4338-9CE2-2316932B4716}" dt="2024-11-27T16:56:02.097" v="196" actId="478"/>
          <ac:spMkLst>
            <pc:docMk/>
            <pc:sldMk cId="1268847539" sldId="280"/>
            <ac:spMk id="35" creationId="{8F75E693-B158-2CDA-D0C9-6ED2B2078FA2}"/>
          </ac:spMkLst>
        </pc:spChg>
        <pc:spChg chg="add mod">
          <ac:chgData name="Sartorius, Carol" userId="717f8656-0c6f-4128-8672-6a166f4ce149" providerId="ADAL" clId="{7EF6F3C4-4684-4338-9CE2-2316932B4716}" dt="2024-11-27T16:56:44.052" v="204" actId="1076"/>
          <ac:spMkLst>
            <pc:docMk/>
            <pc:sldMk cId="1268847539" sldId="280"/>
            <ac:spMk id="37" creationId="{5D9F8092-6147-5B29-6D10-4A209A38EBB5}"/>
          </ac:spMkLst>
        </pc:spChg>
        <pc:spChg chg="add mod">
          <ac:chgData name="Sartorius, Carol" userId="717f8656-0c6f-4128-8672-6a166f4ce149" providerId="ADAL" clId="{7EF6F3C4-4684-4338-9CE2-2316932B4716}" dt="2024-11-27T16:57:16.774" v="267" actId="1038"/>
          <ac:spMkLst>
            <pc:docMk/>
            <pc:sldMk cId="1268847539" sldId="280"/>
            <ac:spMk id="38" creationId="{216BD2F2-3249-7E31-CF3F-2F9189A00E35}"/>
          </ac:spMkLst>
        </pc:spChg>
        <pc:spChg chg="add mod">
          <ac:chgData name="Sartorius, Carol" userId="717f8656-0c6f-4128-8672-6a166f4ce149" providerId="ADAL" clId="{7EF6F3C4-4684-4338-9CE2-2316932B4716}" dt="2024-11-27T16:57:13.097" v="262" actId="1037"/>
          <ac:spMkLst>
            <pc:docMk/>
            <pc:sldMk cId="1268847539" sldId="280"/>
            <ac:spMk id="39" creationId="{EC83F223-7109-F708-5DBB-607063AB383B}"/>
          </ac:spMkLst>
        </pc:spChg>
        <pc:spChg chg="add mod">
          <ac:chgData name="Sartorius, Carol" userId="717f8656-0c6f-4128-8672-6a166f4ce149" providerId="ADAL" clId="{7EF6F3C4-4684-4338-9CE2-2316932B4716}" dt="2024-11-27T16:57:07.808" v="250" actId="1038"/>
          <ac:spMkLst>
            <pc:docMk/>
            <pc:sldMk cId="1268847539" sldId="280"/>
            <ac:spMk id="40" creationId="{9354A368-3C33-D7FD-95F7-E973144C04DE}"/>
          </ac:spMkLst>
        </pc:spChg>
        <pc:spChg chg="add mod">
          <ac:chgData name="Sartorius, Carol" userId="717f8656-0c6f-4128-8672-6a166f4ce149" providerId="ADAL" clId="{7EF6F3C4-4684-4338-9CE2-2316932B4716}" dt="2024-11-27T16:56:44.052" v="204" actId="1076"/>
          <ac:spMkLst>
            <pc:docMk/>
            <pc:sldMk cId="1268847539" sldId="280"/>
            <ac:spMk id="41" creationId="{6CB39812-E12F-97EE-0FF3-EEEF8049EC16}"/>
          </ac:spMkLst>
        </pc:spChg>
        <pc:spChg chg="add mod">
          <ac:chgData name="Sartorius, Carol" userId="717f8656-0c6f-4128-8672-6a166f4ce149" providerId="ADAL" clId="{7EF6F3C4-4684-4338-9CE2-2316932B4716}" dt="2024-11-27T16:56:56.758" v="228" actId="1038"/>
          <ac:spMkLst>
            <pc:docMk/>
            <pc:sldMk cId="1268847539" sldId="280"/>
            <ac:spMk id="42" creationId="{13D6BD61-9543-67E7-3A8A-5AC6809D3103}"/>
          </ac:spMkLst>
        </pc:spChg>
        <pc:spChg chg="add mod">
          <ac:chgData name="Sartorius, Carol" userId="717f8656-0c6f-4128-8672-6a166f4ce149" providerId="ADAL" clId="{7EF6F3C4-4684-4338-9CE2-2316932B4716}" dt="2024-11-27T16:56:51.640" v="216" actId="1038"/>
          <ac:spMkLst>
            <pc:docMk/>
            <pc:sldMk cId="1268847539" sldId="280"/>
            <ac:spMk id="43" creationId="{E8DDAE7D-1734-56FD-0364-5559489E51E3}"/>
          </ac:spMkLst>
        </pc:spChg>
        <pc:spChg chg="add mod">
          <ac:chgData name="Sartorius, Carol" userId="717f8656-0c6f-4128-8672-6a166f4ce149" providerId="ADAL" clId="{7EF6F3C4-4684-4338-9CE2-2316932B4716}" dt="2024-11-27T16:56:44.052" v="204" actId="1076"/>
          <ac:spMkLst>
            <pc:docMk/>
            <pc:sldMk cId="1268847539" sldId="280"/>
            <ac:spMk id="44" creationId="{4207EB66-2898-1984-9484-94563E3C3428}"/>
          </ac:spMkLst>
        </pc:spChg>
        <pc:spChg chg="add mod">
          <ac:chgData name="Sartorius, Carol" userId="717f8656-0c6f-4128-8672-6a166f4ce149" providerId="ADAL" clId="{7EF6F3C4-4684-4338-9CE2-2316932B4716}" dt="2024-11-27T16:57:01.818" v="241" actId="1038"/>
          <ac:spMkLst>
            <pc:docMk/>
            <pc:sldMk cId="1268847539" sldId="280"/>
            <ac:spMk id="45" creationId="{AEC0D9E4-7763-6FE3-8777-906780367089}"/>
          </ac:spMkLst>
        </pc:spChg>
        <pc:cxnChg chg="add mod">
          <ac:chgData name="Sartorius, Carol" userId="717f8656-0c6f-4128-8672-6a166f4ce149" providerId="ADAL" clId="{7EF6F3C4-4684-4338-9CE2-2316932B4716}" dt="2024-11-27T16:55:39.495" v="191" actId="1038"/>
          <ac:cxnSpMkLst>
            <pc:docMk/>
            <pc:sldMk cId="1268847539" sldId="280"/>
            <ac:cxnSpMk id="9" creationId="{136D50CC-63A6-590E-3FCF-594A7F0E86A2}"/>
          </ac:cxnSpMkLst>
        </pc:cxnChg>
        <pc:cxnChg chg="add mod">
          <ac:chgData name="Sartorius, Carol" userId="717f8656-0c6f-4128-8672-6a166f4ce149" providerId="ADAL" clId="{7EF6F3C4-4684-4338-9CE2-2316932B4716}" dt="2024-11-27T16:55:47.226" v="193" actId="1076"/>
          <ac:cxnSpMkLst>
            <pc:docMk/>
            <pc:sldMk cId="1268847539" sldId="280"/>
            <ac:cxnSpMk id="36" creationId="{4264B5C5-9883-C307-21CB-1C26FC69FC57}"/>
          </ac:cxnSpMkLst>
        </pc:cxnChg>
        <pc:cxnChg chg="add mod">
          <ac:chgData name="Sartorius, Carol" userId="717f8656-0c6f-4128-8672-6a166f4ce149" providerId="ADAL" clId="{7EF6F3C4-4684-4338-9CE2-2316932B4716}" dt="2024-11-27T16:56:44.052" v="204" actId="1076"/>
          <ac:cxnSpMkLst>
            <pc:docMk/>
            <pc:sldMk cId="1268847539" sldId="280"/>
            <ac:cxnSpMk id="46" creationId="{801823A3-5F26-4871-BBDC-0DBBBC90F78B}"/>
          </ac:cxnSpMkLst>
        </pc:cxnChg>
        <pc:cxnChg chg="add mod">
          <ac:chgData name="Sartorius, Carol" userId="717f8656-0c6f-4128-8672-6a166f4ce149" providerId="ADAL" clId="{7EF6F3C4-4684-4338-9CE2-2316932B4716}" dt="2024-11-27T16:56:44.052" v="204" actId="1076"/>
          <ac:cxnSpMkLst>
            <pc:docMk/>
            <pc:sldMk cId="1268847539" sldId="280"/>
            <ac:cxnSpMk id="47" creationId="{719C1944-2A15-C625-09F0-211BE512960E}"/>
          </ac:cxnSpMkLst>
        </pc:cxnChg>
      </pc:sldChg>
      <pc:sldChg chg="ord">
        <pc:chgData name="Sartorius, Carol" userId="717f8656-0c6f-4128-8672-6a166f4ce149" providerId="ADAL" clId="{7EF6F3C4-4684-4338-9CE2-2316932B4716}" dt="2024-12-02T02:22:03.401" v="901"/>
        <pc:sldMkLst>
          <pc:docMk/>
          <pc:sldMk cId="3274515102" sldId="282"/>
        </pc:sldMkLst>
      </pc:sldChg>
    </pc:docChg>
  </pc:docChgLst>
  <pc:docChgLst>
    <pc:chgData name="Sartorius, Carol" userId="717f8656-0c6f-4128-8672-6a166f4ce149" providerId="ADAL" clId="{C54814D0-1ED5-46F1-A9DB-A900A18121C8}"/>
    <pc:docChg chg="undo custSel modSld sldOrd">
      <pc:chgData name="Sartorius, Carol" userId="717f8656-0c6f-4128-8672-6a166f4ce149" providerId="ADAL" clId="{C54814D0-1ED5-46F1-A9DB-A900A18121C8}" dt="2024-12-05T23:55:50.075" v="2208" actId="20577"/>
      <pc:docMkLst>
        <pc:docMk/>
      </pc:docMkLst>
      <pc:sldChg chg="addSp delSp modSp mod">
        <pc:chgData name="Sartorius, Carol" userId="717f8656-0c6f-4128-8672-6a166f4ce149" providerId="ADAL" clId="{C54814D0-1ED5-46F1-A9DB-A900A18121C8}" dt="2024-12-02T23:24:06.661" v="1699" actId="3064"/>
        <pc:sldMkLst>
          <pc:docMk/>
          <pc:sldMk cId="2911261070" sldId="263"/>
        </pc:sldMkLst>
        <pc:spChg chg="mod">
          <ac:chgData name="Sartorius, Carol" userId="717f8656-0c6f-4128-8672-6a166f4ce149" providerId="ADAL" clId="{C54814D0-1ED5-46F1-A9DB-A900A18121C8}" dt="2024-12-02T22:01:14.835" v="997" actId="20577"/>
          <ac:spMkLst>
            <pc:docMk/>
            <pc:sldMk cId="2911261070" sldId="263"/>
            <ac:spMk id="8" creationId="{D432024D-04A1-3E8C-770B-C35C3098A895}"/>
          </ac:spMkLst>
        </pc:spChg>
        <pc:spChg chg="mod topLvl">
          <ac:chgData name="Sartorius, Carol" userId="717f8656-0c6f-4128-8672-6a166f4ce149" providerId="ADAL" clId="{C54814D0-1ED5-46F1-A9DB-A900A18121C8}" dt="2024-12-02T23:24:02.093" v="1698" actId="3064"/>
          <ac:spMkLst>
            <pc:docMk/>
            <pc:sldMk cId="2911261070" sldId="263"/>
            <ac:spMk id="126" creationId="{67BA4D94-20CE-B069-20DA-F18B18BFA9D1}"/>
          </ac:spMkLst>
        </pc:spChg>
        <pc:spChg chg="mod topLvl">
          <ac:chgData name="Sartorius, Carol" userId="717f8656-0c6f-4128-8672-6a166f4ce149" providerId="ADAL" clId="{C54814D0-1ED5-46F1-A9DB-A900A18121C8}" dt="2024-12-02T23:24:02.093" v="1698" actId="3064"/>
          <ac:spMkLst>
            <pc:docMk/>
            <pc:sldMk cId="2911261070" sldId="263"/>
            <ac:spMk id="127" creationId="{9F5E2020-C448-C76F-0132-A91D8B7C9881}"/>
          </ac:spMkLst>
        </pc:spChg>
        <pc:spChg chg="mod topLvl">
          <ac:chgData name="Sartorius, Carol" userId="717f8656-0c6f-4128-8672-6a166f4ce149" providerId="ADAL" clId="{C54814D0-1ED5-46F1-A9DB-A900A18121C8}" dt="2024-12-02T23:24:06.661" v="1699" actId="3064"/>
          <ac:spMkLst>
            <pc:docMk/>
            <pc:sldMk cId="2911261070" sldId="263"/>
            <ac:spMk id="128" creationId="{FA550F3E-4DA8-4D69-F7A2-603665FCB6C9}"/>
          </ac:spMkLst>
        </pc:spChg>
        <pc:grpChg chg="add del mod">
          <ac:chgData name="Sartorius, Carol" userId="717f8656-0c6f-4128-8672-6a166f4ce149" providerId="ADAL" clId="{C54814D0-1ED5-46F1-A9DB-A900A18121C8}" dt="2024-12-02T23:23:42.137" v="1697" actId="165"/>
          <ac:grpSpMkLst>
            <pc:docMk/>
            <pc:sldMk cId="2911261070" sldId="263"/>
            <ac:grpSpMk id="2" creationId="{65F8FB07-81F0-025B-1FAE-59CBB8F78490}"/>
          </ac:grpSpMkLst>
        </pc:grpChg>
        <pc:picChg chg="mod topLvl">
          <ac:chgData name="Sartorius, Carol" userId="717f8656-0c6f-4128-8672-6a166f4ce149" providerId="ADAL" clId="{C54814D0-1ED5-46F1-A9DB-A900A18121C8}" dt="2024-12-02T23:23:42.137" v="1697" actId="165"/>
          <ac:picMkLst>
            <pc:docMk/>
            <pc:sldMk cId="2911261070" sldId="263"/>
            <ac:picMk id="4" creationId="{42F86EB2-AE1D-A4E3-683A-A8AAB09A9211}"/>
          </ac:picMkLst>
        </pc:picChg>
        <pc:picChg chg="mod topLvl">
          <ac:chgData name="Sartorius, Carol" userId="717f8656-0c6f-4128-8672-6a166f4ce149" providerId="ADAL" clId="{C54814D0-1ED5-46F1-A9DB-A900A18121C8}" dt="2024-12-02T23:23:42.137" v="1697" actId="165"/>
          <ac:picMkLst>
            <pc:docMk/>
            <pc:sldMk cId="2911261070" sldId="263"/>
            <ac:picMk id="5" creationId="{AEF17CF0-3F4B-6517-054F-88385C274C9E}"/>
          </ac:picMkLst>
        </pc:picChg>
        <pc:picChg chg="mod topLvl">
          <ac:chgData name="Sartorius, Carol" userId="717f8656-0c6f-4128-8672-6a166f4ce149" providerId="ADAL" clId="{C54814D0-1ED5-46F1-A9DB-A900A18121C8}" dt="2024-12-02T23:23:42.137" v="1697" actId="165"/>
          <ac:picMkLst>
            <pc:docMk/>
            <pc:sldMk cId="2911261070" sldId="263"/>
            <ac:picMk id="28" creationId="{DAA4B437-66B5-3583-B5FC-4DFDA8470316}"/>
          </ac:picMkLst>
        </pc:picChg>
      </pc:sldChg>
      <pc:sldChg chg="addSp delSp modSp mod ord">
        <pc:chgData name="Sartorius, Carol" userId="717f8656-0c6f-4128-8672-6a166f4ce149" providerId="ADAL" clId="{C54814D0-1ED5-46F1-A9DB-A900A18121C8}" dt="2024-12-02T23:29:09.828" v="1718" actId="20577"/>
        <pc:sldMkLst>
          <pc:docMk/>
          <pc:sldMk cId="3004741895" sldId="264"/>
        </pc:sldMkLst>
        <pc:spChg chg="mod">
          <ac:chgData name="Sartorius, Carol" userId="717f8656-0c6f-4128-8672-6a166f4ce149" providerId="ADAL" clId="{C54814D0-1ED5-46F1-A9DB-A900A18121C8}" dt="2024-12-02T21:42:04.206" v="399" actId="164"/>
          <ac:spMkLst>
            <pc:docMk/>
            <pc:sldMk cId="3004741895" sldId="264"/>
            <ac:spMk id="4" creationId="{53D6B75E-FE3D-5E4B-0987-E42AFFB0BAA9}"/>
          </ac:spMkLst>
        </pc:spChg>
        <pc:spChg chg="mod">
          <ac:chgData name="Sartorius, Carol" userId="717f8656-0c6f-4128-8672-6a166f4ce149" providerId="ADAL" clId="{C54814D0-1ED5-46F1-A9DB-A900A18121C8}" dt="2024-12-02T21:42:04.206" v="399" actId="164"/>
          <ac:spMkLst>
            <pc:docMk/>
            <pc:sldMk cId="3004741895" sldId="264"/>
            <ac:spMk id="5" creationId="{408464C1-A778-7B3C-D9B1-0771B3C69EB9}"/>
          </ac:spMkLst>
        </pc:spChg>
        <pc:spChg chg="mod">
          <ac:chgData name="Sartorius, Carol" userId="717f8656-0c6f-4128-8672-6a166f4ce149" providerId="ADAL" clId="{C54814D0-1ED5-46F1-A9DB-A900A18121C8}" dt="2024-12-02T21:42:04.206" v="399" actId="164"/>
          <ac:spMkLst>
            <pc:docMk/>
            <pc:sldMk cId="3004741895" sldId="264"/>
            <ac:spMk id="7" creationId="{CCFC4192-589E-CEE2-CDAF-82E42E6F3B99}"/>
          </ac:spMkLst>
        </pc:spChg>
        <pc:spChg chg="mod">
          <ac:chgData name="Sartorius, Carol" userId="717f8656-0c6f-4128-8672-6a166f4ce149" providerId="ADAL" clId="{C54814D0-1ED5-46F1-A9DB-A900A18121C8}" dt="2024-12-02T21:42:04.206" v="399" actId="164"/>
          <ac:spMkLst>
            <pc:docMk/>
            <pc:sldMk cId="3004741895" sldId="264"/>
            <ac:spMk id="8" creationId="{67CC8A78-7638-691D-1CD4-3A9BAB7DB335}"/>
          </ac:spMkLst>
        </pc:spChg>
        <pc:spChg chg="mod">
          <ac:chgData name="Sartorius, Carol" userId="717f8656-0c6f-4128-8672-6a166f4ce149" providerId="ADAL" clId="{C54814D0-1ED5-46F1-A9DB-A900A18121C8}" dt="2024-12-02T21:42:04.206" v="399" actId="164"/>
          <ac:spMkLst>
            <pc:docMk/>
            <pc:sldMk cId="3004741895" sldId="264"/>
            <ac:spMk id="9" creationId="{97E5746A-6A8E-8A14-F506-B2CD65F09F64}"/>
          </ac:spMkLst>
        </pc:spChg>
        <pc:spChg chg="mod">
          <ac:chgData name="Sartorius, Carol" userId="717f8656-0c6f-4128-8672-6a166f4ce149" providerId="ADAL" clId="{C54814D0-1ED5-46F1-A9DB-A900A18121C8}" dt="2024-12-02T21:42:04.206" v="399" actId="164"/>
          <ac:spMkLst>
            <pc:docMk/>
            <pc:sldMk cId="3004741895" sldId="264"/>
            <ac:spMk id="10" creationId="{50961BF8-56DB-2A99-FED5-411254C54A11}"/>
          </ac:spMkLst>
        </pc:spChg>
        <pc:spChg chg="mod">
          <ac:chgData name="Sartorius, Carol" userId="717f8656-0c6f-4128-8672-6a166f4ce149" providerId="ADAL" clId="{C54814D0-1ED5-46F1-A9DB-A900A18121C8}" dt="2024-12-02T21:42:04.206" v="399" actId="164"/>
          <ac:spMkLst>
            <pc:docMk/>
            <pc:sldMk cId="3004741895" sldId="264"/>
            <ac:spMk id="11" creationId="{9F4D6A45-7C89-ECA0-3722-15F55F169E6C}"/>
          </ac:spMkLst>
        </pc:spChg>
        <pc:spChg chg="mod">
          <ac:chgData name="Sartorius, Carol" userId="717f8656-0c6f-4128-8672-6a166f4ce149" providerId="ADAL" clId="{C54814D0-1ED5-46F1-A9DB-A900A18121C8}" dt="2024-12-02T21:42:04.206" v="399" actId="164"/>
          <ac:spMkLst>
            <pc:docMk/>
            <pc:sldMk cId="3004741895" sldId="264"/>
            <ac:spMk id="12" creationId="{DA83A3EA-D053-3F31-9864-7229FFE30D56}"/>
          </ac:spMkLst>
        </pc:spChg>
        <pc:spChg chg="mod">
          <ac:chgData name="Sartorius, Carol" userId="717f8656-0c6f-4128-8672-6a166f4ce149" providerId="ADAL" clId="{C54814D0-1ED5-46F1-A9DB-A900A18121C8}" dt="2024-12-02T21:42:04.206" v="399" actId="164"/>
          <ac:spMkLst>
            <pc:docMk/>
            <pc:sldMk cId="3004741895" sldId="264"/>
            <ac:spMk id="13" creationId="{138FD98E-45FA-3AED-839E-2693F7ED2F8E}"/>
          </ac:spMkLst>
        </pc:spChg>
        <pc:spChg chg="mod">
          <ac:chgData name="Sartorius, Carol" userId="717f8656-0c6f-4128-8672-6a166f4ce149" providerId="ADAL" clId="{C54814D0-1ED5-46F1-A9DB-A900A18121C8}" dt="2024-12-02T21:42:04.206" v="399" actId="164"/>
          <ac:spMkLst>
            <pc:docMk/>
            <pc:sldMk cId="3004741895" sldId="264"/>
            <ac:spMk id="14" creationId="{C5E38AE7-DE7B-DF1D-F25E-9F1CC19C4C35}"/>
          </ac:spMkLst>
        </pc:spChg>
        <pc:spChg chg="mod">
          <ac:chgData name="Sartorius, Carol" userId="717f8656-0c6f-4128-8672-6a166f4ce149" providerId="ADAL" clId="{C54814D0-1ED5-46F1-A9DB-A900A18121C8}" dt="2024-12-02T21:42:04.206" v="399" actId="164"/>
          <ac:spMkLst>
            <pc:docMk/>
            <pc:sldMk cId="3004741895" sldId="264"/>
            <ac:spMk id="15" creationId="{873056B1-9E5A-C229-7EB1-A230C64E8AB7}"/>
          </ac:spMkLst>
        </pc:spChg>
        <pc:spChg chg="mod">
          <ac:chgData name="Sartorius, Carol" userId="717f8656-0c6f-4128-8672-6a166f4ce149" providerId="ADAL" clId="{C54814D0-1ED5-46F1-A9DB-A900A18121C8}" dt="2024-12-02T21:42:04.206" v="399" actId="164"/>
          <ac:spMkLst>
            <pc:docMk/>
            <pc:sldMk cId="3004741895" sldId="264"/>
            <ac:spMk id="16" creationId="{5E0B69B2-5469-64DA-BB9C-4F566A454CCD}"/>
          </ac:spMkLst>
        </pc:spChg>
        <pc:spChg chg="mod">
          <ac:chgData name="Sartorius, Carol" userId="717f8656-0c6f-4128-8672-6a166f4ce149" providerId="ADAL" clId="{C54814D0-1ED5-46F1-A9DB-A900A18121C8}" dt="2024-12-02T21:42:04.206" v="399" actId="164"/>
          <ac:spMkLst>
            <pc:docMk/>
            <pc:sldMk cId="3004741895" sldId="264"/>
            <ac:spMk id="17" creationId="{9002CDE1-E33E-A969-0041-45738DAAE29B}"/>
          </ac:spMkLst>
        </pc:spChg>
        <pc:spChg chg="mod">
          <ac:chgData name="Sartorius, Carol" userId="717f8656-0c6f-4128-8672-6a166f4ce149" providerId="ADAL" clId="{C54814D0-1ED5-46F1-A9DB-A900A18121C8}" dt="2024-12-02T21:42:04.206" v="399" actId="164"/>
          <ac:spMkLst>
            <pc:docMk/>
            <pc:sldMk cId="3004741895" sldId="264"/>
            <ac:spMk id="19" creationId="{6FBED441-268A-6C7E-BD6C-1743B673BDA2}"/>
          </ac:spMkLst>
        </pc:spChg>
        <pc:spChg chg="mod">
          <ac:chgData name="Sartorius, Carol" userId="717f8656-0c6f-4128-8672-6a166f4ce149" providerId="ADAL" clId="{C54814D0-1ED5-46F1-A9DB-A900A18121C8}" dt="2024-12-02T21:42:04.206" v="399" actId="164"/>
          <ac:spMkLst>
            <pc:docMk/>
            <pc:sldMk cId="3004741895" sldId="264"/>
            <ac:spMk id="20" creationId="{5143B970-10DD-1A35-4278-7F45955EC5C6}"/>
          </ac:spMkLst>
        </pc:spChg>
        <pc:spChg chg="mod">
          <ac:chgData name="Sartorius, Carol" userId="717f8656-0c6f-4128-8672-6a166f4ce149" providerId="ADAL" clId="{C54814D0-1ED5-46F1-A9DB-A900A18121C8}" dt="2024-12-02T21:42:04.206" v="399" actId="164"/>
          <ac:spMkLst>
            <pc:docMk/>
            <pc:sldMk cId="3004741895" sldId="264"/>
            <ac:spMk id="21" creationId="{91558488-26DF-4E3C-58C2-BB8CF128C72E}"/>
          </ac:spMkLst>
        </pc:spChg>
        <pc:spChg chg="mod">
          <ac:chgData name="Sartorius, Carol" userId="717f8656-0c6f-4128-8672-6a166f4ce149" providerId="ADAL" clId="{C54814D0-1ED5-46F1-A9DB-A900A18121C8}" dt="2024-12-02T21:42:04.206" v="399" actId="164"/>
          <ac:spMkLst>
            <pc:docMk/>
            <pc:sldMk cId="3004741895" sldId="264"/>
            <ac:spMk id="22" creationId="{243649CC-E37E-8678-7BAC-5389D6731FAC}"/>
          </ac:spMkLst>
        </pc:spChg>
        <pc:spChg chg="mod">
          <ac:chgData name="Sartorius, Carol" userId="717f8656-0c6f-4128-8672-6a166f4ce149" providerId="ADAL" clId="{C54814D0-1ED5-46F1-A9DB-A900A18121C8}" dt="2024-12-02T21:42:04.206" v="399" actId="164"/>
          <ac:spMkLst>
            <pc:docMk/>
            <pc:sldMk cId="3004741895" sldId="264"/>
            <ac:spMk id="23" creationId="{99F3D82F-F6EE-93A7-F44C-3FEE08EA0284}"/>
          </ac:spMkLst>
        </pc:spChg>
        <pc:spChg chg="mod">
          <ac:chgData name="Sartorius, Carol" userId="717f8656-0c6f-4128-8672-6a166f4ce149" providerId="ADAL" clId="{C54814D0-1ED5-46F1-A9DB-A900A18121C8}" dt="2024-12-02T21:42:04.206" v="399" actId="164"/>
          <ac:spMkLst>
            <pc:docMk/>
            <pc:sldMk cId="3004741895" sldId="264"/>
            <ac:spMk id="24" creationId="{760052A8-AD70-509B-CC58-F5A7684DD03C}"/>
          </ac:spMkLst>
        </pc:spChg>
        <pc:spChg chg="mod">
          <ac:chgData name="Sartorius, Carol" userId="717f8656-0c6f-4128-8672-6a166f4ce149" providerId="ADAL" clId="{C54814D0-1ED5-46F1-A9DB-A900A18121C8}" dt="2024-12-02T21:42:04.206" v="399" actId="164"/>
          <ac:spMkLst>
            <pc:docMk/>
            <pc:sldMk cId="3004741895" sldId="264"/>
            <ac:spMk id="25" creationId="{5FAFC11A-AE30-33A6-8CD3-E17CAD004000}"/>
          </ac:spMkLst>
        </pc:spChg>
        <pc:spChg chg="mod">
          <ac:chgData name="Sartorius, Carol" userId="717f8656-0c6f-4128-8672-6a166f4ce149" providerId="ADAL" clId="{C54814D0-1ED5-46F1-A9DB-A900A18121C8}" dt="2024-12-02T21:42:04.206" v="399" actId="164"/>
          <ac:spMkLst>
            <pc:docMk/>
            <pc:sldMk cId="3004741895" sldId="264"/>
            <ac:spMk id="26" creationId="{12FB701E-98FD-0AB2-2AF9-8977CE5DE2EA}"/>
          </ac:spMkLst>
        </pc:spChg>
        <pc:spChg chg="mod">
          <ac:chgData name="Sartorius, Carol" userId="717f8656-0c6f-4128-8672-6a166f4ce149" providerId="ADAL" clId="{C54814D0-1ED5-46F1-A9DB-A900A18121C8}" dt="2024-12-02T21:42:04.206" v="399" actId="164"/>
          <ac:spMkLst>
            <pc:docMk/>
            <pc:sldMk cId="3004741895" sldId="264"/>
            <ac:spMk id="27" creationId="{A2C3F980-7447-4D32-61AC-05BDAAA494C6}"/>
          </ac:spMkLst>
        </pc:spChg>
        <pc:spChg chg="mod">
          <ac:chgData name="Sartorius, Carol" userId="717f8656-0c6f-4128-8672-6a166f4ce149" providerId="ADAL" clId="{C54814D0-1ED5-46F1-A9DB-A900A18121C8}" dt="2024-12-02T21:42:04.206" v="399" actId="164"/>
          <ac:spMkLst>
            <pc:docMk/>
            <pc:sldMk cId="3004741895" sldId="264"/>
            <ac:spMk id="28" creationId="{20EF108E-FB1C-9AE8-E285-2239D729F152}"/>
          </ac:spMkLst>
        </pc:spChg>
        <pc:spChg chg="mod">
          <ac:chgData name="Sartorius, Carol" userId="717f8656-0c6f-4128-8672-6a166f4ce149" providerId="ADAL" clId="{C54814D0-1ED5-46F1-A9DB-A900A18121C8}" dt="2024-12-02T21:42:04.206" v="399" actId="164"/>
          <ac:spMkLst>
            <pc:docMk/>
            <pc:sldMk cId="3004741895" sldId="264"/>
            <ac:spMk id="29" creationId="{D977774C-7E7F-800A-E3D1-B5B30586FE42}"/>
          </ac:spMkLst>
        </pc:spChg>
        <pc:spChg chg="mod">
          <ac:chgData name="Sartorius, Carol" userId="717f8656-0c6f-4128-8672-6a166f4ce149" providerId="ADAL" clId="{C54814D0-1ED5-46F1-A9DB-A900A18121C8}" dt="2024-12-02T21:42:04.206" v="399" actId="164"/>
          <ac:spMkLst>
            <pc:docMk/>
            <pc:sldMk cId="3004741895" sldId="264"/>
            <ac:spMk id="30" creationId="{73529A55-82DE-573B-6CDB-04FC92122FEF}"/>
          </ac:spMkLst>
        </pc:spChg>
        <pc:spChg chg="mod">
          <ac:chgData name="Sartorius, Carol" userId="717f8656-0c6f-4128-8672-6a166f4ce149" providerId="ADAL" clId="{C54814D0-1ED5-46F1-A9DB-A900A18121C8}" dt="2024-12-02T21:42:04.206" v="399" actId="164"/>
          <ac:spMkLst>
            <pc:docMk/>
            <pc:sldMk cId="3004741895" sldId="264"/>
            <ac:spMk id="31" creationId="{8369E298-1B6B-8338-2696-78C4AE9413AC}"/>
          </ac:spMkLst>
        </pc:spChg>
        <pc:spChg chg="mod">
          <ac:chgData name="Sartorius, Carol" userId="717f8656-0c6f-4128-8672-6a166f4ce149" providerId="ADAL" clId="{C54814D0-1ED5-46F1-A9DB-A900A18121C8}" dt="2024-12-02T21:42:04.206" v="399" actId="164"/>
          <ac:spMkLst>
            <pc:docMk/>
            <pc:sldMk cId="3004741895" sldId="264"/>
            <ac:spMk id="33" creationId="{4166230F-92E9-414F-CD73-4174909E7BA8}"/>
          </ac:spMkLst>
        </pc:spChg>
        <pc:spChg chg="mod">
          <ac:chgData name="Sartorius, Carol" userId="717f8656-0c6f-4128-8672-6a166f4ce149" providerId="ADAL" clId="{C54814D0-1ED5-46F1-A9DB-A900A18121C8}" dt="2024-12-02T21:42:04.206" v="399" actId="164"/>
          <ac:spMkLst>
            <pc:docMk/>
            <pc:sldMk cId="3004741895" sldId="264"/>
            <ac:spMk id="34" creationId="{521757FA-7917-3CF2-740E-7767AB913C76}"/>
          </ac:spMkLst>
        </pc:spChg>
        <pc:spChg chg="add mod">
          <ac:chgData name="Sartorius, Carol" userId="717f8656-0c6f-4128-8672-6a166f4ce149" providerId="ADAL" clId="{C54814D0-1ED5-46F1-A9DB-A900A18121C8}" dt="2024-12-02T21:51:41.181" v="780" actId="164"/>
          <ac:spMkLst>
            <pc:docMk/>
            <pc:sldMk cId="3004741895" sldId="264"/>
            <ac:spMk id="35" creationId="{FD999220-522C-D128-F1BC-0644ED8FCB3E}"/>
          </ac:spMkLst>
        </pc:spChg>
        <pc:spChg chg="mod topLvl">
          <ac:chgData name="Sartorius, Carol" userId="717f8656-0c6f-4128-8672-6a166f4ce149" providerId="ADAL" clId="{C54814D0-1ED5-46F1-A9DB-A900A18121C8}" dt="2024-12-02T21:51:07.448" v="725" actId="164"/>
          <ac:spMkLst>
            <pc:docMk/>
            <pc:sldMk cId="3004741895" sldId="264"/>
            <ac:spMk id="40" creationId="{C3290AC1-2CAB-9AF6-8D1F-EF12B4EE04FC}"/>
          </ac:spMkLst>
        </pc:spChg>
        <pc:spChg chg="mod topLvl">
          <ac:chgData name="Sartorius, Carol" userId="717f8656-0c6f-4128-8672-6a166f4ce149" providerId="ADAL" clId="{C54814D0-1ED5-46F1-A9DB-A900A18121C8}" dt="2024-12-02T21:51:07.448" v="725" actId="164"/>
          <ac:spMkLst>
            <pc:docMk/>
            <pc:sldMk cId="3004741895" sldId="264"/>
            <ac:spMk id="41" creationId="{6959AB70-FF7D-0C45-CA7E-9D7DC046A438}"/>
          </ac:spMkLst>
        </pc:spChg>
        <pc:spChg chg="mod topLvl">
          <ac:chgData name="Sartorius, Carol" userId="717f8656-0c6f-4128-8672-6a166f4ce149" providerId="ADAL" clId="{C54814D0-1ED5-46F1-A9DB-A900A18121C8}" dt="2024-12-02T21:51:07.448" v="725" actId="164"/>
          <ac:spMkLst>
            <pc:docMk/>
            <pc:sldMk cId="3004741895" sldId="264"/>
            <ac:spMk id="42" creationId="{FFC4FBD3-99DE-98B4-5C5F-51D53E680971}"/>
          </ac:spMkLst>
        </pc:spChg>
        <pc:spChg chg="mod topLvl">
          <ac:chgData name="Sartorius, Carol" userId="717f8656-0c6f-4128-8672-6a166f4ce149" providerId="ADAL" clId="{C54814D0-1ED5-46F1-A9DB-A900A18121C8}" dt="2024-12-02T21:51:07.448" v="725" actId="164"/>
          <ac:spMkLst>
            <pc:docMk/>
            <pc:sldMk cId="3004741895" sldId="264"/>
            <ac:spMk id="43" creationId="{F0D0B9FE-5E93-CE64-397F-D0317ED54EA4}"/>
          </ac:spMkLst>
        </pc:spChg>
        <pc:spChg chg="mod topLvl">
          <ac:chgData name="Sartorius, Carol" userId="717f8656-0c6f-4128-8672-6a166f4ce149" providerId="ADAL" clId="{C54814D0-1ED5-46F1-A9DB-A900A18121C8}" dt="2024-12-02T21:51:07.448" v="725" actId="164"/>
          <ac:spMkLst>
            <pc:docMk/>
            <pc:sldMk cId="3004741895" sldId="264"/>
            <ac:spMk id="44" creationId="{A4A78C9D-8505-EB62-5D74-98705FFEC561}"/>
          </ac:spMkLst>
        </pc:spChg>
        <pc:spChg chg="mod topLvl">
          <ac:chgData name="Sartorius, Carol" userId="717f8656-0c6f-4128-8672-6a166f4ce149" providerId="ADAL" clId="{C54814D0-1ED5-46F1-A9DB-A900A18121C8}" dt="2024-12-02T21:51:07.448" v="725" actId="164"/>
          <ac:spMkLst>
            <pc:docMk/>
            <pc:sldMk cId="3004741895" sldId="264"/>
            <ac:spMk id="46" creationId="{CCCC86D0-2EC2-883F-2E2C-93D5D7AEC960}"/>
          </ac:spMkLst>
        </pc:spChg>
        <pc:spChg chg="mod topLvl">
          <ac:chgData name="Sartorius, Carol" userId="717f8656-0c6f-4128-8672-6a166f4ce149" providerId="ADAL" clId="{C54814D0-1ED5-46F1-A9DB-A900A18121C8}" dt="2024-12-02T21:51:07.448" v="725" actId="164"/>
          <ac:spMkLst>
            <pc:docMk/>
            <pc:sldMk cId="3004741895" sldId="264"/>
            <ac:spMk id="47" creationId="{BD5530B7-BBB6-2FFD-8A6B-6F7C9F632B81}"/>
          </ac:spMkLst>
        </pc:spChg>
        <pc:spChg chg="mod topLvl">
          <ac:chgData name="Sartorius, Carol" userId="717f8656-0c6f-4128-8672-6a166f4ce149" providerId="ADAL" clId="{C54814D0-1ED5-46F1-A9DB-A900A18121C8}" dt="2024-12-02T21:51:07.448" v="725" actId="164"/>
          <ac:spMkLst>
            <pc:docMk/>
            <pc:sldMk cId="3004741895" sldId="264"/>
            <ac:spMk id="48" creationId="{5E82068B-3E87-2DB2-A55D-3554D77276A7}"/>
          </ac:spMkLst>
        </pc:spChg>
        <pc:spChg chg="mod topLvl">
          <ac:chgData name="Sartorius, Carol" userId="717f8656-0c6f-4128-8672-6a166f4ce149" providerId="ADAL" clId="{C54814D0-1ED5-46F1-A9DB-A900A18121C8}" dt="2024-12-02T21:51:07.448" v="725" actId="164"/>
          <ac:spMkLst>
            <pc:docMk/>
            <pc:sldMk cId="3004741895" sldId="264"/>
            <ac:spMk id="52" creationId="{0DC77D11-9A82-FD8A-92D9-09AF98EBCFBC}"/>
          </ac:spMkLst>
        </pc:spChg>
        <pc:spChg chg="mod">
          <ac:chgData name="Sartorius, Carol" userId="717f8656-0c6f-4128-8672-6a166f4ce149" providerId="ADAL" clId="{C54814D0-1ED5-46F1-A9DB-A900A18121C8}" dt="2024-12-02T23:29:09.828" v="1718" actId="20577"/>
          <ac:spMkLst>
            <pc:docMk/>
            <pc:sldMk cId="3004741895" sldId="264"/>
            <ac:spMk id="53" creationId="{917D5808-3EF0-F357-9D97-5D95633AF724}"/>
          </ac:spMkLst>
        </pc:spChg>
        <pc:spChg chg="mod topLvl">
          <ac:chgData name="Sartorius, Carol" userId="717f8656-0c6f-4128-8672-6a166f4ce149" providerId="ADAL" clId="{C54814D0-1ED5-46F1-A9DB-A900A18121C8}" dt="2024-12-02T21:51:07.448" v="725" actId="164"/>
          <ac:spMkLst>
            <pc:docMk/>
            <pc:sldMk cId="3004741895" sldId="264"/>
            <ac:spMk id="54" creationId="{8E7638D4-D410-E696-7979-70D1D893B9F8}"/>
          </ac:spMkLst>
        </pc:spChg>
        <pc:spChg chg="mod topLvl">
          <ac:chgData name="Sartorius, Carol" userId="717f8656-0c6f-4128-8672-6a166f4ce149" providerId="ADAL" clId="{C54814D0-1ED5-46F1-A9DB-A900A18121C8}" dt="2024-12-02T21:51:07.448" v="725" actId="164"/>
          <ac:spMkLst>
            <pc:docMk/>
            <pc:sldMk cId="3004741895" sldId="264"/>
            <ac:spMk id="55" creationId="{4ECA8521-5D79-29A3-C57E-EE04BD334A9C}"/>
          </ac:spMkLst>
        </pc:spChg>
        <pc:spChg chg="mod topLvl">
          <ac:chgData name="Sartorius, Carol" userId="717f8656-0c6f-4128-8672-6a166f4ce149" providerId="ADAL" clId="{C54814D0-1ED5-46F1-A9DB-A900A18121C8}" dt="2024-12-02T21:51:07.448" v="725" actId="164"/>
          <ac:spMkLst>
            <pc:docMk/>
            <pc:sldMk cId="3004741895" sldId="264"/>
            <ac:spMk id="56" creationId="{4D55BA06-91D3-60E2-B34D-67CF936C9B1C}"/>
          </ac:spMkLst>
        </pc:spChg>
        <pc:spChg chg="mod topLvl">
          <ac:chgData name="Sartorius, Carol" userId="717f8656-0c6f-4128-8672-6a166f4ce149" providerId="ADAL" clId="{C54814D0-1ED5-46F1-A9DB-A900A18121C8}" dt="2024-12-02T21:51:07.448" v="725" actId="164"/>
          <ac:spMkLst>
            <pc:docMk/>
            <pc:sldMk cId="3004741895" sldId="264"/>
            <ac:spMk id="57" creationId="{19729210-62E8-F24A-968C-9826CB9E5BE5}"/>
          </ac:spMkLst>
        </pc:spChg>
        <pc:spChg chg="mod topLvl">
          <ac:chgData name="Sartorius, Carol" userId="717f8656-0c6f-4128-8672-6a166f4ce149" providerId="ADAL" clId="{C54814D0-1ED5-46F1-A9DB-A900A18121C8}" dt="2024-12-02T21:51:07.448" v="725" actId="164"/>
          <ac:spMkLst>
            <pc:docMk/>
            <pc:sldMk cId="3004741895" sldId="264"/>
            <ac:spMk id="58" creationId="{EA430C4E-87E1-F8A8-63C1-4138D8B1DD3F}"/>
          </ac:spMkLst>
        </pc:spChg>
        <pc:spChg chg="mod topLvl">
          <ac:chgData name="Sartorius, Carol" userId="717f8656-0c6f-4128-8672-6a166f4ce149" providerId="ADAL" clId="{C54814D0-1ED5-46F1-A9DB-A900A18121C8}" dt="2024-12-02T21:51:07.448" v="725" actId="164"/>
          <ac:spMkLst>
            <pc:docMk/>
            <pc:sldMk cId="3004741895" sldId="264"/>
            <ac:spMk id="59" creationId="{5153D5EA-EE60-1005-A661-B419D8E74F82}"/>
          </ac:spMkLst>
        </pc:spChg>
        <pc:spChg chg="mod topLvl">
          <ac:chgData name="Sartorius, Carol" userId="717f8656-0c6f-4128-8672-6a166f4ce149" providerId="ADAL" clId="{C54814D0-1ED5-46F1-A9DB-A900A18121C8}" dt="2024-12-02T21:51:07.448" v="725" actId="164"/>
          <ac:spMkLst>
            <pc:docMk/>
            <pc:sldMk cId="3004741895" sldId="264"/>
            <ac:spMk id="60" creationId="{E731CF68-AB51-FD3E-21E8-F17C09F84766}"/>
          </ac:spMkLst>
        </pc:spChg>
        <pc:spChg chg="mod topLvl">
          <ac:chgData name="Sartorius, Carol" userId="717f8656-0c6f-4128-8672-6a166f4ce149" providerId="ADAL" clId="{C54814D0-1ED5-46F1-A9DB-A900A18121C8}" dt="2024-12-02T21:51:07.448" v="725" actId="164"/>
          <ac:spMkLst>
            <pc:docMk/>
            <pc:sldMk cId="3004741895" sldId="264"/>
            <ac:spMk id="62" creationId="{A97EEA04-5C5C-48AA-0669-9F268F036505}"/>
          </ac:spMkLst>
        </pc:spChg>
        <pc:spChg chg="mod topLvl">
          <ac:chgData name="Sartorius, Carol" userId="717f8656-0c6f-4128-8672-6a166f4ce149" providerId="ADAL" clId="{C54814D0-1ED5-46F1-A9DB-A900A18121C8}" dt="2024-12-02T21:51:07.448" v="725" actId="164"/>
          <ac:spMkLst>
            <pc:docMk/>
            <pc:sldMk cId="3004741895" sldId="264"/>
            <ac:spMk id="63" creationId="{9078C77D-C6A8-F12D-EB8C-53E6A3139D24}"/>
          </ac:spMkLst>
        </pc:spChg>
        <pc:spChg chg="mod topLvl">
          <ac:chgData name="Sartorius, Carol" userId="717f8656-0c6f-4128-8672-6a166f4ce149" providerId="ADAL" clId="{C54814D0-1ED5-46F1-A9DB-A900A18121C8}" dt="2024-12-02T21:51:07.448" v="725" actId="164"/>
          <ac:spMkLst>
            <pc:docMk/>
            <pc:sldMk cId="3004741895" sldId="264"/>
            <ac:spMk id="65" creationId="{957F91A5-3EFA-B3E3-8D12-E7425B5BD4AB}"/>
          </ac:spMkLst>
        </pc:spChg>
        <pc:spChg chg="mod topLvl">
          <ac:chgData name="Sartorius, Carol" userId="717f8656-0c6f-4128-8672-6a166f4ce149" providerId="ADAL" clId="{C54814D0-1ED5-46F1-A9DB-A900A18121C8}" dt="2024-12-02T21:51:07.448" v="725" actId="164"/>
          <ac:spMkLst>
            <pc:docMk/>
            <pc:sldMk cId="3004741895" sldId="264"/>
            <ac:spMk id="66" creationId="{DD4BD6C1-6F7B-1D90-28B5-91A97BC6398A}"/>
          </ac:spMkLst>
        </pc:spChg>
        <pc:spChg chg="mod topLvl">
          <ac:chgData name="Sartorius, Carol" userId="717f8656-0c6f-4128-8672-6a166f4ce149" providerId="ADAL" clId="{C54814D0-1ED5-46F1-A9DB-A900A18121C8}" dt="2024-12-02T21:51:07.448" v="725" actId="164"/>
          <ac:spMkLst>
            <pc:docMk/>
            <pc:sldMk cId="3004741895" sldId="264"/>
            <ac:spMk id="67" creationId="{08DF3DEB-C514-9752-EA92-218D2AE6A5C3}"/>
          </ac:spMkLst>
        </pc:spChg>
        <pc:spChg chg="mod topLvl">
          <ac:chgData name="Sartorius, Carol" userId="717f8656-0c6f-4128-8672-6a166f4ce149" providerId="ADAL" clId="{C54814D0-1ED5-46F1-A9DB-A900A18121C8}" dt="2024-12-02T21:51:07.448" v="725" actId="164"/>
          <ac:spMkLst>
            <pc:docMk/>
            <pc:sldMk cId="3004741895" sldId="264"/>
            <ac:spMk id="68" creationId="{B95B00F6-B357-1F52-3B9E-3C2C0659F804}"/>
          </ac:spMkLst>
        </pc:spChg>
        <pc:spChg chg="mod topLvl">
          <ac:chgData name="Sartorius, Carol" userId="717f8656-0c6f-4128-8672-6a166f4ce149" providerId="ADAL" clId="{C54814D0-1ED5-46F1-A9DB-A900A18121C8}" dt="2024-12-02T21:51:07.448" v="725" actId="164"/>
          <ac:spMkLst>
            <pc:docMk/>
            <pc:sldMk cId="3004741895" sldId="264"/>
            <ac:spMk id="96" creationId="{5E0DE7AA-8337-C2F1-435A-67F32261CF71}"/>
          </ac:spMkLst>
        </pc:spChg>
        <pc:spChg chg="mod topLvl">
          <ac:chgData name="Sartorius, Carol" userId="717f8656-0c6f-4128-8672-6a166f4ce149" providerId="ADAL" clId="{C54814D0-1ED5-46F1-A9DB-A900A18121C8}" dt="2024-12-02T21:51:07.448" v="725" actId="164"/>
          <ac:spMkLst>
            <pc:docMk/>
            <pc:sldMk cId="3004741895" sldId="264"/>
            <ac:spMk id="97" creationId="{E109B43B-BB2D-95B8-CF61-B1CD1E543591}"/>
          </ac:spMkLst>
        </pc:spChg>
        <pc:spChg chg="mod">
          <ac:chgData name="Sartorius, Carol" userId="717f8656-0c6f-4128-8672-6a166f4ce149" providerId="ADAL" clId="{C54814D0-1ED5-46F1-A9DB-A900A18121C8}" dt="2024-12-02T21:51:41.181" v="780" actId="164"/>
          <ac:spMkLst>
            <pc:docMk/>
            <pc:sldMk cId="3004741895" sldId="264"/>
            <ac:spMk id="102" creationId="{B60004C9-2797-2AB6-D9BE-481A07013CAA}"/>
          </ac:spMkLst>
        </pc:spChg>
        <pc:spChg chg="mod topLvl">
          <ac:chgData name="Sartorius, Carol" userId="717f8656-0c6f-4128-8672-6a166f4ce149" providerId="ADAL" clId="{C54814D0-1ED5-46F1-A9DB-A900A18121C8}" dt="2024-12-02T21:51:07.448" v="725" actId="164"/>
          <ac:spMkLst>
            <pc:docMk/>
            <pc:sldMk cId="3004741895" sldId="264"/>
            <ac:spMk id="103" creationId="{4FDCB41D-7B05-F41E-DFCE-4F73845975E6}"/>
          </ac:spMkLst>
        </pc:spChg>
        <pc:spChg chg="del">
          <ac:chgData name="Sartorius, Carol" userId="717f8656-0c6f-4128-8672-6a166f4ce149" providerId="ADAL" clId="{C54814D0-1ED5-46F1-A9DB-A900A18121C8}" dt="2024-12-02T21:41:58.092" v="398" actId="478"/>
          <ac:spMkLst>
            <pc:docMk/>
            <pc:sldMk cId="3004741895" sldId="264"/>
            <ac:spMk id="106" creationId="{79360BE7-6436-C25E-57B8-A41EB6D7D8B2}"/>
          </ac:spMkLst>
        </pc:spChg>
        <pc:grpChg chg="add mod">
          <ac:chgData name="Sartorius, Carol" userId="717f8656-0c6f-4128-8672-6a166f4ce149" providerId="ADAL" clId="{C54814D0-1ED5-46F1-A9DB-A900A18121C8}" dt="2024-12-02T21:51:41.181" v="780" actId="164"/>
          <ac:grpSpMkLst>
            <pc:docMk/>
            <pc:sldMk cId="3004741895" sldId="264"/>
            <ac:grpSpMk id="18" creationId="{EF3E87F5-0AAB-ABEA-757D-C8C9FFE5E5FD}"/>
          </ac:grpSpMkLst>
        </pc:grpChg>
        <pc:grpChg chg="add del mod">
          <ac:chgData name="Sartorius, Carol" userId="717f8656-0c6f-4128-8672-6a166f4ce149" providerId="ADAL" clId="{C54814D0-1ED5-46F1-A9DB-A900A18121C8}" dt="2024-12-02T21:50:56.186" v="724" actId="165"/>
          <ac:grpSpMkLst>
            <pc:docMk/>
            <pc:sldMk cId="3004741895" sldId="264"/>
            <ac:grpSpMk id="36" creationId="{18CE7681-E506-8D68-DB93-BFD0B852BBAE}"/>
          </ac:grpSpMkLst>
        </pc:grpChg>
        <pc:grpChg chg="add mod">
          <ac:chgData name="Sartorius, Carol" userId="717f8656-0c6f-4128-8672-6a166f4ce149" providerId="ADAL" clId="{C54814D0-1ED5-46F1-A9DB-A900A18121C8}" dt="2024-12-02T21:51:41.181" v="780" actId="164"/>
          <ac:grpSpMkLst>
            <pc:docMk/>
            <pc:sldMk cId="3004741895" sldId="264"/>
            <ac:grpSpMk id="37" creationId="{E7A40E42-3DE3-8D92-1540-C97E1E5B9A49}"/>
          </ac:grpSpMkLst>
        </pc:grpChg>
        <pc:grpChg chg="add mod">
          <ac:chgData name="Sartorius, Carol" userId="717f8656-0c6f-4128-8672-6a166f4ce149" providerId="ADAL" clId="{C54814D0-1ED5-46F1-A9DB-A900A18121C8}" dt="2024-12-02T21:51:41.181" v="780" actId="164"/>
          <ac:grpSpMkLst>
            <pc:docMk/>
            <pc:sldMk cId="3004741895" sldId="264"/>
            <ac:grpSpMk id="45" creationId="{9A8B4BD6-9B49-BC2A-8856-F3D302616B9B}"/>
          </ac:grpSpMkLst>
        </pc:grpChg>
        <pc:picChg chg="mod">
          <ac:chgData name="Sartorius, Carol" userId="717f8656-0c6f-4128-8672-6a166f4ce149" providerId="ADAL" clId="{C54814D0-1ED5-46F1-A9DB-A900A18121C8}" dt="2024-12-02T21:42:04.206" v="399" actId="164"/>
          <ac:picMkLst>
            <pc:docMk/>
            <pc:sldMk cId="3004741895" sldId="264"/>
            <ac:picMk id="2" creationId="{C6F181DC-8053-8078-1092-A2A974781653}"/>
          </ac:picMkLst>
        </pc:picChg>
        <pc:picChg chg="mod">
          <ac:chgData name="Sartorius, Carol" userId="717f8656-0c6f-4128-8672-6a166f4ce149" providerId="ADAL" clId="{C54814D0-1ED5-46F1-A9DB-A900A18121C8}" dt="2024-12-02T21:42:04.206" v="399" actId="164"/>
          <ac:picMkLst>
            <pc:docMk/>
            <pc:sldMk cId="3004741895" sldId="264"/>
            <ac:picMk id="3" creationId="{840B3CF0-15A4-982E-7230-D4FD3CA0E0EF}"/>
          </ac:picMkLst>
        </pc:picChg>
        <pc:picChg chg="mod">
          <ac:chgData name="Sartorius, Carol" userId="717f8656-0c6f-4128-8672-6a166f4ce149" providerId="ADAL" clId="{C54814D0-1ED5-46F1-A9DB-A900A18121C8}" dt="2024-12-02T21:42:04.206" v="399" actId="164"/>
          <ac:picMkLst>
            <pc:docMk/>
            <pc:sldMk cId="3004741895" sldId="264"/>
            <ac:picMk id="6" creationId="{58653D6B-2F50-31AE-1FEF-F0FFFB7A439E}"/>
          </ac:picMkLst>
        </pc:picChg>
        <pc:picChg chg="mod">
          <ac:chgData name="Sartorius, Carol" userId="717f8656-0c6f-4128-8672-6a166f4ce149" providerId="ADAL" clId="{C54814D0-1ED5-46F1-A9DB-A900A18121C8}" dt="2024-12-02T21:42:04.206" v="399" actId="164"/>
          <ac:picMkLst>
            <pc:docMk/>
            <pc:sldMk cId="3004741895" sldId="264"/>
            <ac:picMk id="32" creationId="{17B7A5CC-2BE8-9043-B6E9-230B66C46964}"/>
          </ac:picMkLst>
        </pc:picChg>
        <pc:picChg chg="mod topLvl">
          <ac:chgData name="Sartorius, Carol" userId="717f8656-0c6f-4128-8672-6a166f4ce149" providerId="ADAL" clId="{C54814D0-1ED5-46F1-A9DB-A900A18121C8}" dt="2024-12-02T21:51:07.448" v="725" actId="164"/>
          <ac:picMkLst>
            <pc:docMk/>
            <pc:sldMk cId="3004741895" sldId="264"/>
            <ac:picMk id="38" creationId="{387663DB-FC93-39FF-81A3-75B0A27C1E0C}"/>
          </ac:picMkLst>
        </pc:picChg>
        <pc:picChg chg="mod topLvl">
          <ac:chgData name="Sartorius, Carol" userId="717f8656-0c6f-4128-8672-6a166f4ce149" providerId="ADAL" clId="{C54814D0-1ED5-46F1-A9DB-A900A18121C8}" dt="2024-12-02T21:51:07.448" v="725" actId="164"/>
          <ac:picMkLst>
            <pc:docMk/>
            <pc:sldMk cId="3004741895" sldId="264"/>
            <ac:picMk id="39" creationId="{FBCCF87B-54B6-78B8-84E5-99FAD3641F55}"/>
          </ac:picMkLst>
        </pc:picChg>
        <pc:picChg chg="del">
          <ac:chgData name="Sartorius, Carol" userId="717f8656-0c6f-4128-8672-6a166f4ce149" providerId="ADAL" clId="{C54814D0-1ED5-46F1-A9DB-A900A18121C8}" dt="2024-12-02T21:41:55.717" v="397" actId="478"/>
          <ac:picMkLst>
            <pc:docMk/>
            <pc:sldMk cId="3004741895" sldId="264"/>
            <ac:picMk id="105" creationId="{BE2268C8-0417-4B48-9191-7600AF933CE1}"/>
          </ac:picMkLst>
        </pc:picChg>
      </pc:sldChg>
      <pc:sldChg chg="addSp delSp modSp mod">
        <pc:chgData name="Sartorius, Carol" userId="717f8656-0c6f-4128-8672-6a166f4ce149" providerId="ADAL" clId="{C54814D0-1ED5-46F1-A9DB-A900A18121C8}" dt="2024-12-05T23:55:50.075" v="2208" actId="20577"/>
        <pc:sldMkLst>
          <pc:docMk/>
          <pc:sldMk cId="2970839480" sldId="271"/>
        </pc:sldMkLst>
        <pc:spChg chg="mod">
          <ac:chgData name="Sartorius, Carol" userId="717f8656-0c6f-4128-8672-6a166f4ce149" providerId="ADAL" clId="{C54814D0-1ED5-46F1-A9DB-A900A18121C8}" dt="2024-12-05T23:55:50.075" v="2208" actId="20577"/>
          <ac:spMkLst>
            <pc:docMk/>
            <pc:sldMk cId="2970839480" sldId="271"/>
            <ac:spMk id="2" creationId="{CA4BBAA9-3AE1-E375-30CE-E08F2A2A3BC8}"/>
          </ac:spMkLst>
        </pc:spChg>
        <pc:spChg chg="mod">
          <ac:chgData name="Sartorius, Carol" userId="717f8656-0c6f-4128-8672-6a166f4ce149" providerId="ADAL" clId="{C54814D0-1ED5-46F1-A9DB-A900A18121C8}" dt="2024-12-02T23:27:36.075" v="1710" actId="255"/>
          <ac:spMkLst>
            <pc:docMk/>
            <pc:sldMk cId="2970839480" sldId="271"/>
            <ac:spMk id="7" creationId="{B36DEFA2-A3E6-02BF-FF86-379460FA3728}"/>
          </ac:spMkLst>
        </pc:spChg>
        <pc:spChg chg="mod">
          <ac:chgData name="Sartorius, Carol" userId="717f8656-0c6f-4128-8672-6a166f4ce149" providerId="ADAL" clId="{C54814D0-1ED5-46F1-A9DB-A900A18121C8}" dt="2024-12-02T23:27:36.075" v="1710" actId="255"/>
          <ac:spMkLst>
            <pc:docMk/>
            <pc:sldMk cId="2970839480" sldId="271"/>
            <ac:spMk id="8" creationId="{49D23A22-6F87-D3F3-D1A1-DFD63C2D90B1}"/>
          </ac:spMkLst>
        </pc:spChg>
        <pc:picChg chg="del">
          <ac:chgData name="Sartorius, Carol" userId="717f8656-0c6f-4128-8672-6a166f4ce149" providerId="ADAL" clId="{C54814D0-1ED5-46F1-A9DB-A900A18121C8}" dt="2024-12-04T21:40:51.516" v="1744" actId="478"/>
          <ac:picMkLst>
            <pc:docMk/>
            <pc:sldMk cId="2970839480" sldId="271"/>
            <ac:picMk id="3" creationId="{8300758F-F5B2-57F7-E7A0-BFC87167E1BE}"/>
          </ac:picMkLst>
        </pc:picChg>
        <pc:picChg chg="add del mod">
          <ac:chgData name="Sartorius, Carol" userId="717f8656-0c6f-4128-8672-6a166f4ce149" providerId="ADAL" clId="{C54814D0-1ED5-46F1-A9DB-A900A18121C8}" dt="2024-12-04T21:41:07.750" v="1748" actId="552"/>
          <ac:picMkLst>
            <pc:docMk/>
            <pc:sldMk cId="2970839480" sldId="271"/>
            <ac:picMk id="5" creationId="{28E76A09-6D5B-9406-5708-C79D38A5A2FD}"/>
          </ac:picMkLst>
        </pc:picChg>
        <pc:picChg chg="add mod">
          <ac:chgData name="Sartorius, Carol" userId="717f8656-0c6f-4128-8672-6a166f4ce149" providerId="ADAL" clId="{C54814D0-1ED5-46F1-A9DB-A900A18121C8}" dt="2024-12-04T21:41:07.750" v="1748" actId="552"/>
          <ac:picMkLst>
            <pc:docMk/>
            <pc:sldMk cId="2970839480" sldId="271"/>
            <ac:picMk id="9" creationId="{8275454B-B6C1-2AD6-D11F-E0501815A1B5}"/>
          </ac:picMkLst>
        </pc:picChg>
        <pc:picChg chg="del">
          <ac:chgData name="Sartorius, Carol" userId="717f8656-0c6f-4128-8672-6a166f4ce149" providerId="ADAL" clId="{C54814D0-1ED5-46F1-A9DB-A900A18121C8}" dt="2024-12-04T21:40:30.785" v="1737" actId="478"/>
          <ac:picMkLst>
            <pc:docMk/>
            <pc:sldMk cId="2970839480" sldId="271"/>
            <ac:picMk id="10" creationId="{E5231AF4-460D-30B4-93E4-0352EACA0506}"/>
          </ac:picMkLst>
        </pc:picChg>
        <pc:picChg chg="add mod">
          <ac:chgData name="Sartorius, Carol" userId="717f8656-0c6f-4128-8672-6a166f4ce149" providerId="ADAL" clId="{C54814D0-1ED5-46F1-A9DB-A900A18121C8}" dt="2024-12-04T21:42:41.202" v="1791" actId="1035"/>
          <ac:picMkLst>
            <pc:docMk/>
            <pc:sldMk cId="2970839480" sldId="271"/>
            <ac:picMk id="12" creationId="{438653F7-7AC0-3EF4-D632-C2F8CEF64004}"/>
          </ac:picMkLst>
        </pc:picChg>
        <pc:picChg chg="add mod">
          <ac:chgData name="Sartorius, Carol" userId="717f8656-0c6f-4128-8672-6a166f4ce149" providerId="ADAL" clId="{C54814D0-1ED5-46F1-A9DB-A900A18121C8}" dt="2024-12-04T21:42:59.834" v="1855" actId="1036"/>
          <ac:picMkLst>
            <pc:docMk/>
            <pc:sldMk cId="2970839480" sldId="271"/>
            <ac:picMk id="14" creationId="{CC3F2A87-1287-C1D1-3FF6-D9E701DCAA1A}"/>
          </ac:picMkLst>
        </pc:picChg>
        <pc:cxnChg chg="add mod">
          <ac:chgData name="Sartorius, Carol" userId="717f8656-0c6f-4128-8672-6a166f4ce149" providerId="ADAL" clId="{C54814D0-1ED5-46F1-A9DB-A900A18121C8}" dt="2024-12-04T21:42:56.153" v="1854" actId="1035"/>
          <ac:cxnSpMkLst>
            <pc:docMk/>
            <pc:sldMk cId="2970839480" sldId="271"/>
            <ac:cxnSpMk id="16" creationId="{AC0E06F9-C1D1-C7EB-2837-E7A051857867}"/>
          </ac:cxnSpMkLst>
        </pc:cxnChg>
      </pc:sldChg>
      <pc:sldChg chg="addSp modSp mod">
        <pc:chgData name="Sartorius, Carol" userId="717f8656-0c6f-4128-8672-6a166f4ce149" providerId="ADAL" clId="{C54814D0-1ED5-46F1-A9DB-A900A18121C8}" dt="2024-12-02T22:42:57.891" v="1167" actId="20577"/>
        <pc:sldMkLst>
          <pc:docMk/>
          <pc:sldMk cId="144900757" sldId="278"/>
        </pc:sldMkLst>
        <pc:spChg chg="mod">
          <ac:chgData name="Sartorius, Carol" userId="717f8656-0c6f-4128-8672-6a166f4ce149" providerId="ADAL" clId="{C54814D0-1ED5-46F1-A9DB-A900A18121C8}" dt="2024-12-02T22:01:30.842" v="998" actId="164"/>
          <ac:spMkLst>
            <pc:docMk/>
            <pc:sldMk cId="144900757" sldId="278"/>
            <ac:spMk id="7" creationId="{224CA08F-BB98-330F-B08D-C2ACF5A18A1C}"/>
          </ac:spMkLst>
        </pc:spChg>
        <pc:spChg chg="mod">
          <ac:chgData name="Sartorius, Carol" userId="717f8656-0c6f-4128-8672-6a166f4ce149" providerId="ADAL" clId="{C54814D0-1ED5-46F1-A9DB-A900A18121C8}" dt="2024-12-02T22:01:30.842" v="998" actId="164"/>
          <ac:spMkLst>
            <pc:docMk/>
            <pc:sldMk cId="144900757" sldId="278"/>
            <ac:spMk id="8" creationId="{74556A17-B5BC-F802-EC0A-F407F5A157C3}"/>
          </ac:spMkLst>
        </pc:spChg>
        <pc:spChg chg="mod">
          <ac:chgData name="Sartorius, Carol" userId="717f8656-0c6f-4128-8672-6a166f4ce149" providerId="ADAL" clId="{C54814D0-1ED5-46F1-A9DB-A900A18121C8}" dt="2024-12-02T22:42:57.891" v="1167" actId="20577"/>
          <ac:spMkLst>
            <pc:docMk/>
            <pc:sldMk cId="144900757" sldId="278"/>
            <ac:spMk id="27" creationId="{43BDFAA0-CBD9-C05F-4F54-AC80BA54F02E}"/>
          </ac:spMkLst>
        </pc:spChg>
        <pc:spChg chg="mod">
          <ac:chgData name="Sartorius, Carol" userId="717f8656-0c6f-4128-8672-6a166f4ce149" providerId="ADAL" clId="{C54814D0-1ED5-46F1-A9DB-A900A18121C8}" dt="2024-12-02T22:01:30.842" v="998" actId="164"/>
          <ac:spMkLst>
            <pc:docMk/>
            <pc:sldMk cId="144900757" sldId="278"/>
            <ac:spMk id="29" creationId="{C6D9A907-6519-9CA2-3CC1-2B0943FBF736}"/>
          </ac:spMkLst>
        </pc:spChg>
        <pc:spChg chg="mod">
          <ac:chgData name="Sartorius, Carol" userId="717f8656-0c6f-4128-8672-6a166f4ce149" providerId="ADAL" clId="{C54814D0-1ED5-46F1-A9DB-A900A18121C8}" dt="2024-12-02T22:01:30.842" v="998" actId="164"/>
          <ac:spMkLst>
            <pc:docMk/>
            <pc:sldMk cId="144900757" sldId="278"/>
            <ac:spMk id="31" creationId="{5AC5FBAA-2889-1143-69DF-760E136EBFA3}"/>
          </ac:spMkLst>
        </pc:spChg>
        <pc:spChg chg="mod">
          <ac:chgData name="Sartorius, Carol" userId="717f8656-0c6f-4128-8672-6a166f4ce149" providerId="ADAL" clId="{C54814D0-1ED5-46F1-A9DB-A900A18121C8}" dt="2024-12-02T22:01:30.842" v="998" actId="164"/>
          <ac:spMkLst>
            <pc:docMk/>
            <pc:sldMk cId="144900757" sldId="278"/>
            <ac:spMk id="32" creationId="{068F4F95-5CB3-C765-0E24-A3E26826A417}"/>
          </ac:spMkLst>
        </pc:spChg>
        <pc:spChg chg="mod">
          <ac:chgData name="Sartorius, Carol" userId="717f8656-0c6f-4128-8672-6a166f4ce149" providerId="ADAL" clId="{C54814D0-1ED5-46F1-A9DB-A900A18121C8}" dt="2024-12-02T22:01:30.842" v="998" actId="164"/>
          <ac:spMkLst>
            <pc:docMk/>
            <pc:sldMk cId="144900757" sldId="278"/>
            <ac:spMk id="40" creationId="{1FF6726A-ACD2-1443-55BA-F678DF0D246E}"/>
          </ac:spMkLst>
        </pc:spChg>
        <pc:spChg chg="mod">
          <ac:chgData name="Sartorius, Carol" userId="717f8656-0c6f-4128-8672-6a166f4ce149" providerId="ADAL" clId="{C54814D0-1ED5-46F1-A9DB-A900A18121C8}" dt="2024-12-02T22:01:30.842" v="998" actId="164"/>
          <ac:spMkLst>
            <pc:docMk/>
            <pc:sldMk cId="144900757" sldId="278"/>
            <ac:spMk id="41" creationId="{3B52A14A-F452-0C16-7D76-998D9AD304B2}"/>
          </ac:spMkLst>
        </pc:spChg>
        <pc:spChg chg="mod">
          <ac:chgData name="Sartorius, Carol" userId="717f8656-0c6f-4128-8672-6a166f4ce149" providerId="ADAL" clId="{C54814D0-1ED5-46F1-A9DB-A900A18121C8}" dt="2024-12-02T22:01:30.842" v="998" actId="164"/>
          <ac:spMkLst>
            <pc:docMk/>
            <pc:sldMk cId="144900757" sldId="278"/>
            <ac:spMk id="42" creationId="{4C337CAF-A1F0-76F2-37E5-93673032E867}"/>
          </ac:spMkLst>
        </pc:spChg>
        <pc:spChg chg="mod">
          <ac:chgData name="Sartorius, Carol" userId="717f8656-0c6f-4128-8672-6a166f4ce149" providerId="ADAL" clId="{C54814D0-1ED5-46F1-A9DB-A900A18121C8}" dt="2024-12-02T22:01:30.842" v="998" actId="164"/>
          <ac:spMkLst>
            <pc:docMk/>
            <pc:sldMk cId="144900757" sldId="278"/>
            <ac:spMk id="43" creationId="{8F9A184C-DAF5-4B24-1115-844F74C4C745}"/>
          </ac:spMkLst>
        </pc:spChg>
        <pc:grpChg chg="add mod">
          <ac:chgData name="Sartorius, Carol" userId="717f8656-0c6f-4128-8672-6a166f4ce149" providerId="ADAL" clId="{C54814D0-1ED5-46F1-A9DB-A900A18121C8}" dt="2024-12-02T22:01:30.842" v="998" actId="164"/>
          <ac:grpSpMkLst>
            <pc:docMk/>
            <pc:sldMk cId="144900757" sldId="278"/>
            <ac:grpSpMk id="2" creationId="{51BB1060-28C5-32AE-C1BF-6485A95FB2B5}"/>
          </ac:grpSpMkLst>
        </pc:grpChg>
        <pc:grpChg chg="mod">
          <ac:chgData name="Sartorius, Carol" userId="717f8656-0c6f-4128-8672-6a166f4ce149" providerId="ADAL" clId="{C54814D0-1ED5-46F1-A9DB-A900A18121C8}" dt="2024-12-02T22:01:30.842" v="998" actId="164"/>
          <ac:grpSpMkLst>
            <pc:docMk/>
            <pc:sldMk cId="144900757" sldId="278"/>
            <ac:grpSpMk id="37" creationId="{0270D7FB-203F-590D-17C7-D2E948000B21}"/>
          </ac:grpSpMkLst>
        </pc:grpChg>
        <pc:picChg chg="mod">
          <ac:chgData name="Sartorius, Carol" userId="717f8656-0c6f-4128-8672-6a166f4ce149" providerId="ADAL" clId="{C54814D0-1ED5-46F1-A9DB-A900A18121C8}" dt="2024-12-02T22:01:30.842" v="998" actId="164"/>
          <ac:picMkLst>
            <pc:docMk/>
            <pc:sldMk cId="144900757" sldId="278"/>
            <ac:picMk id="38" creationId="{44D79603-99F8-2467-99FB-1F923A2EDB85}"/>
          </ac:picMkLst>
        </pc:picChg>
      </pc:sldChg>
      <pc:sldChg chg="addSp delSp modSp mod">
        <pc:chgData name="Sartorius, Carol" userId="717f8656-0c6f-4128-8672-6a166f4ce149" providerId="ADAL" clId="{C54814D0-1ED5-46F1-A9DB-A900A18121C8}" dt="2024-12-02T23:31:36.629" v="1720" actId="20577"/>
        <pc:sldMkLst>
          <pc:docMk/>
          <pc:sldMk cId="3618263079" sldId="279"/>
        </pc:sldMkLst>
        <pc:spChg chg="mod">
          <ac:chgData name="Sartorius, Carol" userId="717f8656-0c6f-4128-8672-6a166f4ce149" providerId="ADAL" clId="{C54814D0-1ED5-46F1-A9DB-A900A18121C8}" dt="2024-12-02T23:31:36.629" v="1720" actId="20577"/>
          <ac:spMkLst>
            <pc:docMk/>
            <pc:sldMk cId="3618263079" sldId="279"/>
            <ac:spMk id="2" creationId="{A4F10A4B-69B6-7984-9ED6-55244E080E5A}"/>
          </ac:spMkLst>
        </pc:spChg>
        <pc:spChg chg="ord">
          <ac:chgData name="Sartorius, Carol" userId="717f8656-0c6f-4128-8672-6a166f4ce149" providerId="ADAL" clId="{C54814D0-1ED5-46F1-A9DB-A900A18121C8}" dt="2024-12-02T21:19:58.885" v="90" actId="166"/>
          <ac:spMkLst>
            <pc:docMk/>
            <pc:sldMk cId="3618263079" sldId="279"/>
            <ac:spMk id="6" creationId="{BC737953-3292-305D-1566-C007BA4E6436}"/>
          </ac:spMkLst>
        </pc:spChg>
        <pc:spChg chg="del">
          <ac:chgData name="Sartorius, Carol" userId="717f8656-0c6f-4128-8672-6a166f4ce149" providerId="ADAL" clId="{C54814D0-1ED5-46F1-A9DB-A900A18121C8}" dt="2024-11-25T21:35:26.846" v="69" actId="478"/>
          <ac:spMkLst>
            <pc:docMk/>
            <pc:sldMk cId="3618263079" sldId="279"/>
            <ac:spMk id="7" creationId="{B1CBB68F-4AD9-D7FB-9BD4-7951FAEA1F63}"/>
          </ac:spMkLst>
        </pc:spChg>
        <pc:picChg chg="add mod modCrop">
          <ac:chgData name="Sartorius, Carol" userId="717f8656-0c6f-4128-8672-6a166f4ce149" providerId="ADAL" clId="{C54814D0-1ED5-46F1-A9DB-A900A18121C8}" dt="2024-12-02T21:19:24.029" v="89" actId="1038"/>
          <ac:picMkLst>
            <pc:docMk/>
            <pc:sldMk cId="3618263079" sldId="279"/>
            <ac:picMk id="8" creationId="{2405A92C-274C-1F1E-49D5-6B2574C3DBFE}"/>
          </ac:picMkLst>
        </pc:picChg>
      </pc:sldChg>
      <pc:sldChg chg="addSp modSp mod">
        <pc:chgData name="Sartorius, Carol" userId="717f8656-0c6f-4128-8672-6a166f4ce149" providerId="ADAL" clId="{C54814D0-1ED5-46F1-A9DB-A900A18121C8}" dt="2024-12-02T23:31:59.638" v="1723" actId="113"/>
        <pc:sldMkLst>
          <pc:docMk/>
          <pc:sldMk cId="1268847539" sldId="280"/>
        </pc:sldMkLst>
        <pc:spChg chg="mod">
          <ac:chgData name="Sartorius, Carol" userId="717f8656-0c6f-4128-8672-6a166f4ce149" providerId="ADAL" clId="{C54814D0-1ED5-46F1-A9DB-A900A18121C8}" dt="2024-12-02T22:53:31.248" v="1399" actId="164"/>
          <ac:spMkLst>
            <pc:docMk/>
            <pc:sldMk cId="1268847539" sldId="280"/>
            <ac:spMk id="2" creationId="{6E90A044-560E-5E3B-A01D-399941935A54}"/>
          </ac:spMkLst>
        </pc:spChg>
        <pc:spChg chg="mod">
          <ac:chgData name="Sartorius, Carol" userId="717f8656-0c6f-4128-8672-6a166f4ce149" providerId="ADAL" clId="{C54814D0-1ED5-46F1-A9DB-A900A18121C8}" dt="2024-12-02T23:31:59.638" v="1723" actId="113"/>
          <ac:spMkLst>
            <pc:docMk/>
            <pc:sldMk cId="1268847539" sldId="280"/>
            <ac:spMk id="3" creationId="{C57E9503-4BC3-967E-3D28-93FEBFD6004D}"/>
          </ac:spMkLst>
        </pc:spChg>
        <pc:spChg chg="mod">
          <ac:chgData name="Sartorius, Carol" userId="717f8656-0c6f-4128-8672-6a166f4ce149" providerId="ADAL" clId="{C54814D0-1ED5-46F1-A9DB-A900A18121C8}" dt="2024-12-02T22:53:31.248" v="1399" actId="164"/>
          <ac:spMkLst>
            <pc:docMk/>
            <pc:sldMk cId="1268847539" sldId="280"/>
            <ac:spMk id="5" creationId="{0B17ACC6-604A-9FE7-9AAE-CBC3BEA13684}"/>
          </ac:spMkLst>
        </pc:spChg>
        <pc:spChg chg="mod">
          <ac:chgData name="Sartorius, Carol" userId="717f8656-0c6f-4128-8672-6a166f4ce149" providerId="ADAL" clId="{C54814D0-1ED5-46F1-A9DB-A900A18121C8}" dt="2024-12-02T22:53:31.248" v="1399" actId="164"/>
          <ac:spMkLst>
            <pc:docMk/>
            <pc:sldMk cId="1268847539" sldId="280"/>
            <ac:spMk id="12" creationId="{54FBD016-4F1A-7041-CFF6-C79F4C19EF6A}"/>
          </ac:spMkLst>
        </pc:spChg>
        <pc:spChg chg="mod">
          <ac:chgData name="Sartorius, Carol" userId="717f8656-0c6f-4128-8672-6a166f4ce149" providerId="ADAL" clId="{C54814D0-1ED5-46F1-A9DB-A900A18121C8}" dt="2024-12-02T22:53:31.248" v="1399" actId="164"/>
          <ac:spMkLst>
            <pc:docMk/>
            <pc:sldMk cId="1268847539" sldId="280"/>
            <ac:spMk id="13" creationId="{C9877368-A593-E105-A81F-C102903D8C97}"/>
          </ac:spMkLst>
        </pc:spChg>
        <pc:spChg chg="mod">
          <ac:chgData name="Sartorius, Carol" userId="717f8656-0c6f-4128-8672-6a166f4ce149" providerId="ADAL" clId="{C54814D0-1ED5-46F1-A9DB-A900A18121C8}" dt="2024-12-02T22:53:31.248" v="1399" actId="164"/>
          <ac:spMkLst>
            <pc:docMk/>
            <pc:sldMk cId="1268847539" sldId="280"/>
            <ac:spMk id="14" creationId="{EAB61C68-95DB-C54D-3C6A-6F85BAB294B6}"/>
          </ac:spMkLst>
        </pc:spChg>
        <pc:spChg chg="mod">
          <ac:chgData name="Sartorius, Carol" userId="717f8656-0c6f-4128-8672-6a166f4ce149" providerId="ADAL" clId="{C54814D0-1ED5-46F1-A9DB-A900A18121C8}" dt="2024-12-02T22:53:31.248" v="1399" actId="164"/>
          <ac:spMkLst>
            <pc:docMk/>
            <pc:sldMk cId="1268847539" sldId="280"/>
            <ac:spMk id="15" creationId="{43FE32CE-4338-FE41-4809-33BF867EA2CF}"/>
          </ac:spMkLst>
        </pc:spChg>
        <pc:spChg chg="mod">
          <ac:chgData name="Sartorius, Carol" userId="717f8656-0c6f-4128-8672-6a166f4ce149" providerId="ADAL" clId="{C54814D0-1ED5-46F1-A9DB-A900A18121C8}" dt="2024-12-02T22:53:31.248" v="1399" actId="164"/>
          <ac:spMkLst>
            <pc:docMk/>
            <pc:sldMk cId="1268847539" sldId="280"/>
            <ac:spMk id="16" creationId="{7A1440FE-8759-4F60-7AD6-7B725A08F69D}"/>
          </ac:spMkLst>
        </pc:spChg>
        <pc:spChg chg="mod">
          <ac:chgData name="Sartorius, Carol" userId="717f8656-0c6f-4128-8672-6a166f4ce149" providerId="ADAL" clId="{C54814D0-1ED5-46F1-A9DB-A900A18121C8}" dt="2024-12-02T22:53:31.248" v="1399" actId="164"/>
          <ac:spMkLst>
            <pc:docMk/>
            <pc:sldMk cId="1268847539" sldId="280"/>
            <ac:spMk id="17" creationId="{6F1D3D44-CCB1-87A2-1542-69891729A47A}"/>
          </ac:spMkLst>
        </pc:spChg>
        <pc:spChg chg="mod">
          <ac:chgData name="Sartorius, Carol" userId="717f8656-0c6f-4128-8672-6a166f4ce149" providerId="ADAL" clId="{C54814D0-1ED5-46F1-A9DB-A900A18121C8}" dt="2024-12-02T22:53:31.248" v="1399" actId="164"/>
          <ac:spMkLst>
            <pc:docMk/>
            <pc:sldMk cId="1268847539" sldId="280"/>
            <ac:spMk id="18" creationId="{C517B2DC-4B53-73B8-C096-69DEB71F1CA5}"/>
          </ac:spMkLst>
        </pc:spChg>
        <pc:spChg chg="mod">
          <ac:chgData name="Sartorius, Carol" userId="717f8656-0c6f-4128-8672-6a166f4ce149" providerId="ADAL" clId="{C54814D0-1ED5-46F1-A9DB-A900A18121C8}" dt="2024-12-02T22:53:31.248" v="1399" actId="164"/>
          <ac:spMkLst>
            <pc:docMk/>
            <pc:sldMk cId="1268847539" sldId="280"/>
            <ac:spMk id="19" creationId="{62F2CECE-2BB8-0483-4622-B6611ABA2ECD}"/>
          </ac:spMkLst>
        </pc:spChg>
        <pc:spChg chg="mod">
          <ac:chgData name="Sartorius, Carol" userId="717f8656-0c6f-4128-8672-6a166f4ce149" providerId="ADAL" clId="{C54814D0-1ED5-46F1-A9DB-A900A18121C8}" dt="2024-12-02T22:53:31.248" v="1399" actId="164"/>
          <ac:spMkLst>
            <pc:docMk/>
            <pc:sldMk cId="1268847539" sldId="280"/>
            <ac:spMk id="20" creationId="{595FF878-81A5-DFF5-D988-65700A5F8A33}"/>
          </ac:spMkLst>
        </pc:spChg>
        <pc:spChg chg="mod">
          <ac:chgData name="Sartorius, Carol" userId="717f8656-0c6f-4128-8672-6a166f4ce149" providerId="ADAL" clId="{C54814D0-1ED5-46F1-A9DB-A900A18121C8}" dt="2024-12-02T22:53:31.248" v="1399" actId="164"/>
          <ac:spMkLst>
            <pc:docMk/>
            <pc:sldMk cId="1268847539" sldId="280"/>
            <ac:spMk id="21" creationId="{66023367-BA8A-936A-3BE6-D086E738DD8C}"/>
          </ac:spMkLst>
        </pc:spChg>
        <pc:spChg chg="mod">
          <ac:chgData name="Sartorius, Carol" userId="717f8656-0c6f-4128-8672-6a166f4ce149" providerId="ADAL" clId="{C54814D0-1ED5-46F1-A9DB-A900A18121C8}" dt="2024-12-02T22:53:31.248" v="1399" actId="164"/>
          <ac:spMkLst>
            <pc:docMk/>
            <pc:sldMk cId="1268847539" sldId="280"/>
            <ac:spMk id="22" creationId="{EA1297BE-002A-6BDF-E291-AC73984CC502}"/>
          </ac:spMkLst>
        </pc:spChg>
        <pc:spChg chg="mod">
          <ac:chgData name="Sartorius, Carol" userId="717f8656-0c6f-4128-8672-6a166f4ce149" providerId="ADAL" clId="{C54814D0-1ED5-46F1-A9DB-A900A18121C8}" dt="2024-12-02T22:53:31.248" v="1399" actId="164"/>
          <ac:spMkLst>
            <pc:docMk/>
            <pc:sldMk cId="1268847539" sldId="280"/>
            <ac:spMk id="23" creationId="{2BCB7DAB-80B9-6043-8E4E-668A2D4704D0}"/>
          </ac:spMkLst>
        </pc:spChg>
        <pc:spChg chg="mod">
          <ac:chgData name="Sartorius, Carol" userId="717f8656-0c6f-4128-8672-6a166f4ce149" providerId="ADAL" clId="{C54814D0-1ED5-46F1-A9DB-A900A18121C8}" dt="2024-12-02T22:53:31.248" v="1399" actId="164"/>
          <ac:spMkLst>
            <pc:docMk/>
            <pc:sldMk cId="1268847539" sldId="280"/>
            <ac:spMk id="24" creationId="{EB347F67-E92E-A4EA-E8C7-2092F03A0B8D}"/>
          </ac:spMkLst>
        </pc:spChg>
        <pc:spChg chg="mod">
          <ac:chgData name="Sartorius, Carol" userId="717f8656-0c6f-4128-8672-6a166f4ce149" providerId="ADAL" clId="{C54814D0-1ED5-46F1-A9DB-A900A18121C8}" dt="2024-12-02T22:53:31.248" v="1399" actId="164"/>
          <ac:spMkLst>
            <pc:docMk/>
            <pc:sldMk cId="1268847539" sldId="280"/>
            <ac:spMk id="26" creationId="{2DF7CC4F-ACBF-DC94-7E7C-170990015C1E}"/>
          </ac:spMkLst>
        </pc:spChg>
        <pc:spChg chg="mod">
          <ac:chgData name="Sartorius, Carol" userId="717f8656-0c6f-4128-8672-6a166f4ce149" providerId="ADAL" clId="{C54814D0-1ED5-46F1-A9DB-A900A18121C8}" dt="2024-12-02T22:53:31.248" v="1399" actId="164"/>
          <ac:spMkLst>
            <pc:docMk/>
            <pc:sldMk cId="1268847539" sldId="280"/>
            <ac:spMk id="27" creationId="{D1D215C7-2D49-90BF-BE60-D38DE33BFB56}"/>
          </ac:spMkLst>
        </pc:spChg>
        <pc:spChg chg="mod">
          <ac:chgData name="Sartorius, Carol" userId="717f8656-0c6f-4128-8672-6a166f4ce149" providerId="ADAL" clId="{C54814D0-1ED5-46F1-A9DB-A900A18121C8}" dt="2024-12-02T22:53:31.248" v="1399" actId="164"/>
          <ac:spMkLst>
            <pc:docMk/>
            <pc:sldMk cId="1268847539" sldId="280"/>
            <ac:spMk id="37" creationId="{5D9F8092-6147-5B29-6D10-4A209A38EBB5}"/>
          </ac:spMkLst>
        </pc:spChg>
        <pc:spChg chg="mod">
          <ac:chgData name="Sartorius, Carol" userId="717f8656-0c6f-4128-8672-6a166f4ce149" providerId="ADAL" clId="{C54814D0-1ED5-46F1-A9DB-A900A18121C8}" dt="2024-12-02T22:53:31.248" v="1399" actId="164"/>
          <ac:spMkLst>
            <pc:docMk/>
            <pc:sldMk cId="1268847539" sldId="280"/>
            <ac:spMk id="38" creationId="{216BD2F2-3249-7E31-CF3F-2F9189A00E35}"/>
          </ac:spMkLst>
        </pc:spChg>
        <pc:spChg chg="mod">
          <ac:chgData name="Sartorius, Carol" userId="717f8656-0c6f-4128-8672-6a166f4ce149" providerId="ADAL" clId="{C54814D0-1ED5-46F1-A9DB-A900A18121C8}" dt="2024-12-02T22:53:31.248" v="1399" actId="164"/>
          <ac:spMkLst>
            <pc:docMk/>
            <pc:sldMk cId="1268847539" sldId="280"/>
            <ac:spMk id="39" creationId="{EC83F223-7109-F708-5DBB-607063AB383B}"/>
          </ac:spMkLst>
        </pc:spChg>
        <pc:spChg chg="mod">
          <ac:chgData name="Sartorius, Carol" userId="717f8656-0c6f-4128-8672-6a166f4ce149" providerId="ADAL" clId="{C54814D0-1ED5-46F1-A9DB-A900A18121C8}" dt="2024-12-02T22:53:31.248" v="1399" actId="164"/>
          <ac:spMkLst>
            <pc:docMk/>
            <pc:sldMk cId="1268847539" sldId="280"/>
            <ac:spMk id="40" creationId="{9354A368-3C33-D7FD-95F7-E973144C04DE}"/>
          </ac:spMkLst>
        </pc:spChg>
        <pc:spChg chg="mod">
          <ac:chgData name="Sartorius, Carol" userId="717f8656-0c6f-4128-8672-6a166f4ce149" providerId="ADAL" clId="{C54814D0-1ED5-46F1-A9DB-A900A18121C8}" dt="2024-12-02T22:53:31.248" v="1399" actId="164"/>
          <ac:spMkLst>
            <pc:docMk/>
            <pc:sldMk cId="1268847539" sldId="280"/>
            <ac:spMk id="41" creationId="{6CB39812-E12F-97EE-0FF3-EEEF8049EC16}"/>
          </ac:spMkLst>
        </pc:spChg>
        <pc:spChg chg="mod">
          <ac:chgData name="Sartorius, Carol" userId="717f8656-0c6f-4128-8672-6a166f4ce149" providerId="ADAL" clId="{C54814D0-1ED5-46F1-A9DB-A900A18121C8}" dt="2024-12-02T22:53:31.248" v="1399" actId="164"/>
          <ac:spMkLst>
            <pc:docMk/>
            <pc:sldMk cId="1268847539" sldId="280"/>
            <ac:spMk id="42" creationId="{13D6BD61-9543-67E7-3A8A-5AC6809D3103}"/>
          </ac:spMkLst>
        </pc:spChg>
        <pc:spChg chg="mod">
          <ac:chgData name="Sartorius, Carol" userId="717f8656-0c6f-4128-8672-6a166f4ce149" providerId="ADAL" clId="{C54814D0-1ED5-46F1-A9DB-A900A18121C8}" dt="2024-12-02T22:53:31.248" v="1399" actId="164"/>
          <ac:spMkLst>
            <pc:docMk/>
            <pc:sldMk cId="1268847539" sldId="280"/>
            <ac:spMk id="43" creationId="{E8DDAE7D-1734-56FD-0364-5559489E51E3}"/>
          </ac:spMkLst>
        </pc:spChg>
        <pc:spChg chg="mod">
          <ac:chgData name="Sartorius, Carol" userId="717f8656-0c6f-4128-8672-6a166f4ce149" providerId="ADAL" clId="{C54814D0-1ED5-46F1-A9DB-A900A18121C8}" dt="2024-12-02T22:53:31.248" v="1399" actId="164"/>
          <ac:spMkLst>
            <pc:docMk/>
            <pc:sldMk cId="1268847539" sldId="280"/>
            <ac:spMk id="44" creationId="{4207EB66-2898-1984-9484-94563E3C3428}"/>
          </ac:spMkLst>
        </pc:spChg>
        <pc:spChg chg="mod">
          <ac:chgData name="Sartorius, Carol" userId="717f8656-0c6f-4128-8672-6a166f4ce149" providerId="ADAL" clId="{C54814D0-1ED5-46F1-A9DB-A900A18121C8}" dt="2024-12-02T22:53:31.248" v="1399" actId="164"/>
          <ac:spMkLst>
            <pc:docMk/>
            <pc:sldMk cId="1268847539" sldId="280"/>
            <ac:spMk id="45" creationId="{AEC0D9E4-7763-6FE3-8777-906780367089}"/>
          </ac:spMkLst>
        </pc:spChg>
        <pc:grpChg chg="add mod">
          <ac:chgData name="Sartorius, Carol" userId="717f8656-0c6f-4128-8672-6a166f4ce149" providerId="ADAL" clId="{C54814D0-1ED5-46F1-A9DB-A900A18121C8}" dt="2024-12-02T22:53:31.248" v="1399" actId="164"/>
          <ac:grpSpMkLst>
            <pc:docMk/>
            <pc:sldMk cId="1268847539" sldId="280"/>
            <ac:grpSpMk id="7" creationId="{CDE34103-489E-DAB9-E189-42E40E3E5DF4}"/>
          </ac:grpSpMkLst>
        </pc:grpChg>
        <pc:picChg chg="mod">
          <ac:chgData name="Sartorius, Carol" userId="717f8656-0c6f-4128-8672-6a166f4ce149" providerId="ADAL" clId="{C54814D0-1ED5-46F1-A9DB-A900A18121C8}" dt="2024-12-02T22:53:31.248" v="1399" actId="164"/>
          <ac:picMkLst>
            <pc:docMk/>
            <pc:sldMk cId="1268847539" sldId="280"/>
            <ac:picMk id="4" creationId="{CAD615E4-C717-E420-5D66-84867A84C37D}"/>
          </ac:picMkLst>
        </pc:picChg>
        <pc:picChg chg="mod">
          <ac:chgData name="Sartorius, Carol" userId="717f8656-0c6f-4128-8672-6a166f4ce149" providerId="ADAL" clId="{C54814D0-1ED5-46F1-A9DB-A900A18121C8}" dt="2024-12-02T22:53:31.248" v="1399" actId="164"/>
          <ac:picMkLst>
            <pc:docMk/>
            <pc:sldMk cId="1268847539" sldId="280"/>
            <ac:picMk id="6" creationId="{EBA1DBEA-7481-56AE-8B3F-1C09FC3B94CD}"/>
          </ac:picMkLst>
        </pc:picChg>
        <pc:picChg chg="mod">
          <ac:chgData name="Sartorius, Carol" userId="717f8656-0c6f-4128-8672-6a166f4ce149" providerId="ADAL" clId="{C54814D0-1ED5-46F1-A9DB-A900A18121C8}" dt="2024-12-02T22:53:31.248" v="1399" actId="164"/>
          <ac:picMkLst>
            <pc:docMk/>
            <pc:sldMk cId="1268847539" sldId="280"/>
            <ac:picMk id="8" creationId="{D2D97F2E-EB12-8CBA-F80A-F1898C551FD9}"/>
          </ac:picMkLst>
        </pc:picChg>
        <pc:picChg chg="mod">
          <ac:chgData name="Sartorius, Carol" userId="717f8656-0c6f-4128-8672-6a166f4ce149" providerId="ADAL" clId="{C54814D0-1ED5-46F1-A9DB-A900A18121C8}" dt="2024-12-02T22:53:31.248" v="1399" actId="164"/>
          <ac:picMkLst>
            <pc:docMk/>
            <pc:sldMk cId="1268847539" sldId="280"/>
            <ac:picMk id="10" creationId="{A571F61C-E753-4739-5E33-915C8456B399}"/>
          </ac:picMkLst>
        </pc:picChg>
        <pc:cxnChg chg="mod">
          <ac:chgData name="Sartorius, Carol" userId="717f8656-0c6f-4128-8672-6a166f4ce149" providerId="ADAL" clId="{C54814D0-1ED5-46F1-A9DB-A900A18121C8}" dt="2024-12-02T22:53:31.248" v="1399" actId="164"/>
          <ac:cxnSpMkLst>
            <pc:docMk/>
            <pc:sldMk cId="1268847539" sldId="280"/>
            <ac:cxnSpMk id="9" creationId="{136D50CC-63A6-590E-3FCF-594A7F0E86A2}"/>
          </ac:cxnSpMkLst>
        </pc:cxnChg>
        <pc:cxnChg chg="mod">
          <ac:chgData name="Sartorius, Carol" userId="717f8656-0c6f-4128-8672-6a166f4ce149" providerId="ADAL" clId="{C54814D0-1ED5-46F1-A9DB-A900A18121C8}" dt="2024-12-02T22:53:31.248" v="1399" actId="164"/>
          <ac:cxnSpMkLst>
            <pc:docMk/>
            <pc:sldMk cId="1268847539" sldId="280"/>
            <ac:cxnSpMk id="36" creationId="{4264B5C5-9883-C307-21CB-1C26FC69FC57}"/>
          </ac:cxnSpMkLst>
        </pc:cxnChg>
        <pc:cxnChg chg="mod">
          <ac:chgData name="Sartorius, Carol" userId="717f8656-0c6f-4128-8672-6a166f4ce149" providerId="ADAL" clId="{C54814D0-1ED5-46F1-A9DB-A900A18121C8}" dt="2024-12-02T22:53:31.248" v="1399" actId="164"/>
          <ac:cxnSpMkLst>
            <pc:docMk/>
            <pc:sldMk cId="1268847539" sldId="280"/>
            <ac:cxnSpMk id="46" creationId="{801823A3-5F26-4871-BBDC-0DBBBC90F78B}"/>
          </ac:cxnSpMkLst>
        </pc:cxnChg>
        <pc:cxnChg chg="mod">
          <ac:chgData name="Sartorius, Carol" userId="717f8656-0c6f-4128-8672-6a166f4ce149" providerId="ADAL" clId="{C54814D0-1ED5-46F1-A9DB-A900A18121C8}" dt="2024-12-02T22:53:31.248" v="1399" actId="164"/>
          <ac:cxnSpMkLst>
            <pc:docMk/>
            <pc:sldMk cId="1268847539" sldId="280"/>
            <ac:cxnSpMk id="47" creationId="{719C1944-2A15-C625-09F0-211BE512960E}"/>
          </ac:cxnSpMkLst>
        </pc:cxnChg>
      </pc:sldChg>
      <pc:sldChg chg="addSp delSp modSp mod">
        <pc:chgData name="Sartorius, Carol" userId="717f8656-0c6f-4128-8672-6a166f4ce149" providerId="ADAL" clId="{C54814D0-1ED5-46F1-A9DB-A900A18121C8}" dt="2024-12-02T23:31:50.487" v="1722" actId="113"/>
        <pc:sldMkLst>
          <pc:docMk/>
          <pc:sldMk cId="1313199831" sldId="281"/>
        </pc:sldMkLst>
        <pc:spChg chg="mod">
          <ac:chgData name="Sartorius, Carol" userId="717f8656-0c6f-4128-8672-6a166f4ce149" providerId="ADAL" clId="{C54814D0-1ED5-46F1-A9DB-A900A18121C8}" dt="2024-12-02T23:31:50.487" v="1722" actId="113"/>
          <ac:spMkLst>
            <pc:docMk/>
            <pc:sldMk cId="1313199831" sldId="281"/>
            <ac:spMk id="2" creationId="{2AF6D795-274B-3B14-0EFE-052AA60971BE}"/>
          </ac:spMkLst>
        </pc:spChg>
        <pc:spChg chg="add mod">
          <ac:chgData name="Sartorius, Carol" userId="717f8656-0c6f-4128-8672-6a166f4ce149" providerId="ADAL" clId="{C54814D0-1ED5-46F1-A9DB-A900A18121C8}" dt="2024-09-26T22:50:17.513" v="13" actId="12789"/>
          <ac:spMkLst>
            <pc:docMk/>
            <pc:sldMk cId="1313199831" sldId="281"/>
            <ac:spMk id="7" creationId="{B1CBB68F-4AD9-D7FB-9BD4-7951FAEA1F63}"/>
          </ac:spMkLst>
        </pc:spChg>
        <pc:spChg chg="add mod">
          <ac:chgData name="Sartorius, Carol" userId="717f8656-0c6f-4128-8672-6a166f4ce149" providerId="ADAL" clId="{C54814D0-1ED5-46F1-A9DB-A900A18121C8}" dt="2024-09-26T23:09:07.477" v="66" actId="554"/>
          <ac:spMkLst>
            <pc:docMk/>
            <pc:sldMk cId="1313199831" sldId="281"/>
            <ac:spMk id="12" creationId="{B97A57B3-A4AD-780D-EC08-825E9604D11C}"/>
          </ac:spMkLst>
        </pc:spChg>
        <pc:spChg chg="add mod">
          <ac:chgData name="Sartorius, Carol" userId="717f8656-0c6f-4128-8672-6a166f4ce149" providerId="ADAL" clId="{C54814D0-1ED5-46F1-A9DB-A900A18121C8}" dt="2024-09-26T23:09:07.477" v="66" actId="554"/>
          <ac:spMkLst>
            <pc:docMk/>
            <pc:sldMk cId="1313199831" sldId="281"/>
            <ac:spMk id="13" creationId="{6F6D5148-DA0D-BD0F-585E-135D677B09E3}"/>
          </ac:spMkLst>
        </pc:spChg>
        <pc:picChg chg="add mod modCrop">
          <ac:chgData name="Sartorius, Carol" userId="717f8656-0c6f-4128-8672-6a166f4ce149" providerId="ADAL" clId="{C54814D0-1ED5-46F1-A9DB-A900A18121C8}" dt="2024-09-26T23:08:57.051" v="65" actId="1038"/>
          <ac:picMkLst>
            <pc:docMk/>
            <pc:sldMk cId="1313199831" sldId="281"/>
            <ac:picMk id="4" creationId="{BC4ED977-5C80-B5FF-0113-F9FAA2E59629}"/>
          </ac:picMkLst>
        </pc:picChg>
        <pc:picChg chg="add del mod">
          <ac:chgData name="Sartorius, Carol" userId="717f8656-0c6f-4128-8672-6a166f4ce149" providerId="ADAL" clId="{C54814D0-1ED5-46F1-A9DB-A900A18121C8}" dt="2024-09-26T22:50:45.887" v="18" actId="478"/>
          <ac:picMkLst>
            <pc:docMk/>
            <pc:sldMk cId="1313199831" sldId="281"/>
            <ac:picMk id="6" creationId="{ECB13D5B-D377-EC62-B426-509CC5A4310E}"/>
          </ac:picMkLst>
        </pc:picChg>
        <pc:picChg chg="add del mod">
          <ac:chgData name="Sartorius, Carol" userId="717f8656-0c6f-4128-8672-6a166f4ce149" providerId="ADAL" clId="{C54814D0-1ED5-46F1-A9DB-A900A18121C8}" dt="2024-09-26T23:09:09.976" v="67" actId="478"/>
          <ac:picMkLst>
            <pc:docMk/>
            <pc:sldMk cId="1313199831" sldId="281"/>
            <ac:picMk id="9" creationId="{65AF58E7-8E99-3858-9360-31DCCFE375EA}"/>
          </ac:picMkLst>
        </pc:picChg>
        <pc:picChg chg="add mod">
          <ac:chgData name="Sartorius, Carol" userId="717f8656-0c6f-4128-8672-6a166f4ce149" providerId="ADAL" clId="{C54814D0-1ED5-46F1-A9DB-A900A18121C8}" dt="2024-09-26T23:08:19.858" v="36" actId="1076"/>
          <ac:picMkLst>
            <pc:docMk/>
            <pc:sldMk cId="1313199831" sldId="281"/>
            <ac:picMk id="11" creationId="{F83CAC02-1405-4F5E-28A8-A2B7FC14FE80}"/>
          </ac:picMkLst>
        </pc:picChg>
      </pc:sldChg>
      <pc:sldChg chg="addSp modSp mod ord">
        <pc:chgData name="Sartorius, Carol" userId="717f8656-0c6f-4128-8672-6a166f4ce149" providerId="ADAL" clId="{C54814D0-1ED5-46F1-A9DB-A900A18121C8}" dt="2024-12-02T23:32:30.756" v="1728" actId="113"/>
        <pc:sldMkLst>
          <pc:docMk/>
          <pc:sldMk cId="3274515102" sldId="282"/>
        </pc:sldMkLst>
        <pc:spChg chg="mod">
          <ac:chgData name="Sartorius, Carol" userId="717f8656-0c6f-4128-8672-6a166f4ce149" providerId="ADAL" clId="{C54814D0-1ED5-46F1-A9DB-A900A18121C8}" dt="2024-12-02T22:44:48.771" v="1188" actId="164"/>
          <ac:spMkLst>
            <pc:docMk/>
            <pc:sldMk cId="3274515102" sldId="282"/>
            <ac:spMk id="6" creationId="{6D671AAA-A678-7C45-F2B8-254EC76AA53F}"/>
          </ac:spMkLst>
        </pc:spChg>
        <pc:spChg chg="mod">
          <ac:chgData name="Sartorius, Carol" userId="717f8656-0c6f-4128-8672-6a166f4ce149" providerId="ADAL" clId="{C54814D0-1ED5-46F1-A9DB-A900A18121C8}" dt="2024-12-02T22:44:48.771" v="1188" actId="164"/>
          <ac:spMkLst>
            <pc:docMk/>
            <pc:sldMk cId="3274515102" sldId="282"/>
            <ac:spMk id="8" creationId="{F44609E8-820A-C17B-A227-9C63B450B2BE}"/>
          </ac:spMkLst>
        </pc:spChg>
        <pc:spChg chg="mod">
          <ac:chgData name="Sartorius, Carol" userId="717f8656-0c6f-4128-8672-6a166f4ce149" providerId="ADAL" clId="{C54814D0-1ED5-46F1-A9DB-A900A18121C8}" dt="2024-12-02T23:32:30.756" v="1728" actId="113"/>
          <ac:spMkLst>
            <pc:docMk/>
            <pc:sldMk cId="3274515102" sldId="282"/>
            <ac:spMk id="9" creationId="{9786C0DB-5669-D39D-4642-65D188F8D2E7}"/>
          </ac:spMkLst>
        </pc:spChg>
        <pc:grpChg chg="add mod">
          <ac:chgData name="Sartorius, Carol" userId="717f8656-0c6f-4128-8672-6a166f4ce149" providerId="ADAL" clId="{C54814D0-1ED5-46F1-A9DB-A900A18121C8}" dt="2024-12-02T22:44:48.771" v="1188" actId="164"/>
          <ac:grpSpMkLst>
            <pc:docMk/>
            <pc:sldMk cId="3274515102" sldId="282"/>
            <ac:grpSpMk id="2" creationId="{D238330A-B1B6-B7A8-742A-93E511BE79B3}"/>
          </ac:grpSpMkLst>
        </pc:grpChg>
        <pc:picChg chg="mod">
          <ac:chgData name="Sartorius, Carol" userId="717f8656-0c6f-4128-8672-6a166f4ce149" providerId="ADAL" clId="{C54814D0-1ED5-46F1-A9DB-A900A18121C8}" dt="2024-12-02T22:44:48.771" v="1188" actId="164"/>
          <ac:picMkLst>
            <pc:docMk/>
            <pc:sldMk cId="3274515102" sldId="282"/>
            <ac:picMk id="3" creationId="{FF6C6677-D6E3-8DD0-62A6-73A851FCA709}"/>
          </ac:picMkLst>
        </pc:picChg>
        <pc:picChg chg="mod">
          <ac:chgData name="Sartorius, Carol" userId="717f8656-0c6f-4128-8672-6a166f4ce149" providerId="ADAL" clId="{C54814D0-1ED5-46F1-A9DB-A900A18121C8}" dt="2024-12-02T22:44:48.771" v="1188" actId="164"/>
          <ac:picMkLst>
            <pc:docMk/>
            <pc:sldMk cId="3274515102" sldId="282"/>
            <ac:picMk id="5" creationId="{74A01151-A188-59EF-A96E-0E846EEA21B5}"/>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379CE27-B703-BE43-87BA-4D546F4E33AF}" type="datetimeFigureOut">
              <a:rPr lang="en-US" smtClean="0"/>
              <a:t>12/5/2024</a:t>
            </a:fld>
            <a:endParaRPr lang="en-US"/>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22A2C4C-35D2-DD4A-B8E2-34752DBB5416}" type="slidenum">
              <a:rPr lang="en-US" smtClean="0"/>
              <a:t>‹#›</a:t>
            </a:fld>
            <a:endParaRPr lang="en-US"/>
          </a:p>
        </p:txBody>
      </p:sp>
    </p:spTree>
    <p:extLst>
      <p:ext uri="{BB962C8B-B14F-4D97-AF65-F5344CB8AC3E}">
        <p14:creationId xmlns:p14="http://schemas.microsoft.com/office/powerpoint/2010/main" val="2294622943"/>
      </p:ext>
    </p:extLst>
  </p:cSld>
  <p:clrMap bg1="lt1" tx1="dk1" bg2="lt2" tx2="dk2" accent1="accent1" accent2="accent2" accent3="accent3" accent4="accent4" accent5="accent5" accent6="accent6" hlink="hlink" folHlink="folHlink"/>
  <p:notesStyle>
    <a:lvl1pPr marL="0" algn="l" defTabSz="1018824" rtl="0" eaLnBrk="1" latinLnBrk="0" hangingPunct="1">
      <a:defRPr sz="1337" kern="1200">
        <a:solidFill>
          <a:schemeClr val="tx1"/>
        </a:solidFill>
        <a:latin typeface="+mn-lt"/>
        <a:ea typeface="+mn-ea"/>
        <a:cs typeface="+mn-cs"/>
      </a:defRPr>
    </a:lvl1pPr>
    <a:lvl2pPr marL="509412" algn="l" defTabSz="1018824" rtl="0" eaLnBrk="1" latinLnBrk="0" hangingPunct="1">
      <a:defRPr sz="1337" kern="1200">
        <a:solidFill>
          <a:schemeClr val="tx1"/>
        </a:solidFill>
        <a:latin typeface="+mn-lt"/>
        <a:ea typeface="+mn-ea"/>
        <a:cs typeface="+mn-cs"/>
      </a:defRPr>
    </a:lvl2pPr>
    <a:lvl3pPr marL="1018824" algn="l" defTabSz="1018824" rtl="0" eaLnBrk="1" latinLnBrk="0" hangingPunct="1">
      <a:defRPr sz="1337" kern="1200">
        <a:solidFill>
          <a:schemeClr val="tx1"/>
        </a:solidFill>
        <a:latin typeface="+mn-lt"/>
        <a:ea typeface="+mn-ea"/>
        <a:cs typeface="+mn-cs"/>
      </a:defRPr>
    </a:lvl3pPr>
    <a:lvl4pPr marL="1528237" algn="l" defTabSz="1018824" rtl="0" eaLnBrk="1" latinLnBrk="0" hangingPunct="1">
      <a:defRPr sz="1337" kern="1200">
        <a:solidFill>
          <a:schemeClr val="tx1"/>
        </a:solidFill>
        <a:latin typeface="+mn-lt"/>
        <a:ea typeface="+mn-ea"/>
        <a:cs typeface="+mn-cs"/>
      </a:defRPr>
    </a:lvl4pPr>
    <a:lvl5pPr marL="2037649" algn="l" defTabSz="1018824" rtl="0" eaLnBrk="1" latinLnBrk="0" hangingPunct="1">
      <a:defRPr sz="1337" kern="1200">
        <a:solidFill>
          <a:schemeClr val="tx1"/>
        </a:solidFill>
        <a:latin typeface="+mn-lt"/>
        <a:ea typeface="+mn-ea"/>
        <a:cs typeface="+mn-cs"/>
      </a:defRPr>
    </a:lvl5pPr>
    <a:lvl6pPr marL="2547061" algn="l" defTabSz="1018824" rtl="0" eaLnBrk="1" latinLnBrk="0" hangingPunct="1">
      <a:defRPr sz="1337" kern="1200">
        <a:solidFill>
          <a:schemeClr val="tx1"/>
        </a:solidFill>
        <a:latin typeface="+mn-lt"/>
        <a:ea typeface="+mn-ea"/>
        <a:cs typeface="+mn-cs"/>
      </a:defRPr>
    </a:lvl6pPr>
    <a:lvl7pPr marL="3056473" algn="l" defTabSz="1018824" rtl="0" eaLnBrk="1" latinLnBrk="0" hangingPunct="1">
      <a:defRPr sz="1337" kern="1200">
        <a:solidFill>
          <a:schemeClr val="tx1"/>
        </a:solidFill>
        <a:latin typeface="+mn-lt"/>
        <a:ea typeface="+mn-ea"/>
        <a:cs typeface="+mn-cs"/>
      </a:defRPr>
    </a:lvl7pPr>
    <a:lvl8pPr marL="3565886" algn="l" defTabSz="1018824" rtl="0" eaLnBrk="1" latinLnBrk="0" hangingPunct="1">
      <a:defRPr sz="1337" kern="1200">
        <a:solidFill>
          <a:schemeClr val="tx1"/>
        </a:solidFill>
        <a:latin typeface="+mn-lt"/>
        <a:ea typeface="+mn-ea"/>
        <a:cs typeface="+mn-cs"/>
      </a:defRPr>
    </a:lvl8pPr>
    <a:lvl9pPr marL="4075298" algn="l" defTabSz="1018824" rtl="0" eaLnBrk="1" latinLnBrk="0" hangingPunct="1">
      <a:defRPr sz="1337"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6788" y="1143000"/>
            <a:ext cx="238442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effectLst/>
                <a:latin typeface="TimesNewRomanPS"/>
              </a:rPr>
              <a:t>Sig. Fig. #: FAO Seahorse Mito Stress Test of Parental and ET resistant Breast Cancer Cells. </a:t>
            </a:r>
            <a:r>
              <a:rPr lang="en-US" sz="1800" dirty="0">
                <a:effectLst/>
                <a:latin typeface="TimesNewRomanPSMT"/>
              </a:rPr>
              <a:t>15x10</a:t>
            </a:r>
            <a:r>
              <a:rPr lang="en-US" sz="1800" baseline="30000" dirty="0">
                <a:effectLst/>
                <a:latin typeface="TimesNewRomanPSMT"/>
              </a:rPr>
              <a:t>3</a:t>
            </a:r>
            <a:r>
              <a:rPr lang="en-US" sz="1800" dirty="0">
                <a:effectLst/>
                <a:latin typeface="TimesNewRomanPSMT"/>
              </a:rPr>
              <a:t> T47D </a:t>
            </a:r>
            <a:r>
              <a:rPr lang="en-US" sz="1800" b="0" dirty="0">
                <a:effectLst/>
                <a:latin typeface="TimesNewRomanPSMT"/>
              </a:rPr>
              <a:t>(</a:t>
            </a:r>
            <a:r>
              <a:rPr lang="en-US" sz="1800" b="0" dirty="0">
                <a:effectLst/>
                <a:latin typeface="TimesNewRomanPS"/>
              </a:rPr>
              <a:t>a</a:t>
            </a:r>
            <a:r>
              <a:rPr lang="en-US" sz="1800" b="0" dirty="0">
                <a:effectLst/>
                <a:latin typeface="TimesNewRomanPSMT"/>
              </a:rPr>
              <a:t>)</a:t>
            </a:r>
            <a:r>
              <a:rPr lang="en-US" sz="1800" dirty="0">
                <a:effectLst/>
                <a:latin typeface="TimesNewRomanPSMT"/>
              </a:rPr>
              <a:t> and UCD4 </a:t>
            </a:r>
            <a:r>
              <a:rPr lang="en-US" sz="1800" b="0" dirty="0">
                <a:effectLst/>
                <a:latin typeface="TimesNewRomanPSMT"/>
              </a:rPr>
              <a:t>(</a:t>
            </a:r>
            <a:r>
              <a:rPr lang="en-US" sz="1800" b="0" dirty="0">
                <a:effectLst/>
                <a:latin typeface="TimesNewRomanPS"/>
              </a:rPr>
              <a:t>b</a:t>
            </a:r>
            <a:r>
              <a:rPr lang="en-US" sz="1800" b="0" dirty="0">
                <a:effectLst/>
                <a:latin typeface="TimesNewRomanPSMT"/>
              </a:rPr>
              <a:t>)</a:t>
            </a:r>
            <a:r>
              <a:rPr lang="en-US" sz="1800" dirty="0">
                <a:effectLst/>
                <a:latin typeface="TimesNewRomanPSMT"/>
              </a:rPr>
              <a:t> parental and ET resistant cells were plated in XF96-well Seahorse Assay plates (n=6 each), nutrient deprived, and supplemented with BSA control or XF Palmitate-BSA conjugate 4 hours prior to performing the assay. Assays were standard XF Mito Stress Tests conducted in a 96XFe format. Oxygen consumption rate (OCR) was normalized to cell count obtained by Hoechst 33342 dye and Agilent </a:t>
            </a:r>
            <a:r>
              <a:rPr lang="en-US" sz="1800" dirty="0" err="1">
                <a:effectLst/>
                <a:latin typeface="TimesNewRomanPSMT"/>
              </a:rPr>
              <a:t>Cytation</a:t>
            </a:r>
            <a:r>
              <a:rPr lang="en-US" sz="1800" dirty="0">
                <a:effectLst/>
                <a:latin typeface="TimesNewRomanPSMT"/>
              </a:rPr>
              <a:t> instrument post-assay. Oligo=</a:t>
            </a:r>
            <a:r>
              <a:rPr lang="en-US" sz="1800" dirty="0" err="1">
                <a:effectLst/>
                <a:latin typeface="TimesNewRomanPSMT"/>
              </a:rPr>
              <a:t>Oligimycin</a:t>
            </a:r>
            <a:r>
              <a:rPr lang="en-US" sz="1800" dirty="0">
                <a:effectLst/>
                <a:latin typeface="TimesNewRomanPSMT"/>
              </a:rPr>
              <a:t>; FCCP= Trifluoromethoxy </a:t>
            </a:r>
            <a:r>
              <a:rPr lang="en-US" sz="1800" dirty="0" err="1">
                <a:effectLst/>
                <a:latin typeface="TimesNewRomanPSMT"/>
              </a:rPr>
              <a:t>carbonylcyanide</a:t>
            </a:r>
            <a:r>
              <a:rPr lang="en-US" sz="1800" dirty="0">
                <a:effectLst/>
                <a:latin typeface="TimesNewRomanPSMT"/>
              </a:rPr>
              <a:t> phenylhydrazone; Rot/AA=Rotenone and Antimycin A. Error bars represent SD. </a:t>
            </a:r>
            <a:endParaRPr lang="en-US" dirty="0"/>
          </a:p>
          <a:p>
            <a:endParaRPr lang="en-US" dirty="0"/>
          </a:p>
        </p:txBody>
      </p:sp>
      <p:sp>
        <p:nvSpPr>
          <p:cNvPr id="4" name="Slide Number Placeholder 3"/>
          <p:cNvSpPr>
            <a:spLocks noGrp="1"/>
          </p:cNvSpPr>
          <p:nvPr>
            <p:ph type="sldNum" sz="quarter" idx="5"/>
          </p:nvPr>
        </p:nvSpPr>
        <p:spPr/>
        <p:txBody>
          <a:bodyPr/>
          <a:lstStyle/>
          <a:p>
            <a:fld id="{F730F0B7-A9AE-DA41-B198-2BE2069BAF96}" type="slidenum">
              <a:rPr lang="en-US" smtClean="0"/>
              <a:t>4</a:t>
            </a:fld>
            <a:endParaRPr lang="en-US"/>
          </a:p>
        </p:txBody>
      </p:sp>
    </p:spTree>
    <p:extLst>
      <p:ext uri="{BB962C8B-B14F-4D97-AF65-F5344CB8AC3E}">
        <p14:creationId xmlns:p14="http://schemas.microsoft.com/office/powerpoint/2010/main" val="113136846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6788" y="1143000"/>
            <a:ext cx="2384425" cy="3086100"/>
          </a:xfrm>
        </p:spPr>
      </p:sp>
      <p:sp>
        <p:nvSpPr>
          <p:cNvPr id="3" name="Notes Placeholder 2"/>
          <p:cNvSpPr>
            <a:spLocks noGrp="1"/>
          </p:cNvSpPr>
          <p:nvPr>
            <p:ph type="body" idx="1"/>
          </p:nvPr>
        </p:nvSpPr>
        <p:spPr/>
        <p:txBody>
          <a:bodyPr/>
          <a:lstStyle/>
          <a:p>
            <a:r>
              <a:rPr lang="en-US" sz="1200" dirty="0"/>
              <a:t>30 min Oligomycin (0.5µM) </a:t>
            </a:r>
            <a:r>
              <a:rPr lang="en-US" sz="1200" dirty="0" err="1"/>
              <a:t>tx</a:t>
            </a:r>
            <a:r>
              <a:rPr lang="en-US" sz="1200" dirty="0"/>
              <a:t> for pACC1 positive control</a:t>
            </a:r>
          </a:p>
          <a:p>
            <a:r>
              <a:rPr lang="en-US" sz="1200" dirty="0"/>
              <a:t>25ug protein loaded per sample</a:t>
            </a:r>
          </a:p>
          <a:p>
            <a:endParaRPr lang="en-US" dirty="0"/>
          </a:p>
        </p:txBody>
      </p:sp>
      <p:sp>
        <p:nvSpPr>
          <p:cNvPr id="4" name="Slide Number Placeholder 3"/>
          <p:cNvSpPr>
            <a:spLocks noGrp="1"/>
          </p:cNvSpPr>
          <p:nvPr>
            <p:ph type="sldNum" sz="quarter" idx="5"/>
          </p:nvPr>
        </p:nvSpPr>
        <p:spPr/>
        <p:txBody>
          <a:bodyPr/>
          <a:lstStyle/>
          <a:p>
            <a:fld id="{13FEAAB9-D8BB-7B47-AB24-EAC0C4243C81}" type="slidenum">
              <a:rPr lang="en-US" smtClean="0"/>
              <a:t>6</a:t>
            </a:fld>
            <a:endParaRPr lang="en-US"/>
          </a:p>
        </p:txBody>
      </p:sp>
    </p:spTree>
    <p:extLst>
      <p:ext uri="{BB962C8B-B14F-4D97-AF65-F5344CB8AC3E}">
        <p14:creationId xmlns:p14="http://schemas.microsoft.com/office/powerpoint/2010/main" val="315431084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2D5D4A6-2EB2-DE4F-8918-8AA8AFFB4553}" type="datetimeFigureOut">
              <a:rPr lang="en-US" smtClean="0"/>
              <a:t>12/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63D996-FED7-9B43-99FF-70BBD373510B}" type="slidenum">
              <a:rPr lang="en-US" smtClean="0"/>
              <a:t>‹#›</a:t>
            </a:fld>
            <a:endParaRPr lang="en-US"/>
          </a:p>
        </p:txBody>
      </p:sp>
    </p:spTree>
    <p:extLst>
      <p:ext uri="{BB962C8B-B14F-4D97-AF65-F5344CB8AC3E}">
        <p14:creationId xmlns:p14="http://schemas.microsoft.com/office/powerpoint/2010/main" val="7924780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2D5D4A6-2EB2-DE4F-8918-8AA8AFFB4553}" type="datetimeFigureOut">
              <a:rPr lang="en-US" smtClean="0"/>
              <a:t>12/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63D996-FED7-9B43-99FF-70BBD373510B}" type="slidenum">
              <a:rPr lang="en-US" smtClean="0"/>
              <a:t>‹#›</a:t>
            </a:fld>
            <a:endParaRPr lang="en-US"/>
          </a:p>
        </p:txBody>
      </p:sp>
    </p:spTree>
    <p:extLst>
      <p:ext uri="{BB962C8B-B14F-4D97-AF65-F5344CB8AC3E}">
        <p14:creationId xmlns:p14="http://schemas.microsoft.com/office/powerpoint/2010/main" val="39169382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2D5D4A6-2EB2-DE4F-8918-8AA8AFFB4553}" type="datetimeFigureOut">
              <a:rPr lang="en-US" smtClean="0"/>
              <a:t>12/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63D996-FED7-9B43-99FF-70BBD373510B}" type="slidenum">
              <a:rPr lang="en-US" smtClean="0"/>
              <a:t>‹#›</a:t>
            </a:fld>
            <a:endParaRPr lang="en-US"/>
          </a:p>
        </p:txBody>
      </p:sp>
    </p:spTree>
    <p:extLst>
      <p:ext uri="{BB962C8B-B14F-4D97-AF65-F5344CB8AC3E}">
        <p14:creationId xmlns:p14="http://schemas.microsoft.com/office/powerpoint/2010/main" val="3945701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2D5D4A6-2EB2-DE4F-8918-8AA8AFFB4553}" type="datetimeFigureOut">
              <a:rPr lang="en-US" smtClean="0"/>
              <a:t>12/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63D996-FED7-9B43-99FF-70BBD373510B}" type="slidenum">
              <a:rPr lang="en-US" smtClean="0"/>
              <a:t>‹#›</a:t>
            </a:fld>
            <a:endParaRPr lang="en-US"/>
          </a:p>
        </p:txBody>
      </p:sp>
    </p:spTree>
    <p:extLst>
      <p:ext uri="{BB962C8B-B14F-4D97-AF65-F5344CB8AC3E}">
        <p14:creationId xmlns:p14="http://schemas.microsoft.com/office/powerpoint/2010/main" val="31607730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tint val="82000"/>
                  </a:schemeClr>
                </a:solidFill>
              </a:defRPr>
            </a:lvl1pPr>
            <a:lvl2pPr marL="388620" indent="0">
              <a:buNone/>
              <a:defRPr sz="1700">
                <a:solidFill>
                  <a:schemeClr val="tx1">
                    <a:tint val="82000"/>
                  </a:schemeClr>
                </a:solidFill>
              </a:defRPr>
            </a:lvl2pPr>
            <a:lvl3pPr marL="777240" indent="0">
              <a:buNone/>
              <a:defRPr sz="1530">
                <a:solidFill>
                  <a:schemeClr val="tx1">
                    <a:tint val="82000"/>
                  </a:schemeClr>
                </a:solidFill>
              </a:defRPr>
            </a:lvl3pPr>
            <a:lvl4pPr marL="1165860" indent="0">
              <a:buNone/>
              <a:defRPr sz="1360">
                <a:solidFill>
                  <a:schemeClr val="tx1">
                    <a:tint val="82000"/>
                  </a:schemeClr>
                </a:solidFill>
              </a:defRPr>
            </a:lvl4pPr>
            <a:lvl5pPr marL="1554480" indent="0">
              <a:buNone/>
              <a:defRPr sz="1360">
                <a:solidFill>
                  <a:schemeClr val="tx1">
                    <a:tint val="82000"/>
                  </a:schemeClr>
                </a:solidFill>
              </a:defRPr>
            </a:lvl5pPr>
            <a:lvl6pPr marL="1943100" indent="0">
              <a:buNone/>
              <a:defRPr sz="1360">
                <a:solidFill>
                  <a:schemeClr val="tx1">
                    <a:tint val="82000"/>
                  </a:schemeClr>
                </a:solidFill>
              </a:defRPr>
            </a:lvl6pPr>
            <a:lvl7pPr marL="2331720" indent="0">
              <a:buNone/>
              <a:defRPr sz="1360">
                <a:solidFill>
                  <a:schemeClr val="tx1">
                    <a:tint val="82000"/>
                  </a:schemeClr>
                </a:solidFill>
              </a:defRPr>
            </a:lvl7pPr>
            <a:lvl8pPr marL="2720340" indent="0">
              <a:buNone/>
              <a:defRPr sz="1360">
                <a:solidFill>
                  <a:schemeClr val="tx1">
                    <a:tint val="82000"/>
                  </a:schemeClr>
                </a:solidFill>
              </a:defRPr>
            </a:lvl8pPr>
            <a:lvl9pPr marL="3108960" indent="0">
              <a:buNone/>
              <a:defRPr sz="136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2D5D4A6-2EB2-DE4F-8918-8AA8AFFB4553}" type="datetimeFigureOut">
              <a:rPr lang="en-US" smtClean="0"/>
              <a:t>12/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63D996-FED7-9B43-99FF-70BBD373510B}" type="slidenum">
              <a:rPr lang="en-US" smtClean="0"/>
              <a:t>‹#›</a:t>
            </a:fld>
            <a:endParaRPr lang="en-US"/>
          </a:p>
        </p:txBody>
      </p:sp>
    </p:spTree>
    <p:extLst>
      <p:ext uri="{BB962C8B-B14F-4D97-AF65-F5344CB8AC3E}">
        <p14:creationId xmlns:p14="http://schemas.microsoft.com/office/powerpoint/2010/main" val="25364235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2D5D4A6-2EB2-DE4F-8918-8AA8AFFB4553}" type="datetimeFigureOut">
              <a:rPr lang="en-US" smtClean="0"/>
              <a:t>12/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A63D996-FED7-9B43-99FF-70BBD373510B}" type="slidenum">
              <a:rPr lang="en-US" smtClean="0"/>
              <a:t>‹#›</a:t>
            </a:fld>
            <a:endParaRPr lang="en-US"/>
          </a:p>
        </p:txBody>
      </p:sp>
    </p:spTree>
    <p:extLst>
      <p:ext uri="{BB962C8B-B14F-4D97-AF65-F5344CB8AC3E}">
        <p14:creationId xmlns:p14="http://schemas.microsoft.com/office/powerpoint/2010/main" val="16398222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2D5D4A6-2EB2-DE4F-8918-8AA8AFFB4553}" type="datetimeFigureOut">
              <a:rPr lang="en-US" smtClean="0"/>
              <a:t>12/5/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A63D996-FED7-9B43-99FF-70BBD373510B}" type="slidenum">
              <a:rPr lang="en-US" smtClean="0"/>
              <a:t>‹#›</a:t>
            </a:fld>
            <a:endParaRPr lang="en-US"/>
          </a:p>
        </p:txBody>
      </p:sp>
    </p:spTree>
    <p:extLst>
      <p:ext uri="{BB962C8B-B14F-4D97-AF65-F5344CB8AC3E}">
        <p14:creationId xmlns:p14="http://schemas.microsoft.com/office/powerpoint/2010/main" val="38846204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2D5D4A6-2EB2-DE4F-8918-8AA8AFFB4553}" type="datetimeFigureOut">
              <a:rPr lang="en-US" smtClean="0"/>
              <a:t>12/5/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A63D996-FED7-9B43-99FF-70BBD373510B}" type="slidenum">
              <a:rPr lang="en-US" smtClean="0"/>
              <a:t>‹#›</a:t>
            </a:fld>
            <a:endParaRPr lang="en-US"/>
          </a:p>
        </p:txBody>
      </p:sp>
    </p:spTree>
    <p:extLst>
      <p:ext uri="{BB962C8B-B14F-4D97-AF65-F5344CB8AC3E}">
        <p14:creationId xmlns:p14="http://schemas.microsoft.com/office/powerpoint/2010/main" val="23379578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2D5D4A6-2EB2-DE4F-8918-8AA8AFFB4553}" type="datetimeFigureOut">
              <a:rPr lang="en-US" smtClean="0"/>
              <a:t>12/5/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A63D996-FED7-9B43-99FF-70BBD373510B}" type="slidenum">
              <a:rPr lang="en-US" smtClean="0"/>
              <a:t>‹#›</a:t>
            </a:fld>
            <a:endParaRPr lang="en-US"/>
          </a:p>
        </p:txBody>
      </p:sp>
    </p:spTree>
    <p:extLst>
      <p:ext uri="{BB962C8B-B14F-4D97-AF65-F5344CB8AC3E}">
        <p14:creationId xmlns:p14="http://schemas.microsoft.com/office/powerpoint/2010/main" val="14746299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42D5D4A6-2EB2-DE4F-8918-8AA8AFFB4553}" type="datetimeFigureOut">
              <a:rPr lang="en-US" smtClean="0"/>
              <a:t>12/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A63D996-FED7-9B43-99FF-70BBD373510B}" type="slidenum">
              <a:rPr lang="en-US" smtClean="0"/>
              <a:t>‹#›</a:t>
            </a:fld>
            <a:endParaRPr lang="en-US"/>
          </a:p>
        </p:txBody>
      </p:sp>
    </p:spTree>
    <p:extLst>
      <p:ext uri="{BB962C8B-B14F-4D97-AF65-F5344CB8AC3E}">
        <p14:creationId xmlns:p14="http://schemas.microsoft.com/office/powerpoint/2010/main" val="32784103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42D5D4A6-2EB2-DE4F-8918-8AA8AFFB4553}" type="datetimeFigureOut">
              <a:rPr lang="en-US" smtClean="0"/>
              <a:t>12/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A63D996-FED7-9B43-99FF-70BBD373510B}" type="slidenum">
              <a:rPr lang="en-US" smtClean="0"/>
              <a:t>‹#›</a:t>
            </a:fld>
            <a:endParaRPr lang="en-US"/>
          </a:p>
        </p:txBody>
      </p:sp>
    </p:spTree>
    <p:extLst>
      <p:ext uri="{BB962C8B-B14F-4D97-AF65-F5344CB8AC3E}">
        <p14:creationId xmlns:p14="http://schemas.microsoft.com/office/powerpoint/2010/main" val="14005138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82000"/>
                  </a:schemeClr>
                </a:solidFill>
              </a:defRPr>
            </a:lvl1pPr>
          </a:lstStyle>
          <a:p>
            <a:fld id="{42D5D4A6-2EB2-DE4F-8918-8AA8AFFB4553}" type="datetimeFigureOut">
              <a:rPr lang="en-US" smtClean="0"/>
              <a:t>12/5/2024</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82000"/>
                  </a:schemeClr>
                </a:solidFill>
              </a:defRPr>
            </a:lvl1pPr>
          </a:lstStyle>
          <a:p>
            <a:fld id="{AA63D996-FED7-9B43-99FF-70BBD373510B}" type="slidenum">
              <a:rPr lang="en-US" smtClean="0"/>
              <a:t>‹#›</a:t>
            </a:fld>
            <a:endParaRPr lang="en-US"/>
          </a:p>
        </p:txBody>
      </p:sp>
    </p:spTree>
    <p:extLst>
      <p:ext uri="{BB962C8B-B14F-4D97-AF65-F5344CB8AC3E}">
        <p14:creationId xmlns:p14="http://schemas.microsoft.com/office/powerpoint/2010/main" val="617925702"/>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Relationship Id="rId2" Type="http://schemas.openxmlformats.org/officeDocument/2006/relationships/image" Target="../media/image1.emf"/><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image" Target="../media/image6.jp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11.jpg"/><Relationship Id="rId5" Type="http://schemas.openxmlformats.org/officeDocument/2006/relationships/image" Target="../media/image10.jpg"/><Relationship Id="rId4" Type="http://schemas.openxmlformats.org/officeDocument/2006/relationships/image" Target="../media/image9.tif"/></Relationships>
</file>

<file path=ppt/slides/_rels/slide5.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7.xml"/><Relationship Id="rId5" Type="http://schemas.openxmlformats.org/officeDocument/2006/relationships/image" Target="../media/image15.png"/><Relationship Id="rId4" Type="http://schemas.openxmlformats.org/officeDocument/2006/relationships/image" Target="../media/image14.png"/></Relationships>
</file>

<file path=ppt/slides/_rels/slide6.xml.rels><?xml version="1.0" encoding="UTF-8" standalone="yes"?>
<Relationships xmlns="http://schemas.openxmlformats.org/package/2006/relationships"><Relationship Id="rId8" Type="http://schemas.openxmlformats.org/officeDocument/2006/relationships/image" Target="../media/image21.png"/><Relationship Id="rId3" Type="http://schemas.openxmlformats.org/officeDocument/2006/relationships/image" Target="../media/image16.tiff"/><Relationship Id="rId7" Type="http://schemas.openxmlformats.org/officeDocument/2006/relationships/image" Target="../media/image20.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19.png"/><Relationship Id="rId5" Type="http://schemas.openxmlformats.org/officeDocument/2006/relationships/image" Target="../media/image18.png"/><Relationship Id="rId4" Type="http://schemas.openxmlformats.org/officeDocument/2006/relationships/image" Target="../media/image17.png"/></Relationships>
</file>

<file path=ppt/slides/_rels/slide7.xml.rels><?xml version="1.0" encoding="UTF-8" standalone="yes"?>
<Relationships xmlns="http://schemas.openxmlformats.org/package/2006/relationships"><Relationship Id="rId3" Type="http://schemas.openxmlformats.org/officeDocument/2006/relationships/image" Target="../media/image23.jpg"/><Relationship Id="rId2" Type="http://schemas.openxmlformats.org/officeDocument/2006/relationships/image" Target="../media/image22.jp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25.tif"/><Relationship Id="rId2" Type="http://schemas.openxmlformats.org/officeDocument/2006/relationships/image" Target="../media/image24.emf"/><Relationship Id="rId1" Type="http://schemas.openxmlformats.org/officeDocument/2006/relationships/slideLayout" Target="../slideLayouts/slideLayout7.xml"/><Relationship Id="rId4" Type="http://schemas.openxmlformats.org/officeDocument/2006/relationships/image" Target="../media/image26.t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D432024D-04A1-3E8C-770B-C35C3098A895}"/>
              </a:ext>
            </a:extLst>
          </p:cNvPr>
          <p:cNvSpPr txBox="1"/>
          <p:nvPr/>
        </p:nvSpPr>
        <p:spPr>
          <a:xfrm>
            <a:off x="457200" y="4183626"/>
            <a:ext cx="6858000" cy="2409699"/>
          </a:xfrm>
          <a:prstGeom prst="rect">
            <a:avLst/>
          </a:prstGeom>
          <a:noFill/>
        </p:spPr>
        <p:txBody>
          <a:bodyPr wrap="square" rtlCol="0">
            <a:spAutoFit/>
          </a:bodyPr>
          <a:lstStyle/>
          <a:p>
            <a:pPr algn="just">
              <a:lnSpc>
                <a:spcPct val="200000"/>
              </a:lnSpc>
            </a:pPr>
            <a:r>
              <a:rPr lang="en-US" sz="1100" b="1" kern="100" dirty="0">
                <a:latin typeface="Arial" panose="020B0604020202020204" pitchFamily="34" charset="0"/>
                <a:ea typeface="Aptos" panose="020B0004020202020204" pitchFamily="34" charset="0"/>
                <a:cs typeface="Arial" panose="020B0604020202020204" pitchFamily="34" charset="0"/>
              </a:rPr>
              <a:t>Supplemental Figure S1: Growth and ER expression in endocrine resistant cell lines. </a:t>
            </a:r>
            <a:r>
              <a:rPr lang="en-US" sz="1100" kern="100" dirty="0">
                <a:latin typeface="Arial" panose="020B0604020202020204" pitchFamily="34" charset="0"/>
                <a:ea typeface="Aptos" panose="020B0004020202020204" pitchFamily="34" charset="0"/>
                <a:cs typeface="Arial" panose="020B0604020202020204" pitchFamily="34" charset="0"/>
              </a:rPr>
              <a:t>a-b) Proliferation growth curves of parental and endocrine resistant T47D (a) and UCD4 (b) cells. Fold change (FC) from timepoint 0 was calculated using the IncuCyte platform. T47D and UCD4 cell lines were plated at 7500 and 15,000 cells/well, respectively, in sextuplicate, and images were captured every 4 h for 6 days. Statistical significance at the final timepoint was calculated using One-way ANOVA. ****P&lt;0.0001. c) JESS ProteinSimple analysis of ER (alpha) expression in T47D and UCD4 cells. Bands represent peak intensities normalized to total protein, as analyzed using JESS software.</a:t>
            </a:r>
          </a:p>
        </p:txBody>
      </p:sp>
      <p:pic>
        <p:nvPicPr>
          <p:cNvPr id="4" name="Picture 3">
            <a:extLst>
              <a:ext uri="{FF2B5EF4-FFF2-40B4-BE49-F238E27FC236}">
                <a16:creationId xmlns:a16="http://schemas.microsoft.com/office/drawing/2014/main" id="{42F86EB2-AE1D-A4E3-683A-A8AAB09A9211}"/>
              </a:ext>
            </a:extLst>
          </p:cNvPr>
          <p:cNvPicPr>
            <a:picLocks noChangeAspect="1"/>
          </p:cNvPicPr>
          <p:nvPr/>
        </p:nvPicPr>
        <p:blipFill>
          <a:blip r:embed="rId2"/>
          <a:srcRect/>
          <a:stretch/>
        </p:blipFill>
        <p:spPr>
          <a:xfrm>
            <a:off x="3766049" y="954396"/>
            <a:ext cx="2735179" cy="2011680"/>
          </a:xfrm>
          <a:prstGeom prst="rect">
            <a:avLst/>
          </a:prstGeom>
        </p:spPr>
      </p:pic>
      <p:sp>
        <p:nvSpPr>
          <p:cNvPr id="127" name="TextBox 126">
            <a:extLst>
              <a:ext uri="{FF2B5EF4-FFF2-40B4-BE49-F238E27FC236}">
                <a16:creationId xmlns:a16="http://schemas.microsoft.com/office/drawing/2014/main" id="{9F5E2020-C448-C76F-0132-A91D8B7C9881}"/>
              </a:ext>
            </a:extLst>
          </p:cNvPr>
          <p:cNvSpPr txBox="1"/>
          <p:nvPr/>
        </p:nvSpPr>
        <p:spPr>
          <a:xfrm>
            <a:off x="3557506" y="797540"/>
            <a:ext cx="325730"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
        <p:nvSpPr>
          <p:cNvPr id="128" name="TextBox 127">
            <a:extLst>
              <a:ext uri="{FF2B5EF4-FFF2-40B4-BE49-F238E27FC236}">
                <a16:creationId xmlns:a16="http://schemas.microsoft.com/office/drawing/2014/main" id="{FA550F3E-4DA8-4D69-F7A2-603665FCB6C9}"/>
              </a:ext>
            </a:extLst>
          </p:cNvPr>
          <p:cNvSpPr txBox="1"/>
          <p:nvPr/>
        </p:nvSpPr>
        <p:spPr>
          <a:xfrm>
            <a:off x="628785" y="2987725"/>
            <a:ext cx="312906"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c</a:t>
            </a:r>
          </a:p>
        </p:txBody>
      </p:sp>
      <p:pic>
        <p:nvPicPr>
          <p:cNvPr id="5" name="Picture 4" descr="A graph of cell lines&#10;&#10;Description automatically generated">
            <a:extLst>
              <a:ext uri="{FF2B5EF4-FFF2-40B4-BE49-F238E27FC236}">
                <a16:creationId xmlns:a16="http://schemas.microsoft.com/office/drawing/2014/main" id="{AEF17CF0-3F4B-6517-054F-88385C274C9E}"/>
              </a:ext>
            </a:extLst>
          </p:cNvPr>
          <p:cNvPicPr>
            <a:picLocks noChangeAspect="1"/>
          </p:cNvPicPr>
          <p:nvPr/>
        </p:nvPicPr>
        <p:blipFill>
          <a:blip r:embed="rId3"/>
          <a:stretch>
            <a:fillRect/>
          </a:stretch>
        </p:blipFill>
        <p:spPr>
          <a:xfrm>
            <a:off x="796764" y="958916"/>
            <a:ext cx="2740447" cy="2011680"/>
          </a:xfrm>
          <a:prstGeom prst="rect">
            <a:avLst/>
          </a:prstGeom>
        </p:spPr>
      </p:pic>
      <p:sp>
        <p:nvSpPr>
          <p:cNvPr id="126" name="TextBox 125">
            <a:extLst>
              <a:ext uri="{FF2B5EF4-FFF2-40B4-BE49-F238E27FC236}">
                <a16:creationId xmlns:a16="http://schemas.microsoft.com/office/drawing/2014/main" id="{67BA4D94-20CE-B069-20DA-F18B18BFA9D1}"/>
              </a:ext>
            </a:extLst>
          </p:cNvPr>
          <p:cNvSpPr txBox="1"/>
          <p:nvPr/>
        </p:nvSpPr>
        <p:spPr>
          <a:xfrm>
            <a:off x="599842" y="797540"/>
            <a:ext cx="312906"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pic>
        <p:nvPicPr>
          <p:cNvPr id="28" name="Picture 27" descr="A close up of a black background&#10;&#10;Description automatically generated with medium confidence">
            <a:extLst>
              <a:ext uri="{FF2B5EF4-FFF2-40B4-BE49-F238E27FC236}">
                <a16:creationId xmlns:a16="http://schemas.microsoft.com/office/drawing/2014/main" id="{DAA4B437-66B5-3583-B5FC-4DFDA8470316}"/>
              </a:ext>
            </a:extLst>
          </p:cNvPr>
          <p:cNvPicPr>
            <a:picLocks noChangeAspect="1"/>
          </p:cNvPicPr>
          <p:nvPr/>
        </p:nvPicPr>
        <p:blipFill>
          <a:blip r:embed="rId4"/>
          <a:stretch>
            <a:fillRect/>
          </a:stretch>
        </p:blipFill>
        <p:spPr>
          <a:xfrm>
            <a:off x="833758" y="3069671"/>
            <a:ext cx="4784078" cy="1005840"/>
          </a:xfrm>
          <a:prstGeom prst="rect">
            <a:avLst/>
          </a:prstGeom>
        </p:spPr>
      </p:pic>
    </p:spTree>
    <p:extLst>
      <p:ext uri="{BB962C8B-B14F-4D97-AF65-F5344CB8AC3E}">
        <p14:creationId xmlns:p14="http://schemas.microsoft.com/office/powerpoint/2010/main" val="291126107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 name="TextBox 26">
            <a:extLst>
              <a:ext uri="{FF2B5EF4-FFF2-40B4-BE49-F238E27FC236}">
                <a16:creationId xmlns:a16="http://schemas.microsoft.com/office/drawing/2014/main" id="{43BDFAA0-CBD9-C05F-4F54-AC80BA54F02E}"/>
              </a:ext>
            </a:extLst>
          </p:cNvPr>
          <p:cNvSpPr txBox="1"/>
          <p:nvPr/>
        </p:nvSpPr>
        <p:spPr>
          <a:xfrm>
            <a:off x="457200" y="7783427"/>
            <a:ext cx="6858000" cy="1882695"/>
          </a:xfrm>
          <a:prstGeom prst="rect">
            <a:avLst/>
          </a:prstGeom>
          <a:noFill/>
        </p:spPr>
        <p:txBody>
          <a:bodyPr wrap="square">
            <a:spAutoFit/>
          </a:bodyPr>
          <a:lstStyle/>
          <a:p>
            <a:pPr algn="just">
              <a:lnSpc>
                <a:spcPct val="200000"/>
              </a:lnSpc>
            </a:pPr>
            <a:r>
              <a:rPr lang="en-US" sz="1200" b="1" kern="100" dirty="0">
                <a:latin typeface="Times New Roman" panose="02020603050405020304" pitchFamily="18" charset="0"/>
                <a:ea typeface="Aptos" panose="020B0004020202020204" pitchFamily="34" charset="0"/>
                <a:cs typeface="Times New Roman" panose="02020603050405020304" pitchFamily="18" charset="0"/>
              </a:rPr>
              <a:t>Supplemental Figure S2: Full LION heatmaps of endocrine resistant breast cancer cells. </a:t>
            </a:r>
            <a:r>
              <a:rPr lang="en-US" sz="1200" kern="100" dirty="0">
                <a:latin typeface="Times New Roman" panose="02020603050405020304" pitchFamily="18" charset="0"/>
                <a:ea typeface="Aptos" panose="020B0004020202020204" pitchFamily="34" charset="0"/>
                <a:cs typeface="Times New Roman" panose="02020603050405020304" pitchFamily="18" charset="0"/>
              </a:rPr>
              <a:t>Full LION heatmaps and hierarchical clustering of lipidomics data from T47D (a) and UCD4 (b) parental and endocrine resistant cell lines. Lipid signatures are grouped into five clusters based on hierarchical clustering. Heatmap colors (yellow to red) represent mean z-scores. Names and IDs of the selected lipid terms are displayed on the right. </a:t>
            </a:r>
          </a:p>
        </p:txBody>
      </p:sp>
      <p:grpSp>
        <p:nvGrpSpPr>
          <p:cNvPr id="2" name="Group 1">
            <a:extLst>
              <a:ext uri="{FF2B5EF4-FFF2-40B4-BE49-F238E27FC236}">
                <a16:creationId xmlns:a16="http://schemas.microsoft.com/office/drawing/2014/main" id="{51BB1060-28C5-32AE-C1BF-6485A95FB2B5}"/>
              </a:ext>
            </a:extLst>
          </p:cNvPr>
          <p:cNvGrpSpPr/>
          <p:nvPr/>
        </p:nvGrpSpPr>
        <p:grpSpPr>
          <a:xfrm>
            <a:off x="616134" y="386418"/>
            <a:ext cx="5299102" cy="7416362"/>
            <a:chOff x="616134" y="386418"/>
            <a:chExt cx="5299102" cy="7416362"/>
          </a:xfrm>
        </p:grpSpPr>
        <p:sp>
          <p:nvSpPr>
            <p:cNvPr id="7" name="TextBox 6">
              <a:extLst>
                <a:ext uri="{FF2B5EF4-FFF2-40B4-BE49-F238E27FC236}">
                  <a16:creationId xmlns:a16="http://schemas.microsoft.com/office/drawing/2014/main" id="{224CA08F-BB98-330F-B08D-C2ACF5A18A1C}"/>
                </a:ext>
              </a:extLst>
            </p:cNvPr>
            <p:cNvSpPr txBox="1"/>
            <p:nvPr/>
          </p:nvSpPr>
          <p:spPr>
            <a:xfrm>
              <a:off x="616134" y="386418"/>
              <a:ext cx="26315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74556A17-B5BC-F802-EC0A-F407F5A157C3}"/>
                </a:ext>
              </a:extLst>
            </p:cNvPr>
            <p:cNvSpPr txBox="1"/>
            <p:nvPr/>
          </p:nvSpPr>
          <p:spPr>
            <a:xfrm>
              <a:off x="616134" y="3715302"/>
              <a:ext cx="263156"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b</a:t>
              </a:r>
            </a:p>
          </p:txBody>
        </p:sp>
        <p:sp>
          <p:nvSpPr>
            <p:cNvPr id="29" name="TextBox 28">
              <a:extLst>
                <a:ext uri="{FF2B5EF4-FFF2-40B4-BE49-F238E27FC236}">
                  <a16:creationId xmlns:a16="http://schemas.microsoft.com/office/drawing/2014/main" id="{C6D9A907-6519-9CA2-3CC1-2B0943FBF736}"/>
                </a:ext>
              </a:extLst>
            </p:cNvPr>
            <p:cNvSpPr txBox="1"/>
            <p:nvPr/>
          </p:nvSpPr>
          <p:spPr>
            <a:xfrm>
              <a:off x="1375446" y="3781946"/>
              <a:ext cx="466794" cy="230832"/>
            </a:xfrm>
            <a:prstGeom prst="rect">
              <a:avLst/>
            </a:prstGeom>
            <a:noFill/>
          </p:spPr>
          <p:txBody>
            <a:bodyPr wrap="none" rtlCol="0">
              <a:spAutoFit/>
            </a:bodyPr>
            <a:lstStyle/>
            <a:p>
              <a:pPr algn="r"/>
              <a:r>
                <a:rPr lang="en-US" sz="900" b="1" dirty="0">
                  <a:solidFill>
                    <a:schemeClr val="tx1">
                      <a:lumMod val="50000"/>
                      <a:lumOff val="50000"/>
                    </a:schemeClr>
                  </a:solidFill>
                  <a:latin typeface="Arial" panose="020B0604020202020204" pitchFamily="34" charset="0"/>
                  <a:cs typeface="Arial" panose="020B0604020202020204" pitchFamily="34" charset="0"/>
                </a:rPr>
                <a:t>T47D</a:t>
              </a:r>
              <a:endParaRPr lang="en-US" sz="700" b="1" dirty="0">
                <a:solidFill>
                  <a:schemeClr val="tx1">
                    <a:lumMod val="50000"/>
                    <a:lumOff val="50000"/>
                  </a:schemeClr>
                </a:solidFill>
                <a:latin typeface="Arial" panose="020B0604020202020204" pitchFamily="34" charset="0"/>
                <a:cs typeface="Arial" panose="020B0604020202020204" pitchFamily="34" charset="0"/>
              </a:endParaRPr>
            </a:p>
          </p:txBody>
        </p:sp>
        <p:sp>
          <p:nvSpPr>
            <p:cNvPr id="31" name="TextBox 30">
              <a:extLst>
                <a:ext uri="{FF2B5EF4-FFF2-40B4-BE49-F238E27FC236}">
                  <a16:creationId xmlns:a16="http://schemas.microsoft.com/office/drawing/2014/main" id="{5AC5FBAA-2889-1143-69DF-760E136EBFA3}"/>
                </a:ext>
              </a:extLst>
            </p:cNvPr>
            <p:cNvSpPr txBox="1"/>
            <p:nvPr/>
          </p:nvSpPr>
          <p:spPr>
            <a:xfrm>
              <a:off x="1985611" y="3781946"/>
              <a:ext cx="825867" cy="230832"/>
            </a:xfrm>
            <a:prstGeom prst="rect">
              <a:avLst/>
            </a:prstGeom>
            <a:noFill/>
          </p:spPr>
          <p:txBody>
            <a:bodyPr wrap="none" rtlCol="0">
              <a:spAutoFit/>
            </a:bodyPr>
            <a:lstStyle/>
            <a:p>
              <a:pPr algn="r"/>
              <a:r>
                <a:rPr lang="en-US" sz="900" b="1" dirty="0">
                  <a:solidFill>
                    <a:srgbClr val="C00000"/>
                  </a:solidFill>
                  <a:latin typeface="Arial" panose="020B0604020202020204" pitchFamily="34" charset="0"/>
                  <a:cs typeface="Arial" panose="020B0604020202020204" pitchFamily="34" charset="0"/>
                </a:rPr>
                <a:t>T47D-TamR</a:t>
              </a:r>
            </a:p>
          </p:txBody>
        </p:sp>
        <p:sp>
          <p:nvSpPr>
            <p:cNvPr id="32" name="TextBox 31">
              <a:extLst>
                <a:ext uri="{FF2B5EF4-FFF2-40B4-BE49-F238E27FC236}">
                  <a16:creationId xmlns:a16="http://schemas.microsoft.com/office/drawing/2014/main" id="{068F4F95-5CB3-C765-0E24-A3E26826A417}"/>
                </a:ext>
              </a:extLst>
            </p:cNvPr>
            <p:cNvSpPr txBox="1"/>
            <p:nvPr/>
          </p:nvSpPr>
          <p:spPr>
            <a:xfrm>
              <a:off x="2744863" y="3781946"/>
              <a:ext cx="825867" cy="230832"/>
            </a:xfrm>
            <a:prstGeom prst="rect">
              <a:avLst/>
            </a:prstGeom>
            <a:noFill/>
          </p:spPr>
          <p:txBody>
            <a:bodyPr wrap="none" rtlCol="0">
              <a:spAutoFit/>
            </a:bodyPr>
            <a:lstStyle/>
            <a:p>
              <a:pPr algn="r"/>
              <a:r>
                <a:rPr lang="en-US" sz="900" b="1" dirty="0">
                  <a:solidFill>
                    <a:schemeClr val="accent6">
                      <a:lumMod val="75000"/>
                    </a:schemeClr>
                  </a:solidFill>
                  <a:latin typeface="Arial" panose="020B0604020202020204" pitchFamily="34" charset="0"/>
                  <a:cs typeface="Arial" panose="020B0604020202020204" pitchFamily="34" charset="0"/>
                </a:rPr>
                <a:t>T47D-FulvR</a:t>
              </a:r>
            </a:p>
          </p:txBody>
        </p:sp>
        <p:grpSp>
          <p:nvGrpSpPr>
            <p:cNvPr id="37" name="Group 36">
              <a:extLst>
                <a:ext uri="{FF2B5EF4-FFF2-40B4-BE49-F238E27FC236}">
                  <a16:creationId xmlns:a16="http://schemas.microsoft.com/office/drawing/2014/main" id="{0270D7FB-203F-590D-17C7-D2E948000B21}"/>
                </a:ext>
              </a:extLst>
            </p:cNvPr>
            <p:cNvGrpSpPr/>
            <p:nvPr/>
          </p:nvGrpSpPr>
          <p:grpSpPr>
            <a:xfrm>
              <a:off x="978445" y="3962300"/>
              <a:ext cx="4073332" cy="3840480"/>
              <a:chOff x="978445" y="3962300"/>
              <a:chExt cx="4073332" cy="3840480"/>
            </a:xfrm>
          </p:grpSpPr>
          <p:pic>
            <p:nvPicPr>
              <p:cNvPr id="35" name="Picture 34" descr="A screenshot of a screen&#10;&#10;Description automatically generated">
                <a:extLst>
                  <a:ext uri="{FF2B5EF4-FFF2-40B4-BE49-F238E27FC236}">
                    <a16:creationId xmlns:a16="http://schemas.microsoft.com/office/drawing/2014/main" id="{2D5173A5-61EA-32B7-E5EE-FF050A55C02C}"/>
                  </a:ext>
                </a:extLst>
              </p:cNvPr>
              <p:cNvPicPr>
                <a:picLocks noChangeAspect="1"/>
              </p:cNvPicPr>
              <p:nvPr/>
            </p:nvPicPr>
            <p:blipFill rotWithShape="1">
              <a:blip r:embed="rId2"/>
              <a:srcRect l="34185" r="6825" b="7406"/>
              <a:stretch/>
            </p:blipFill>
            <p:spPr>
              <a:xfrm>
                <a:off x="1993384" y="3962300"/>
                <a:ext cx="3058393" cy="3840480"/>
              </a:xfrm>
              <a:prstGeom prst="rect">
                <a:avLst/>
              </a:prstGeom>
            </p:spPr>
          </p:pic>
          <p:pic>
            <p:nvPicPr>
              <p:cNvPr id="36" name="Picture 35" descr="A screenshot of a screen&#10;&#10;Description automatically generated">
                <a:extLst>
                  <a:ext uri="{FF2B5EF4-FFF2-40B4-BE49-F238E27FC236}">
                    <a16:creationId xmlns:a16="http://schemas.microsoft.com/office/drawing/2014/main" id="{5304953F-A5A3-2B1D-D4DB-B88091A6AFAD}"/>
                  </a:ext>
                </a:extLst>
              </p:cNvPr>
              <p:cNvPicPr>
                <a:picLocks noChangeAspect="1"/>
              </p:cNvPicPr>
              <p:nvPr/>
            </p:nvPicPr>
            <p:blipFill rotWithShape="1">
              <a:blip r:embed="rId2"/>
              <a:srcRect r="80375" b="7406"/>
              <a:stretch/>
            </p:blipFill>
            <p:spPr>
              <a:xfrm>
                <a:off x="978445" y="3962300"/>
                <a:ext cx="1017432" cy="3840480"/>
              </a:xfrm>
              <a:prstGeom prst="rect">
                <a:avLst/>
              </a:prstGeom>
            </p:spPr>
          </p:pic>
        </p:grpSp>
        <p:pic>
          <p:nvPicPr>
            <p:cNvPr id="38" name="Picture 37">
              <a:extLst>
                <a:ext uri="{FF2B5EF4-FFF2-40B4-BE49-F238E27FC236}">
                  <a16:creationId xmlns:a16="http://schemas.microsoft.com/office/drawing/2014/main" id="{44D79603-99F8-2467-99FB-1F923A2EDB85}"/>
                </a:ext>
              </a:extLst>
            </p:cNvPr>
            <p:cNvPicPr>
              <a:picLocks noChangeAspect="1"/>
            </p:cNvPicPr>
            <p:nvPr/>
          </p:nvPicPr>
          <p:blipFill rotWithShape="1">
            <a:blip r:embed="rId3"/>
            <a:srcRect r="7416" b="11206"/>
            <a:stretch/>
          </p:blipFill>
          <p:spPr>
            <a:xfrm>
              <a:off x="949630" y="637499"/>
              <a:ext cx="4965606" cy="3017520"/>
            </a:xfrm>
            <a:prstGeom prst="rect">
              <a:avLst/>
            </a:prstGeom>
          </p:spPr>
        </p:pic>
        <p:sp>
          <p:nvSpPr>
            <p:cNvPr id="40" name="TextBox 39">
              <a:extLst>
                <a:ext uri="{FF2B5EF4-FFF2-40B4-BE49-F238E27FC236}">
                  <a16:creationId xmlns:a16="http://schemas.microsoft.com/office/drawing/2014/main" id="{1FF6726A-ACD2-1443-55BA-F678DF0D246E}"/>
                </a:ext>
              </a:extLst>
            </p:cNvPr>
            <p:cNvSpPr txBox="1"/>
            <p:nvPr/>
          </p:nvSpPr>
          <p:spPr>
            <a:xfrm>
              <a:off x="1350526" y="451194"/>
              <a:ext cx="498856" cy="230832"/>
            </a:xfrm>
            <a:prstGeom prst="rect">
              <a:avLst/>
            </a:prstGeom>
            <a:noFill/>
          </p:spPr>
          <p:txBody>
            <a:bodyPr wrap="none" rtlCol="0">
              <a:spAutoFit/>
            </a:bodyPr>
            <a:lstStyle/>
            <a:p>
              <a:pPr algn="r"/>
              <a:r>
                <a:rPr lang="en-US" sz="900" b="1" dirty="0">
                  <a:solidFill>
                    <a:schemeClr val="tx1">
                      <a:lumMod val="50000"/>
                      <a:lumOff val="50000"/>
                    </a:schemeClr>
                  </a:solidFill>
                  <a:latin typeface="Arial" panose="020B0604020202020204" pitchFamily="34" charset="0"/>
                  <a:cs typeface="Arial" panose="020B0604020202020204" pitchFamily="34" charset="0"/>
                </a:rPr>
                <a:t>UCD4</a:t>
              </a:r>
            </a:p>
          </p:txBody>
        </p:sp>
        <p:sp>
          <p:nvSpPr>
            <p:cNvPr id="41" name="TextBox 40">
              <a:extLst>
                <a:ext uri="{FF2B5EF4-FFF2-40B4-BE49-F238E27FC236}">
                  <a16:creationId xmlns:a16="http://schemas.microsoft.com/office/drawing/2014/main" id="{3B52A14A-F452-0C16-7D76-998D9AD304B2}"/>
                </a:ext>
              </a:extLst>
            </p:cNvPr>
            <p:cNvSpPr txBox="1"/>
            <p:nvPr/>
          </p:nvSpPr>
          <p:spPr>
            <a:xfrm>
              <a:off x="1976711" y="451231"/>
              <a:ext cx="806631" cy="230832"/>
            </a:xfrm>
            <a:prstGeom prst="rect">
              <a:avLst/>
            </a:prstGeom>
            <a:noFill/>
          </p:spPr>
          <p:txBody>
            <a:bodyPr wrap="none" rtlCol="0">
              <a:spAutoFit/>
            </a:bodyPr>
            <a:lstStyle/>
            <a:p>
              <a:pPr algn="r"/>
              <a:r>
                <a:rPr lang="en-US" sz="900" b="1" dirty="0">
                  <a:solidFill>
                    <a:schemeClr val="accent1"/>
                  </a:solidFill>
                  <a:latin typeface="Arial" panose="020B0604020202020204" pitchFamily="34" charset="0"/>
                  <a:cs typeface="Arial" panose="020B0604020202020204" pitchFamily="34" charset="0"/>
                </a:rPr>
                <a:t>UCD4-EWD</a:t>
              </a:r>
            </a:p>
          </p:txBody>
        </p:sp>
        <p:sp>
          <p:nvSpPr>
            <p:cNvPr id="42" name="TextBox 41">
              <a:extLst>
                <a:ext uri="{FF2B5EF4-FFF2-40B4-BE49-F238E27FC236}">
                  <a16:creationId xmlns:a16="http://schemas.microsoft.com/office/drawing/2014/main" id="{4C337CAF-A1F0-76F2-37E5-93673032E867}"/>
                </a:ext>
              </a:extLst>
            </p:cNvPr>
            <p:cNvSpPr txBox="1"/>
            <p:nvPr/>
          </p:nvSpPr>
          <p:spPr>
            <a:xfrm>
              <a:off x="2729043" y="451194"/>
              <a:ext cx="857927" cy="230832"/>
            </a:xfrm>
            <a:prstGeom prst="rect">
              <a:avLst/>
            </a:prstGeom>
            <a:noFill/>
          </p:spPr>
          <p:txBody>
            <a:bodyPr wrap="none" rtlCol="0">
              <a:spAutoFit/>
            </a:bodyPr>
            <a:lstStyle/>
            <a:p>
              <a:pPr algn="r"/>
              <a:r>
                <a:rPr lang="en-US" sz="900" b="1" dirty="0">
                  <a:solidFill>
                    <a:srgbClr val="C00000"/>
                  </a:solidFill>
                  <a:latin typeface="Arial" panose="020B0604020202020204" pitchFamily="34" charset="0"/>
                  <a:cs typeface="Arial" panose="020B0604020202020204" pitchFamily="34" charset="0"/>
                </a:rPr>
                <a:t>UCD4-TamR</a:t>
              </a:r>
            </a:p>
          </p:txBody>
        </p:sp>
        <p:sp>
          <p:nvSpPr>
            <p:cNvPr id="43" name="TextBox 42">
              <a:extLst>
                <a:ext uri="{FF2B5EF4-FFF2-40B4-BE49-F238E27FC236}">
                  <a16:creationId xmlns:a16="http://schemas.microsoft.com/office/drawing/2014/main" id="{8F9A184C-DAF5-4B24-1115-844F74C4C745}"/>
                </a:ext>
              </a:extLst>
            </p:cNvPr>
            <p:cNvSpPr txBox="1"/>
            <p:nvPr/>
          </p:nvSpPr>
          <p:spPr>
            <a:xfrm>
              <a:off x="3486078" y="451194"/>
              <a:ext cx="857928" cy="230832"/>
            </a:xfrm>
            <a:prstGeom prst="rect">
              <a:avLst/>
            </a:prstGeom>
            <a:noFill/>
          </p:spPr>
          <p:txBody>
            <a:bodyPr wrap="none" rtlCol="0">
              <a:spAutoFit/>
            </a:bodyPr>
            <a:lstStyle/>
            <a:p>
              <a:pPr algn="r"/>
              <a:r>
                <a:rPr lang="en-US" sz="900" b="1" dirty="0">
                  <a:solidFill>
                    <a:schemeClr val="accent6">
                      <a:lumMod val="75000"/>
                    </a:schemeClr>
                  </a:solidFill>
                  <a:latin typeface="Arial" panose="020B0604020202020204" pitchFamily="34" charset="0"/>
                  <a:cs typeface="Arial" panose="020B0604020202020204" pitchFamily="34" charset="0"/>
                </a:rPr>
                <a:t>UCD4-FulvR</a:t>
              </a:r>
            </a:p>
          </p:txBody>
        </p:sp>
      </p:grpSp>
    </p:spTree>
    <p:extLst>
      <p:ext uri="{BB962C8B-B14F-4D97-AF65-F5344CB8AC3E}">
        <p14:creationId xmlns:p14="http://schemas.microsoft.com/office/powerpoint/2010/main" val="14490075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D238330A-B1B6-B7A8-742A-93E511BE79B3}"/>
              </a:ext>
            </a:extLst>
          </p:cNvPr>
          <p:cNvGrpSpPr/>
          <p:nvPr/>
        </p:nvGrpSpPr>
        <p:grpSpPr>
          <a:xfrm>
            <a:off x="479711" y="454662"/>
            <a:ext cx="6312976" cy="4285466"/>
            <a:chOff x="479711" y="454662"/>
            <a:chExt cx="6312976" cy="4285466"/>
          </a:xfrm>
        </p:grpSpPr>
        <p:pic>
          <p:nvPicPr>
            <p:cNvPr id="3" name="Picture 2" descr="A diagram of a number of different colored boxes&#10;&#10;Description automatically generated">
              <a:extLst>
                <a:ext uri="{FF2B5EF4-FFF2-40B4-BE49-F238E27FC236}">
                  <a16:creationId xmlns:a16="http://schemas.microsoft.com/office/drawing/2014/main" id="{FF6C6677-D6E3-8DD0-62A6-73A851FCA709}"/>
                </a:ext>
              </a:extLst>
            </p:cNvPr>
            <p:cNvPicPr>
              <a:picLocks noChangeAspect="1"/>
            </p:cNvPicPr>
            <p:nvPr/>
          </p:nvPicPr>
          <p:blipFill>
            <a:blip r:embed="rId2"/>
            <a:stretch>
              <a:fillRect/>
            </a:stretch>
          </p:blipFill>
          <p:spPr>
            <a:xfrm>
              <a:off x="794658" y="2435635"/>
              <a:ext cx="3722828" cy="2304493"/>
            </a:xfrm>
            <a:prstGeom prst="rect">
              <a:avLst/>
            </a:prstGeom>
          </p:spPr>
        </p:pic>
        <p:pic>
          <p:nvPicPr>
            <p:cNvPr id="5" name="Picture 4" descr="A close-up of a microscope&#10;&#10;Description automatically generated">
              <a:extLst>
                <a:ext uri="{FF2B5EF4-FFF2-40B4-BE49-F238E27FC236}">
                  <a16:creationId xmlns:a16="http://schemas.microsoft.com/office/drawing/2014/main" id="{74A01151-A188-59EF-A96E-0E846EEA21B5}"/>
                </a:ext>
              </a:extLst>
            </p:cNvPr>
            <p:cNvPicPr>
              <a:picLocks noChangeAspect="1"/>
            </p:cNvPicPr>
            <p:nvPr/>
          </p:nvPicPr>
          <p:blipFill>
            <a:blip r:embed="rId3"/>
            <a:stretch>
              <a:fillRect/>
            </a:stretch>
          </p:blipFill>
          <p:spPr>
            <a:xfrm>
              <a:off x="794658" y="689746"/>
              <a:ext cx="5998029" cy="1724433"/>
            </a:xfrm>
            <a:prstGeom prst="rect">
              <a:avLst/>
            </a:prstGeom>
          </p:spPr>
        </p:pic>
        <p:sp>
          <p:nvSpPr>
            <p:cNvPr id="6" name="TextBox 5">
              <a:extLst>
                <a:ext uri="{FF2B5EF4-FFF2-40B4-BE49-F238E27FC236}">
                  <a16:creationId xmlns:a16="http://schemas.microsoft.com/office/drawing/2014/main" id="{6D671AAA-A678-7C45-F2B8-254EC76AA53F}"/>
                </a:ext>
              </a:extLst>
            </p:cNvPr>
            <p:cNvSpPr txBox="1"/>
            <p:nvPr/>
          </p:nvSpPr>
          <p:spPr>
            <a:xfrm>
              <a:off x="479711" y="454662"/>
              <a:ext cx="327334" cy="400110"/>
            </a:xfrm>
            <a:prstGeom prst="rect">
              <a:avLst/>
            </a:prstGeom>
            <a:noFill/>
          </p:spPr>
          <p:txBody>
            <a:bodyPr wrap="none" rtlCol="0">
              <a:spAutoFit/>
            </a:bodyPr>
            <a:lstStyle/>
            <a:p>
              <a:r>
                <a:rPr lang="en-US" sz="2000" b="1" dirty="0">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F44609E8-820A-C17B-A227-9C63B450B2BE}"/>
                </a:ext>
              </a:extLst>
            </p:cNvPr>
            <p:cNvSpPr txBox="1"/>
            <p:nvPr/>
          </p:nvSpPr>
          <p:spPr>
            <a:xfrm>
              <a:off x="494138" y="2270609"/>
              <a:ext cx="341760" cy="400110"/>
            </a:xfrm>
            <a:prstGeom prst="rect">
              <a:avLst/>
            </a:prstGeom>
            <a:noFill/>
          </p:spPr>
          <p:txBody>
            <a:bodyPr wrap="none" rtlCol="0">
              <a:spAutoFit/>
            </a:bodyPr>
            <a:lstStyle/>
            <a:p>
              <a:r>
                <a:rPr lang="en-US" sz="2000" b="1" dirty="0">
                  <a:latin typeface="Arial" panose="020B0604020202020204" pitchFamily="34" charset="0"/>
                  <a:cs typeface="Arial" panose="020B0604020202020204" pitchFamily="34" charset="0"/>
                </a:rPr>
                <a:t>b</a:t>
              </a:r>
            </a:p>
          </p:txBody>
        </p:sp>
      </p:grpSp>
      <p:sp>
        <p:nvSpPr>
          <p:cNvPr id="9" name="TextBox 8">
            <a:extLst>
              <a:ext uri="{FF2B5EF4-FFF2-40B4-BE49-F238E27FC236}">
                <a16:creationId xmlns:a16="http://schemas.microsoft.com/office/drawing/2014/main" id="{9786C0DB-5669-D39D-4642-65D188F8D2E7}"/>
              </a:ext>
            </a:extLst>
          </p:cNvPr>
          <p:cNvSpPr txBox="1"/>
          <p:nvPr/>
        </p:nvSpPr>
        <p:spPr>
          <a:xfrm>
            <a:off x="452129" y="5000839"/>
            <a:ext cx="6835489" cy="2748253"/>
          </a:xfrm>
          <a:prstGeom prst="rect">
            <a:avLst/>
          </a:prstGeom>
          <a:noFill/>
        </p:spPr>
        <p:txBody>
          <a:bodyPr wrap="square" rtlCol="0">
            <a:spAutoFit/>
          </a:bodyPr>
          <a:lstStyle/>
          <a:p>
            <a:pPr algn="just">
              <a:lnSpc>
                <a:spcPct val="200000"/>
              </a:lnSpc>
            </a:pPr>
            <a:r>
              <a:rPr lang="en-US" sz="1100" b="1" dirty="0">
                <a:latin typeface="Arial" panose="020B0604020202020204" pitchFamily="34" charset="0"/>
                <a:cs typeface="Arial" panose="020B0604020202020204" pitchFamily="34" charset="0"/>
              </a:rPr>
              <a:t>Supplemental Figure S3.</a:t>
            </a:r>
            <a:r>
              <a:rPr lang="en-US" sz="1100" dirty="0">
                <a:latin typeface="Arial" panose="020B0604020202020204" pitchFamily="34" charset="0"/>
                <a:cs typeface="Arial" panose="020B0604020202020204" pitchFamily="34" charset="0"/>
              </a:rPr>
              <a:t> </a:t>
            </a:r>
            <a:r>
              <a:rPr lang="en-US" sz="1100" b="1" dirty="0">
                <a:latin typeface="Arial" panose="020B0604020202020204" pitchFamily="34" charset="0"/>
                <a:cs typeface="Arial" panose="020B0604020202020204" pitchFamily="34" charset="0"/>
              </a:rPr>
              <a:t>Lipid droplet accumulation in T47D cells with acute endocrine drug treatment</a:t>
            </a:r>
            <a:r>
              <a:rPr lang="en-US" sz="1100" dirty="0">
                <a:latin typeface="Arial" panose="020B0604020202020204" pitchFamily="34" charset="0"/>
                <a:cs typeface="Arial" panose="020B0604020202020204" pitchFamily="34" charset="0"/>
              </a:rPr>
              <a:t>. a) Oil Red O (ORO) staining of T47D-parental cells treated with vehicle (Par), 1 µM 4-OH-Tam, or 100 </a:t>
            </a:r>
            <a:r>
              <a:rPr lang="en-US" sz="1100" dirty="0" err="1">
                <a:latin typeface="Arial" panose="020B0604020202020204" pitchFamily="34" charset="0"/>
                <a:cs typeface="Arial" panose="020B0604020202020204" pitchFamily="34" charset="0"/>
              </a:rPr>
              <a:t>nM</a:t>
            </a:r>
            <a:r>
              <a:rPr lang="en-US" sz="1100" dirty="0">
                <a:latin typeface="Arial" panose="020B0604020202020204" pitchFamily="34" charset="0"/>
                <a:cs typeface="Arial" panose="020B0604020202020204" pitchFamily="34" charset="0"/>
              </a:rPr>
              <a:t> </a:t>
            </a:r>
            <a:r>
              <a:rPr lang="en-US" sz="1100" dirty="0" err="1">
                <a:latin typeface="Arial" panose="020B0604020202020204" pitchFamily="34" charset="0"/>
                <a:cs typeface="Arial" panose="020B0604020202020204" pitchFamily="34" charset="0"/>
              </a:rPr>
              <a:t>Fulv</a:t>
            </a:r>
            <a:r>
              <a:rPr lang="en-US" sz="1100" dirty="0">
                <a:latin typeface="Arial" panose="020B0604020202020204" pitchFamily="34" charset="0"/>
                <a:cs typeface="Arial" panose="020B0604020202020204" pitchFamily="34" charset="0"/>
              </a:rPr>
              <a:t> for 72 h, compared to </a:t>
            </a:r>
            <a:r>
              <a:rPr lang="en-US" sz="1100" dirty="0" err="1">
                <a:latin typeface="Arial" panose="020B0604020202020204" pitchFamily="34" charset="0"/>
                <a:cs typeface="Arial" panose="020B0604020202020204" pitchFamily="34" charset="0"/>
              </a:rPr>
              <a:t>TamR</a:t>
            </a:r>
            <a:r>
              <a:rPr lang="en-US" sz="1100" dirty="0">
                <a:latin typeface="Arial" panose="020B0604020202020204" pitchFamily="34" charset="0"/>
                <a:cs typeface="Arial" panose="020B0604020202020204" pitchFamily="34" charset="0"/>
              </a:rPr>
              <a:t> and </a:t>
            </a:r>
            <a:r>
              <a:rPr lang="en-US" sz="1100" dirty="0" err="1">
                <a:latin typeface="Arial" panose="020B0604020202020204" pitchFamily="34" charset="0"/>
                <a:cs typeface="Arial" panose="020B0604020202020204" pitchFamily="34" charset="0"/>
              </a:rPr>
              <a:t>FulvR</a:t>
            </a:r>
            <a:r>
              <a:rPr lang="en-US" sz="1100" dirty="0">
                <a:latin typeface="Arial" panose="020B0604020202020204" pitchFamily="34" charset="0"/>
                <a:cs typeface="Arial" panose="020B0604020202020204" pitchFamily="34" charset="0"/>
              </a:rPr>
              <a:t> cells. A total of 5 x 10</a:t>
            </a:r>
            <a:r>
              <a:rPr lang="en-US" sz="1100" baseline="30000" dirty="0">
                <a:latin typeface="Arial" panose="020B0604020202020204" pitchFamily="34" charset="0"/>
                <a:cs typeface="Arial" panose="020B0604020202020204" pitchFamily="34" charset="0"/>
              </a:rPr>
              <a:t>4</a:t>
            </a:r>
            <a:r>
              <a:rPr lang="en-US" sz="1100" dirty="0">
                <a:latin typeface="Arial" panose="020B0604020202020204" pitchFamily="34" charset="0"/>
                <a:cs typeface="Arial" panose="020B0604020202020204" pitchFamily="34" charset="0"/>
              </a:rPr>
              <a:t> cells per condition were plated on glass coverslips with the appropriate drug treatments. Cells were formalin fixed, stained with ORO and imaged by light microscopy. Scale bars, 50 </a:t>
            </a:r>
            <a:r>
              <a:rPr lang="el-GR" sz="1100" dirty="0">
                <a:latin typeface="Arial" panose="020B0604020202020204" pitchFamily="34" charset="0"/>
                <a:ea typeface="Calibri" panose="020F0502020204030204" pitchFamily="34" charset="0"/>
                <a:cs typeface="Arial" panose="020B0604020202020204" pitchFamily="34" charset="0"/>
              </a:rPr>
              <a:t>μ</a:t>
            </a:r>
            <a:r>
              <a:rPr lang="en-US" sz="1100" dirty="0">
                <a:latin typeface="Arial" panose="020B0604020202020204" pitchFamily="34" charset="0"/>
                <a:cs typeface="Arial" panose="020B0604020202020204" pitchFamily="34" charset="0"/>
              </a:rPr>
              <a:t>M. b) Quantification of ORO staining. Images were analyzed using ImageJ software (4 fields per condition) to calculate the ORO-positive area normalized to cell number. Fold change relative to T47D-Par is shown. Statistical comparisons were performed using one-way ANOVA to compare endocrine resistant to parental cells. *P&lt;0.05; **P&lt;0.01. </a:t>
            </a:r>
          </a:p>
        </p:txBody>
      </p:sp>
    </p:spTree>
    <p:extLst>
      <p:ext uri="{BB962C8B-B14F-4D97-AF65-F5344CB8AC3E}">
        <p14:creationId xmlns:p14="http://schemas.microsoft.com/office/powerpoint/2010/main" val="327451510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B36DEFA2-A3E6-02BF-FF86-379460FA3728}"/>
              </a:ext>
            </a:extLst>
          </p:cNvPr>
          <p:cNvSpPr txBox="1"/>
          <p:nvPr/>
        </p:nvSpPr>
        <p:spPr>
          <a:xfrm>
            <a:off x="523529" y="513908"/>
            <a:ext cx="312906"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49D23A22-6F87-D3F3-D1A1-DFD63C2D90B1}"/>
              </a:ext>
            </a:extLst>
          </p:cNvPr>
          <p:cNvSpPr txBox="1"/>
          <p:nvPr/>
        </p:nvSpPr>
        <p:spPr>
          <a:xfrm>
            <a:off x="523530" y="2809619"/>
            <a:ext cx="325730" cy="369332"/>
          </a:xfrm>
          <a:prstGeom prst="rect">
            <a:avLst/>
          </a:prstGeom>
          <a:noFill/>
        </p:spPr>
        <p:txBody>
          <a:bodyPr wrap="none" rtlCol="0">
            <a:spAutoFit/>
          </a:bodyPr>
          <a:lstStyle>
            <a:defPPr>
              <a:defRPr lang="en-US"/>
            </a:defPPr>
            <a:lvl1pPr>
              <a:defRPr sz="1200" b="1">
                <a:latin typeface="Arial" panose="020B0604020202020204" pitchFamily="34" charset="0"/>
                <a:cs typeface="Arial" panose="020B0604020202020204" pitchFamily="34" charset="0"/>
              </a:defRPr>
            </a:lvl1pPr>
          </a:lstStyle>
          <a:p>
            <a:r>
              <a:rPr lang="en-US" sz="1800" dirty="0"/>
              <a:t>b</a:t>
            </a:r>
          </a:p>
        </p:txBody>
      </p:sp>
      <p:sp>
        <p:nvSpPr>
          <p:cNvPr id="2" name="TextBox 1">
            <a:extLst>
              <a:ext uri="{FF2B5EF4-FFF2-40B4-BE49-F238E27FC236}">
                <a16:creationId xmlns:a16="http://schemas.microsoft.com/office/drawing/2014/main" id="{CA4BBAA9-3AE1-E375-30CE-E08F2A2A3BC8}"/>
              </a:ext>
            </a:extLst>
          </p:cNvPr>
          <p:cNvSpPr txBox="1"/>
          <p:nvPr/>
        </p:nvSpPr>
        <p:spPr>
          <a:xfrm>
            <a:off x="457200" y="4726970"/>
            <a:ext cx="6858000" cy="3425361"/>
          </a:xfrm>
          <a:prstGeom prst="rect">
            <a:avLst/>
          </a:prstGeom>
          <a:noFill/>
        </p:spPr>
        <p:txBody>
          <a:bodyPr wrap="square" rtlCol="0">
            <a:spAutoFit/>
          </a:bodyPr>
          <a:lstStyle/>
          <a:p>
            <a:pPr marL="0" marR="0" algn="just">
              <a:lnSpc>
                <a:spcPct val="200000"/>
              </a:lnSpc>
              <a:spcBef>
                <a:spcPts val="0"/>
              </a:spcBef>
              <a:spcAft>
                <a:spcPts val="0"/>
              </a:spcAft>
            </a:pPr>
            <a:r>
              <a:rPr lang="en-US" sz="1100" b="1" kern="100" dirty="0">
                <a:effectLst/>
                <a:latin typeface="Arial" panose="020B0604020202020204" pitchFamily="34" charset="0"/>
                <a:ea typeface="Aptos" panose="020B0004020202020204" pitchFamily="34" charset="0"/>
                <a:cs typeface="Arial" panose="020B0604020202020204" pitchFamily="34" charset="0"/>
              </a:rPr>
              <a:t>Supplemental Figure S4</a:t>
            </a:r>
            <a:r>
              <a:rPr lang="en-US" sz="1100" b="1" kern="100" dirty="0">
                <a:latin typeface="Arial" panose="020B0604020202020204" pitchFamily="34" charset="0"/>
                <a:ea typeface="Aptos" panose="020B0004020202020204" pitchFamily="34" charset="0"/>
                <a:cs typeface="Arial" panose="020B0604020202020204" pitchFamily="34" charset="0"/>
              </a:rPr>
              <a:t>.</a:t>
            </a:r>
            <a:r>
              <a:rPr lang="en-US" sz="1100" b="1" kern="100" dirty="0">
                <a:effectLst/>
                <a:latin typeface="Arial" panose="020B0604020202020204" pitchFamily="34" charset="0"/>
                <a:ea typeface="Aptos" panose="020B0004020202020204" pitchFamily="34" charset="0"/>
                <a:cs typeface="Arial" panose="020B0604020202020204" pitchFamily="34" charset="0"/>
              </a:rPr>
              <a:t> Fatty acid oxidation (FAO) </a:t>
            </a:r>
            <a:r>
              <a:rPr lang="en-US" sz="1100" b="1" kern="100" dirty="0">
                <a:latin typeface="Arial" panose="020B0604020202020204" pitchFamily="34" charset="0"/>
                <a:ea typeface="Aptos" panose="020B0004020202020204" pitchFamily="34" charset="0"/>
                <a:cs typeface="Arial" panose="020B0604020202020204" pitchFamily="34" charset="0"/>
              </a:rPr>
              <a:t>in endocrine resistant cells</a:t>
            </a:r>
            <a:r>
              <a:rPr lang="en-US" sz="1100" b="1" kern="100" dirty="0">
                <a:effectLst/>
                <a:latin typeface="Arial" panose="020B0604020202020204" pitchFamily="34" charset="0"/>
                <a:ea typeface="Aptos" panose="020B0004020202020204" pitchFamily="34" charset="0"/>
                <a:cs typeface="Arial" panose="020B0604020202020204" pitchFamily="34" charset="0"/>
              </a:rPr>
              <a:t>.</a:t>
            </a:r>
            <a:r>
              <a:rPr lang="en-US" sz="1100" b="1" kern="100" dirty="0">
                <a:latin typeface="Arial" panose="020B0604020202020204" pitchFamily="34" charset="0"/>
                <a:ea typeface="Aptos" panose="020B0004020202020204" pitchFamily="34" charset="0"/>
                <a:cs typeface="Arial" panose="020B0604020202020204" pitchFamily="34" charset="0"/>
              </a:rPr>
              <a:t> </a:t>
            </a:r>
            <a:r>
              <a:rPr lang="en-US" sz="1100" kern="100" dirty="0">
                <a:effectLst/>
                <a:latin typeface="Arial" panose="020B0604020202020204" pitchFamily="34" charset="0"/>
                <a:ea typeface="Aptos" panose="020B0004020202020204" pitchFamily="34" charset="0"/>
                <a:cs typeface="Arial" panose="020B0604020202020204" pitchFamily="34" charset="0"/>
              </a:rPr>
              <a:t>a-b) </a:t>
            </a:r>
            <a:r>
              <a:rPr lang="en-US" sz="1100" dirty="0">
                <a:latin typeface="Arial" panose="020B0604020202020204" pitchFamily="34" charset="0"/>
                <a:cs typeface="Arial" panose="020B0604020202020204" pitchFamily="34" charset="0"/>
              </a:rPr>
              <a:t>oxygen consumption rate (OCR) kinetic curves. </a:t>
            </a:r>
            <a:r>
              <a:rPr lang="en-US" sz="1100" kern="100" dirty="0">
                <a:effectLst/>
                <a:latin typeface="Arial" panose="020B0604020202020204" pitchFamily="34" charset="0"/>
                <a:ea typeface="Aptos" panose="020B0004020202020204" pitchFamily="34" charset="0"/>
                <a:cs typeface="Arial" panose="020B0604020202020204" pitchFamily="34" charset="0"/>
              </a:rPr>
              <a:t>7,500 T47D (a) and 15,000 UCD4 (b) parental and endocrine resistant cells were plated in XF96-well Seahorse Assay plates (n=6 each), nutrient deprived, and supplemented with BSA control or XF Palmitate-BSA conjugate 4 hours prior to performing the assay. Assays were standard XF Mito Stress Tests conducted in a 96XFe format. OCR was normalized to cell count obtained by Hoechst 33342 dye and Agilent </a:t>
            </a:r>
            <a:r>
              <a:rPr lang="en-US" sz="1100" kern="100" dirty="0" err="1">
                <a:effectLst/>
                <a:latin typeface="Arial" panose="020B0604020202020204" pitchFamily="34" charset="0"/>
                <a:ea typeface="Aptos" panose="020B0004020202020204" pitchFamily="34" charset="0"/>
                <a:cs typeface="Arial" panose="020B0604020202020204" pitchFamily="34" charset="0"/>
              </a:rPr>
              <a:t>Cytation</a:t>
            </a:r>
            <a:r>
              <a:rPr lang="en-US" sz="1100" kern="100" dirty="0">
                <a:effectLst/>
                <a:latin typeface="Arial" panose="020B0604020202020204" pitchFamily="34" charset="0"/>
                <a:ea typeface="Aptos" panose="020B0004020202020204" pitchFamily="34" charset="0"/>
                <a:cs typeface="Arial" panose="020B0604020202020204" pitchFamily="34" charset="0"/>
              </a:rPr>
              <a:t> instrument post-assay. Oligo = Oligomycin; FCCP =  Trifluoromethoxy </a:t>
            </a:r>
            <a:r>
              <a:rPr lang="en-US" sz="1100" kern="100" dirty="0" err="1">
                <a:effectLst/>
                <a:latin typeface="Arial" panose="020B0604020202020204" pitchFamily="34" charset="0"/>
                <a:ea typeface="Aptos" panose="020B0004020202020204" pitchFamily="34" charset="0"/>
                <a:cs typeface="Arial" panose="020B0604020202020204" pitchFamily="34" charset="0"/>
              </a:rPr>
              <a:t>carbonylcyanide</a:t>
            </a:r>
            <a:r>
              <a:rPr lang="en-US" sz="1100" kern="100" dirty="0">
                <a:effectLst/>
                <a:latin typeface="Arial" panose="020B0604020202020204" pitchFamily="34" charset="0"/>
                <a:ea typeface="Aptos" panose="020B0004020202020204" pitchFamily="34" charset="0"/>
                <a:cs typeface="Arial" panose="020B0604020202020204" pitchFamily="34" charset="0"/>
              </a:rPr>
              <a:t> phenylhydrazone; Rot/AA = Rotenone and Antimycin A. Error bars represent SEM. c-d) Relative FAO-specific OCR rates in T47D (c) and UCD4 (d) parental (Par) and endocrine resistant cells. FAO-OCR was determined by comparing palmitate versus BSA conditions minus non-mitochondrial respiration. One-way ANOVA compared to Par is shown. </a:t>
            </a:r>
            <a:r>
              <a:rPr lang="en-US" sz="1100" kern="100">
                <a:effectLst/>
                <a:latin typeface="Arial" panose="020B0604020202020204" pitchFamily="34" charset="0"/>
                <a:ea typeface="Aptos" panose="020B0004020202020204" pitchFamily="34" charset="0"/>
                <a:cs typeface="Arial" panose="020B0604020202020204" pitchFamily="34" charset="0"/>
              </a:rPr>
              <a:t>*P&lt;0.05, **P&lt;0.01, ***P&lt;0.001,</a:t>
            </a:r>
            <a:endParaRPr lang="en-US" sz="1100" kern="100" dirty="0">
              <a:effectLst/>
              <a:latin typeface="Arial" panose="020B0604020202020204" pitchFamily="34" charset="0"/>
              <a:ea typeface="Aptos" panose="020B0004020202020204" pitchFamily="34" charset="0"/>
              <a:cs typeface="Arial" panose="020B0604020202020204" pitchFamily="34" charset="0"/>
            </a:endParaRPr>
          </a:p>
        </p:txBody>
      </p:sp>
      <p:pic>
        <p:nvPicPr>
          <p:cNvPr id="5" name="Picture 4" descr="A graph showing the number of seahorse ay&#10;&#10;Description automatically generated">
            <a:extLst>
              <a:ext uri="{FF2B5EF4-FFF2-40B4-BE49-F238E27FC236}">
                <a16:creationId xmlns:a16="http://schemas.microsoft.com/office/drawing/2014/main" id="{28E76A09-6D5B-9406-5708-C79D38A5A2FD}"/>
              </a:ext>
            </a:extLst>
          </p:cNvPr>
          <p:cNvPicPr>
            <a:picLocks noChangeAspect="1"/>
          </p:cNvPicPr>
          <p:nvPr/>
        </p:nvPicPr>
        <p:blipFill>
          <a:blip r:embed="rId3"/>
          <a:stretch>
            <a:fillRect/>
          </a:stretch>
        </p:blipFill>
        <p:spPr>
          <a:xfrm>
            <a:off x="769676" y="650052"/>
            <a:ext cx="3857625" cy="1828800"/>
          </a:xfrm>
          <a:prstGeom prst="rect">
            <a:avLst/>
          </a:prstGeom>
        </p:spPr>
      </p:pic>
      <p:pic>
        <p:nvPicPr>
          <p:cNvPr id="9" name="Picture 8" descr="A graph of different colored lines&#10;&#10;Description automatically generated">
            <a:extLst>
              <a:ext uri="{FF2B5EF4-FFF2-40B4-BE49-F238E27FC236}">
                <a16:creationId xmlns:a16="http://schemas.microsoft.com/office/drawing/2014/main" id="{8275454B-B6C1-2AD6-D11F-E0501815A1B5}"/>
              </a:ext>
            </a:extLst>
          </p:cNvPr>
          <p:cNvPicPr>
            <a:picLocks noChangeAspect="1"/>
          </p:cNvPicPr>
          <p:nvPr/>
        </p:nvPicPr>
        <p:blipFill>
          <a:blip r:embed="rId4"/>
          <a:stretch>
            <a:fillRect/>
          </a:stretch>
        </p:blipFill>
        <p:spPr>
          <a:xfrm>
            <a:off x="769676" y="2809619"/>
            <a:ext cx="3792548" cy="1828800"/>
          </a:xfrm>
          <a:prstGeom prst="rect">
            <a:avLst/>
          </a:prstGeom>
        </p:spPr>
      </p:pic>
      <p:pic>
        <p:nvPicPr>
          <p:cNvPr id="12" name="Picture 11" descr="A graph of a number of different colored bars&#10;&#10;Description automatically generated with medium confidence">
            <a:extLst>
              <a:ext uri="{FF2B5EF4-FFF2-40B4-BE49-F238E27FC236}">
                <a16:creationId xmlns:a16="http://schemas.microsoft.com/office/drawing/2014/main" id="{438653F7-7AC0-3EF4-D632-C2F8CEF64004}"/>
              </a:ext>
            </a:extLst>
          </p:cNvPr>
          <p:cNvPicPr>
            <a:picLocks noChangeAspect="1"/>
          </p:cNvPicPr>
          <p:nvPr/>
        </p:nvPicPr>
        <p:blipFill>
          <a:blip r:embed="rId5"/>
          <a:stretch>
            <a:fillRect/>
          </a:stretch>
        </p:blipFill>
        <p:spPr>
          <a:xfrm>
            <a:off x="4794507" y="462702"/>
            <a:ext cx="2067194" cy="2103120"/>
          </a:xfrm>
          <a:prstGeom prst="rect">
            <a:avLst/>
          </a:prstGeom>
        </p:spPr>
      </p:pic>
      <p:pic>
        <p:nvPicPr>
          <p:cNvPr id="14" name="Picture 13" descr="A graph of different colored bars&#10;&#10;Description automatically generated with medium confidence">
            <a:extLst>
              <a:ext uri="{FF2B5EF4-FFF2-40B4-BE49-F238E27FC236}">
                <a16:creationId xmlns:a16="http://schemas.microsoft.com/office/drawing/2014/main" id="{CC3F2A87-1287-C1D1-3FF6-D9E701DCAA1A}"/>
              </a:ext>
            </a:extLst>
          </p:cNvPr>
          <p:cNvPicPr>
            <a:picLocks noChangeAspect="1"/>
          </p:cNvPicPr>
          <p:nvPr/>
        </p:nvPicPr>
        <p:blipFill>
          <a:blip r:embed="rId6"/>
          <a:stretch>
            <a:fillRect/>
          </a:stretch>
        </p:blipFill>
        <p:spPr>
          <a:xfrm>
            <a:off x="4745401" y="2623253"/>
            <a:ext cx="2450694" cy="2103120"/>
          </a:xfrm>
          <a:prstGeom prst="rect">
            <a:avLst/>
          </a:prstGeom>
        </p:spPr>
      </p:pic>
      <p:cxnSp>
        <p:nvCxnSpPr>
          <p:cNvPr id="16" name="Straight Connector 15">
            <a:extLst>
              <a:ext uri="{FF2B5EF4-FFF2-40B4-BE49-F238E27FC236}">
                <a16:creationId xmlns:a16="http://schemas.microsoft.com/office/drawing/2014/main" id="{AC0E06F9-C1D1-C7EB-2837-E7A051857867}"/>
              </a:ext>
            </a:extLst>
          </p:cNvPr>
          <p:cNvCxnSpPr/>
          <p:nvPr/>
        </p:nvCxnSpPr>
        <p:spPr>
          <a:xfrm flipV="1">
            <a:off x="769676" y="4289120"/>
            <a:ext cx="7446767" cy="46049"/>
          </a:xfrm>
          <a:prstGeom prst="line">
            <a:avLst/>
          </a:prstGeom>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97083948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C57E9503-4BC3-967E-3D28-93FEBFD6004D}"/>
              </a:ext>
            </a:extLst>
          </p:cNvPr>
          <p:cNvSpPr txBox="1"/>
          <p:nvPr/>
        </p:nvSpPr>
        <p:spPr>
          <a:xfrm>
            <a:off x="457200" y="5426964"/>
            <a:ext cx="6858000" cy="1394036"/>
          </a:xfrm>
          <a:prstGeom prst="rect">
            <a:avLst/>
          </a:prstGeom>
          <a:noFill/>
        </p:spPr>
        <p:txBody>
          <a:bodyPr wrap="square" rtlCol="0">
            <a:spAutoFit/>
          </a:bodyPr>
          <a:lstStyle/>
          <a:p>
            <a:pPr marL="0" marR="0" algn="just">
              <a:lnSpc>
                <a:spcPct val="200000"/>
              </a:lnSpc>
              <a:spcBef>
                <a:spcPts val="0"/>
              </a:spcBef>
              <a:spcAft>
                <a:spcPts val="0"/>
              </a:spcAft>
            </a:pPr>
            <a:r>
              <a:rPr lang="en-US" sz="1100" b="1" dirty="0">
                <a:latin typeface="Arial" panose="020B0604020202020204" pitchFamily="34" charset="0"/>
                <a:cs typeface="Arial" panose="020B0604020202020204" pitchFamily="34" charset="0"/>
              </a:rPr>
              <a:t>Supplemental Figure S5.</a:t>
            </a:r>
            <a:r>
              <a:rPr lang="en-US" sz="1100" dirty="0">
                <a:latin typeface="Arial" panose="020B0604020202020204" pitchFamily="34" charset="0"/>
                <a:cs typeface="Arial" panose="020B0604020202020204" pitchFamily="34" charset="0"/>
              </a:rPr>
              <a:t> </a:t>
            </a:r>
            <a:r>
              <a:rPr lang="en-US" sz="1100" b="1" dirty="0">
                <a:latin typeface="Arial" panose="020B0604020202020204" pitchFamily="34" charset="0"/>
                <a:cs typeface="Arial" panose="020B0604020202020204" pitchFamily="34" charset="0"/>
              </a:rPr>
              <a:t>Full immunoblots of FASN and ACC1 in endocrine resistant breast cancer cells. </a:t>
            </a:r>
            <a:r>
              <a:rPr lang="en-US" sz="1100" dirty="0">
                <a:latin typeface="Arial" panose="020B0604020202020204" pitchFamily="34" charset="0"/>
                <a:cs typeface="Arial" panose="020B0604020202020204" pitchFamily="34" charset="0"/>
              </a:rPr>
              <a:t>Full </a:t>
            </a:r>
            <a:r>
              <a:rPr lang="en-US" sz="1100" kern="100" dirty="0">
                <a:effectLst/>
                <a:latin typeface="Arial" panose="020B0604020202020204" pitchFamily="34" charset="0"/>
                <a:ea typeface="Aptos" panose="020B0004020202020204" pitchFamily="34" charset="0"/>
                <a:cs typeface="Arial" panose="020B0604020202020204" pitchFamily="34" charset="0"/>
              </a:rPr>
              <a:t>immunoblots for FASN and ACC1 protein levels in parental (Par) and endocrine resistant T47D and UCD4 cells, corresponding to the cropped blots shown in Figure 4a. </a:t>
            </a:r>
            <a:r>
              <a:rPr lang="el-GR" sz="1100" kern="100" dirty="0">
                <a:effectLst/>
                <a:latin typeface="Arial" panose="020B0604020202020204" pitchFamily="34" charset="0"/>
                <a:ea typeface="Aptos" panose="020B0004020202020204" pitchFamily="34" charset="0"/>
                <a:cs typeface="Arial" panose="020B0604020202020204" pitchFamily="34" charset="0"/>
              </a:rPr>
              <a:t>β-</a:t>
            </a:r>
            <a:r>
              <a:rPr lang="en-US" sz="1100" kern="100" dirty="0">
                <a:effectLst/>
                <a:latin typeface="Arial" panose="020B0604020202020204" pitchFamily="34" charset="0"/>
                <a:ea typeface="Aptos" panose="020B0004020202020204" pitchFamily="34" charset="0"/>
                <a:cs typeface="Arial" panose="020B0604020202020204" pitchFamily="34" charset="0"/>
              </a:rPr>
              <a:t>actin used as loading control (bottom). Note that some lanes were not included in this study.</a:t>
            </a:r>
          </a:p>
        </p:txBody>
      </p:sp>
      <p:grpSp>
        <p:nvGrpSpPr>
          <p:cNvPr id="7" name="Group 6">
            <a:extLst>
              <a:ext uri="{FF2B5EF4-FFF2-40B4-BE49-F238E27FC236}">
                <a16:creationId xmlns:a16="http://schemas.microsoft.com/office/drawing/2014/main" id="{CDE34103-489E-DAB9-E189-42E40E3E5DF4}"/>
              </a:ext>
            </a:extLst>
          </p:cNvPr>
          <p:cNvGrpSpPr/>
          <p:nvPr/>
        </p:nvGrpSpPr>
        <p:grpSpPr>
          <a:xfrm>
            <a:off x="687129" y="614652"/>
            <a:ext cx="6263782" cy="4559513"/>
            <a:chOff x="687129" y="614652"/>
            <a:chExt cx="6263782" cy="4559513"/>
          </a:xfrm>
        </p:grpSpPr>
        <p:pic>
          <p:nvPicPr>
            <p:cNvPr id="4" name="Picture 3" descr="A close-up of a test&#10;&#10;Description automatically generated">
              <a:extLst>
                <a:ext uri="{FF2B5EF4-FFF2-40B4-BE49-F238E27FC236}">
                  <a16:creationId xmlns:a16="http://schemas.microsoft.com/office/drawing/2014/main" id="{CAD615E4-C717-E420-5D66-84867A84C37D}"/>
                </a:ext>
              </a:extLst>
            </p:cNvPr>
            <p:cNvPicPr>
              <a:picLocks noChangeAspect="1"/>
            </p:cNvPicPr>
            <p:nvPr/>
          </p:nvPicPr>
          <p:blipFill rotWithShape="1">
            <a:blip r:embed="rId2"/>
            <a:srcRect l="818" t="7948" r="6573" b="4224"/>
            <a:stretch/>
          </p:blipFill>
          <p:spPr>
            <a:xfrm>
              <a:off x="778564" y="931097"/>
              <a:ext cx="2822713" cy="1985456"/>
            </a:xfrm>
            <a:prstGeom prst="rect">
              <a:avLst/>
            </a:prstGeom>
          </p:spPr>
        </p:pic>
        <p:pic>
          <p:nvPicPr>
            <p:cNvPr id="6" name="Picture 5" descr="A close-up of a test&#10;&#10;Description automatically generated">
              <a:extLst>
                <a:ext uri="{FF2B5EF4-FFF2-40B4-BE49-F238E27FC236}">
                  <a16:creationId xmlns:a16="http://schemas.microsoft.com/office/drawing/2014/main" id="{EBA1DBEA-7481-56AE-8B3F-1C09FC3B94CD}"/>
                </a:ext>
              </a:extLst>
            </p:cNvPr>
            <p:cNvPicPr>
              <a:picLocks noChangeAspect="1"/>
            </p:cNvPicPr>
            <p:nvPr/>
          </p:nvPicPr>
          <p:blipFill rotWithShape="1">
            <a:blip r:embed="rId3"/>
            <a:srcRect l="1" t="5258" r="7391" b="6913"/>
            <a:stretch/>
          </p:blipFill>
          <p:spPr>
            <a:xfrm>
              <a:off x="778564" y="3188708"/>
              <a:ext cx="2822713" cy="1985457"/>
            </a:xfrm>
            <a:prstGeom prst="rect">
              <a:avLst/>
            </a:prstGeom>
          </p:spPr>
        </p:pic>
        <p:pic>
          <p:nvPicPr>
            <p:cNvPr id="8" name="Picture 7" descr="A close-up of a test&#10;&#10;Description automatically generated">
              <a:extLst>
                <a:ext uri="{FF2B5EF4-FFF2-40B4-BE49-F238E27FC236}">
                  <a16:creationId xmlns:a16="http://schemas.microsoft.com/office/drawing/2014/main" id="{D2D97F2E-EB12-8CBA-F80A-F1898C551FD9}"/>
                </a:ext>
              </a:extLst>
            </p:cNvPr>
            <p:cNvPicPr>
              <a:picLocks noChangeAspect="1"/>
            </p:cNvPicPr>
            <p:nvPr/>
          </p:nvPicPr>
          <p:blipFill rotWithShape="1">
            <a:blip r:embed="rId4"/>
            <a:srcRect l="4188" t="12172" r="3204" b="4585"/>
            <a:stretch/>
          </p:blipFill>
          <p:spPr>
            <a:xfrm>
              <a:off x="3886200" y="931100"/>
              <a:ext cx="2978182" cy="1985456"/>
            </a:xfrm>
            <a:prstGeom prst="rect">
              <a:avLst/>
            </a:prstGeom>
          </p:spPr>
        </p:pic>
        <p:pic>
          <p:nvPicPr>
            <p:cNvPr id="10" name="Picture 9" descr="A black line on a white background&#10;&#10;Description automatically generated">
              <a:extLst>
                <a:ext uri="{FF2B5EF4-FFF2-40B4-BE49-F238E27FC236}">
                  <a16:creationId xmlns:a16="http://schemas.microsoft.com/office/drawing/2014/main" id="{A571F61C-E753-4739-5E33-915C8456B399}"/>
                </a:ext>
              </a:extLst>
            </p:cNvPr>
            <p:cNvPicPr>
              <a:picLocks noChangeAspect="1"/>
            </p:cNvPicPr>
            <p:nvPr/>
          </p:nvPicPr>
          <p:blipFill rotWithShape="1">
            <a:blip r:embed="rId5"/>
            <a:srcRect l="4130" t="11076" r="3261" b="5680"/>
            <a:stretch/>
          </p:blipFill>
          <p:spPr>
            <a:xfrm>
              <a:off x="3886200" y="3188710"/>
              <a:ext cx="2978180" cy="1985455"/>
            </a:xfrm>
            <a:prstGeom prst="rect">
              <a:avLst/>
            </a:prstGeom>
          </p:spPr>
        </p:pic>
        <p:sp>
          <p:nvSpPr>
            <p:cNvPr id="12" name="TextBox 11">
              <a:extLst>
                <a:ext uri="{FF2B5EF4-FFF2-40B4-BE49-F238E27FC236}">
                  <a16:creationId xmlns:a16="http://schemas.microsoft.com/office/drawing/2014/main" id="{54FBD016-4F1A-7041-CFF6-C79F4C19EF6A}"/>
                </a:ext>
              </a:extLst>
            </p:cNvPr>
            <p:cNvSpPr txBox="1"/>
            <p:nvPr/>
          </p:nvSpPr>
          <p:spPr>
            <a:xfrm>
              <a:off x="3157168" y="1197864"/>
              <a:ext cx="562975" cy="261610"/>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FASN</a:t>
              </a:r>
            </a:p>
          </p:txBody>
        </p:sp>
        <p:sp>
          <p:nvSpPr>
            <p:cNvPr id="13" name="TextBox 12">
              <a:extLst>
                <a:ext uri="{FF2B5EF4-FFF2-40B4-BE49-F238E27FC236}">
                  <a16:creationId xmlns:a16="http://schemas.microsoft.com/office/drawing/2014/main" id="{C9877368-A593-E105-A81F-C102903D8C97}"/>
                </a:ext>
              </a:extLst>
            </p:cNvPr>
            <p:cNvSpPr txBox="1"/>
            <p:nvPr/>
          </p:nvSpPr>
          <p:spPr>
            <a:xfrm>
              <a:off x="6301405" y="1145515"/>
              <a:ext cx="553357" cy="253916"/>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ACC1</a:t>
              </a:r>
            </a:p>
          </p:txBody>
        </p:sp>
        <p:sp>
          <p:nvSpPr>
            <p:cNvPr id="14" name="TextBox 13">
              <a:extLst>
                <a:ext uri="{FF2B5EF4-FFF2-40B4-BE49-F238E27FC236}">
                  <a16:creationId xmlns:a16="http://schemas.microsoft.com/office/drawing/2014/main" id="{EAB61C68-95DB-C54D-3C6A-6F85BAB294B6}"/>
                </a:ext>
              </a:extLst>
            </p:cNvPr>
            <p:cNvSpPr txBox="1"/>
            <p:nvPr/>
          </p:nvSpPr>
          <p:spPr>
            <a:xfrm>
              <a:off x="3181181" y="4076767"/>
              <a:ext cx="625492" cy="253916"/>
            </a:xfrm>
            <a:prstGeom prst="rect">
              <a:avLst/>
            </a:prstGeom>
            <a:noFill/>
          </p:spPr>
          <p:txBody>
            <a:bodyPr wrap="none" rtlCol="0">
              <a:spAutoFit/>
            </a:bodyPr>
            <a:lstStyle/>
            <a:p>
              <a:r>
                <a:rPr lang="el-GR" sz="1050" b="1" dirty="0">
                  <a:latin typeface="Arial" panose="020B0604020202020204" pitchFamily="34" charset="0"/>
                  <a:cs typeface="Arial" panose="020B0604020202020204" pitchFamily="34" charset="0"/>
                </a:rPr>
                <a:t>β</a:t>
              </a:r>
              <a:r>
                <a:rPr lang="en-US" sz="1050" b="1" dirty="0">
                  <a:latin typeface="Arial" panose="020B0604020202020204" pitchFamily="34" charset="0"/>
                  <a:cs typeface="Arial" panose="020B0604020202020204" pitchFamily="34" charset="0"/>
                </a:rPr>
                <a:t>-actin</a:t>
              </a:r>
            </a:p>
          </p:txBody>
        </p:sp>
        <p:sp>
          <p:nvSpPr>
            <p:cNvPr id="15" name="TextBox 14">
              <a:extLst>
                <a:ext uri="{FF2B5EF4-FFF2-40B4-BE49-F238E27FC236}">
                  <a16:creationId xmlns:a16="http://schemas.microsoft.com/office/drawing/2014/main" id="{43FE32CE-4338-FE41-4809-33BF867EA2CF}"/>
                </a:ext>
              </a:extLst>
            </p:cNvPr>
            <p:cNvSpPr txBox="1"/>
            <p:nvPr/>
          </p:nvSpPr>
          <p:spPr>
            <a:xfrm>
              <a:off x="6325419" y="4024418"/>
              <a:ext cx="625492" cy="253916"/>
            </a:xfrm>
            <a:prstGeom prst="rect">
              <a:avLst/>
            </a:prstGeom>
            <a:noFill/>
          </p:spPr>
          <p:txBody>
            <a:bodyPr wrap="none" rtlCol="0">
              <a:spAutoFit/>
            </a:bodyPr>
            <a:lstStyle/>
            <a:p>
              <a:r>
                <a:rPr lang="el-GR" sz="1050" b="1" dirty="0">
                  <a:latin typeface="Arial" panose="020B0604020202020204" pitchFamily="34" charset="0"/>
                  <a:cs typeface="Arial" panose="020B0604020202020204" pitchFamily="34" charset="0"/>
                </a:rPr>
                <a:t>β</a:t>
              </a:r>
              <a:r>
                <a:rPr lang="en-US" sz="1050" b="1" dirty="0">
                  <a:latin typeface="Arial" panose="020B0604020202020204" pitchFamily="34" charset="0"/>
                  <a:cs typeface="Arial" panose="020B0604020202020204" pitchFamily="34" charset="0"/>
                </a:rPr>
                <a:t>-actin</a:t>
              </a:r>
            </a:p>
          </p:txBody>
        </p:sp>
        <p:sp>
          <p:nvSpPr>
            <p:cNvPr id="16" name="TextBox 15">
              <a:extLst>
                <a:ext uri="{FF2B5EF4-FFF2-40B4-BE49-F238E27FC236}">
                  <a16:creationId xmlns:a16="http://schemas.microsoft.com/office/drawing/2014/main" id="{7A1440FE-8759-4F60-7AD6-7B725A08F69D}"/>
                </a:ext>
              </a:extLst>
            </p:cNvPr>
            <p:cNvSpPr txBox="1"/>
            <p:nvPr/>
          </p:nvSpPr>
          <p:spPr>
            <a:xfrm>
              <a:off x="687129" y="702242"/>
              <a:ext cx="5677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m090</a:t>
              </a:r>
            </a:p>
          </p:txBody>
        </p:sp>
        <p:sp>
          <p:nvSpPr>
            <p:cNvPr id="17" name="TextBox 16">
              <a:extLst>
                <a:ext uri="{FF2B5EF4-FFF2-40B4-BE49-F238E27FC236}">
                  <a16:creationId xmlns:a16="http://schemas.microsoft.com/office/drawing/2014/main" id="{6F1D3D44-CCB1-87A2-1542-69891729A47A}"/>
                </a:ext>
              </a:extLst>
            </p:cNvPr>
            <p:cNvSpPr txBox="1"/>
            <p:nvPr/>
          </p:nvSpPr>
          <p:spPr>
            <a:xfrm>
              <a:off x="3796945" y="701734"/>
              <a:ext cx="5677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m091</a:t>
              </a:r>
            </a:p>
          </p:txBody>
        </p:sp>
        <p:sp>
          <p:nvSpPr>
            <p:cNvPr id="18" name="TextBox 17">
              <a:extLst>
                <a:ext uri="{FF2B5EF4-FFF2-40B4-BE49-F238E27FC236}">
                  <a16:creationId xmlns:a16="http://schemas.microsoft.com/office/drawing/2014/main" id="{C517B2DC-4B53-73B8-C096-69DEB71F1CA5}"/>
                </a:ext>
              </a:extLst>
            </p:cNvPr>
            <p:cNvSpPr txBox="1"/>
            <p:nvPr/>
          </p:nvSpPr>
          <p:spPr>
            <a:xfrm>
              <a:off x="687129" y="2970334"/>
              <a:ext cx="5677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m090</a:t>
              </a:r>
            </a:p>
          </p:txBody>
        </p:sp>
        <p:sp>
          <p:nvSpPr>
            <p:cNvPr id="19" name="TextBox 18">
              <a:extLst>
                <a:ext uri="{FF2B5EF4-FFF2-40B4-BE49-F238E27FC236}">
                  <a16:creationId xmlns:a16="http://schemas.microsoft.com/office/drawing/2014/main" id="{62F2CECE-2BB8-0483-4622-B6611ABA2ECD}"/>
                </a:ext>
              </a:extLst>
            </p:cNvPr>
            <p:cNvSpPr txBox="1"/>
            <p:nvPr/>
          </p:nvSpPr>
          <p:spPr>
            <a:xfrm>
              <a:off x="3796945" y="2969826"/>
              <a:ext cx="5677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m091</a:t>
              </a:r>
            </a:p>
          </p:txBody>
        </p:sp>
        <p:sp>
          <p:nvSpPr>
            <p:cNvPr id="20" name="TextBox 19">
              <a:extLst>
                <a:ext uri="{FF2B5EF4-FFF2-40B4-BE49-F238E27FC236}">
                  <a16:creationId xmlns:a16="http://schemas.microsoft.com/office/drawing/2014/main" id="{595FF878-81A5-DFF5-D988-65700A5F8A33}"/>
                </a:ext>
              </a:extLst>
            </p:cNvPr>
            <p:cNvSpPr txBox="1"/>
            <p:nvPr/>
          </p:nvSpPr>
          <p:spPr>
            <a:xfrm>
              <a:off x="1463913" y="680910"/>
              <a:ext cx="534121"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UCD4</a:t>
              </a:r>
            </a:p>
          </p:txBody>
        </p:sp>
        <p:sp>
          <p:nvSpPr>
            <p:cNvPr id="21" name="TextBox 20">
              <a:extLst>
                <a:ext uri="{FF2B5EF4-FFF2-40B4-BE49-F238E27FC236}">
                  <a16:creationId xmlns:a16="http://schemas.microsoft.com/office/drawing/2014/main" id="{66023367-BA8A-936A-3BE6-D086E738DD8C}"/>
                </a:ext>
              </a:extLst>
            </p:cNvPr>
            <p:cNvSpPr txBox="1"/>
            <p:nvPr/>
          </p:nvSpPr>
          <p:spPr>
            <a:xfrm rot="16200000">
              <a:off x="1332695" y="1004502"/>
              <a:ext cx="453970"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EWD</a:t>
              </a:r>
            </a:p>
          </p:txBody>
        </p:sp>
        <p:sp>
          <p:nvSpPr>
            <p:cNvPr id="22" name="TextBox 21">
              <a:extLst>
                <a:ext uri="{FF2B5EF4-FFF2-40B4-BE49-F238E27FC236}">
                  <a16:creationId xmlns:a16="http://schemas.microsoft.com/office/drawing/2014/main" id="{EA1297BE-002A-6BDF-E291-AC73984CC502}"/>
                </a:ext>
              </a:extLst>
            </p:cNvPr>
            <p:cNvSpPr txBox="1"/>
            <p:nvPr/>
          </p:nvSpPr>
          <p:spPr>
            <a:xfrm rot="16200000">
              <a:off x="1553324" y="982059"/>
              <a:ext cx="498855" cy="230832"/>
            </a:xfrm>
            <a:prstGeom prst="rect">
              <a:avLst/>
            </a:prstGeom>
            <a:noFill/>
          </p:spPr>
          <p:txBody>
            <a:bodyPr wrap="none" rtlCol="0">
              <a:spAutoFit/>
            </a:bodyPr>
            <a:lstStyle/>
            <a:p>
              <a:r>
                <a:rPr lang="en-US" sz="900" dirty="0" err="1">
                  <a:latin typeface="Arial" panose="020B0604020202020204" pitchFamily="34" charset="0"/>
                  <a:cs typeface="Arial" panose="020B0604020202020204" pitchFamily="34" charset="0"/>
                </a:rPr>
                <a:t>TamR</a:t>
              </a:r>
              <a:endParaRPr lang="en-US" sz="900" dirty="0">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2BCB7DAB-80B9-6043-8E4E-668A2D4704D0}"/>
                </a:ext>
              </a:extLst>
            </p:cNvPr>
            <p:cNvSpPr txBox="1"/>
            <p:nvPr/>
          </p:nvSpPr>
          <p:spPr>
            <a:xfrm rot="16200000">
              <a:off x="1804977" y="988472"/>
              <a:ext cx="486030" cy="230832"/>
            </a:xfrm>
            <a:prstGeom prst="rect">
              <a:avLst/>
            </a:prstGeom>
            <a:noFill/>
          </p:spPr>
          <p:txBody>
            <a:bodyPr wrap="none" rtlCol="0">
              <a:spAutoFit/>
            </a:bodyPr>
            <a:lstStyle/>
            <a:p>
              <a:r>
                <a:rPr lang="en-US" sz="900" dirty="0" err="1">
                  <a:latin typeface="Arial" panose="020B0604020202020204" pitchFamily="34" charset="0"/>
                  <a:cs typeface="Arial" panose="020B0604020202020204" pitchFamily="34" charset="0"/>
                </a:rPr>
                <a:t>FulvR</a:t>
              </a:r>
              <a:endParaRPr lang="en-US" sz="900" dirty="0">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EB347F67-E92E-A4EA-E8C7-2092F03A0B8D}"/>
                </a:ext>
              </a:extLst>
            </p:cNvPr>
            <p:cNvSpPr txBox="1"/>
            <p:nvPr/>
          </p:nvSpPr>
          <p:spPr>
            <a:xfrm>
              <a:off x="2376740" y="680909"/>
              <a:ext cx="49725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T47D</a:t>
              </a:r>
            </a:p>
          </p:txBody>
        </p:sp>
        <p:sp>
          <p:nvSpPr>
            <p:cNvPr id="26" name="TextBox 25">
              <a:extLst>
                <a:ext uri="{FF2B5EF4-FFF2-40B4-BE49-F238E27FC236}">
                  <a16:creationId xmlns:a16="http://schemas.microsoft.com/office/drawing/2014/main" id="{2DF7CC4F-ACBF-DC94-7E7C-170990015C1E}"/>
                </a:ext>
              </a:extLst>
            </p:cNvPr>
            <p:cNvSpPr txBox="1"/>
            <p:nvPr/>
          </p:nvSpPr>
          <p:spPr>
            <a:xfrm rot="16200000">
              <a:off x="2524480" y="982059"/>
              <a:ext cx="498855" cy="230832"/>
            </a:xfrm>
            <a:prstGeom prst="rect">
              <a:avLst/>
            </a:prstGeom>
            <a:noFill/>
          </p:spPr>
          <p:txBody>
            <a:bodyPr wrap="none" rtlCol="0">
              <a:spAutoFit/>
            </a:bodyPr>
            <a:lstStyle/>
            <a:p>
              <a:r>
                <a:rPr lang="en-US" sz="900" dirty="0" err="1">
                  <a:latin typeface="Arial" panose="020B0604020202020204" pitchFamily="34" charset="0"/>
                  <a:cs typeface="Arial" panose="020B0604020202020204" pitchFamily="34" charset="0"/>
                </a:rPr>
                <a:t>TamR</a:t>
              </a:r>
              <a:endParaRPr lang="en-US" sz="900" dirty="0">
                <a:latin typeface="Arial" panose="020B0604020202020204" pitchFamily="34" charset="0"/>
                <a:cs typeface="Arial" panose="020B0604020202020204" pitchFamily="34" charset="0"/>
              </a:endParaRPr>
            </a:p>
          </p:txBody>
        </p:sp>
        <p:sp>
          <p:nvSpPr>
            <p:cNvPr id="27" name="TextBox 26">
              <a:extLst>
                <a:ext uri="{FF2B5EF4-FFF2-40B4-BE49-F238E27FC236}">
                  <a16:creationId xmlns:a16="http://schemas.microsoft.com/office/drawing/2014/main" id="{D1D215C7-2D49-90BF-BE60-D38DE33BFB56}"/>
                </a:ext>
              </a:extLst>
            </p:cNvPr>
            <p:cNvSpPr txBox="1"/>
            <p:nvPr/>
          </p:nvSpPr>
          <p:spPr>
            <a:xfrm rot="16200000">
              <a:off x="2794850" y="988472"/>
              <a:ext cx="486030" cy="230832"/>
            </a:xfrm>
            <a:prstGeom prst="rect">
              <a:avLst/>
            </a:prstGeom>
            <a:noFill/>
          </p:spPr>
          <p:txBody>
            <a:bodyPr wrap="none" rtlCol="0">
              <a:spAutoFit/>
            </a:bodyPr>
            <a:lstStyle/>
            <a:p>
              <a:r>
                <a:rPr lang="en-US" sz="900" dirty="0" err="1">
                  <a:latin typeface="Arial" panose="020B0604020202020204" pitchFamily="34" charset="0"/>
                  <a:cs typeface="Arial" panose="020B0604020202020204" pitchFamily="34" charset="0"/>
                </a:rPr>
                <a:t>FulvR</a:t>
              </a:r>
              <a:endParaRPr lang="en-US" sz="900" dirty="0">
                <a:latin typeface="Arial" panose="020B0604020202020204" pitchFamily="34" charset="0"/>
                <a:cs typeface="Arial" panose="020B0604020202020204" pitchFamily="34" charset="0"/>
              </a:endParaRPr>
            </a:p>
          </p:txBody>
        </p:sp>
        <p:sp>
          <p:nvSpPr>
            <p:cNvPr id="2" name="TextBox 1">
              <a:extLst>
                <a:ext uri="{FF2B5EF4-FFF2-40B4-BE49-F238E27FC236}">
                  <a16:creationId xmlns:a16="http://schemas.microsoft.com/office/drawing/2014/main" id="{6E90A044-560E-5E3B-A01D-399941935A54}"/>
                </a:ext>
              </a:extLst>
            </p:cNvPr>
            <p:cNvSpPr txBox="1"/>
            <p:nvPr/>
          </p:nvSpPr>
          <p:spPr>
            <a:xfrm rot="16200000">
              <a:off x="1134562" y="1032073"/>
              <a:ext cx="38343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Par</a:t>
              </a:r>
            </a:p>
          </p:txBody>
        </p:sp>
        <p:sp>
          <p:nvSpPr>
            <p:cNvPr id="5" name="TextBox 4">
              <a:extLst>
                <a:ext uri="{FF2B5EF4-FFF2-40B4-BE49-F238E27FC236}">
                  <a16:creationId xmlns:a16="http://schemas.microsoft.com/office/drawing/2014/main" id="{0B17ACC6-604A-9FE7-9AAE-CBC3BEA13684}"/>
                </a:ext>
              </a:extLst>
            </p:cNvPr>
            <p:cNvSpPr txBox="1"/>
            <p:nvPr/>
          </p:nvSpPr>
          <p:spPr>
            <a:xfrm rot="16200000">
              <a:off x="2084227" y="1032073"/>
              <a:ext cx="38343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Par</a:t>
              </a:r>
            </a:p>
          </p:txBody>
        </p:sp>
        <p:cxnSp>
          <p:nvCxnSpPr>
            <p:cNvPr id="9" name="Straight Connector 8">
              <a:extLst>
                <a:ext uri="{FF2B5EF4-FFF2-40B4-BE49-F238E27FC236}">
                  <a16:creationId xmlns:a16="http://schemas.microsoft.com/office/drawing/2014/main" id="{136D50CC-63A6-590E-3FCF-594A7F0E86A2}"/>
                </a:ext>
              </a:extLst>
            </p:cNvPr>
            <p:cNvCxnSpPr>
              <a:cxnSpLocks/>
            </p:cNvCxnSpPr>
            <p:nvPr/>
          </p:nvCxnSpPr>
          <p:spPr>
            <a:xfrm>
              <a:off x="1299034" y="888874"/>
              <a:ext cx="793079"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6" name="Straight Connector 35">
              <a:extLst>
                <a:ext uri="{FF2B5EF4-FFF2-40B4-BE49-F238E27FC236}">
                  <a16:creationId xmlns:a16="http://schemas.microsoft.com/office/drawing/2014/main" id="{4264B5C5-9883-C307-21CB-1C26FC69FC57}"/>
                </a:ext>
              </a:extLst>
            </p:cNvPr>
            <p:cNvCxnSpPr>
              <a:cxnSpLocks/>
            </p:cNvCxnSpPr>
            <p:nvPr/>
          </p:nvCxnSpPr>
          <p:spPr>
            <a:xfrm>
              <a:off x="2244786" y="887411"/>
              <a:ext cx="793079"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37" name="TextBox 36">
              <a:extLst>
                <a:ext uri="{FF2B5EF4-FFF2-40B4-BE49-F238E27FC236}">
                  <a16:creationId xmlns:a16="http://schemas.microsoft.com/office/drawing/2014/main" id="{5D9F8092-6147-5B29-6D10-4A209A38EBB5}"/>
                </a:ext>
              </a:extLst>
            </p:cNvPr>
            <p:cNvSpPr txBox="1"/>
            <p:nvPr/>
          </p:nvSpPr>
          <p:spPr>
            <a:xfrm>
              <a:off x="4556289" y="614653"/>
              <a:ext cx="534121"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UCD4</a:t>
              </a:r>
            </a:p>
          </p:txBody>
        </p:sp>
        <p:sp>
          <p:nvSpPr>
            <p:cNvPr id="38" name="TextBox 37">
              <a:extLst>
                <a:ext uri="{FF2B5EF4-FFF2-40B4-BE49-F238E27FC236}">
                  <a16:creationId xmlns:a16="http://schemas.microsoft.com/office/drawing/2014/main" id="{216BD2F2-3249-7E31-CF3F-2F9189A00E35}"/>
                </a:ext>
              </a:extLst>
            </p:cNvPr>
            <p:cNvSpPr txBox="1"/>
            <p:nvPr/>
          </p:nvSpPr>
          <p:spPr>
            <a:xfrm rot="16200000">
              <a:off x="4445126" y="938245"/>
              <a:ext cx="453970"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EWD</a:t>
              </a:r>
            </a:p>
          </p:txBody>
        </p:sp>
        <p:sp>
          <p:nvSpPr>
            <p:cNvPr id="39" name="TextBox 38">
              <a:extLst>
                <a:ext uri="{FF2B5EF4-FFF2-40B4-BE49-F238E27FC236}">
                  <a16:creationId xmlns:a16="http://schemas.microsoft.com/office/drawing/2014/main" id="{EC83F223-7109-F708-5DBB-607063AB383B}"/>
                </a:ext>
              </a:extLst>
            </p:cNvPr>
            <p:cNvSpPr txBox="1"/>
            <p:nvPr/>
          </p:nvSpPr>
          <p:spPr>
            <a:xfrm rot="16200000">
              <a:off x="4677788" y="915802"/>
              <a:ext cx="498855" cy="230832"/>
            </a:xfrm>
            <a:prstGeom prst="rect">
              <a:avLst/>
            </a:prstGeom>
            <a:noFill/>
          </p:spPr>
          <p:txBody>
            <a:bodyPr wrap="none" rtlCol="0">
              <a:spAutoFit/>
            </a:bodyPr>
            <a:lstStyle/>
            <a:p>
              <a:r>
                <a:rPr lang="en-US" sz="900" dirty="0" err="1">
                  <a:latin typeface="Arial" panose="020B0604020202020204" pitchFamily="34" charset="0"/>
                  <a:cs typeface="Arial" panose="020B0604020202020204" pitchFamily="34" charset="0"/>
                </a:rPr>
                <a:t>TamR</a:t>
              </a:r>
              <a:endParaRPr lang="en-US" sz="900" dirty="0">
                <a:latin typeface="Arial" panose="020B0604020202020204" pitchFamily="34" charset="0"/>
                <a:cs typeface="Arial" panose="020B0604020202020204" pitchFamily="34" charset="0"/>
              </a:endParaRPr>
            </a:p>
          </p:txBody>
        </p:sp>
        <p:sp>
          <p:nvSpPr>
            <p:cNvPr id="40" name="TextBox 39">
              <a:extLst>
                <a:ext uri="{FF2B5EF4-FFF2-40B4-BE49-F238E27FC236}">
                  <a16:creationId xmlns:a16="http://schemas.microsoft.com/office/drawing/2014/main" id="{9354A368-3C33-D7FD-95F7-E973144C04DE}"/>
                </a:ext>
              </a:extLst>
            </p:cNvPr>
            <p:cNvSpPr txBox="1"/>
            <p:nvPr/>
          </p:nvSpPr>
          <p:spPr>
            <a:xfrm rot="16200000">
              <a:off x="4933452" y="922215"/>
              <a:ext cx="486030" cy="230832"/>
            </a:xfrm>
            <a:prstGeom prst="rect">
              <a:avLst/>
            </a:prstGeom>
            <a:noFill/>
          </p:spPr>
          <p:txBody>
            <a:bodyPr wrap="none" rtlCol="0">
              <a:spAutoFit/>
            </a:bodyPr>
            <a:lstStyle/>
            <a:p>
              <a:r>
                <a:rPr lang="en-US" sz="900" dirty="0" err="1">
                  <a:latin typeface="Arial" panose="020B0604020202020204" pitchFamily="34" charset="0"/>
                  <a:cs typeface="Arial" panose="020B0604020202020204" pitchFamily="34" charset="0"/>
                </a:rPr>
                <a:t>FulvR</a:t>
              </a:r>
              <a:endParaRPr lang="en-US" sz="900" dirty="0">
                <a:latin typeface="Arial" panose="020B0604020202020204" pitchFamily="34" charset="0"/>
                <a:cs typeface="Arial" panose="020B0604020202020204" pitchFamily="34" charset="0"/>
              </a:endParaRPr>
            </a:p>
          </p:txBody>
        </p:sp>
        <p:sp>
          <p:nvSpPr>
            <p:cNvPr id="41" name="TextBox 40">
              <a:extLst>
                <a:ext uri="{FF2B5EF4-FFF2-40B4-BE49-F238E27FC236}">
                  <a16:creationId xmlns:a16="http://schemas.microsoft.com/office/drawing/2014/main" id="{6CB39812-E12F-97EE-0FF3-EEEF8049EC16}"/>
                </a:ext>
              </a:extLst>
            </p:cNvPr>
            <p:cNvSpPr txBox="1"/>
            <p:nvPr/>
          </p:nvSpPr>
          <p:spPr>
            <a:xfrm>
              <a:off x="5469116" y="614652"/>
              <a:ext cx="49725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T47D</a:t>
              </a:r>
            </a:p>
          </p:txBody>
        </p:sp>
        <p:sp>
          <p:nvSpPr>
            <p:cNvPr id="42" name="TextBox 41">
              <a:extLst>
                <a:ext uri="{FF2B5EF4-FFF2-40B4-BE49-F238E27FC236}">
                  <a16:creationId xmlns:a16="http://schemas.microsoft.com/office/drawing/2014/main" id="{13D6BD61-9543-67E7-3A8A-5AC6809D3103}"/>
                </a:ext>
              </a:extLst>
            </p:cNvPr>
            <p:cNvSpPr txBox="1"/>
            <p:nvPr/>
          </p:nvSpPr>
          <p:spPr>
            <a:xfrm rot="16200000">
              <a:off x="5664988" y="915802"/>
              <a:ext cx="498855" cy="230832"/>
            </a:xfrm>
            <a:prstGeom prst="rect">
              <a:avLst/>
            </a:prstGeom>
            <a:noFill/>
          </p:spPr>
          <p:txBody>
            <a:bodyPr wrap="none" rtlCol="0">
              <a:spAutoFit/>
            </a:bodyPr>
            <a:lstStyle/>
            <a:p>
              <a:r>
                <a:rPr lang="en-US" sz="900" dirty="0" err="1">
                  <a:latin typeface="Arial" panose="020B0604020202020204" pitchFamily="34" charset="0"/>
                  <a:cs typeface="Arial" panose="020B0604020202020204" pitchFamily="34" charset="0"/>
                </a:rPr>
                <a:t>TamR</a:t>
              </a:r>
              <a:endParaRPr lang="en-US" sz="900" dirty="0">
                <a:latin typeface="Arial" panose="020B0604020202020204" pitchFamily="34" charset="0"/>
                <a:cs typeface="Arial" panose="020B0604020202020204" pitchFamily="34" charset="0"/>
              </a:endParaRPr>
            </a:p>
          </p:txBody>
        </p:sp>
        <p:sp>
          <p:nvSpPr>
            <p:cNvPr id="43" name="TextBox 42">
              <a:extLst>
                <a:ext uri="{FF2B5EF4-FFF2-40B4-BE49-F238E27FC236}">
                  <a16:creationId xmlns:a16="http://schemas.microsoft.com/office/drawing/2014/main" id="{E8DDAE7D-1734-56FD-0364-5559489E51E3}"/>
                </a:ext>
              </a:extLst>
            </p:cNvPr>
            <p:cNvSpPr txBox="1"/>
            <p:nvPr/>
          </p:nvSpPr>
          <p:spPr>
            <a:xfrm rot="16200000">
              <a:off x="5935358" y="922215"/>
              <a:ext cx="486030" cy="230832"/>
            </a:xfrm>
            <a:prstGeom prst="rect">
              <a:avLst/>
            </a:prstGeom>
            <a:noFill/>
          </p:spPr>
          <p:txBody>
            <a:bodyPr wrap="none" rtlCol="0">
              <a:spAutoFit/>
            </a:bodyPr>
            <a:lstStyle/>
            <a:p>
              <a:r>
                <a:rPr lang="en-US" sz="900" dirty="0" err="1">
                  <a:latin typeface="Arial" panose="020B0604020202020204" pitchFamily="34" charset="0"/>
                  <a:cs typeface="Arial" panose="020B0604020202020204" pitchFamily="34" charset="0"/>
                </a:rPr>
                <a:t>FulvR</a:t>
              </a:r>
              <a:endParaRPr lang="en-US" sz="900" dirty="0">
                <a:latin typeface="Arial" panose="020B0604020202020204" pitchFamily="34" charset="0"/>
                <a:cs typeface="Arial" panose="020B0604020202020204" pitchFamily="34" charset="0"/>
              </a:endParaRPr>
            </a:p>
          </p:txBody>
        </p:sp>
        <p:sp>
          <p:nvSpPr>
            <p:cNvPr id="44" name="TextBox 43">
              <a:extLst>
                <a:ext uri="{FF2B5EF4-FFF2-40B4-BE49-F238E27FC236}">
                  <a16:creationId xmlns:a16="http://schemas.microsoft.com/office/drawing/2014/main" id="{4207EB66-2898-1984-9484-94563E3C3428}"/>
                </a:ext>
              </a:extLst>
            </p:cNvPr>
            <p:cNvSpPr txBox="1"/>
            <p:nvPr/>
          </p:nvSpPr>
          <p:spPr>
            <a:xfrm rot="16200000">
              <a:off x="4226938" y="965816"/>
              <a:ext cx="38343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Par</a:t>
              </a:r>
            </a:p>
          </p:txBody>
        </p:sp>
        <p:sp>
          <p:nvSpPr>
            <p:cNvPr id="45" name="TextBox 44">
              <a:extLst>
                <a:ext uri="{FF2B5EF4-FFF2-40B4-BE49-F238E27FC236}">
                  <a16:creationId xmlns:a16="http://schemas.microsoft.com/office/drawing/2014/main" id="{AEC0D9E4-7763-6FE3-8777-906780367089}"/>
                </a:ext>
              </a:extLst>
            </p:cNvPr>
            <p:cNvSpPr txBox="1"/>
            <p:nvPr/>
          </p:nvSpPr>
          <p:spPr>
            <a:xfrm rot="16200000">
              <a:off x="5228746" y="965816"/>
              <a:ext cx="38343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Par</a:t>
              </a:r>
            </a:p>
          </p:txBody>
        </p:sp>
        <p:cxnSp>
          <p:nvCxnSpPr>
            <p:cNvPr id="46" name="Straight Connector 45">
              <a:extLst>
                <a:ext uri="{FF2B5EF4-FFF2-40B4-BE49-F238E27FC236}">
                  <a16:creationId xmlns:a16="http://schemas.microsoft.com/office/drawing/2014/main" id="{801823A3-5F26-4871-BBDC-0DBBBC90F78B}"/>
                </a:ext>
              </a:extLst>
            </p:cNvPr>
            <p:cNvCxnSpPr>
              <a:cxnSpLocks/>
            </p:cNvCxnSpPr>
            <p:nvPr/>
          </p:nvCxnSpPr>
          <p:spPr>
            <a:xfrm>
              <a:off x="4391410" y="822617"/>
              <a:ext cx="793079"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47" name="Straight Connector 46">
              <a:extLst>
                <a:ext uri="{FF2B5EF4-FFF2-40B4-BE49-F238E27FC236}">
                  <a16:creationId xmlns:a16="http://schemas.microsoft.com/office/drawing/2014/main" id="{719C1944-2A15-C625-09F0-211BE512960E}"/>
                </a:ext>
              </a:extLst>
            </p:cNvPr>
            <p:cNvCxnSpPr>
              <a:cxnSpLocks/>
            </p:cNvCxnSpPr>
            <p:nvPr/>
          </p:nvCxnSpPr>
          <p:spPr>
            <a:xfrm>
              <a:off x="5337162" y="821154"/>
              <a:ext cx="793079"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grpSp>
    </p:spTree>
    <p:extLst>
      <p:ext uri="{BB962C8B-B14F-4D97-AF65-F5344CB8AC3E}">
        <p14:creationId xmlns:p14="http://schemas.microsoft.com/office/powerpoint/2010/main" val="126884753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 name="TextBox 52">
            <a:extLst>
              <a:ext uri="{FF2B5EF4-FFF2-40B4-BE49-F238E27FC236}">
                <a16:creationId xmlns:a16="http://schemas.microsoft.com/office/drawing/2014/main" id="{917D5808-3EF0-F357-9D97-5D95633AF724}"/>
              </a:ext>
            </a:extLst>
          </p:cNvPr>
          <p:cNvSpPr txBox="1"/>
          <p:nvPr/>
        </p:nvSpPr>
        <p:spPr>
          <a:xfrm>
            <a:off x="457200" y="6739409"/>
            <a:ext cx="6857999" cy="1732590"/>
          </a:xfrm>
          <a:prstGeom prst="rect">
            <a:avLst/>
          </a:prstGeom>
          <a:noFill/>
        </p:spPr>
        <p:txBody>
          <a:bodyPr wrap="square">
            <a:spAutoFit/>
          </a:bodyPr>
          <a:lstStyle/>
          <a:p>
            <a:pPr marL="0" marR="0" algn="just">
              <a:lnSpc>
                <a:spcPct val="200000"/>
              </a:lnSpc>
              <a:spcBef>
                <a:spcPts val="0"/>
              </a:spcBef>
              <a:spcAft>
                <a:spcPts val="0"/>
              </a:spcAft>
            </a:pPr>
            <a:r>
              <a:rPr lang="en-US" sz="1100" b="1" kern="100" dirty="0">
                <a:effectLst/>
                <a:latin typeface="Arial" panose="020B0604020202020204" pitchFamily="34" charset="0"/>
                <a:ea typeface="Aptos" panose="020B0004020202020204" pitchFamily="34" charset="0"/>
                <a:cs typeface="Arial" panose="020B0604020202020204" pitchFamily="34" charset="0"/>
              </a:rPr>
              <a:t>Supplemental Figure S6. Endocrine resistant cell lines retain activated ACC1. </a:t>
            </a:r>
            <a:r>
              <a:rPr lang="en-US" sz="1100" kern="100" dirty="0">
                <a:latin typeface="Arial" panose="020B0604020202020204" pitchFamily="34" charset="0"/>
                <a:ea typeface="Aptos" panose="020B0004020202020204" pitchFamily="34" charset="0"/>
                <a:cs typeface="Arial" panose="020B0604020202020204" pitchFamily="34" charset="0"/>
              </a:rPr>
              <a:t>a</a:t>
            </a:r>
            <a:r>
              <a:rPr lang="en-US" sz="1100" kern="100" dirty="0">
                <a:effectLst/>
                <a:latin typeface="Arial" panose="020B0604020202020204" pitchFamily="34" charset="0"/>
                <a:ea typeface="Aptos" panose="020B0004020202020204" pitchFamily="34" charset="0"/>
                <a:cs typeface="Arial" panose="020B0604020202020204" pitchFamily="34" charset="0"/>
              </a:rPr>
              <a:t>) Immunoblot analysis of phosphorylated ACC1 (pACC1 at Ser79) and total ACC1 levels in parental and endocrine resistant T47D and UCD4 cells. </a:t>
            </a:r>
            <a:r>
              <a:rPr lang="el-GR" sz="1100" kern="100" dirty="0">
                <a:effectLst/>
                <a:latin typeface="Arial" panose="020B0604020202020204" pitchFamily="34" charset="0"/>
                <a:ea typeface="Aptos" panose="020B0004020202020204" pitchFamily="34" charset="0"/>
                <a:cs typeface="Arial" panose="020B0604020202020204" pitchFamily="34" charset="0"/>
              </a:rPr>
              <a:t>β-</a:t>
            </a:r>
            <a:r>
              <a:rPr lang="en-US" sz="1100" kern="100" dirty="0">
                <a:effectLst/>
                <a:latin typeface="Arial" panose="020B0604020202020204" pitchFamily="34" charset="0"/>
                <a:ea typeface="Aptos" panose="020B0004020202020204" pitchFamily="34" charset="0"/>
                <a:cs typeface="Arial" panose="020B0604020202020204" pitchFamily="34" charset="0"/>
              </a:rPr>
              <a:t>actin was used as a loading control. Protein bands were normalized to </a:t>
            </a:r>
            <a:r>
              <a:rPr lang="el-GR" sz="1100" kern="100" dirty="0">
                <a:effectLst/>
                <a:latin typeface="Arial" panose="020B0604020202020204" pitchFamily="34" charset="0"/>
                <a:ea typeface="Aptos" panose="020B0004020202020204" pitchFamily="34" charset="0"/>
                <a:cs typeface="Arial" panose="020B0604020202020204" pitchFamily="34" charset="0"/>
              </a:rPr>
              <a:t>β-</a:t>
            </a:r>
            <a:r>
              <a:rPr lang="en-US" sz="1100" kern="100" dirty="0">
                <a:effectLst/>
                <a:latin typeface="Arial" panose="020B0604020202020204" pitchFamily="34" charset="0"/>
                <a:ea typeface="Aptos" panose="020B0004020202020204" pitchFamily="34" charset="0"/>
                <a:cs typeface="Arial" panose="020B0604020202020204" pitchFamily="34" charset="0"/>
              </a:rPr>
              <a:t>actin, and the fold change of pAAC1/ACC1 relative to parental cells is indicated.</a:t>
            </a:r>
            <a:r>
              <a:rPr lang="en-US" sz="1100" b="1" kern="100" dirty="0">
                <a:latin typeface="Arial" panose="020B0604020202020204" pitchFamily="34" charset="0"/>
                <a:ea typeface="Aptos" panose="020B0004020202020204" pitchFamily="34" charset="0"/>
                <a:cs typeface="Arial" panose="020B0604020202020204" pitchFamily="34" charset="0"/>
              </a:rPr>
              <a:t> </a:t>
            </a:r>
            <a:r>
              <a:rPr lang="en-US" sz="1100" kern="100" dirty="0">
                <a:latin typeface="Arial" panose="020B0604020202020204" pitchFamily="34" charset="0"/>
                <a:ea typeface="Aptos" panose="020B0004020202020204" pitchFamily="34" charset="0"/>
                <a:cs typeface="Arial" panose="020B0604020202020204" pitchFamily="34" charset="0"/>
              </a:rPr>
              <a:t>b)</a:t>
            </a:r>
            <a:r>
              <a:rPr lang="en-US" sz="1100" b="1" kern="100" dirty="0">
                <a:latin typeface="Arial" panose="020B0604020202020204" pitchFamily="34" charset="0"/>
                <a:ea typeface="Aptos" panose="020B0004020202020204" pitchFamily="34" charset="0"/>
                <a:cs typeface="Arial" panose="020B0604020202020204" pitchFamily="34" charset="0"/>
              </a:rPr>
              <a:t> </a:t>
            </a:r>
            <a:r>
              <a:rPr lang="en-US" sz="1100" kern="100" dirty="0">
                <a:effectLst/>
                <a:latin typeface="Arial" panose="020B0604020202020204" pitchFamily="34" charset="0"/>
                <a:ea typeface="Aptos" panose="020B0004020202020204" pitchFamily="34" charset="0"/>
                <a:cs typeface="Arial" panose="020B0604020202020204" pitchFamily="34" charset="0"/>
              </a:rPr>
              <a:t>Full immunoblots corresponding to data depicted in (a). Note that some lanes were not included in this study.</a:t>
            </a:r>
          </a:p>
        </p:txBody>
      </p:sp>
      <p:grpSp>
        <p:nvGrpSpPr>
          <p:cNvPr id="45" name="Group 44">
            <a:extLst>
              <a:ext uri="{FF2B5EF4-FFF2-40B4-BE49-F238E27FC236}">
                <a16:creationId xmlns:a16="http://schemas.microsoft.com/office/drawing/2014/main" id="{9A8B4BD6-9B49-BC2A-8856-F3D302616B9B}"/>
              </a:ext>
            </a:extLst>
          </p:cNvPr>
          <p:cNvGrpSpPr/>
          <p:nvPr/>
        </p:nvGrpSpPr>
        <p:grpSpPr>
          <a:xfrm>
            <a:off x="357915" y="441119"/>
            <a:ext cx="6945070" cy="6047177"/>
            <a:chOff x="357915" y="441119"/>
            <a:chExt cx="6945070" cy="6047177"/>
          </a:xfrm>
        </p:grpSpPr>
        <p:sp>
          <p:nvSpPr>
            <p:cNvPr id="102" name="TextBox 101">
              <a:extLst>
                <a:ext uri="{FF2B5EF4-FFF2-40B4-BE49-F238E27FC236}">
                  <a16:creationId xmlns:a16="http://schemas.microsoft.com/office/drawing/2014/main" id="{B60004C9-2797-2AB6-D9BE-481A07013CAA}"/>
                </a:ext>
              </a:extLst>
            </p:cNvPr>
            <p:cNvSpPr txBox="1"/>
            <p:nvPr/>
          </p:nvSpPr>
          <p:spPr>
            <a:xfrm>
              <a:off x="357915" y="3324847"/>
              <a:ext cx="341760" cy="400110"/>
            </a:xfrm>
            <a:prstGeom prst="rect">
              <a:avLst/>
            </a:prstGeom>
            <a:noFill/>
          </p:spPr>
          <p:txBody>
            <a:bodyPr wrap="none" rtlCol="0">
              <a:spAutoFit/>
            </a:bodyPr>
            <a:lstStyle>
              <a:defPPr>
                <a:defRPr lang="en-US"/>
              </a:defPPr>
              <a:lvl1pPr>
                <a:defRPr sz="1400" b="1">
                  <a:latin typeface="Arial" panose="020B0604020202020204" pitchFamily="34" charset="0"/>
                  <a:cs typeface="Arial" panose="020B0604020202020204" pitchFamily="34" charset="0"/>
                </a:defRPr>
              </a:lvl1pPr>
            </a:lstStyle>
            <a:p>
              <a:r>
                <a:rPr lang="en-US" sz="2000" dirty="0"/>
                <a:t>b</a:t>
              </a:r>
            </a:p>
          </p:txBody>
        </p:sp>
        <p:grpSp>
          <p:nvGrpSpPr>
            <p:cNvPr id="18" name="Group 17">
              <a:extLst>
                <a:ext uri="{FF2B5EF4-FFF2-40B4-BE49-F238E27FC236}">
                  <a16:creationId xmlns:a16="http://schemas.microsoft.com/office/drawing/2014/main" id="{EF3E87F5-0AAB-ABEA-757D-C8C9FFE5E5FD}"/>
                </a:ext>
              </a:extLst>
            </p:cNvPr>
            <p:cNvGrpSpPr/>
            <p:nvPr/>
          </p:nvGrpSpPr>
          <p:grpSpPr>
            <a:xfrm>
              <a:off x="1015581" y="441119"/>
              <a:ext cx="4945168" cy="2591503"/>
              <a:chOff x="1242952" y="4939910"/>
              <a:chExt cx="4945168" cy="2591503"/>
            </a:xfrm>
          </p:grpSpPr>
          <p:pic>
            <p:nvPicPr>
              <p:cNvPr id="2" name="Picture 1" descr="A picture containing text, black and white, stationary&#10;&#10;Description automatically generated">
                <a:extLst>
                  <a:ext uri="{FF2B5EF4-FFF2-40B4-BE49-F238E27FC236}">
                    <a16:creationId xmlns:a16="http://schemas.microsoft.com/office/drawing/2014/main" id="{C6F181DC-8053-8078-1092-A2A974781653}"/>
                  </a:ext>
                </a:extLst>
              </p:cNvPr>
              <p:cNvPicPr>
                <a:picLocks noChangeAspect="1"/>
              </p:cNvPicPr>
              <p:nvPr/>
            </p:nvPicPr>
            <p:blipFill rotWithShape="1">
              <a:blip r:embed="rId3" cstate="email">
                <a:extLst>
                  <a:ext uri="{28A0092B-C50C-407E-A947-70E740481C1C}">
                    <a14:useLocalDpi xmlns:a14="http://schemas.microsoft.com/office/drawing/2010/main"/>
                  </a:ext>
                </a:extLst>
              </a:blip>
              <a:srcRect/>
              <a:stretch/>
            </p:blipFill>
            <p:spPr>
              <a:xfrm>
                <a:off x="2454788" y="6194077"/>
                <a:ext cx="3064661" cy="335712"/>
              </a:xfrm>
              <a:prstGeom prst="rect">
                <a:avLst/>
              </a:prstGeom>
              <a:ln>
                <a:solidFill>
                  <a:schemeClr val="tx1"/>
                </a:solidFill>
              </a:ln>
            </p:spPr>
          </p:pic>
          <p:pic>
            <p:nvPicPr>
              <p:cNvPr id="3" name="Picture 2" descr="A close-up of a test&#10;&#10;Description automatically generated with low confidence">
                <a:extLst>
                  <a:ext uri="{FF2B5EF4-FFF2-40B4-BE49-F238E27FC236}">
                    <a16:creationId xmlns:a16="http://schemas.microsoft.com/office/drawing/2014/main" id="{840B3CF0-15A4-982E-7230-D4FD3CA0E0EF}"/>
                  </a:ext>
                </a:extLst>
              </p:cNvPr>
              <p:cNvPicPr>
                <a:picLocks noChangeAspect="1"/>
              </p:cNvPicPr>
              <p:nvPr/>
            </p:nvPicPr>
            <p:blipFill rotWithShape="1">
              <a:blip r:embed="rId4" cstate="email">
                <a:extLst>
                  <a:ext uri="{28A0092B-C50C-407E-A947-70E740481C1C}">
                    <a14:useLocalDpi xmlns:a14="http://schemas.microsoft.com/office/drawing/2010/main"/>
                  </a:ext>
                </a:extLst>
              </a:blip>
              <a:srcRect/>
              <a:stretch/>
            </p:blipFill>
            <p:spPr>
              <a:xfrm>
                <a:off x="2454788" y="5819116"/>
                <a:ext cx="3064661" cy="318235"/>
              </a:xfrm>
              <a:prstGeom prst="rect">
                <a:avLst/>
              </a:prstGeom>
              <a:ln>
                <a:solidFill>
                  <a:schemeClr val="tx1"/>
                </a:solidFill>
              </a:ln>
            </p:spPr>
          </p:pic>
          <p:sp>
            <p:nvSpPr>
              <p:cNvPr id="4" name="TextBox 67">
                <a:extLst>
                  <a:ext uri="{FF2B5EF4-FFF2-40B4-BE49-F238E27FC236}">
                    <a16:creationId xmlns:a16="http://schemas.microsoft.com/office/drawing/2014/main" id="{53D6B75E-FE3D-5E4B-0987-E42AFFB0BAA9}"/>
                  </a:ext>
                </a:extLst>
              </p:cNvPr>
              <p:cNvSpPr txBox="1"/>
              <p:nvPr/>
            </p:nvSpPr>
            <p:spPr>
              <a:xfrm>
                <a:off x="1371342" y="5881711"/>
                <a:ext cx="1111622" cy="24820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r"/>
                <a:r>
                  <a:rPr lang="en-US" sz="1013" b="1" dirty="0">
                    <a:latin typeface="Arial" panose="020B0604020202020204" pitchFamily="34" charset="0"/>
                    <a:cs typeface="Arial" panose="020B0604020202020204" pitchFamily="34" charset="0"/>
                  </a:rPr>
                  <a:t>pACC1 (Ser79)</a:t>
                </a:r>
              </a:p>
            </p:txBody>
          </p:sp>
          <p:sp>
            <p:nvSpPr>
              <p:cNvPr id="5" name="TextBox 68">
                <a:extLst>
                  <a:ext uri="{FF2B5EF4-FFF2-40B4-BE49-F238E27FC236}">
                    <a16:creationId xmlns:a16="http://schemas.microsoft.com/office/drawing/2014/main" id="{408464C1-A778-7B3C-D9B1-0771B3C69EB9}"/>
                  </a:ext>
                </a:extLst>
              </p:cNvPr>
              <p:cNvSpPr txBox="1"/>
              <p:nvPr/>
            </p:nvSpPr>
            <p:spPr>
              <a:xfrm>
                <a:off x="1242952" y="6222203"/>
                <a:ext cx="1240009" cy="24820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r"/>
                <a:r>
                  <a:rPr lang="en-US" sz="1013" b="1" dirty="0">
                    <a:latin typeface="Arial" panose="020B0604020202020204" pitchFamily="34" charset="0"/>
                    <a:cs typeface="Arial" panose="020B0604020202020204" pitchFamily="34" charset="0"/>
                  </a:rPr>
                  <a:t>Total ACC1</a:t>
                </a:r>
              </a:p>
            </p:txBody>
          </p:sp>
          <p:pic>
            <p:nvPicPr>
              <p:cNvPr id="6" name="Picture 5" descr="A piece of paper with black lines&#10;&#10;Description automatically generated with low confidence">
                <a:extLst>
                  <a:ext uri="{FF2B5EF4-FFF2-40B4-BE49-F238E27FC236}">
                    <a16:creationId xmlns:a16="http://schemas.microsoft.com/office/drawing/2014/main" id="{58653D6B-2F50-31AE-1FEF-F0FFFB7A439E}"/>
                  </a:ext>
                </a:extLst>
              </p:cNvPr>
              <p:cNvPicPr>
                <a:picLocks noChangeAspect="1"/>
              </p:cNvPicPr>
              <p:nvPr/>
            </p:nvPicPr>
            <p:blipFill rotWithShape="1">
              <a:blip r:embed="rId5" cstate="email">
                <a:extLst>
                  <a:ext uri="{28A0092B-C50C-407E-A947-70E740481C1C}">
                    <a14:useLocalDpi xmlns:a14="http://schemas.microsoft.com/office/drawing/2010/main"/>
                  </a:ext>
                </a:extLst>
              </a:blip>
              <a:srcRect/>
              <a:stretch/>
            </p:blipFill>
            <p:spPr>
              <a:xfrm>
                <a:off x="2443874" y="7220918"/>
                <a:ext cx="3061053" cy="310495"/>
              </a:xfrm>
              <a:prstGeom prst="rect">
                <a:avLst/>
              </a:prstGeom>
              <a:ln>
                <a:solidFill>
                  <a:schemeClr val="tx1"/>
                </a:solidFill>
              </a:ln>
            </p:spPr>
          </p:pic>
          <p:sp>
            <p:nvSpPr>
              <p:cNvPr id="7" name="TextBox 70">
                <a:extLst>
                  <a:ext uri="{FF2B5EF4-FFF2-40B4-BE49-F238E27FC236}">
                    <a16:creationId xmlns:a16="http://schemas.microsoft.com/office/drawing/2014/main" id="{CCFC4192-589E-CEE2-CDAF-82E42E6F3B99}"/>
                  </a:ext>
                </a:extLst>
              </p:cNvPr>
              <p:cNvSpPr txBox="1"/>
              <p:nvPr/>
            </p:nvSpPr>
            <p:spPr>
              <a:xfrm>
                <a:off x="1859030" y="7255067"/>
                <a:ext cx="612900" cy="24820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r"/>
                <a:r>
                  <a:rPr lang="el-GR" sz="1013" b="1" dirty="0">
                    <a:latin typeface="Arial" panose="020B0604020202020204" pitchFamily="34" charset="0"/>
                    <a:cs typeface="Arial" panose="020B0604020202020204" pitchFamily="34" charset="0"/>
                  </a:rPr>
                  <a:t>β</a:t>
                </a:r>
                <a:r>
                  <a:rPr lang="en-US" sz="1013" b="1" dirty="0">
                    <a:latin typeface="Arial" panose="020B0604020202020204" pitchFamily="34" charset="0"/>
                    <a:cs typeface="Arial" panose="020B0604020202020204" pitchFamily="34" charset="0"/>
                  </a:rPr>
                  <a:t>-actin</a:t>
                </a:r>
              </a:p>
            </p:txBody>
          </p:sp>
          <p:sp>
            <p:nvSpPr>
              <p:cNvPr id="8" name="TextBox 71">
                <a:extLst>
                  <a:ext uri="{FF2B5EF4-FFF2-40B4-BE49-F238E27FC236}">
                    <a16:creationId xmlns:a16="http://schemas.microsoft.com/office/drawing/2014/main" id="{67CC8A78-7638-691D-1CD4-3A9BAB7DB335}"/>
                  </a:ext>
                </a:extLst>
              </p:cNvPr>
              <p:cNvSpPr txBox="1"/>
              <p:nvPr/>
            </p:nvSpPr>
            <p:spPr>
              <a:xfrm>
                <a:off x="5499180" y="5880885"/>
                <a:ext cx="688940" cy="24820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13" b="1" dirty="0">
                    <a:latin typeface="Arial" panose="020B0604020202020204" pitchFamily="34" charset="0"/>
                    <a:cs typeface="Arial" panose="020B0604020202020204" pitchFamily="34" charset="0"/>
                  </a:rPr>
                  <a:t>280 </a:t>
                </a:r>
                <a:r>
                  <a:rPr lang="en-US" sz="1013" b="1" dirty="0" err="1">
                    <a:latin typeface="Arial" panose="020B0604020202020204" pitchFamily="34" charset="0"/>
                    <a:cs typeface="Arial" panose="020B0604020202020204" pitchFamily="34" charset="0"/>
                  </a:rPr>
                  <a:t>kDa</a:t>
                </a:r>
                <a:endParaRPr lang="en-US" sz="1013" b="1" dirty="0">
                  <a:latin typeface="Arial" panose="020B0604020202020204" pitchFamily="34" charset="0"/>
                  <a:cs typeface="Arial" panose="020B0604020202020204" pitchFamily="34" charset="0"/>
                </a:endParaRPr>
              </a:p>
            </p:txBody>
          </p:sp>
          <p:sp>
            <p:nvSpPr>
              <p:cNvPr id="9" name="TextBox 72">
                <a:extLst>
                  <a:ext uri="{FF2B5EF4-FFF2-40B4-BE49-F238E27FC236}">
                    <a16:creationId xmlns:a16="http://schemas.microsoft.com/office/drawing/2014/main" id="{97E5746A-6A8E-8A14-F506-B2CD65F09F64}"/>
                  </a:ext>
                </a:extLst>
              </p:cNvPr>
              <p:cNvSpPr txBox="1"/>
              <p:nvPr/>
            </p:nvSpPr>
            <p:spPr>
              <a:xfrm>
                <a:off x="5499180" y="6222203"/>
                <a:ext cx="688940" cy="24820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13" b="1" dirty="0">
                    <a:latin typeface="Arial" panose="020B0604020202020204" pitchFamily="34" charset="0"/>
                    <a:cs typeface="Arial" panose="020B0604020202020204" pitchFamily="34" charset="0"/>
                  </a:rPr>
                  <a:t>280 </a:t>
                </a:r>
                <a:r>
                  <a:rPr lang="en-US" sz="1013" b="1" dirty="0" err="1">
                    <a:latin typeface="Arial" panose="020B0604020202020204" pitchFamily="34" charset="0"/>
                    <a:cs typeface="Arial" panose="020B0604020202020204" pitchFamily="34" charset="0"/>
                  </a:rPr>
                  <a:t>kDa</a:t>
                </a:r>
                <a:endParaRPr lang="en-US" sz="1013" b="1" dirty="0">
                  <a:latin typeface="Arial" panose="020B0604020202020204" pitchFamily="34" charset="0"/>
                  <a:cs typeface="Arial" panose="020B0604020202020204" pitchFamily="34" charset="0"/>
                </a:endParaRPr>
              </a:p>
            </p:txBody>
          </p:sp>
          <p:sp>
            <p:nvSpPr>
              <p:cNvPr id="10" name="TextBox 73">
                <a:extLst>
                  <a:ext uri="{FF2B5EF4-FFF2-40B4-BE49-F238E27FC236}">
                    <a16:creationId xmlns:a16="http://schemas.microsoft.com/office/drawing/2014/main" id="{50961BF8-56DB-2A99-FED5-411254C54A11}"/>
                  </a:ext>
                </a:extLst>
              </p:cNvPr>
              <p:cNvSpPr txBox="1"/>
              <p:nvPr/>
            </p:nvSpPr>
            <p:spPr>
              <a:xfrm>
                <a:off x="5457863" y="7233965"/>
                <a:ext cx="661363" cy="24820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13" b="1" dirty="0">
                    <a:latin typeface="Arial" panose="020B0604020202020204" pitchFamily="34" charset="0"/>
                    <a:cs typeface="Arial" panose="020B0604020202020204" pitchFamily="34" charset="0"/>
                  </a:rPr>
                  <a:t>42 </a:t>
                </a:r>
                <a:r>
                  <a:rPr lang="en-US" sz="1013" b="1" dirty="0" err="1">
                    <a:latin typeface="Arial" panose="020B0604020202020204" pitchFamily="34" charset="0"/>
                    <a:cs typeface="Arial" panose="020B0604020202020204" pitchFamily="34" charset="0"/>
                  </a:rPr>
                  <a:t>kDa</a:t>
                </a:r>
                <a:endParaRPr lang="en-US" sz="1013" b="1" dirty="0">
                  <a:latin typeface="Arial" panose="020B0604020202020204" pitchFamily="34" charset="0"/>
                  <a:cs typeface="Arial" panose="020B0604020202020204" pitchFamily="34" charset="0"/>
                </a:endParaRPr>
              </a:p>
            </p:txBody>
          </p:sp>
          <p:sp>
            <p:nvSpPr>
              <p:cNvPr id="11" name="TextBox 74">
                <a:extLst>
                  <a:ext uri="{FF2B5EF4-FFF2-40B4-BE49-F238E27FC236}">
                    <a16:creationId xmlns:a16="http://schemas.microsoft.com/office/drawing/2014/main" id="{9F4D6A45-7C89-ECA0-3722-15F55F169E6C}"/>
                  </a:ext>
                </a:extLst>
              </p:cNvPr>
              <p:cNvSpPr txBox="1"/>
              <p:nvPr/>
            </p:nvSpPr>
            <p:spPr>
              <a:xfrm rot="18161804">
                <a:off x="2437226" y="5466537"/>
                <a:ext cx="498855"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b="1" dirty="0">
                    <a:latin typeface="Arial" panose="020B0604020202020204" pitchFamily="34" charset="0"/>
                    <a:cs typeface="Arial" panose="020B0604020202020204" pitchFamily="34" charset="0"/>
                  </a:rPr>
                  <a:t>UCD4</a:t>
                </a:r>
              </a:p>
            </p:txBody>
          </p:sp>
          <p:sp>
            <p:nvSpPr>
              <p:cNvPr id="12" name="TextBox 75">
                <a:extLst>
                  <a:ext uri="{FF2B5EF4-FFF2-40B4-BE49-F238E27FC236}">
                    <a16:creationId xmlns:a16="http://schemas.microsoft.com/office/drawing/2014/main" id="{DA83A3EA-D053-3F31-9864-7229FFE30D56}"/>
                  </a:ext>
                </a:extLst>
              </p:cNvPr>
              <p:cNvSpPr txBox="1"/>
              <p:nvPr/>
            </p:nvSpPr>
            <p:spPr>
              <a:xfrm rot="18161804">
                <a:off x="2619257" y="5287121"/>
                <a:ext cx="925253"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b="1" dirty="0">
                    <a:latin typeface="Arial" panose="020B0604020202020204" pitchFamily="34" charset="0"/>
                    <a:cs typeface="Arial" panose="020B0604020202020204" pitchFamily="34" charset="0"/>
                  </a:rPr>
                  <a:t>UCD4 + Oligo</a:t>
                </a:r>
              </a:p>
            </p:txBody>
          </p:sp>
          <p:sp>
            <p:nvSpPr>
              <p:cNvPr id="13" name="TextBox 76">
                <a:extLst>
                  <a:ext uri="{FF2B5EF4-FFF2-40B4-BE49-F238E27FC236}">
                    <a16:creationId xmlns:a16="http://schemas.microsoft.com/office/drawing/2014/main" id="{138FD98E-45FA-3AED-839E-2693F7ED2F8E}"/>
                  </a:ext>
                </a:extLst>
              </p:cNvPr>
              <p:cNvSpPr txBox="1"/>
              <p:nvPr/>
            </p:nvSpPr>
            <p:spPr>
              <a:xfrm rot="18161804">
                <a:off x="2952470" y="5337034"/>
                <a:ext cx="806631"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b="1" dirty="0">
                    <a:latin typeface="Arial" panose="020B0604020202020204" pitchFamily="34" charset="0"/>
                    <a:cs typeface="Arial" panose="020B0604020202020204" pitchFamily="34" charset="0"/>
                  </a:rPr>
                  <a:t>UCD4-EWD</a:t>
                </a:r>
              </a:p>
            </p:txBody>
          </p:sp>
          <p:sp>
            <p:nvSpPr>
              <p:cNvPr id="14" name="TextBox 77">
                <a:extLst>
                  <a:ext uri="{FF2B5EF4-FFF2-40B4-BE49-F238E27FC236}">
                    <a16:creationId xmlns:a16="http://schemas.microsoft.com/office/drawing/2014/main" id="{C5E38AE7-DE7B-DF1D-F25E-9F1CC19C4C35}"/>
                  </a:ext>
                </a:extLst>
              </p:cNvPr>
              <p:cNvSpPr txBox="1"/>
              <p:nvPr/>
            </p:nvSpPr>
            <p:spPr>
              <a:xfrm rot="18161804">
                <a:off x="3256045" y="5305291"/>
                <a:ext cx="882072"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b="1" dirty="0">
                    <a:latin typeface="Arial" panose="020B0604020202020204" pitchFamily="34" charset="0"/>
                    <a:cs typeface="Arial" panose="020B0604020202020204" pitchFamily="34" charset="0"/>
                  </a:rPr>
                  <a:t>UCD4-TamR</a:t>
                </a:r>
              </a:p>
            </p:txBody>
          </p:sp>
          <p:sp>
            <p:nvSpPr>
              <p:cNvPr id="15" name="TextBox 78">
                <a:extLst>
                  <a:ext uri="{FF2B5EF4-FFF2-40B4-BE49-F238E27FC236}">
                    <a16:creationId xmlns:a16="http://schemas.microsoft.com/office/drawing/2014/main" id="{873056B1-9E5A-C229-7EB1-A230C64E8AB7}"/>
                  </a:ext>
                </a:extLst>
              </p:cNvPr>
              <p:cNvSpPr txBox="1"/>
              <p:nvPr/>
            </p:nvSpPr>
            <p:spPr>
              <a:xfrm rot="18161804">
                <a:off x="3538693" y="5305291"/>
                <a:ext cx="882071"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b="1" dirty="0">
                    <a:latin typeface="Arial" panose="020B0604020202020204" pitchFamily="34" charset="0"/>
                    <a:cs typeface="Arial" panose="020B0604020202020204" pitchFamily="34" charset="0"/>
                  </a:rPr>
                  <a:t>UCD4-FulvR</a:t>
                </a:r>
              </a:p>
            </p:txBody>
          </p:sp>
          <p:sp>
            <p:nvSpPr>
              <p:cNvPr id="16" name="TextBox 79">
                <a:extLst>
                  <a:ext uri="{FF2B5EF4-FFF2-40B4-BE49-F238E27FC236}">
                    <a16:creationId xmlns:a16="http://schemas.microsoft.com/office/drawing/2014/main" id="{5E0B69B2-5469-64DA-BB9C-4F566A454CCD}"/>
                  </a:ext>
                </a:extLst>
              </p:cNvPr>
              <p:cNvSpPr txBox="1"/>
              <p:nvPr/>
            </p:nvSpPr>
            <p:spPr>
              <a:xfrm rot="18161804">
                <a:off x="3966857" y="5480027"/>
                <a:ext cx="466794"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b="1" dirty="0">
                    <a:latin typeface="Arial" panose="020B0604020202020204" pitchFamily="34" charset="0"/>
                    <a:cs typeface="Arial" panose="020B0604020202020204" pitchFamily="34" charset="0"/>
                  </a:rPr>
                  <a:t>T47D</a:t>
                </a:r>
              </a:p>
            </p:txBody>
          </p:sp>
          <p:sp>
            <p:nvSpPr>
              <p:cNvPr id="17" name="TextBox 80">
                <a:extLst>
                  <a:ext uri="{FF2B5EF4-FFF2-40B4-BE49-F238E27FC236}">
                    <a16:creationId xmlns:a16="http://schemas.microsoft.com/office/drawing/2014/main" id="{9002CDE1-E33E-A969-0041-45738DAAE29B}"/>
                  </a:ext>
                </a:extLst>
              </p:cNvPr>
              <p:cNvSpPr txBox="1"/>
              <p:nvPr/>
            </p:nvSpPr>
            <p:spPr>
              <a:xfrm rot="18161804">
                <a:off x="4155786" y="5300611"/>
                <a:ext cx="893193"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b="1" dirty="0">
                    <a:latin typeface="Arial" panose="020B0604020202020204" pitchFamily="34" charset="0"/>
                    <a:cs typeface="Arial" panose="020B0604020202020204" pitchFamily="34" charset="0"/>
                  </a:rPr>
                  <a:t>T47D + Oligo</a:t>
                </a:r>
              </a:p>
            </p:txBody>
          </p:sp>
          <p:sp>
            <p:nvSpPr>
              <p:cNvPr id="19" name="TextBox 82">
                <a:extLst>
                  <a:ext uri="{FF2B5EF4-FFF2-40B4-BE49-F238E27FC236}">
                    <a16:creationId xmlns:a16="http://schemas.microsoft.com/office/drawing/2014/main" id="{6FBED441-268A-6C7E-BD6C-1743B673BDA2}"/>
                  </a:ext>
                </a:extLst>
              </p:cNvPr>
              <p:cNvSpPr txBox="1"/>
              <p:nvPr/>
            </p:nvSpPr>
            <p:spPr>
              <a:xfrm rot="18161804">
                <a:off x="4771150" y="5328940"/>
                <a:ext cx="825867"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b="1" dirty="0">
                    <a:latin typeface="Arial" panose="020B0604020202020204" pitchFamily="34" charset="0"/>
                    <a:cs typeface="Arial" panose="020B0604020202020204" pitchFamily="34" charset="0"/>
                  </a:rPr>
                  <a:t>T47D-TamR</a:t>
                </a:r>
              </a:p>
            </p:txBody>
          </p:sp>
          <p:sp>
            <p:nvSpPr>
              <p:cNvPr id="20" name="TextBox 83">
                <a:extLst>
                  <a:ext uri="{FF2B5EF4-FFF2-40B4-BE49-F238E27FC236}">
                    <a16:creationId xmlns:a16="http://schemas.microsoft.com/office/drawing/2014/main" id="{5143B970-10DD-1A35-4278-7F45955EC5C6}"/>
                  </a:ext>
                </a:extLst>
              </p:cNvPr>
              <p:cNvSpPr txBox="1"/>
              <p:nvPr/>
            </p:nvSpPr>
            <p:spPr>
              <a:xfrm rot="18161804">
                <a:off x="5095590" y="5328940"/>
                <a:ext cx="825867"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b="1" dirty="0">
                    <a:latin typeface="Arial" panose="020B0604020202020204" pitchFamily="34" charset="0"/>
                    <a:cs typeface="Arial" panose="020B0604020202020204" pitchFamily="34" charset="0"/>
                  </a:rPr>
                  <a:t>T47D-FulvR</a:t>
                </a:r>
              </a:p>
            </p:txBody>
          </p:sp>
          <p:sp>
            <p:nvSpPr>
              <p:cNvPr id="21" name="TextBox 85">
                <a:extLst>
                  <a:ext uri="{FF2B5EF4-FFF2-40B4-BE49-F238E27FC236}">
                    <a16:creationId xmlns:a16="http://schemas.microsoft.com/office/drawing/2014/main" id="{91558488-26DF-4E3C-58C2-BB8CF128C72E}"/>
                  </a:ext>
                </a:extLst>
              </p:cNvPr>
              <p:cNvSpPr txBox="1"/>
              <p:nvPr/>
            </p:nvSpPr>
            <p:spPr>
              <a:xfrm>
                <a:off x="1246722" y="6572105"/>
                <a:ext cx="1240009" cy="24820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r"/>
                <a:r>
                  <a:rPr lang="en-US" sz="1013" b="1" dirty="0">
                    <a:latin typeface="Arial" panose="020B0604020202020204" pitchFamily="34" charset="0"/>
                    <a:cs typeface="Arial" panose="020B0604020202020204" pitchFamily="34" charset="0"/>
                  </a:rPr>
                  <a:t>pACC1/ACC1</a:t>
                </a:r>
              </a:p>
            </p:txBody>
          </p:sp>
          <p:sp>
            <p:nvSpPr>
              <p:cNvPr id="22" name="TextBox 86">
                <a:extLst>
                  <a:ext uri="{FF2B5EF4-FFF2-40B4-BE49-F238E27FC236}">
                    <a16:creationId xmlns:a16="http://schemas.microsoft.com/office/drawing/2014/main" id="{243649CC-E37E-8678-7BAC-5389D6731FAC}"/>
                  </a:ext>
                </a:extLst>
              </p:cNvPr>
              <p:cNvSpPr txBox="1"/>
              <p:nvPr/>
            </p:nvSpPr>
            <p:spPr>
              <a:xfrm>
                <a:off x="2500687" y="6555094"/>
                <a:ext cx="443113" cy="24820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13" b="1" dirty="0">
                    <a:latin typeface="Arial" panose="020B0604020202020204" pitchFamily="34" charset="0"/>
                    <a:cs typeface="Arial" panose="020B0604020202020204" pitchFamily="34" charset="0"/>
                  </a:rPr>
                  <a:t>1.0</a:t>
                </a:r>
              </a:p>
            </p:txBody>
          </p:sp>
          <p:sp>
            <p:nvSpPr>
              <p:cNvPr id="23" name="TextBox 87">
                <a:extLst>
                  <a:ext uri="{FF2B5EF4-FFF2-40B4-BE49-F238E27FC236}">
                    <a16:creationId xmlns:a16="http://schemas.microsoft.com/office/drawing/2014/main" id="{99F3D82F-F6EE-93A7-F44C-3FEE08EA0284}"/>
                  </a:ext>
                </a:extLst>
              </p:cNvPr>
              <p:cNvSpPr txBox="1"/>
              <p:nvPr/>
            </p:nvSpPr>
            <p:spPr>
              <a:xfrm>
                <a:off x="2797160" y="6555094"/>
                <a:ext cx="443113" cy="24820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13" b="1" dirty="0">
                    <a:latin typeface="Arial" panose="020B0604020202020204" pitchFamily="34" charset="0"/>
                    <a:cs typeface="Arial" panose="020B0604020202020204" pitchFamily="34" charset="0"/>
                  </a:rPr>
                  <a:t>3.1</a:t>
                </a:r>
              </a:p>
            </p:txBody>
          </p:sp>
          <p:sp>
            <p:nvSpPr>
              <p:cNvPr id="24" name="TextBox 88">
                <a:extLst>
                  <a:ext uri="{FF2B5EF4-FFF2-40B4-BE49-F238E27FC236}">
                    <a16:creationId xmlns:a16="http://schemas.microsoft.com/office/drawing/2014/main" id="{760052A8-AD70-509B-CC58-F5A7684DD03C}"/>
                  </a:ext>
                </a:extLst>
              </p:cNvPr>
              <p:cNvSpPr txBox="1"/>
              <p:nvPr/>
            </p:nvSpPr>
            <p:spPr>
              <a:xfrm>
                <a:off x="3093631" y="6555094"/>
                <a:ext cx="443113" cy="24820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13" b="1" dirty="0">
                    <a:latin typeface="Arial" panose="020B0604020202020204" pitchFamily="34" charset="0"/>
                    <a:cs typeface="Arial" panose="020B0604020202020204" pitchFamily="34" charset="0"/>
                  </a:rPr>
                  <a:t>1.1</a:t>
                </a:r>
              </a:p>
            </p:txBody>
          </p:sp>
          <p:sp>
            <p:nvSpPr>
              <p:cNvPr id="25" name="TextBox 89">
                <a:extLst>
                  <a:ext uri="{FF2B5EF4-FFF2-40B4-BE49-F238E27FC236}">
                    <a16:creationId xmlns:a16="http://schemas.microsoft.com/office/drawing/2014/main" id="{5FAFC11A-AE30-33A6-8CD3-E17CAD004000}"/>
                  </a:ext>
                </a:extLst>
              </p:cNvPr>
              <p:cNvSpPr txBox="1"/>
              <p:nvPr/>
            </p:nvSpPr>
            <p:spPr>
              <a:xfrm>
                <a:off x="3390104" y="6555094"/>
                <a:ext cx="443113" cy="24820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13" b="1" dirty="0">
                    <a:latin typeface="Arial" panose="020B0604020202020204" pitchFamily="34" charset="0"/>
                    <a:cs typeface="Arial" panose="020B0604020202020204" pitchFamily="34" charset="0"/>
                  </a:rPr>
                  <a:t>0.8</a:t>
                </a:r>
              </a:p>
            </p:txBody>
          </p:sp>
          <p:sp>
            <p:nvSpPr>
              <p:cNvPr id="26" name="TextBox 90">
                <a:extLst>
                  <a:ext uri="{FF2B5EF4-FFF2-40B4-BE49-F238E27FC236}">
                    <a16:creationId xmlns:a16="http://schemas.microsoft.com/office/drawing/2014/main" id="{12FB701E-98FD-0AB2-2AF9-8977CE5DE2EA}"/>
                  </a:ext>
                </a:extLst>
              </p:cNvPr>
              <p:cNvSpPr txBox="1"/>
              <p:nvPr/>
            </p:nvSpPr>
            <p:spPr>
              <a:xfrm>
                <a:off x="3686577" y="6555094"/>
                <a:ext cx="443113" cy="24820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13" b="1" dirty="0">
                    <a:latin typeface="Arial" panose="020B0604020202020204" pitchFamily="34" charset="0"/>
                    <a:cs typeface="Arial" panose="020B0604020202020204" pitchFamily="34" charset="0"/>
                  </a:rPr>
                  <a:t>1.2</a:t>
                </a:r>
              </a:p>
            </p:txBody>
          </p:sp>
          <p:sp>
            <p:nvSpPr>
              <p:cNvPr id="27" name="TextBox 91">
                <a:extLst>
                  <a:ext uri="{FF2B5EF4-FFF2-40B4-BE49-F238E27FC236}">
                    <a16:creationId xmlns:a16="http://schemas.microsoft.com/office/drawing/2014/main" id="{A2C3F980-7447-4D32-61AC-05BDAAA494C6}"/>
                  </a:ext>
                </a:extLst>
              </p:cNvPr>
              <p:cNvSpPr txBox="1"/>
              <p:nvPr/>
            </p:nvSpPr>
            <p:spPr>
              <a:xfrm>
                <a:off x="3983050" y="6555094"/>
                <a:ext cx="443113" cy="24820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13" b="1" dirty="0">
                    <a:latin typeface="Arial" panose="020B0604020202020204" pitchFamily="34" charset="0"/>
                    <a:cs typeface="Arial" panose="020B0604020202020204" pitchFamily="34" charset="0"/>
                  </a:rPr>
                  <a:t>1.1</a:t>
                </a:r>
              </a:p>
            </p:txBody>
          </p:sp>
          <p:sp>
            <p:nvSpPr>
              <p:cNvPr id="28" name="TextBox 92">
                <a:extLst>
                  <a:ext uri="{FF2B5EF4-FFF2-40B4-BE49-F238E27FC236}">
                    <a16:creationId xmlns:a16="http://schemas.microsoft.com/office/drawing/2014/main" id="{20EF108E-FB1C-9AE8-E285-2239D729F152}"/>
                  </a:ext>
                </a:extLst>
              </p:cNvPr>
              <p:cNvSpPr txBox="1"/>
              <p:nvPr/>
            </p:nvSpPr>
            <p:spPr>
              <a:xfrm>
                <a:off x="4279522" y="6555094"/>
                <a:ext cx="443113" cy="24820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13" b="1" dirty="0">
                    <a:latin typeface="Arial" panose="020B0604020202020204" pitchFamily="34" charset="0"/>
                    <a:cs typeface="Arial" panose="020B0604020202020204" pitchFamily="34" charset="0"/>
                  </a:rPr>
                  <a:t>3.9</a:t>
                </a:r>
              </a:p>
            </p:txBody>
          </p:sp>
          <p:sp>
            <p:nvSpPr>
              <p:cNvPr id="29" name="TextBox 93">
                <a:extLst>
                  <a:ext uri="{FF2B5EF4-FFF2-40B4-BE49-F238E27FC236}">
                    <a16:creationId xmlns:a16="http://schemas.microsoft.com/office/drawing/2014/main" id="{D977774C-7E7F-800A-E3D1-B5B30586FE42}"/>
                  </a:ext>
                </a:extLst>
              </p:cNvPr>
              <p:cNvSpPr txBox="1"/>
              <p:nvPr/>
            </p:nvSpPr>
            <p:spPr>
              <a:xfrm>
                <a:off x="4575993" y="6555094"/>
                <a:ext cx="443113" cy="24820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13" b="1" dirty="0">
                    <a:latin typeface="Arial" panose="020B0604020202020204" pitchFamily="34" charset="0"/>
                    <a:cs typeface="Arial" panose="020B0604020202020204" pitchFamily="34" charset="0"/>
                  </a:rPr>
                  <a:t>1.2</a:t>
                </a:r>
              </a:p>
            </p:txBody>
          </p:sp>
          <p:sp>
            <p:nvSpPr>
              <p:cNvPr id="30" name="TextBox 94">
                <a:extLst>
                  <a:ext uri="{FF2B5EF4-FFF2-40B4-BE49-F238E27FC236}">
                    <a16:creationId xmlns:a16="http://schemas.microsoft.com/office/drawing/2014/main" id="{73529A55-82DE-573B-6CDB-04FC92122FEF}"/>
                  </a:ext>
                </a:extLst>
              </p:cNvPr>
              <p:cNvSpPr txBox="1"/>
              <p:nvPr/>
            </p:nvSpPr>
            <p:spPr>
              <a:xfrm>
                <a:off x="4872466" y="6555094"/>
                <a:ext cx="443113" cy="24820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13" b="1" dirty="0">
                    <a:latin typeface="Arial" panose="020B0604020202020204" pitchFamily="34" charset="0"/>
                    <a:cs typeface="Arial" panose="020B0604020202020204" pitchFamily="34" charset="0"/>
                  </a:rPr>
                  <a:t>1.7</a:t>
                </a:r>
              </a:p>
            </p:txBody>
          </p:sp>
          <p:sp>
            <p:nvSpPr>
              <p:cNvPr id="31" name="TextBox 95">
                <a:extLst>
                  <a:ext uri="{FF2B5EF4-FFF2-40B4-BE49-F238E27FC236}">
                    <a16:creationId xmlns:a16="http://schemas.microsoft.com/office/drawing/2014/main" id="{8369E298-1B6B-8338-2696-78C4AE9413AC}"/>
                  </a:ext>
                </a:extLst>
              </p:cNvPr>
              <p:cNvSpPr txBox="1"/>
              <p:nvPr/>
            </p:nvSpPr>
            <p:spPr>
              <a:xfrm>
                <a:off x="5232245" y="6555094"/>
                <a:ext cx="443113" cy="24820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13" b="1" dirty="0">
                    <a:latin typeface="Arial" panose="020B0604020202020204" pitchFamily="34" charset="0"/>
                    <a:cs typeface="Arial" panose="020B0604020202020204" pitchFamily="34" charset="0"/>
                  </a:rPr>
                  <a:t>1.0</a:t>
                </a:r>
              </a:p>
            </p:txBody>
          </p:sp>
          <p:pic>
            <p:nvPicPr>
              <p:cNvPr id="32" name="Picture 31" descr="A close-up of a test&#10;&#10;Description automatically generated with low confidence">
                <a:extLst>
                  <a:ext uri="{FF2B5EF4-FFF2-40B4-BE49-F238E27FC236}">
                    <a16:creationId xmlns:a16="http://schemas.microsoft.com/office/drawing/2014/main" id="{17B7A5CC-2BE8-9043-B6E9-230B66C46964}"/>
                  </a:ext>
                </a:extLst>
              </p:cNvPr>
              <p:cNvPicPr>
                <a:picLocks/>
              </p:cNvPicPr>
              <p:nvPr/>
            </p:nvPicPr>
            <p:blipFill rotWithShape="1">
              <a:blip r:embed="rId6" cstate="email">
                <a:extLst>
                  <a:ext uri="{28A0092B-C50C-407E-A947-70E740481C1C}">
                    <a14:useLocalDpi xmlns:a14="http://schemas.microsoft.com/office/drawing/2010/main"/>
                  </a:ext>
                </a:extLst>
              </a:blip>
              <a:srcRect/>
              <a:stretch/>
            </p:blipFill>
            <p:spPr>
              <a:xfrm>
                <a:off x="2443874" y="6863649"/>
                <a:ext cx="3061053" cy="310495"/>
              </a:xfrm>
              <a:prstGeom prst="rect">
                <a:avLst/>
              </a:prstGeom>
              <a:ln>
                <a:solidFill>
                  <a:schemeClr val="tx1"/>
                </a:solidFill>
              </a:ln>
            </p:spPr>
          </p:pic>
          <p:sp>
            <p:nvSpPr>
              <p:cNvPr id="33" name="TextBox 98">
                <a:extLst>
                  <a:ext uri="{FF2B5EF4-FFF2-40B4-BE49-F238E27FC236}">
                    <a16:creationId xmlns:a16="http://schemas.microsoft.com/office/drawing/2014/main" id="{4166230F-92E9-414F-CD73-4174909E7BA8}"/>
                  </a:ext>
                </a:extLst>
              </p:cNvPr>
              <p:cNvSpPr txBox="1"/>
              <p:nvPr/>
            </p:nvSpPr>
            <p:spPr>
              <a:xfrm>
                <a:off x="1873831" y="6897798"/>
                <a:ext cx="612900" cy="24820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r"/>
                <a:r>
                  <a:rPr lang="el-GR" sz="1013" b="1" dirty="0">
                    <a:latin typeface="Arial" panose="020B0604020202020204" pitchFamily="34" charset="0"/>
                    <a:cs typeface="Arial" panose="020B0604020202020204" pitchFamily="34" charset="0"/>
                  </a:rPr>
                  <a:t>β</a:t>
                </a:r>
                <a:r>
                  <a:rPr lang="en-US" sz="1013" b="1" dirty="0">
                    <a:latin typeface="Arial" panose="020B0604020202020204" pitchFamily="34" charset="0"/>
                    <a:cs typeface="Arial" panose="020B0604020202020204" pitchFamily="34" charset="0"/>
                  </a:rPr>
                  <a:t>-actin</a:t>
                </a:r>
              </a:p>
            </p:txBody>
          </p:sp>
          <p:sp>
            <p:nvSpPr>
              <p:cNvPr id="34" name="TextBox 99">
                <a:extLst>
                  <a:ext uri="{FF2B5EF4-FFF2-40B4-BE49-F238E27FC236}">
                    <a16:creationId xmlns:a16="http://schemas.microsoft.com/office/drawing/2014/main" id="{521757FA-7917-3CF2-740E-7767AB913C76}"/>
                  </a:ext>
                </a:extLst>
              </p:cNvPr>
              <p:cNvSpPr txBox="1"/>
              <p:nvPr/>
            </p:nvSpPr>
            <p:spPr>
              <a:xfrm>
                <a:off x="5468895" y="6876696"/>
                <a:ext cx="661363" cy="24820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13" b="1" dirty="0">
                    <a:latin typeface="Arial" panose="020B0604020202020204" pitchFamily="34" charset="0"/>
                    <a:cs typeface="Arial" panose="020B0604020202020204" pitchFamily="34" charset="0"/>
                  </a:rPr>
                  <a:t>42 </a:t>
                </a:r>
                <a:r>
                  <a:rPr lang="en-US" sz="1013" b="1" dirty="0" err="1">
                    <a:latin typeface="Arial" panose="020B0604020202020204" pitchFamily="34" charset="0"/>
                    <a:cs typeface="Arial" panose="020B0604020202020204" pitchFamily="34" charset="0"/>
                  </a:rPr>
                  <a:t>kDa</a:t>
                </a:r>
                <a:endParaRPr lang="en-US" sz="1013" b="1" dirty="0">
                  <a:latin typeface="Arial" panose="020B0604020202020204" pitchFamily="34" charset="0"/>
                  <a:cs typeface="Arial" panose="020B0604020202020204" pitchFamily="34" charset="0"/>
                </a:endParaRPr>
              </a:p>
            </p:txBody>
          </p:sp>
        </p:grpSp>
        <p:grpSp>
          <p:nvGrpSpPr>
            <p:cNvPr id="37" name="Group 36">
              <a:extLst>
                <a:ext uri="{FF2B5EF4-FFF2-40B4-BE49-F238E27FC236}">
                  <a16:creationId xmlns:a16="http://schemas.microsoft.com/office/drawing/2014/main" id="{E7A40E42-3DE3-8D92-1540-C97E1E5B9A49}"/>
                </a:ext>
              </a:extLst>
            </p:cNvPr>
            <p:cNvGrpSpPr/>
            <p:nvPr/>
          </p:nvGrpSpPr>
          <p:grpSpPr>
            <a:xfrm>
              <a:off x="616928" y="3321287"/>
              <a:ext cx="6686057" cy="3167009"/>
              <a:chOff x="945789" y="3650148"/>
              <a:chExt cx="6686057" cy="3167009"/>
            </a:xfrm>
          </p:grpSpPr>
          <p:sp>
            <p:nvSpPr>
              <p:cNvPr id="103" name="TextBox 102">
                <a:extLst>
                  <a:ext uri="{FF2B5EF4-FFF2-40B4-BE49-F238E27FC236}">
                    <a16:creationId xmlns:a16="http://schemas.microsoft.com/office/drawing/2014/main" id="{4FDCB41D-7B05-F41E-DFCE-4F73845975E6}"/>
                  </a:ext>
                </a:extLst>
              </p:cNvPr>
              <p:cNvSpPr txBox="1"/>
              <p:nvPr/>
            </p:nvSpPr>
            <p:spPr>
              <a:xfrm>
                <a:off x="6968331" y="5157334"/>
                <a:ext cx="327334" cy="400110"/>
              </a:xfrm>
              <a:prstGeom prst="rect">
                <a:avLst/>
              </a:prstGeom>
              <a:noFill/>
            </p:spPr>
            <p:txBody>
              <a:bodyPr wrap="none" rtlCol="0">
                <a:spAutoFit/>
              </a:bodyPr>
              <a:lstStyle>
                <a:defPPr>
                  <a:defRPr lang="en-US"/>
                </a:defPPr>
                <a:lvl1pPr>
                  <a:defRPr sz="1400" b="1">
                    <a:latin typeface="Arial" panose="020B0604020202020204" pitchFamily="34" charset="0"/>
                    <a:cs typeface="Arial" panose="020B0604020202020204" pitchFamily="34" charset="0"/>
                  </a:defRPr>
                </a:lvl1pPr>
              </a:lstStyle>
              <a:p>
                <a:r>
                  <a:rPr lang="en-US" sz="2000" dirty="0"/>
                  <a:t>c</a:t>
                </a:r>
              </a:p>
            </p:txBody>
          </p:sp>
          <p:pic>
            <p:nvPicPr>
              <p:cNvPr id="38" name="Picture 37" descr="A close-up of a test&#10;&#10;Description automatically generated with low confidence">
                <a:extLst>
                  <a:ext uri="{FF2B5EF4-FFF2-40B4-BE49-F238E27FC236}">
                    <a16:creationId xmlns:a16="http://schemas.microsoft.com/office/drawing/2014/main" id="{387663DB-FC93-39FF-81A3-75B0A27C1E0C}"/>
                  </a:ext>
                </a:extLst>
              </p:cNvPr>
              <p:cNvPicPr>
                <a:picLocks noChangeAspect="1"/>
              </p:cNvPicPr>
              <p:nvPr/>
            </p:nvPicPr>
            <p:blipFill rotWithShape="1">
              <a:blip r:embed="rId7" cstate="email">
                <a:extLst>
                  <a:ext uri="{28A0092B-C50C-407E-A947-70E740481C1C}">
                    <a14:useLocalDpi xmlns:a14="http://schemas.microsoft.com/office/drawing/2010/main"/>
                  </a:ext>
                </a:extLst>
              </a:blip>
              <a:srcRect/>
              <a:stretch/>
            </p:blipFill>
            <p:spPr>
              <a:xfrm>
                <a:off x="4202846" y="4522035"/>
                <a:ext cx="3075520" cy="2061182"/>
              </a:xfrm>
              <a:prstGeom prst="rect">
                <a:avLst/>
              </a:prstGeom>
            </p:spPr>
          </p:pic>
          <p:pic>
            <p:nvPicPr>
              <p:cNvPr id="39" name="Picture 38" descr="A piece of paper with black lines&#10;&#10;Description automatically generated with low confidence">
                <a:extLst>
                  <a:ext uri="{FF2B5EF4-FFF2-40B4-BE49-F238E27FC236}">
                    <a16:creationId xmlns:a16="http://schemas.microsoft.com/office/drawing/2014/main" id="{FBCCF87B-54B6-78B8-84E5-99FAD3641F55}"/>
                  </a:ext>
                </a:extLst>
              </p:cNvPr>
              <p:cNvPicPr>
                <a:picLocks noChangeAspect="1"/>
              </p:cNvPicPr>
              <p:nvPr/>
            </p:nvPicPr>
            <p:blipFill rotWithShape="1">
              <a:blip r:embed="rId8" cstate="email">
                <a:extLst>
                  <a:ext uri="{28A0092B-C50C-407E-A947-70E740481C1C}">
                    <a14:useLocalDpi xmlns:a14="http://schemas.microsoft.com/office/drawing/2010/main"/>
                  </a:ext>
                </a:extLst>
              </a:blip>
              <a:srcRect/>
              <a:stretch/>
            </p:blipFill>
            <p:spPr>
              <a:xfrm>
                <a:off x="945789" y="4489932"/>
                <a:ext cx="3192026" cy="2327225"/>
              </a:xfrm>
              <a:prstGeom prst="rect">
                <a:avLst/>
              </a:prstGeom>
            </p:spPr>
          </p:pic>
          <p:sp>
            <p:nvSpPr>
              <p:cNvPr id="40" name="TextBox 6">
                <a:extLst>
                  <a:ext uri="{FF2B5EF4-FFF2-40B4-BE49-F238E27FC236}">
                    <a16:creationId xmlns:a16="http://schemas.microsoft.com/office/drawing/2014/main" id="{C3290AC1-2CAB-9AF6-8D1F-EF12B4EE04FC}"/>
                  </a:ext>
                </a:extLst>
              </p:cNvPr>
              <p:cNvSpPr txBox="1"/>
              <p:nvPr/>
            </p:nvSpPr>
            <p:spPr>
              <a:xfrm>
                <a:off x="945789" y="4253611"/>
                <a:ext cx="510076" cy="248209"/>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13" dirty="0">
                    <a:latin typeface="Arial" panose="020B0604020202020204" pitchFamily="34" charset="0"/>
                    <a:cs typeface="Arial" panose="020B0604020202020204" pitchFamily="34" charset="0"/>
                  </a:rPr>
                  <a:t>m068</a:t>
                </a:r>
              </a:p>
            </p:txBody>
          </p:sp>
          <p:sp>
            <p:nvSpPr>
              <p:cNvPr id="41" name="TextBox 7">
                <a:extLst>
                  <a:ext uri="{FF2B5EF4-FFF2-40B4-BE49-F238E27FC236}">
                    <a16:creationId xmlns:a16="http://schemas.microsoft.com/office/drawing/2014/main" id="{6959AB70-FF7D-0C45-CA7E-9D7DC046A438}"/>
                  </a:ext>
                </a:extLst>
              </p:cNvPr>
              <p:cNvSpPr txBox="1"/>
              <p:nvPr/>
            </p:nvSpPr>
            <p:spPr>
              <a:xfrm>
                <a:off x="4163865" y="4280047"/>
                <a:ext cx="510076" cy="248209"/>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13" dirty="0">
                    <a:latin typeface="Arial" panose="020B0604020202020204" pitchFamily="34" charset="0"/>
                    <a:cs typeface="Arial" panose="020B0604020202020204" pitchFamily="34" charset="0"/>
                  </a:rPr>
                  <a:t>m069</a:t>
                </a:r>
              </a:p>
            </p:txBody>
          </p:sp>
          <p:sp>
            <p:nvSpPr>
              <p:cNvPr id="42" name="TextBox 8">
                <a:extLst>
                  <a:ext uri="{FF2B5EF4-FFF2-40B4-BE49-F238E27FC236}">
                    <a16:creationId xmlns:a16="http://schemas.microsoft.com/office/drawing/2014/main" id="{FFC4FBD3-99DE-98B4-5C5F-51D53E680971}"/>
                  </a:ext>
                </a:extLst>
              </p:cNvPr>
              <p:cNvSpPr txBox="1"/>
              <p:nvPr/>
            </p:nvSpPr>
            <p:spPr>
              <a:xfrm rot="18161804">
                <a:off x="1273607" y="4449555"/>
                <a:ext cx="498855"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dirty="0">
                    <a:latin typeface="Arial" panose="020B0604020202020204" pitchFamily="34" charset="0"/>
                    <a:cs typeface="Arial" panose="020B0604020202020204" pitchFamily="34" charset="0"/>
                  </a:rPr>
                  <a:t>UCD4</a:t>
                </a:r>
              </a:p>
            </p:txBody>
          </p:sp>
          <p:sp>
            <p:nvSpPr>
              <p:cNvPr id="43" name="TextBox 10">
                <a:extLst>
                  <a:ext uri="{FF2B5EF4-FFF2-40B4-BE49-F238E27FC236}">
                    <a16:creationId xmlns:a16="http://schemas.microsoft.com/office/drawing/2014/main" id="{F0D0B9FE-5E93-CE64-397F-D0317ED54EA4}"/>
                  </a:ext>
                </a:extLst>
              </p:cNvPr>
              <p:cNvSpPr txBox="1"/>
              <p:nvPr/>
            </p:nvSpPr>
            <p:spPr>
              <a:xfrm rot="18161804">
                <a:off x="1581981" y="4320052"/>
                <a:ext cx="806631"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dirty="0">
                    <a:latin typeface="Arial" panose="020B0604020202020204" pitchFamily="34" charset="0"/>
                    <a:cs typeface="Arial" panose="020B0604020202020204" pitchFamily="34" charset="0"/>
                  </a:rPr>
                  <a:t>UCD4-EWD</a:t>
                </a:r>
              </a:p>
            </p:txBody>
          </p:sp>
          <p:sp>
            <p:nvSpPr>
              <p:cNvPr id="44" name="TextBox 11">
                <a:extLst>
                  <a:ext uri="{FF2B5EF4-FFF2-40B4-BE49-F238E27FC236}">
                    <a16:creationId xmlns:a16="http://schemas.microsoft.com/office/drawing/2014/main" id="{A4A78C9D-8505-EB62-5D74-98705FFEC561}"/>
                  </a:ext>
                </a:extLst>
              </p:cNvPr>
              <p:cNvSpPr txBox="1"/>
              <p:nvPr/>
            </p:nvSpPr>
            <p:spPr>
              <a:xfrm rot="18161804">
                <a:off x="1738356" y="4287570"/>
                <a:ext cx="883830"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dirty="0">
                    <a:latin typeface="Arial" panose="020B0604020202020204" pitchFamily="34" charset="0"/>
                    <a:cs typeface="Arial" panose="020B0604020202020204" pitchFamily="34" charset="0"/>
                  </a:rPr>
                  <a:t>UCD4-TamR</a:t>
                </a:r>
              </a:p>
            </p:txBody>
          </p:sp>
          <p:sp>
            <p:nvSpPr>
              <p:cNvPr id="46" name="TextBox 12">
                <a:extLst>
                  <a:ext uri="{FF2B5EF4-FFF2-40B4-BE49-F238E27FC236}">
                    <a16:creationId xmlns:a16="http://schemas.microsoft.com/office/drawing/2014/main" id="{CCCC86D0-2EC2-883F-2E2C-93D5D7AEC960}"/>
                  </a:ext>
                </a:extLst>
              </p:cNvPr>
              <p:cNvSpPr txBox="1"/>
              <p:nvPr/>
            </p:nvSpPr>
            <p:spPr>
              <a:xfrm rot="18161804">
                <a:off x="1900800" y="4208417"/>
                <a:ext cx="1071942" cy="230832"/>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dirty="0">
                    <a:latin typeface="Arial" panose="020B0604020202020204" pitchFamily="34" charset="0"/>
                    <a:cs typeface="Arial" panose="020B0604020202020204" pitchFamily="34" charset="0"/>
                  </a:rPr>
                  <a:t>UCD4-FulvR</a:t>
                </a:r>
              </a:p>
            </p:txBody>
          </p:sp>
          <p:sp>
            <p:nvSpPr>
              <p:cNvPr id="47" name="TextBox 13">
                <a:extLst>
                  <a:ext uri="{FF2B5EF4-FFF2-40B4-BE49-F238E27FC236}">
                    <a16:creationId xmlns:a16="http://schemas.microsoft.com/office/drawing/2014/main" id="{BD5530B7-BBB6-2FFD-8A6B-6F7C9F632B81}"/>
                  </a:ext>
                </a:extLst>
              </p:cNvPr>
              <p:cNvSpPr txBox="1"/>
              <p:nvPr/>
            </p:nvSpPr>
            <p:spPr>
              <a:xfrm rot="18161804">
                <a:off x="2272508" y="4463045"/>
                <a:ext cx="466794"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dirty="0">
                    <a:latin typeface="Arial" panose="020B0604020202020204" pitchFamily="34" charset="0"/>
                    <a:cs typeface="Arial" panose="020B0604020202020204" pitchFamily="34" charset="0"/>
                  </a:rPr>
                  <a:t>T47D</a:t>
                </a:r>
              </a:p>
            </p:txBody>
          </p:sp>
          <p:sp>
            <p:nvSpPr>
              <p:cNvPr id="48" name="TextBox 14">
                <a:extLst>
                  <a:ext uri="{FF2B5EF4-FFF2-40B4-BE49-F238E27FC236}">
                    <a16:creationId xmlns:a16="http://schemas.microsoft.com/office/drawing/2014/main" id="{5E82068B-3E87-2DB2-A55D-3554D77276A7}"/>
                  </a:ext>
                </a:extLst>
              </p:cNvPr>
              <p:cNvSpPr txBox="1"/>
              <p:nvPr/>
            </p:nvSpPr>
            <p:spPr>
              <a:xfrm rot="18161804">
                <a:off x="2321669" y="4119187"/>
                <a:ext cx="1168910"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dirty="0">
                    <a:latin typeface="Arial" panose="020B0604020202020204" pitchFamily="34" charset="0"/>
                    <a:cs typeface="Arial" panose="020B0604020202020204" pitchFamily="34" charset="0"/>
                  </a:rPr>
                  <a:t>T47D + Oligomycin</a:t>
                </a:r>
              </a:p>
            </p:txBody>
          </p:sp>
          <p:sp>
            <p:nvSpPr>
              <p:cNvPr id="52" name="TextBox 16">
                <a:extLst>
                  <a:ext uri="{FF2B5EF4-FFF2-40B4-BE49-F238E27FC236}">
                    <a16:creationId xmlns:a16="http://schemas.microsoft.com/office/drawing/2014/main" id="{0DC77D11-9A82-FD8A-92D9-09AF98EBCFBC}"/>
                  </a:ext>
                </a:extLst>
              </p:cNvPr>
              <p:cNvSpPr txBox="1"/>
              <p:nvPr/>
            </p:nvSpPr>
            <p:spPr>
              <a:xfrm rot="18161804">
                <a:off x="2759978" y="4314656"/>
                <a:ext cx="819455"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dirty="0">
                    <a:latin typeface="Arial" panose="020B0604020202020204" pitchFamily="34" charset="0"/>
                    <a:cs typeface="Arial" panose="020B0604020202020204" pitchFamily="34" charset="0"/>
                  </a:rPr>
                  <a:t>T47D-TamR</a:t>
                </a:r>
              </a:p>
            </p:txBody>
          </p:sp>
          <p:sp>
            <p:nvSpPr>
              <p:cNvPr id="54" name="TextBox 17">
                <a:extLst>
                  <a:ext uri="{FF2B5EF4-FFF2-40B4-BE49-F238E27FC236}">
                    <a16:creationId xmlns:a16="http://schemas.microsoft.com/office/drawing/2014/main" id="{8E7638D4-D410-E696-7979-70D1D893B9F8}"/>
                  </a:ext>
                </a:extLst>
              </p:cNvPr>
              <p:cNvSpPr txBox="1"/>
              <p:nvPr/>
            </p:nvSpPr>
            <p:spPr>
              <a:xfrm rot="18161804">
                <a:off x="3063239" y="4300919"/>
                <a:ext cx="806631"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dirty="0">
                    <a:latin typeface="Arial" panose="020B0604020202020204" pitchFamily="34" charset="0"/>
                    <a:cs typeface="Arial" panose="020B0604020202020204" pitchFamily="34" charset="0"/>
                  </a:rPr>
                  <a:t>T47D-FulvR</a:t>
                </a:r>
              </a:p>
            </p:txBody>
          </p:sp>
          <p:sp>
            <p:nvSpPr>
              <p:cNvPr id="55" name="TextBox 19">
                <a:extLst>
                  <a:ext uri="{FF2B5EF4-FFF2-40B4-BE49-F238E27FC236}">
                    <a16:creationId xmlns:a16="http://schemas.microsoft.com/office/drawing/2014/main" id="{4ECA8521-5D79-29A3-C57E-EE04BD334A9C}"/>
                  </a:ext>
                </a:extLst>
              </p:cNvPr>
              <p:cNvSpPr txBox="1"/>
              <p:nvPr/>
            </p:nvSpPr>
            <p:spPr>
              <a:xfrm rot="18161804">
                <a:off x="4613785" y="4527217"/>
                <a:ext cx="498855"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dirty="0">
                    <a:latin typeface="Arial" panose="020B0604020202020204" pitchFamily="34" charset="0"/>
                    <a:cs typeface="Arial" panose="020B0604020202020204" pitchFamily="34" charset="0"/>
                  </a:rPr>
                  <a:t>UCD4</a:t>
                </a:r>
              </a:p>
            </p:txBody>
          </p:sp>
          <p:sp>
            <p:nvSpPr>
              <p:cNvPr id="56" name="TextBox 21">
                <a:extLst>
                  <a:ext uri="{FF2B5EF4-FFF2-40B4-BE49-F238E27FC236}">
                    <a16:creationId xmlns:a16="http://schemas.microsoft.com/office/drawing/2014/main" id="{4D55BA06-91D3-60E2-B34D-67CF936C9B1C}"/>
                  </a:ext>
                </a:extLst>
              </p:cNvPr>
              <p:cNvSpPr txBox="1"/>
              <p:nvPr/>
            </p:nvSpPr>
            <p:spPr>
              <a:xfrm rot="18161804">
                <a:off x="4940354" y="4397714"/>
                <a:ext cx="806631"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dirty="0">
                    <a:latin typeface="Arial" panose="020B0604020202020204" pitchFamily="34" charset="0"/>
                    <a:cs typeface="Arial" panose="020B0604020202020204" pitchFamily="34" charset="0"/>
                  </a:rPr>
                  <a:t>UCD4-EWD</a:t>
                </a:r>
              </a:p>
            </p:txBody>
          </p:sp>
          <p:sp>
            <p:nvSpPr>
              <p:cNvPr id="57" name="TextBox 22">
                <a:extLst>
                  <a:ext uri="{FF2B5EF4-FFF2-40B4-BE49-F238E27FC236}">
                    <a16:creationId xmlns:a16="http://schemas.microsoft.com/office/drawing/2014/main" id="{19729210-62E8-F24A-968C-9826CB9E5BE5}"/>
                  </a:ext>
                </a:extLst>
              </p:cNvPr>
              <p:cNvSpPr txBox="1"/>
              <p:nvPr/>
            </p:nvSpPr>
            <p:spPr>
              <a:xfrm rot="18161804">
                <a:off x="5125639" y="4368130"/>
                <a:ext cx="876939"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dirty="0">
                    <a:latin typeface="Arial" panose="020B0604020202020204" pitchFamily="34" charset="0"/>
                    <a:cs typeface="Arial" panose="020B0604020202020204" pitchFamily="34" charset="0"/>
                  </a:rPr>
                  <a:t>UCD4-TamR</a:t>
                </a:r>
              </a:p>
            </p:txBody>
          </p:sp>
          <p:sp>
            <p:nvSpPr>
              <p:cNvPr id="58" name="TextBox 23">
                <a:extLst>
                  <a:ext uri="{FF2B5EF4-FFF2-40B4-BE49-F238E27FC236}">
                    <a16:creationId xmlns:a16="http://schemas.microsoft.com/office/drawing/2014/main" id="{EA430C4E-87E1-F8A8-63C1-4138D8B1DD3F}"/>
                  </a:ext>
                </a:extLst>
              </p:cNvPr>
              <p:cNvSpPr txBox="1"/>
              <p:nvPr/>
            </p:nvSpPr>
            <p:spPr>
              <a:xfrm rot="18161804">
                <a:off x="5343767" y="4384224"/>
                <a:ext cx="838691"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dirty="0">
                    <a:latin typeface="Arial" panose="020B0604020202020204" pitchFamily="34" charset="0"/>
                    <a:cs typeface="Arial" panose="020B0604020202020204" pitchFamily="34" charset="0"/>
                  </a:rPr>
                  <a:t>UCD4-FulvR</a:t>
                </a:r>
              </a:p>
            </p:txBody>
          </p:sp>
          <p:sp>
            <p:nvSpPr>
              <p:cNvPr id="59" name="TextBox 24">
                <a:extLst>
                  <a:ext uri="{FF2B5EF4-FFF2-40B4-BE49-F238E27FC236}">
                    <a16:creationId xmlns:a16="http://schemas.microsoft.com/office/drawing/2014/main" id="{5153D5EA-EE60-1005-A661-B419D8E74F82}"/>
                  </a:ext>
                </a:extLst>
              </p:cNvPr>
              <p:cNvSpPr txBox="1"/>
              <p:nvPr/>
            </p:nvSpPr>
            <p:spPr>
              <a:xfrm rot="18161804">
                <a:off x="5599691" y="4540707"/>
                <a:ext cx="466794"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dirty="0">
                    <a:latin typeface="Arial" panose="020B0604020202020204" pitchFamily="34" charset="0"/>
                    <a:cs typeface="Arial" panose="020B0604020202020204" pitchFamily="34" charset="0"/>
                  </a:rPr>
                  <a:t>T47D</a:t>
                </a:r>
              </a:p>
            </p:txBody>
          </p:sp>
          <p:sp>
            <p:nvSpPr>
              <p:cNvPr id="60" name="TextBox 25">
                <a:extLst>
                  <a:ext uri="{FF2B5EF4-FFF2-40B4-BE49-F238E27FC236}">
                    <a16:creationId xmlns:a16="http://schemas.microsoft.com/office/drawing/2014/main" id="{E731CF68-AB51-FD3E-21E8-F17C09F84766}"/>
                  </a:ext>
                </a:extLst>
              </p:cNvPr>
              <p:cNvSpPr txBox="1"/>
              <p:nvPr/>
            </p:nvSpPr>
            <p:spPr>
              <a:xfrm rot="18161804">
                <a:off x="5648862" y="4245277"/>
                <a:ext cx="1168910"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dirty="0">
                    <a:latin typeface="Arial" panose="020B0604020202020204" pitchFamily="34" charset="0"/>
                    <a:cs typeface="Arial" panose="020B0604020202020204" pitchFamily="34" charset="0"/>
                  </a:rPr>
                  <a:t>T47D + Oligomycin</a:t>
                </a:r>
              </a:p>
            </p:txBody>
          </p:sp>
          <p:sp>
            <p:nvSpPr>
              <p:cNvPr id="62" name="TextBox 27">
                <a:extLst>
                  <a:ext uri="{FF2B5EF4-FFF2-40B4-BE49-F238E27FC236}">
                    <a16:creationId xmlns:a16="http://schemas.microsoft.com/office/drawing/2014/main" id="{A97EEA04-5C5C-48AA-0669-9F268F036505}"/>
                  </a:ext>
                </a:extLst>
              </p:cNvPr>
              <p:cNvSpPr txBox="1"/>
              <p:nvPr/>
            </p:nvSpPr>
            <p:spPr>
              <a:xfrm rot="18161804">
                <a:off x="6180262" y="4392318"/>
                <a:ext cx="819455"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dirty="0">
                    <a:latin typeface="Arial" panose="020B0604020202020204" pitchFamily="34" charset="0"/>
                    <a:cs typeface="Arial" panose="020B0604020202020204" pitchFamily="34" charset="0"/>
                  </a:rPr>
                  <a:t>T47D-TamR</a:t>
                </a:r>
              </a:p>
            </p:txBody>
          </p:sp>
          <p:sp>
            <p:nvSpPr>
              <p:cNvPr id="63" name="TextBox 28">
                <a:extLst>
                  <a:ext uri="{FF2B5EF4-FFF2-40B4-BE49-F238E27FC236}">
                    <a16:creationId xmlns:a16="http://schemas.microsoft.com/office/drawing/2014/main" id="{9078C77D-C6A8-F12D-EB8C-53E6A3139D24}"/>
                  </a:ext>
                </a:extLst>
              </p:cNvPr>
              <p:cNvSpPr txBox="1"/>
              <p:nvPr/>
            </p:nvSpPr>
            <p:spPr>
              <a:xfrm rot="18161804">
                <a:off x="6366594" y="4397714"/>
                <a:ext cx="806631"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dirty="0">
                    <a:latin typeface="Arial" panose="020B0604020202020204" pitchFamily="34" charset="0"/>
                    <a:cs typeface="Arial" panose="020B0604020202020204" pitchFamily="34" charset="0"/>
                  </a:rPr>
                  <a:t>T47D-FulvR</a:t>
                </a:r>
              </a:p>
            </p:txBody>
          </p:sp>
          <p:sp>
            <p:nvSpPr>
              <p:cNvPr id="65" name="TextBox 31">
                <a:extLst>
                  <a:ext uri="{FF2B5EF4-FFF2-40B4-BE49-F238E27FC236}">
                    <a16:creationId xmlns:a16="http://schemas.microsoft.com/office/drawing/2014/main" id="{957F91A5-3EFA-B3E3-8D12-E7425B5BD4AB}"/>
                  </a:ext>
                </a:extLst>
              </p:cNvPr>
              <p:cNvSpPr txBox="1"/>
              <p:nvPr/>
            </p:nvSpPr>
            <p:spPr>
              <a:xfrm>
                <a:off x="3434869" y="4720155"/>
                <a:ext cx="532518" cy="248209"/>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13" dirty="0">
                    <a:latin typeface="Arial" panose="020B0604020202020204" pitchFamily="34" charset="0"/>
                    <a:cs typeface="Arial" panose="020B0604020202020204" pitchFamily="34" charset="0"/>
                  </a:rPr>
                  <a:t>ACC1</a:t>
                </a:r>
              </a:p>
            </p:txBody>
          </p:sp>
          <p:sp>
            <p:nvSpPr>
              <p:cNvPr id="66" name="TextBox 32">
                <a:extLst>
                  <a:ext uri="{FF2B5EF4-FFF2-40B4-BE49-F238E27FC236}">
                    <a16:creationId xmlns:a16="http://schemas.microsoft.com/office/drawing/2014/main" id="{DD4BD6C1-6F7B-1D90-28B5-91A97BC6398A}"/>
                  </a:ext>
                </a:extLst>
              </p:cNvPr>
              <p:cNvSpPr txBox="1"/>
              <p:nvPr/>
            </p:nvSpPr>
            <p:spPr>
              <a:xfrm>
                <a:off x="3481218" y="5816843"/>
                <a:ext cx="579005" cy="248209"/>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l-GR" sz="1013" dirty="0">
                    <a:latin typeface="Arial" panose="020B0604020202020204" pitchFamily="34" charset="0"/>
                    <a:cs typeface="Arial" panose="020B0604020202020204" pitchFamily="34" charset="0"/>
                  </a:rPr>
                  <a:t>β</a:t>
                </a:r>
                <a:r>
                  <a:rPr lang="en-US" sz="1013" dirty="0">
                    <a:latin typeface="Arial" panose="020B0604020202020204" pitchFamily="34" charset="0"/>
                    <a:cs typeface="Arial" panose="020B0604020202020204" pitchFamily="34" charset="0"/>
                  </a:rPr>
                  <a:t>-actin</a:t>
                </a:r>
              </a:p>
            </p:txBody>
          </p:sp>
          <p:sp>
            <p:nvSpPr>
              <p:cNvPr id="67" name="TextBox 34">
                <a:extLst>
                  <a:ext uri="{FF2B5EF4-FFF2-40B4-BE49-F238E27FC236}">
                    <a16:creationId xmlns:a16="http://schemas.microsoft.com/office/drawing/2014/main" id="{08DF3DEB-C514-9752-EA92-218D2AE6A5C3}"/>
                  </a:ext>
                </a:extLst>
              </p:cNvPr>
              <p:cNvSpPr txBox="1"/>
              <p:nvPr/>
            </p:nvSpPr>
            <p:spPr>
              <a:xfrm>
                <a:off x="6968362" y="5832365"/>
                <a:ext cx="663484" cy="24820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l-GR" sz="1013" dirty="0">
                    <a:latin typeface="Arial" panose="020B0604020202020204" pitchFamily="34" charset="0"/>
                    <a:cs typeface="Arial" panose="020B0604020202020204" pitchFamily="34" charset="0"/>
                  </a:rPr>
                  <a:t>β</a:t>
                </a:r>
                <a:r>
                  <a:rPr lang="en-US" sz="1013" dirty="0">
                    <a:latin typeface="Arial" panose="020B0604020202020204" pitchFamily="34" charset="0"/>
                    <a:cs typeface="Arial" panose="020B0604020202020204" pitchFamily="34" charset="0"/>
                  </a:rPr>
                  <a:t>-actin</a:t>
                </a:r>
              </a:p>
            </p:txBody>
          </p:sp>
          <p:sp>
            <p:nvSpPr>
              <p:cNvPr id="68" name="TextBox 35">
                <a:extLst>
                  <a:ext uri="{FF2B5EF4-FFF2-40B4-BE49-F238E27FC236}">
                    <a16:creationId xmlns:a16="http://schemas.microsoft.com/office/drawing/2014/main" id="{B95B00F6-B357-1F52-3B9E-3C2C0659F804}"/>
                  </a:ext>
                </a:extLst>
              </p:cNvPr>
              <p:cNvSpPr txBox="1"/>
              <p:nvPr/>
            </p:nvSpPr>
            <p:spPr>
              <a:xfrm>
                <a:off x="6968361" y="4800095"/>
                <a:ext cx="625399" cy="24820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13" dirty="0">
                    <a:latin typeface="Arial" panose="020B0604020202020204" pitchFamily="34" charset="0"/>
                    <a:cs typeface="Arial" panose="020B0604020202020204" pitchFamily="34" charset="0"/>
                  </a:rPr>
                  <a:t>pACC1</a:t>
                </a:r>
              </a:p>
            </p:txBody>
          </p:sp>
          <p:sp>
            <p:nvSpPr>
              <p:cNvPr id="96" name="TextBox 9">
                <a:extLst>
                  <a:ext uri="{FF2B5EF4-FFF2-40B4-BE49-F238E27FC236}">
                    <a16:creationId xmlns:a16="http://schemas.microsoft.com/office/drawing/2014/main" id="{5E0DE7AA-8337-C2F1-435A-67F32261CF71}"/>
                  </a:ext>
                </a:extLst>
              </p:cNvPr>
              <p:cNvSpPr txBox="1"/>
              <p:nvPr/>
            </p:nvSpPr>
            <p:spPr>
              <a:xfrm rot="18161804">
                <a:off x="1304203" y="4212945"/>
                <a:ext cx="1101584"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dirty="0"/>
                  <a:t>UCD4 + </a:t>
                </a:r>
                <a:r>
                  <a:rPr lang="en-US" sz="900" dirty="0" err="1"/>
                  <a:t>Oliomycin</a:t>
                </a:r>
                <a:endParaRPr lang="en-US" sz="900" dirty="0"/>
              </a:p>
            </p:txBody>
          </p:sp>
          <p:sp>
            <p:nvSpPr>
              <p:cNvPr id="97" name="TextBox 9">
                <a:extLst>
                  <a:ext uri="{FF2B5EF4-FFF2-40B4-BE49-F238E27FC236}">
                    <a16:creationId xmlns:a16="http://schemas.microsoft.com/office/drawing/2014/main" id="{E109B43B-BB2D-95B8-CF61-B1CD1E543591}"/>
                  </a:ext>
                </a:extLst>
              </p:cNvPr>
              <p:cNvSpPr txBox="1"/>
              <p:nvPr/>
            </p:nvSpPr>
            <p:spPr>
              <a:xfrm rot="18161804">
                <a:off x="4671296" y="4264514"/>
                <a:ext cx="1101584" cy="2308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900" dirty="0"/>
                  <a:t>UCD4 + </a:t>
                </a:r>
                <a:r>
                  <a:rPr lang="en-US" sz="900" dirty="0" err="1"/>
                  <a:t>Oliomycin</a:t>
                </a:r>
                <a:endParaRPr lang="en-US" sz="900" dirty="0"/>
              </a:p>
            </p:txBody>
          </p:sp>
        </p:grpSp>
        <p:sp>
          <p:nvSpPr>
            <p:cNvPr id="35" name="TextBox 34">
              <a:extLst>
                <a:ext uri="{FF2B5EF4-FFF2-40B4-BE49-F238E27FC236}">
                  <a16:creationId xmlns:a16="http://schemas.microsoft.com/office/drawing/2014/main" id="{FD999220-522C-D128-F1BC-0644ED8FCB3E}"/>
                </a:ext>
              </a:extLst>
            </p:cNvPr>
            <p:cNvSpPr txBox="1"/>
            <p:nvPr/>
          </p:nvSpPr>
          <p:spPr>
            <a:xfrm>
              <a:off x="357915" y="745510"/>
              <a:ext cx="327334" cy="400110"/>
            </a:xfrm>
            <a:prstGeom prst="rect">
              <a:avLst/>
            </a:prstGeom>
            <a:noFill/>
          </p:spPr>
          <p:txBody>
            <a:bodyPr wrap="none" rtlCol="0">
              <a:spAutoFit/>
            </a:bodyPr>
            <a:lstStyle>
              <a:defPPr>
                <a:defRPr lang="en-US"/>
              </a:defPPr>
              <a:lvl1pPr>
                <a:defRPr sz="1400" b="1">
                  <a:latin typeface="Arial" panose="020B0604020202020204" pitchFamily="34" charset="0"/>
                  <a:cs typeface="Arial" panose="020B0604020202020204" pitchFamily="34" charset="0"/>
                </a:defRPr>
              </a:lvl1pPr>
            </a:lstStyle>
            <a:p>
              <a:r>
                <a:rPr lang="en-US" sz="2000" dirty="0"/>
                <a:t>a</a:t>
              </a:r>
            </a:p>
          </p:txBody>
        </p:sp>
      </p:grpSp>
    </p:spTree>
    <p:extLst>
      <p:ext uri="{BB962C8B-B14F-4D97-AF65-F5344CB8AC3E}">
        <p14:creationId xmlns:p14="http://schemas.microsoft.com/office/powerpoint/2010/main" val="300474189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AF6D795-274B-3B14-0EFE-052AA60971BE}"/>
              </a:ext>
            </a:extLst>
          </p:cNvPr>
          <p:cNvSpPr txBox="1"/>
          <p:nvPr/>
        </p:nvSpPr>
        <p:spPr>
          <a:xfrm>
            <a:off x="479711" y="6139107"/>
            <a:ext cx="6835489" cy="2409699"/>
          </a:xfrm>
          <a:prstGeom prst="rect">
            <a:avLst/>
          </a:prstGeom>
          <a:noFill/>
        </p:spPr>
        <p:txBody>
          <a:bodyPr wrap="square" rtlCol="0">
            <a:spAutoFit/>
          </a:bodyPr>
          <a:lstStyle/>
          <a:p>
            <a:pPr algn="just">
              <a:lnSpc>
                <a:spcPct val="200000"/>
              </a:lnSpc>
            </a:pPr>
            <a:r>
              <a:rPr lang="en-US" sz="1100" b="1" dirty="0">
                <a:latin typeface="Arial" panose="020B0604020202020204" pitchFamily="34" charset="0"/>
                <a:cs typeface="Arial" panose="020B0604020202020204" pitchFamily="34" charset="0"/>
              </a:rPr>
              <a:t>Supplemental Figure S7.</a:t>
            </a:r>
            <a:r>
              <a:rPr lang="en-US" sz="1100" dirty="0">
                <a:latin typeface="Arial" panose="020B0604020202020204" pitchFamily="34" charset="0"/>
                <a:cs typeface="Arial" panose="020B0604020202020204" pitchFamily="34" charset="0"/>
              </a:rPr>
              <a:t> </a:t>
            </a:r>
            <a:r>
              <a:rPr lang="en-US" sz="1100" b="1" dirty="0">
                <a:latin typeface="Arial" panose="020B0604020202020204" pitchFamily="34" charset="0"/>
                <a:cs typeface="Arial" panose="020B0604020202020204" pitchFamily="34" charset="0"/>
              </a:rPr>
              <a:t>Lipid droplet accumulation in UCD65 parental and </a:t>
            </a:r>
            <a:r>
              <a:rPr lang="en-US" sz="1100" b="1" dirty="0" err="1">
                <a:latin typeface="Arial" panose="020B0604020202020204" pitchFamily="34" charset="0"/>
                <a:cs typeface="Arial" panose="020B0604020202020204" pitchFamily="34" charset="0"/>
              </a:rPr>
              <a:t>TamR</a:t>
            </a:r>
            <a:r>
              <a:rPr lang="en-US" sz="1100" b="1" dirty="0">
                <a:latin typeface="Arial" panose="020B0604020202020204" pitchFamily="34" charset="0"/>
                <a:cs typeface="Arial" panose="020B0604020202020204" pitchFamily="34" charset="0"/>
              </a:rPr>
              <a:t> cells treated with TVB-2640.</a:t>
            </a:r>
            <a:r>
              <a:rPr lang="en-US" sz="1100" dirty="0">
                <a:latin typeface="Arial" panose="020B0604020202020204" pitchFamily="34" charset="0"/>
                <a:cs typeface="Arial" panose="020B0604020202020204" pitchFamily="34" charset="0"/>
              </a:rPr>
              <a:t> a) Oil Red O (ORO) staining of UCD65-parental (Par) and </a:t>
            </a:r>
            <a:r>
              <a:rPr lang="en-US" sz="1100" dirty="0" err="1">
                <a:latin typeface="Arial" panose="020B0604020202020204" pitchFamily="34" charset="0"/>
                <a:cs typeface="Arial" panose="020B0604020202020204" pitchFamily="34" charset="0"/>
              </a:rPr>
              <a:t>TamR</a:t>
            </a:r>
            <a:r>
              <a:rPr lang="en-US" sz="1100" dirty="0">
                <a:latin typeface="Arial" panose="020B0604020202020204" pitchFamily="34" charset="0"/>
                <a:cs typeface="Arial" panose="020B0604020202020204" pitchFamily="34" charset="0"/>
              </a:rPr>
              <a:t> cells. A total of 7.5 x 10</a:t>
            </a:r>
            <a:r>
              <a:rPr lang="en-US" sz="1100" baseline="30000" dirty="0">
                <a:latin typeface="Arial" panose="020B0604020202020204" pitchFamily="34" charset="0"/>
                <a:cs typeface="Arial" panose="020B0604020202020204" pitchFamily="34" charset="0"/>
              </a:rPr>
              <a:t>4</a:t>
            </a:r>
            <a:r>
              <a:rPr lang="en-US" sz="1100" dirty="0">
                <a:latin typeface="Arial" panose="020B0604020202020204" pitchFamily="34" charset="0"/>
                <a:cs typeface="Arial" panose="020B0604020202020204" pitchFamily="34" charset="0"/>
              </a:rPr>
              <a:t> cells per condition were plated on glass coverslips in standard media. Cells were treated with vehicle (DMSO) or 10 </a:t>
            </a:r>
            <a:r>
              <a:rPr lang="en-US" sz="1100" dirty="0" err="1">
                <a:latin typeface="Arial" panose="020B0604020202020204" pitchFamily="34" charset="0"/>
                <a:cs typeface="Arial" panose="020B0604020202020204" pitchFamily="34" charset="0"/>
              </a:rPr>
              <a:t>uM</a:t>
            </a:r>
            <a:r>
              <a:rPr lang="en-US" sz="1100" dirty="0">
                <a:latin typeface="Arial" panose="020B0604020202020204" pitchFamily="34" charset="0"/>
                <a:cs typeface="Arial" panose="020B0604020202020204" pitchFamily="34" charset="0"/>
              </a:rPr>
              <a:t> TVB-2640 for 72 h. Cells were formalin fixed, stained with ORO, and imaged by light microscopy. Scale bars, 50 </a:t>
            </a:r>
            <a:r>
              <a:rPr lang="el-GR" sz="1100" dirty="0">
                <a:latin typeface="Arial" panose="020B0604020202020204" pitchFamily="34" charset="0"/>
                <a:ea typeface="Calibri" panose="020F0502020204030204" pitchFamily="34" charset="0"/>
                <a:cs typeface="Arial" panose="020B0604020202020204" pitchFamily="34" charset="0"/>
              </a:rPr>
              <a:t>μ</a:t>
            </a:r>
            <a:r>
              <a:rPr lang="en-US" sz="1100" dirty="0">
                <a:latin typeface="Arial" panose="020B0604020202020204" pitchFamily="34" charset="0"/>
                <a:cs typeface="Arial" panose="020B0604020202020204" pitchFamily="34" charset="0"/>
              </a:rPr>
              <a:t>M. b) Quantification of ORO staining. Images were analyzed by ImageJ software (4 fields per condition) to determine the ORO-positive area normalized to cell number. Fold change relative to Par cells is shown. Statistical comparisons were performed using one-way ANOVA. *P&lt;0.05; **P&lt;0.01. </a:t>
            </a:r>
          </a:p>
        </p:txBody>
      </p:sp>
      <p:sp>
        <p:nvSpPr>
          <p:cNvPr id="12" name="TextBox 11">
            <a:extLst>
              <a:ext uri="{FF2B5EF4-FFF2-40B4-BE49-F238E27FC236}">
                <a16:creationId xmlns:a16="http://schemas.microsoft.com/office/drawing/2014/main" id="{B97A57B3-A4AD-780D-EC08-825E9604D11C}"/>
              </a:ext>
            </a:extLst>
          </p:cNvPr>
          <p:cNvSpPr txBox="1"/>
          <p:nvPr/>
        </p:nvSpPr>
        <p:spPr>
          <a:xfrm>
            <a:off x="479711" y="454662"/>
            <a:ext cx="327334" cy="400110"/>
          </a:xfrm>
          <a:prstGeom prst="rect">
            <a:avLst/>
          </a:prstGeom>
          <a:noFill/>
        </p:spPr>
        <p:txBody>
          <a:bodyPr wrap="none" rtlCol="0">
            <a:spAutoFit/>
          </a:bodyPr>
          <a:lstStyle/>
          <a:p>
            <a:r>
              <a:rPr lang="en-US" sz="2000" b="1" dirty="0">
                <a:latin typeface="Arial" panose="020B0604020202020204" pitchFamily="34" charset="0"/>
                <a:cs typeface="Arial" panose="020B0604020202020204" pitchFamily="34" charset="0"/>
              </a:rPr>
              <a:t>a</a:t>
            </a:r>
          </a:p>
        </p:txBody>
      </p:sp>
      <p:sp>
        <p:nvSpPr>
          <p:cNvPr id="13" name="TextBox 12">
            <a:extLst>
              <a:ext uri="{FF2B5EF4-FFF2-40B4-BE49-F238E27FC236}">
                <a16:creationId xmlns:a16="http://schemas.microsoft.com/office/drawing/2014/main" id="{6F6D5148-DA0D-BD0F-585E-135D677B09E3}"/>
              </a:ext>
            </a:extLst>
          </p:cNvPr>
          <p:cNvSpPr txBox="1"/>
          <p:nvPr/>
        </p:nvSpPr>
        <p:spPr>
          <a:xfrm>
            <a:off x="494138" y="3457152"/>
            <a:ext cx="341760" cy="400110"/>
          </a:xfrm>
          <a:prstGeom prst="rect">
            <a:avLst/>
          </a:prstGeom>
          <a:noFill/>
        </p:spPr>
        <p:txBody>
          <a:bodyPr wrap="none" rtlCol="0">
            <a:spAutoFit/>
          </a:bodyPr>
          <a:lstStyle/>
          <a:p>
            <a:r>
              <a:rPr lang="en-US" sz="2000" b="1" dirty="0">
                <a:latin typeface="Arial" panose="020B0604020202020204" pitchFamily="34" charset="0"/>
                <a:cs typeface="Arial" panose="020B0604020202020204" pitchFamily="34" charset="0"/>
              </a:rPr>
              <a:t>b</a:t>
            </a:r>
          </a:p>
        </p:txBody>
      </p:sp>
      <p:pic>
        <p:nvPicPr>
          <p:cNvPr id="5" name="Picture 4" descr="A graph of a number of people&#10;&#10;Description automatically generated with medium confidence">
            <a:extLst>
              <a:ext uri="{FF2B5EF4-FFF2-40B4-BE49-F238E27FC236}">
                <a16:creationId xmlns:a16="http://schemas.microsoft.com/office/drawing/2014/main" id="{FE81A481-3928-AB7A-566B-FAE95DAED8F7}"/>
              </a:ext>
            </a:extLst>
          </p:cNvPr>
          <p:cNvPicPr>
            <a:picLocks noChangeAspect="1"/>
          </p:cNvPicPr>
          <p:nvPr/>
        </p:nvPicPr>
        <p:blipFill>
          <a:blip r:embed="rId2"/>
          <a:srcRect l="2480" t="3850" r="3460" b="3457"/>
          <a:stretch/>
        </p:blipFill>
        <p:spPr>
          <a:xfrm>
            <a:off x="872836" y="3627896"/>
            <a:ext cx="3276690" cy="2373476"/>
          </a:xfrm>
          <a:prstGeom prst="rect">
            <a:avLst/>
          </a:prstGeom>
        </p:spPr>
      </p:pic>
      <p:pic>
        <p:nvPicPr>
          <p:cNvPr id="8" name="Picture 7" descr="A collage of red blotches&#10;&#10;Description automatically generated">
            <a:extLst>
              <a:ext uri="{FF2B5EF4-FFF2-40B4-BE49-F238E27FC236}">
                <a16:creationId xmlns:a16="http://schemas.microsoft.com/office/drawing/2014/main" id="{768FB610-4707-D093-D6C7-25EACEA30945}"/>
              </a:ext>
            </a:extLst>
          </p:cNvPr>
          <p:cNvPicPr>
            <a:picLocks noChangeAspect="1"/>
          </p:cNvPicPr>
          <p:nvPr/>
        </p:nvPicPr>
        <p:blipFill>
          <a:blip r:embed="rId3"/>
          <a:srcRect l="813" t="1658" r="1246" b="4090"/>
          <a:stretch/>
        </p:blipFill>
        <p:spPr>
          <a:xfrm>
            <a:off x="828918" y="641491"/>
            <a:ext cx="4561115" cy="2710170"/>
          </a:xfrm>
          <a:prstGeom prst="rect">
            <a:avLst/>
          </a:prstGeom>
        </p:spPr>
      </p:pic>
    </p:spTree>
    <p:extLst>
      <p:ext uri="{BB962C8B-B14F-4D97-AF65-F5344CB8AC3E}">
        <p14:creationId xmlns:p14="http://schemas.microsoft.com/office/powerpoint/2010/main" val="131319983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05777F17-98B4-DDB1-9A86-D9C9DC972F6A}"/>
              </a:ext>
            </a:extLst>
          </p:cNvPr>
          <p:cNvSpPr txBox="1"/>
          <p:nvPr/>
        </p:nvSpPr>
        <p:spPr>
          <a:xfrm>
            <a:off x="599842" y="460954"/>
            <a:ext cx="327334" cy="400110"/>
          </a:xfrm>
          <a:prstGeom prst="rect">
            <a:avLst/>
          </a:prstGeom>
          <a:noFill/>
        </p:spPr>
        <p:txBody>
          <a:bodyPr wrap="none" rtlCol="0">
            <a:spAutoFit/>
          </a:bodyPr>
          <a:lstStyle/>
          <a:p>
            <a:r>
              <a:rPr lang="en-US" sz="2000" b="1" dirty="0">
                <a:latin typeface="Arial" panose="020B0604020202020204" pitchFamily="34" charset="0"/>
                <a:cs typeface="Arial" panose="020B0604020202020204" pitchFamily="34" charset="0"/>
              </a:rPr>
              <a:t>a</a:t>
            </a:r>
          </a:p>
        </p:txBody>
      </p:sp>
      <p:sp>
        <p:nvSpPr>
          <p:cNvPr id="5" name="TextBox 4">
            <a:extLst>
              <a:ext uri="{FF2B5EF4-FFF2-40B4-BE49-F238E27FC236}">
                <a16:creationId xmlns:a16="http://schemas.microsoft.com/office/drawing/2014/main" id="{37085FFE-2F7C-CD47-DBFD-1EE557C77D72}"/>
              </a:ext>
            </a:extLst>
          </p:cNvPr>
          <p:cNvSpPr txBox="1"/>
          <p:nvPr/>
        </p:nvSpPr>
        <p:spPr>
          <a:xfrm>
            <a:off x="3922964" y="460954"/>
            <a:ext cx="341760" cy="400110"/>
          </a:xfrm>
          <a:prstGeom prst="rect">
            <a:avLst/>
          </a:prstGeom>
          <a:noFill/>
        </p:spPr>
        <p:txBody>
          <a:bodyPr wrap="none" rtlCol="0">
            <a:spAutoFit/>
          </a:bodyPr>
          <a:lstStyle>
            <a:defPPr>
              <a:defRPr lang="en-US"/>
            </a:defPPr>
            <a:lvl1pPr>
              <a:defRPr sz="1200" b="1">
                <a:latin typeface="Arial" panose="020B0604020202020204" pitchFamily="34" charset="0"/>
                <a:cs typeface="Arial" panose="020B0604020202020204" pitchFamily="34" charset="0"/>
              </a:defRPr>
            </a:lvl1pPr>
          </a:lstStyle>
          <a:p>
            <a:r>
              <a:rPr lang="en-US" sz="2000" dirty="0"/>
              <a:t>b</a:t>
            </a:r>
          </a:p>
        </p:txBody>
      </p:sp>
      <p:pic>
        <p:nvPicPr>
          <p:cNvPr id="14" name="Picture 13">
            <a:extLst>
              <a:ext uri="{FF2B5EF4-FFF2-40B4-BE49-F238E27FC236}">
                <a16:creationId xmlns:a16="http://schemas.microsoft.com/office/drawing/2014/main" id="{E17F0037-2B10-91D2-0CF8-D79994FA154A}"/>
              </a:ext>
            </a:extLst>
          </p:cNvPr>
          <p:cNvPicPr>
            <a:picLocks noChangeAspect="1"/>
          </p:cNvPicPr>
          <p:nvPr/>
        </p:nvPicPr>
        <p:blipFill>
          <a:blip r:embed="rId2"/>
          <a:stretch>
            <a:fillRect/>
          </a:stretch>
        </p:blipFill>
        <p:spPr>
          <a:xfrm>
            <a:off x="4219112" y="711612"/>
            <a:ext cx="2741501" cy="2185157"/>
          </a:xfrm>
          <a:prstGeom prst="rect">
            <a:avLst/>
          </a:prstGeom>
        </p:spPr>
      </p:pic>
      <p:sp>
        <p:nvSpPr>
          <p:cNvPr id="2" name="TextBox 1">
            <a:extLst>
              <a:ext uri="{FF2B5EF4-FFF2-40B4-BE49-F238E27FC236}">
                <a16:creationId xmlns:a16="http://schemas.microsoft.com/office/drawing/2014/main" id="{A4F10A4B-69B6-7984-9ED6-55244E080E5A}"/>
              </a:ext>
            </a:extLst>
          </p:cNvPr>
          <p:cNvSpPr txBox="1"/>
          <p:nvPr/>
        </p:nvSpPr>
        <p:spPr>
          <a:xfrm>
            <a:off x="458328" y="5012735"/>
            <a:ext cx="6858000" cy="3092193"/>
          </a:xfrm>
          <a:prstGeom prst="rect">
            <a:avLst/>
          </a:prstGeom>
          <a:noFill/>
        </p:spPr>
        <p:txBody>
          <a:bodyPr wrap="square" rtlCol="0">
            <a:spAutoFit/>
          </a:bodyPr>
          <a:lstStyle/>
          <a:p>
            <a:pPr marL="0" marR="0" algn="just">
              <a:lnSpc>
                <a:spcPct val="200000"/>
              </a:lnSpc>
              <a:spcBef>
                <a:spcPts val="0"/>
              </a:spcBef>
              <a:spcAft>
                <a:spcPts val="0"/>
              </a:spcAft>
            </a:pPr>
            <a:r>
              <a:rPr lang="en-US" sz="1100" b="1" kern="100" dirty="0">
                <a:effectLst/>
                <a:latin typeface="Arial" panose="020B0604020202020204" pitchFamily="34" charset="0"/>
                <a:ea typeface="Aptos" panose="020B0004020202020204" pitchFamily="34" charset="0"/>
                <a:cs typeface="Arial" panose="020B0604020202020204" pitchFamily="34" charset="0"/>
              </a:rPr>
              <a:t>Supplemental Figure S8. Dose curves for TVB-2640 for endocrine therapy-resistant breast cancer cells.</a:t>
            </a:r>
            <a:r>
              <a:rPr lang="en-US" sz="1100" b="1" kern="100" dirty="0">
                <a:latin typeface="Arial" panose="020B0604020202020204" pitchFamily="34" charset="0"/>
                <a:ea typeface="Aptos" panose="020B00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a-b) Dose-response curves of T47D (a) and UCD4 (b) parental and endocrine therapy-resistant cells treated with increasing concentrations of TVB-2640 or vehicle (DMSO). The IC50 value for TVB-2640 is indicated on the graph for T47D cells. The IC50 for UCD4 cells could not be determined, as the drug was insufficient to induce significant cell death even at the highest concentration tested. </a:t>
            </a:r>
            <a:r>
              <a:rPr lang="en-US" sz="1100" kern="100" dirty="0">
                <a:effectLst/>
                <a:latin typeface="Arial" panose="020B0604020202020204" pitchFamily="34" charset="0"/>
                <a:ea typeface="Aptos" panose="020B0004020202020204" pitchFamily="34" charset="0"/>
                <a:cs typeface="Arial" panose="020B0604020202020204" pitchFamily="34" charset="0"/>
              </a:rPr>
              <a:t>c) Growth curves of UCD65-Par and -</a:t>
            </a:r>
            <a:r>
              <a:rPr lang="en-US" sz="1100" kern="100" dirty="0" err="1">
                <a:effectLst/>
                <a:latin typeface="Arial" panose="020B0604020202020204" pitchFamily="34" charset="0"/>
                <a:ea typeface="Aptos" panose="020B0004020202020204" pitchFamily="34" charset="0"/>
                <a:cs typeface="Arial" panose="020B0604020202020204" pitchFamily="34" charset="0"/>
              </a:rPr>
              <a:t>TamR</a:t>
            </a:r>
            <a:r>
              <a:rPr lang="en-US" sz="1100" kern="100" dirty="0">
                <a:effectLst/>
                <a:latin typeface="Arial" panose="020B0604020202020204" pitchFamily="34" charset="0"/>
                <a:ea typeface="Aptos" panose="020B0004020202020204" pitchFamily="34" charset="0"/>
                <a:cs typeface="Arial" panose="020B0604020202020204" pitchFamily="34" charset="0"/>
              </a:rPr>
              <a:t> cells treated with increasing concentrations of TVB-2640. </a:t>
            </a:r>
            <a:r>
              <a:rPr lang="en-US" sz="1100" dirty="0">
                <a:latin typeface="Arial" panose="020B0604020202020204" pitchFamily="34" charset="0"/>
                <a:cs typeface="Arial" panose="020B0604020202020204" pitchFamily="34" charset="0"/>
              </a:rPr>
              <a:t>Fold change (FC) in percent confluence relative to parental cells is shown. Data represent sextuplicate samples ± SD. Statistical significance for differences in fold changes greater than 1.2 was calculated using a two-way ANOVA; significance is indicated. ****P&lt;0.0001.</a:t>
            </a:r>
            <a:endParaRPr lang="en-US" sz="1100" kern="100" dirty="0">
              <a:latin typeface="Arial" panose="020B0604020202020204" pitchFamily="34" charset="0"/>
              <a:ea typeface="Aptos" panose="020B0004020202020204" pitchFamily="34" charset="0"/>
              <a:cs typeface="Arial" panose="020B0604020202020204" pitchFamily="34" charset="0"/>
            </a:endParaRPr>
          </a:p>
        </p:txBody>
      </p:sp>
      <p:pic>
        <p:nvPicPr>
          <p:cNvPr id="7" name="Picture 6" descr="A graph of a number of samples&#10;&#10;Description automatically generated with medium confidence">
            <a:extLst>
              <a:ext uri="{FF2B5EF4-FFF2-40B4-BE49-F238E27FC236}">
                <a16:creationId xmlns:a16="http://schemas.microsoft.com/office/drawing/2014/main" id="{BF6F79AB-E8AF-C39A-6239-FD32D542B1AD}"/>
              </a:ext>
            </a:extLst>
          </p:cNvPr>
          <p:cNvPicPr>
            <a:picLocks noChangeAspect="1"/>
          </p:cNvPicPr>
          <p:nvPr/>
        </p:nvPicPr>
        <p:blipFill>
          <a:blip r:embed="rId3"/>
          <a:stretch>
            <a:fillRect/>
          </a:stretch>
        </p:blipFill>
        <p:spPr>
          <a:xfrm>
            <a:off x="865980" y="661009"/>
            <a:ext cx="3056984" cy="2286000"/>
          </a:xfrm>
          <a:prstGeom prst="rect">
            <a:avLst/>
          </a:prstGeom>
        </p:spPr>
      </p:pic>
      <p:pic>
        <p:nvPicPr>
          <p:cNvPr id="8" name="Picture 7" descr="A diagram of a computer&#10;&#10;Description automatically generated with medium confidence">
            <a:extLst>
              <a:ext uri="{FF2B5EF4-FFF2-40B4-BE49-F238E27FC236}">
                <a16:creationId xmlns:a16="http://schemas.microsoft.com/office/drawing/2014/main" id="{2405A92C-274C-1F1E-49D5-6B2574C3DBFE}"/>
              </a:ext>
            </a:extLst>
          </p:cNvPr>
          <p:cNvPicPr>
            <a:picLocks noChangeAspect="1"/>
          </p:cNvPicPr>
          <p:nvPr/>
        </p:nvPicPr>
        <p:blipFill>
          <a:blip r:embed="rId4"/>
          <a:srcRect l="1433" t="6140" r="1972" b="5470"/>
          <a:stretch/>
        </p:blipFill>
        <p:spPr>
          <a:xfrm>
            <a:off x="776252" y="3062288"/>
            <a:ext cx="6624467" cy="1950447"/>
          </a:xfrm>
          <a:prstGeom prst="rect">
            <a:avLst/>
          </a:prstGeom>
        </p:spPr>
      </p:pic>
      <p:sp>
        <p:nvSpPr>
          <p:cNvPr id="6" name="TextBox 5">
            <a:extLst>
              <a:ext uri="{FF2B5EF4-FFF2-40B4-BE49-F238E27FC236}">
                <a16:creationId xmlns:a16="http://schemas.microsoft.com/office/drawing/2014/main" id="{BC737953-3292-305D-1566-C007BA4E6436}"/>
              </a:ext>
            </a:extLst>
          </p:cNvPr>
          <p:cNvSpPr txBox="1"/>
          <p:nvPr/>
        </p:nvSpPr>
        <p:spPr>
          <a:xfrm>
            <a:off x="599842" y="2959901"/>
            <a:ext cx="327334" cy="400110"/>
          </a:xfrm>
          <a:prstGeom prst="rect">
            <a:avLst/>
          </a:prstGeom>
          <a:noFill/>
        </p:spPr>
        <p:txBody>
          <a:bodyPr wrap="none" rtlCol="0">
            <a:spAutoFit/>
          </a:bodyPr>
          <a:lstStyle/>
          <a:p>
            <a:r>
              <a:rPr lang="en-US" sz="2000" b="1" dirty="0">
                <a:latin typeface="Arial" panose="020B0604020202020204" pitchFamily="34" charset="0"/>
                <a:cs typeface="Arial" panose="020B0604020202020204" pitchFamily="34" charset="0"/>
              </a:rPr>
              <a:t>c</a:t>
            </a:r>
          </a:p>
        </p:txBody>
      </p:sp>
    </p:spTree>
    <p:extLst>
      <p:ext uri="{BB962C8B-B14F-4D97-AF65-F5344CB8AC3E}">
        <p14:creationId xmlns:p14="http://schemas.microsoft.com/office/powerpoint/2010/main" val="361826307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4198</TotalTime>
  <Words>1286</Words>
  <Application>Microsoft Office PowerPoint</Application>
  <PresentationFormat>Custom</PresentationFormat>
  <Paragraphs>115</Paragraphs>
  <Slides>8</Slides>
  <Notes>2</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8</vt:i4>
      </vt:variant>
    </vt:vector>
  </HeadingPairs>
  <TitlesOfParts>
    <vt:vector size="15" baseType="lpstr">
      <vt:lpstr>Aptos</vt:lpstr>
      <vt:lpstr>Aptos Display</vt:lpstr>
      <vt:lpstr>Arial</vt:lpstr>
      <vt:lpstr>Times New Roman</vt:lpstr>
      <vt:lpstr>TimesNewRomanPS</vt:lpstr>
      <vt:lpstr>TimesNewRomanPSM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ard, Ashley2</dc:creator>
  <cp:lastModifiedBy>Sartorius, Carol</cp:lastModifiedBy>
  <cp:revision>9</cp:revision>
  <dcterms:created xsi:type="dcterms:W3CDTF">2024-03-01T22:52:35Z</dcterms:created>
  <dcterms:modified xsi:type="dcterms:W3CDTF">2024-12-05T23:55:52Z</dcterms:modified>
</cp:coreProperties>
</file>